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104" y="23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0618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06181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061914_WT14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061914_WT14f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651659970534186"/>
          <c:y val="5.1400554097404488E-2"/>
          <c:w val="0.73681671175571706"/>
          <c:h val="0.757596237970253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WT4FN!$B$1</c:f>
              <c:strCache>
                <c:ptCount val="1"/>
                <c:pt idx="0">
                  <c:v>WT4 Con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WT4FN!$D$2:$D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1E-4</c:v>
                  </c:pt>
                  <c:pt idx="2">
                    <c:v>3.0999999999999999E-3</c:v>
                  </c:pt>
                  <c:pt idx="3">
                    <c:v>1.9E-3</c:v>
                  </c:pt>
                  <c:pt idx="4">
                    <c:v>8.0000000000000004E-4</c:v>
                  </c:pt>
                  <c:pt idx="5">
                    <c:v>0</c:v>
                  </c:pt>
                  <c:pt idx="6">
                    <c:v>1.6999999999999999E-3</c:v>
                  </c:pt>
                  <c:pt idx="7">
                    <c:v>2.9999999999999997E-4</c:v>
                  </c:pt>
                  <c:pt idx="8">
                    <c:v>2.3E-3</c:v>
                  </c:pt>
                  <c:pt idx="9">
                    <c:v>1.9E-3</c:v>
                  </c:pt>
                  <c:pt idx="10">
                    <c:v>1.4E-3</c:v>
                  </c:pt>
                  <c:pt idx="11">
                    <c:v>4.1000000000000003E-3</c:v>
                  </c:pt>
                  <c:pt idx="12">
                    <c:v>3.7000000000000002E-3</c:v>
                  </c:pt>
                  <c:pt idx="13">
                    <c:v>4.1999999999999997E-3</c:v>
                  </c:pt>
                  <c:pt idx="14">
                    <c:v>3.8E-3</c:v>
                  </c:pt>
                  <c:pt idx="15">
                    <c:v>5.9999999999999995E-4</c:v>
                  </c:pt>
                  <c:pt idx="16">
                    <c:v>1.1999999999999999E-3</c:v>
                  </c:pt>
                  <c:pt idx="17">
                    <c:v>1.6000000000000001E-3</c:v>
                  </c:pt>
                  <c:pt idx="18">
                    <c:v>1.1000000000000001E-3</c:v>
                  </c:pt>
                  <c:pt idx="19">
                    <c:v>1E-3</c:v>
                  </c:pt>
                  <c:pt idx="20">
                    <c:v>3.8E-3</c:v>
                  </c:pt>
                  <c:pt idx="21">
                    <c:v>2E-3</c:v>
                  </c:pt>
                  <c:pt idx="22">
                    <c:v>4.1000000000000003E-3</c:v>
                  </c:pt>
                  <c:pt idx="23">
                    <c:v>8.0000000000000004E-4</c:v>
                  </c:pt>
                  <c:pt idx="24">
                    <c:v>1.1999999999999999E-3</c:v>
                  </c:pt>
                  <c:pt idx="25">
                    <c:v>5.0000000000000001E-4</c:v>
                  </c:pt>
                  <c:pt idx="26">
                    <c:v>1.4E-3</c:v>
                  </c:pt>
                  <c:pt idx="27">
                    <c:v>2.0999999999999999E-3</c:v>
                  </c:pt>
                  <c:pt idx="28">
                    <c:v>5.7000000000000002E-3</c:v>
                  </c:pt>
                  <c:pt idx="29">
                    <c:v>2.8E-3</c:v>
                  </c:pt>
                  <c:pt idx="30">
                    <c:v>1.2999999999999999E-3</c:v>
                  </c:pt>
                  <c:pt idx="31">
                    <c:v>3.3E-3</c:v>
                  </c:pt>
                  <c:pt idx="32">
                    <c:v>2.3999999999999998E-3</c:v>
                  </c:pt>
                  <c:pt idx="33">
                    <c:v>5.0000000000000001E-3</c:v>
                  </c:pt>
                  <c:pt idx="34">
                    <c:v>1.6000000000000001E-3</c:v>
                  </c:pt>
                  <c:pt idx="35">
                    <c:v>2E-3</c:v>
                  </c:pt>
                  <c:pt idx="36">
                    <c:v>1.5E-3</c:v>
                  </c:pt>
                  <c:pt idx="37">
                    <c:v>2.0000000000000001E-4</c:v>
                  </c:pt>
                  <c:pt idx="38">
                    <c:v>2.9999999999999997E-4</c:v>
                  </c:pt>
                  <c:pt idx="39">
                    <c:v>8.9999999999999998E-4</c:v>
                  </c:pt>
                  <c:pt idx="40">
                    <c:v>3.0999999999999999E-3</c:v>
                  </c:pt>
                  <c:pt idx="41">
                    <c:v>3.5999999999999999E-3</c:v>
                  </c:pt>
                  <c:pt idx="42">
                    <c:v>1.1000000000000001E-3</c:v>
                  </c:pt>
                  <c:pt idx="43">
                    <c:v>3.2000000000000002E-3</c:v>
                  </c:pt>
                  <c:pt idx="44">
                    <c:v>3.0999999999999999E-3</c:v>
                  </c:pt>
                  <c:pt idx="45">
                    <c:v>5.7000000000000002E-3</c:v>
                  </c:pt>
                  <c:pt idx="46">
                    <c:v>2E-3</c:v>
                  </c:pt>
                  <c:pt idx="47">
                    <c:v>1.5E-3</c:v>
                  </c:pt>
                  <c:pt idx="48">
                    <c:v>2.7000000000000001E-3</c:v>
                  </c:pt>
                  <c:pt idx="49">
                    <c:v>6.9999999999999999E-4</c:v>
                  </c:pt>
                  <c:pt idx="50">
                    <c:v>8.0000000000000004E-4</c:v>
                  </c:pt>
                  <c:pt idx="51">
                    <c:v>4.0000000000000001E-3</c:v>
                  </c:pt>
                  <c:pt idx="52">
                    <c:v>2.3999999999999998E-3</c:v>
                  </c:pt>
                  <c:pt idx="53">
                    <c:v>4.7000000000000002E-3</c:v>
                  </c:pt>
                  <c:pt idx="54">
                    <c:v>3.3E-3</c:v>
                  </c:pt>
                  <c:pt idx="55">
                    <c:v>5.0000000000000001E-3</c:v>
                  </c:pt>
                  <c:pt idx="56">
                    <c:v>8.3000000000000001E-3</c:v>
                  </c:pt>
                  <c:pt idx="57">
                    <c:v>5.7999999999999996E-3</c:v>
                  </c:pt>
                  <c:pt idx="58">
                    <c:v>8.0000000000000002E-3</c:v>
                  </c:pt>
                  <c:pt idx="59">
                    <c:v>1.04E-2</c:v>
                  </c:pt>
                  <c:pt idx="60">
                    <c:v>5.4000000000000003E-3</c:v>
                  </c:pt>
                  <c:pt idx="61">
                    <c:v>7.1000000000000004E-3</c:v>
                  </c:pt>
                  <c:pt idx="62">
                    <c:v>6.0000000000000001E-3</c:v>
                  </c:pt>
                  <c:pt idx="63">
                    <c:v>2.3999999999999998E-3</c:v>
                  </c:pt>
                  <c:pt idx="64">
                    <c:v>5.4999999999999997E-3</c:v>
                  </c:pt>
                  <c:pt idx="65">
                    <c:v>2.8999999999999998E-3</c:v>
                  </c:pt>
                  <c:pt idx="66">
                    <c:v>4.4999999999999997E-3</c:v>
                  </c:pt>
                  <c:pt idx="67">
                    <c:v>4.5999999999999999E-3</c:v>
                  </c:pt>
                  <c:pt idx="68">
                    <c:v>0.01</c:v>
                  </c:pt>
                  <c:pt idx="69">
                    <c:v>1.11E-2</c:v>
                  </c:pt>
                  <c:pt idx="70">
                    <c:v>0.01</c:v>
                  </c:pt>
                  <c:pt idx="71">
                    <c:v>9.4000000000000004E-3</c:v>
                  </c:pt>
                  <c:pt idx="72">
                    <c:v>1.0999999999999999E-2</c:v>
                  </c:pt>
                  <c:pt idx="73">
                    <c:v>1.0800000000000001E-2</c:v>
                  </c:pt>
                  <c:pt idx="74">
                    <c:v>1.0200000000000001E-2</c:v>
                  </c:pt>
                  <c:pt idx="75">
                    <c:v>1.17E-2</c:v>
                  </c:pt>
                  <c:pt idx="76">
                    <c:v>1.11E-2</c:v>
                  </c:pt>
                  <c:pt idx="77">
                    <c:v>1.2E-2</c:v>
                  </c:pt>
                  <c:pt idx="78">
                    <c:v>1.04E-2</c:v>
                  </c:pt>
                  <c:pt idx="79">
                    <c:v>9.4000000000000004E-3</c:v>
                  </c:pt>
                  <c:pt idx="80">
                    <c:v>1.11E-2</c:v>
                  </c:pt>
                  <c:pt idx="81">
                    <c:v>1.0200000000000001E-2</c:v>
                  </c:pt>
                  <c:pt idx="82">
                    <c:v>1.04E-2</c:v>
                  </c:pt>
                  <c:pt idx="83">
                    <c:v>1.21E-2</c:v>
                  </c:pt>
                  <c:pt idx="84">
                    <c:v>1.18E-2</c:v>
                  </c:pt>
                  <c:pt idx="85">
                    <c:v>1.4200000000000001E-2</c:v>
                  </c:pt>
                  <c:pt idx="86">
                    <c:v>8.3000000000000001E-3</c:v>
                  </c:pt>
                  <c:pt idx="87">
                    <c:v>1.3599999999999999E-2</c:v>
                  </c:pt>
                  <c:pt idx="88">
                    <c:v>1.46E-2</c:v>
                  </c:pt>
                  <c:pt idx="89">
                    <c:v>1.6500000000000001E-2</c:v>
                  </c:pt>
                  <c:pt idx="90">
                    <c:v>1.8800000000000001E-2</c:v>
                  </c:pt>
                  <c:pt idx="91">
                    <c:v>2.4299999999999999E-2</c:v>
                  </c:pt>
                  <c:pt idx="92">
                    <c:v>2.4299999999999999E-2</c:v>
                  </c:pt>
                  <c:pt idx="93">
                    <c:v>2.4899999999999999E-2</c:v>
                  </c:pt>
                  <c:pt idx="94">
                    <c:v>3.1699999999999999E-2</c:v>
                  </c:pt>
                  <c:pt idx="95">
                    <c:v>3.0099999999999998E-2</c:v>
                  </c:pt>
                  <c:pt idx="96">
                    <c:v>2.8199999999999999E-2</c:v>
                  </c:pt>
                  <c:pt idx="97">
                    <c:v>2.47E-2</c:v>
                  </c:pt>
                  <c:pt idx="98">
                    <c:v>2.5899999999999999E-2</c:v>
                  </c:pt>
                  <c:pt idx="99">
                    <c:v>2.5000000000000001E-2</c:v>
                  </c:pt>
                  <c:pt idx="100">
                    <c:v>2.3300000000000001E-2</c:v>
                  </c:pt>
                  <c:pt idx="101">
                    <c:v>2.6100000000000002E-2</c:v>
                  </c:pt>
                  <c:pt idx="102">
                    <c:v>2.52E-2</c:v>
                  </c:pt>
                  <c:pt idx="103">
                    <c:v>2.6100000000000002E-2</c:v>
                  </c:pt>
                  <c:pt idx="104">
                    <c:v>2.3099999999999999E-2</c:v>
                  </c:pt>
                  <c:pt idx="105">
                    <c:v>2.3099999999999999E-2</c:v>
                  </c:pt>
                  <c:pt idx="106">
                    <c:v>2.35E-2</c:v>
                  </c:pt>
                  <c:pt idx="107">
                    <c:v>2.6599999999999999E-2</c:v>
                  </c:pt>
                  <c:pt idx="108">
                    <c:v>2.5600000000000001E-2</c:v>
                  </c:pt>
                  <c:pt idx="109">
                    <c:v>2.4899999999999999E-2</c:v>
                  </c:pt>
                  <c:pt idx="110">
                    <c:v>2.86E-2</c:v>
                  </c:pt>
                  <c:pt idx="111">
                    <c:v>2.2200000000000001E-2</c:v>
                  </c:pt>
                  <c:pt idx="112">
                    <c:v>1.9300000000000001E-2</c:v>
                  </c:pt>
                  <c:pt idx="113">
                    <c:v>1.66E-2</c:v>
                  </c:pt>
                  <c:pt idx="114">
                    <c:v>1.7600000000000001E-2</c:v>
                  </c:pt>
                  <c:pt idx="115">
                    <c:v>1.95E-2</c:v>
                  </c:pt>
                  <c:pt idx="116">
                    <c:v>1.8700000000000001E-2</c:v>
                  </c:pt>
                  <c:pt idx="117">
                    <c:v>2.3E-2</c:v>
                  </c:pt>
                  <c:pt idx="118">
                    <c:v>2.1399999999999999E-2</c:v>
                  </c:pt>
                  <c:pt idx="119">
                    <c:v>2.2700000000000001E-2</c:v>
                  </c:pt>
                  <c:pt idx="120">
                    <c:v>2.3400000000000001E-2</c:v>
                  </c:pt>
                  <c:pt idx="121">
                    <c:v>2.0500000000000001E-2</c:v>
                  </c:pt>
                  <c:pt idx="122">
                    <c:v>2.2200000000000001E-2</c:v>
                  </c:pt>
                  <c:pt idx="123">
                    <c:v>2.1999999999999999E-2</c:v>
                  </c:pt>
                  <c:pt idx="124">
                    <c:v>2.1700000000000001E-2</c:v>
                  </c:pt>
                  <c:pt idx="125">
                    <c:v>2.18E-2</c:v>
                  </c:pt>
                  <c:pt idx="126">
                    <c:v>1.9900000000000001E-2</c:v>
                  </c:pt>
                  <c:pt idx="127">
                    <c:v>1.7299999999999999E-2</c:v>
                  </c:pt>
                  <c:pt idx="128">
                    <c:v>1.6899999999999998E-2</c:v>
                  </c:pt>
                  <c:pt idx="129">
                    <c:v>1.06E-2</c:v>
                  </c:pt>
                  <c:pt idx="130">
                    <c:v>1.0800000000000001E-2</c:v>
                  </c:pt>
                  <c:pt idx="131">
                    <c:v>8.2000000000000007E-3</c:v>
                  </c:pt>
                  <c:pt idx="132">
                    <c:v>1.0999999999999999E-2</c:v>
                  </c:pt>
                  <c:pt idx="133">
                    <c:v>7.1999999999999998E-3</c:v>
                  </c:pt>
                  <c:pt idx="134">
                    <c:v>7.0000000000000001E-3</c:v>
                  </c:pt>
                  <c:pt idx="135">
                    <c:v>1.26E-2</c:v>
                  </c:pt>
                  <c:pt idx="136">
                    <c:v>1.21E-2</c:v>
                  </c:pt>
                  <c:pt idx="137">
                    <c:v>1.3599999999999999E-2</c:v>
                  </c:pt>
                  <c:pt idx="138">
                    <c:v>1.4800000000000001E-2</c:v>
                  </c:pt>
                  <c:pt idx="139">
                    <c:v>1.1900000000000001E-2</c:v>
                  </c:pt>
                  <c:pt idx="140">
                    <c:v>1.0800000000000001E-2</c:v>
                  </c:pt>
                  <c:pt idx="141">
                    <c:v>1.5699999999999999E-2</c:v>
                  </c:pt>
                  <c:pt idx="142">
                    <c:v>1.11E-2</c:v>
                  </c:pt>
                  <c:pt idx="143">
                    <c:v>8.3999999999999995E-3</c:v>
                  </c:pt>
                  <c:pt idx="144">
                    <c:v>8.0000000000000002E-3</c:v>
                  </c:pt>
                  <c:pt idx="145">
                    <c:v>6.1000000000000004E-3</c:v>
                  </c:pt>
                  <c:pt idx="146">
                    <c:v>5.1000000000000004E-3</c:v>
                  </c:pt>
                  <c:pt idx="147">
                    <c:v>5.9999999999999995E-4</c:v>
                  </c:pt>
                  <c:pt idx="148">
                    <c:v>6.6E-3</c:v>
                  </c:pt>
                  <c:pt idx="149">
                    <c:v>2.8E-3</c:v>
                  </c:pt>
                  <c:pt idx="150">
                    <c:v>2.0000000000000001E-4</c:v>
                  </c:pt>
                  <c:pt idx="151">
                    <c:v>2.3E-3</c:v>
                  </c:pt>
                  <c:pt idx="152">
                    <c:v>1.6000000000000001E-3</c:v>
                  </c:pt>
                  <c:pt idx="153">
                    <c:v>1.4E-3</c:v>
                  </c:pt>
                  <c:pt idx="154">
                    <c:v>1.1000000000000001E-3</c:v>
                  </c:pt>
                  <c:pt idx="155">
                    <c:v>5.1000000000000004E-3</c:v>
                  </c:pt>
                  <c:pt idx="156">
                    <c:v>1.1999999999999999E-3</c:v>
                  </c:pt>
                  <c:pt idx="157">
                    <c:v>1.6000000000000001E-3</c:v>
                  </c:pt>
                  <c:pt idx="158">
                    <c:v>5.5999999999999999E-3</c:v>
                  </c:pt>
                  <c:pt idx="159">
                    <c:v>2.0999999999999999E-3</c:v>
                  </c:pt>
                  <c:pt idx="160">
                    <c:v>3.8E-3</c:v>
                  </c:pt>
                </c:numCache>
              </c:numRef>
            </c:plus>
            <c:minus>
              <c:numRef>
                <c:f>WT4FN!$D$2:$D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1E-4</c:v>
                  </c:pt>
                  <c:pt idx="2">
                    <c:v>3.0999999999999999E-3</c:v>
                  </c:pt>
                  <c:pt idx="3">
                    <c:v>1.9E-3</c:v>
                  </c:pt>
                  <c:pt idx="4">
                    <c:v>8.0000000000000004E-4</c:v>
                  </c:pt>
                  <c:pt idx="5">
                    <c:v>0</c:v>
                  </c:pt>
                  <c:pt idx="6">
                    <c:v>1.6999999999999999E-3</c:v>
                  </c:pt>
                  <c:pt idx="7">
                    <c:v>2.9999999999999997E-4</c:v>
                  </c:pt>
                  <c:pt idx="8">
                    <c:v>2.3E-3</c:v>
                  </c:pt>
                  <c:pt idx="9">
                    <c:v>1.9E-3</c:v>
                  </c:pt>
                  <c:pt idx="10">
                    <c:v>1.4E-3</c:v>
                  </c:pt>
                  <c:pt idx="11">
                    <c:v>4.1000000000000003E-3</c:v>
                  </c:pt>
                  <c:pt idx="12">
                    <c:v>3.7000000000000002E-3</c:v>
                  </c:pt>
                  <c:pt idx="13">
                    <c:v>4.1999999999999997E-3</c:v>
                  </c:pt>
                  <c:pt idx="14">
                    <c:v>3.8E-3</c:v>
                  </c:pt>
                  <c:pt idx="15">
                    <c:v>5.9999999999999995E-4</c:v>
                  </c:pt>
                  <c:pt idx="16">
                    <c:v>1.1999999999999999E-3</c:v>
                  </c:pt>
                  <c:pt idx="17">
                    <c:v>1.6000000000000001E-3</c:v>
                  </c:pt>
                  <c:pt idx="18">
                    <c:v>1.1000000000000001E-3</c:v>
                  </c:pt>
                  <c:pt idx="19">
                    <c:v>1E-3</c:v>
                  </c:pt>
                  <c:pt idx="20">
                    <c:v>3.8E-3</c:v>
                  </c:pt>
                  <c:pt idx="21">
                    <c:v>2E-3</c:v>
                  </c:pt>
                  <c:pt idx="22">
                    <c:v>4.1000000000000003E-3</c:v>
                  </c:pt>
                  <c:pt idx="23">
                    <c:v>8.0000000000000004E-4</c:v>
                  </c:pt>
                  <c:pt idx="24">
                    <c:v>1.1999999999999999E-3</c:v>
                  </c:pt>
                  <c:pt idx="25">
                    <c:v>5.0000000000000001E-4</c:v>
                  </c:pt>
                  <c:pt idx="26">
                    <c:v>1.4E-3</c:v>
                  </c:pt>
                  <c:pt idx="27">
                    <c:v>2.0999999999999999E-3</c:v>
                  </c:pt>
                  <c:pt idx="28">
                    <c:v>5.7000000000000002E-3</c:v>
                  </c:pt>
                  <c:pt idx="29">
                    <c:v>2.8E-3</c:v>
                  </c:pt>
                  <c:pt idx="30">
                    <c:v>1.2999999999999999E-3</c:v>
                  </c:pt>
                  <c:pt idx="31">
                    <c:v>3.3E-3</c:v>
                  </c:pt>
                  <c:pt idx="32">
                    <c:v>2.3999999999999998E-3</c:v>
                  </c:pt>
                  <c:pt idx="33">
                    <c:v>5.0000000000000001E-3</c:v>
                  </c:pt>
                  <c:pt idx="34">
                    <c:v>1.6000000000000001E-3</c:v>
                  </c:pt>
                  <c:pt idx="35">
                    <c:v>2E-3</c:v>
                  </c:pt>
                  <c:pt idx="36">
                    <c:v>1.5E-3</c:v>
                  </c:pt>
                  <c:pt idx="37">
                    <c:v>2.0000000000000001E-4</c:v>
                  </c:pt>
                  <c:pt idx="38">
                    <c:v>2.9999999999999997E-4</c:v>
                  </c:pt>
                  <c:pt idx="39">
                    <c:v>8.9999999999999998E-4</c:v>
                  </c:pt>
                  <c:pt idx="40">
                    <c:v>3.0999999999999999E-3</c:v>
                  </c:pt>
                  <c:pt idx="41">
                    <c:v>3.5999999999999999E-3</c:v>
                  </c:pt>
                  <c:pt idx="42">
                    <c:v>1.1000000000000001E-3</c:v>
                  </c:pt>
                  <c:pt idx="43">
                    <c:v>3.2000000000000002E-3</c:v>
                  </c:pt>
                  <c:pt idx="44">
                    <c:v>3.0999999999999999E-3</c:v>
                  </c:pt>
                  <c:pt idx="45">
                    <c:v>5.7000000000000002E-3</c:v>
                  </c:pt>
                  <c:pt idx="46">
                    <c:v>2E-3</c:v>
                  </c:pt>
                  <c:pt idx="47">
                    <c:v>1.5E-3</c:v>
                  </c:pt>
                  <c:pt idx="48">
                    <c:v>2.7000000000000001E-3</c:v>
                  </c:pt>
                  <c:pt idx="49">
                    <c:v>6.9999999999999999E-4</c:v>
                  </c:pt>
                  <c:pt idx="50">
                    <c:v>8.0000000000000004E-4</c:v>
                  </c:pt>
                  <c:pt idx="51">
                    <c:v>4.0000000000000001E-3</c:v>
                  </c:pt>
                  <c:pt idx="52">
                    <c:v>2.3999999999999998E-3</c:v>
                  </c:pt>
                  <c:pt idx="53">
                    <c:v>4.7000000000000002E-3</c:v>
                  </c:pt>
                  <c:pt idx="54">
                    <c:v>3.3E-3</c:v>
                  </c:pt>
                  <c:pt idx="55">
                    <c:v>5.0000000000000001E-3</c:v>
                  </c:pt>
                  <c:pt idx="56">
                    <c:v>8.3000000000000001E-3</c:v>
                  </c:pt>
                  <c:pt idx="57">
                    <c:v>5.7999999999999996E-3</c:v>
                  </c:pt>
                  <c:pt idx="58">
                    <c:v>8.0000000000000002E-3</c:v>
                  </c:pt>
                  <c:pt idx="59">
                    <c:v>1.04E-2</c:v>
                  </c:pt>
                  <c:pt idx="60">
                    <c:v>5.4000000000000003E-3</c:v>
                  </c:pt>
                  <c:pt idx="61">
                    <c:v>7.1000000000000004E-3</c:v>
                  </c:pt>
                  <c:pt idx="62">
                    <c:v>6.0000000000000001E-3</c:v>
                  </c:pt>
                  <c:pt idx="63">
                    <c:v>2.3999999999999998E-3</c:v>
                  </c:pt>
                  <c:pt idx="64">
                    <c:v>5.4999999999999997E-3</c:v>
                  </c:pt>
                  <c:pt idx="65">
                    <c:v>2.8999999999999998E-3</c:v>
                  </c:pt>
                  <c:pt idx="66">
                    <c:v>4.4999999999999997E-3</c:v>
                  </c:pt>
                  <c:pt idx="67">
                    <c:v>4.5999999999999999E-3</c:v>
                  </c:pt>
                  <c:pt idx="68">
                    <c:v>0.01</c:v>
                  </c:pt>
                  <c:pt idx="69">
                    <c:v>1.11E-2</c:v>
                  </c:pt>
                  <c:pt idx="70">
                    <c:v>0.01</c:v>
                  </c:pt>
                  <c:pt idx="71">
                    <c:v>9.4000000000000004E-3</c:v>
                  </c:pt>
                  <c:pt idx="72">
                    <c:v>1.0999999999999999E-2</c:v>
                  </c:pt>
                  <c:pt idx="73">
                    <c:v>1.0800000000000001E-2</c:v>
                  </c:pt>
                  <c:pt idx="74">
                    <c:v>1.0200000000000001E-2</c:v>
                  </c:pt>
                  <c:pt idx="75">
                    <c:v>1.17E-2</c:v>
                  </c:pt>
                  <c:pt idx="76">
                    <c:v>1.11E-2</c:v>
                  </c:pt>
                  <c:pt idx="77">
                    <c:v>1.2E-2</c:v>
                  </c:pt>
                  <c:pt idx="78">
                    <c:v>1.04E-2</c:v>
                  </c:pt>
                  <c:pt idx="79">
                    <c:v>9.4000000000000004E-3</c:v>
                  </c:pt>
                  <c:pt idx="80">
                    <c:v>1.11E-2</c:v>
                  </c:pt>
                  <c:pt idx="81">
                    <c:v>1.0200000000000001E-2</c:v>
                  </c:pt>
                  <c:pt idx="82">
                    <c:v>1.04E-2</c:v>
                  </c:pt>
                  <c:pt idx="83">
                    <c:v>1.21E-2</c:v>
                  </c:pt>
                  <c:pt idx="84">
                    <c:v>1.18E-2</c:v>
                  </c:pt>
                  <c:pt idx="85">
                    <c:v>1.4200000000000001E-2</c:v>
                  </c:pt>
                  <c:pt idx="86">
                    <c:v>8.3000000000000001E-3</c:v>
                  </c:pt>
                  <c:pt idx="87">
                    <c:v>1.3599999999999999E-2</c:v>
                  </c:pt>
                  <c:pt idx="88">
                    <c:v>1.46E-2</c:v>
                  </c:pt>
                  <c:pt idx="89">
                    <c:v>1.6500000000000001E-2</c:v>
                  </c:pt>
                  <c:pt idx="90">
                    <c:v>1.8800000000000001E-2</c:v>
                  </c:pt>
                  <c:pt idx="91">
                    <c:v>2.4299999999999999E-2</c:v>
                  </c:pt>
                  <c:pt idx="92">
                    <c:v>2.4299999999999999E-2</c:v>
                  </c:pt>
                  <c:pt idx="93">
                    <c:v>2.4899999999999999E-2</c:v>
                  </c:pt>
                  <c:pt idx="94">
                    <c:v>3.1699999999999999E-2</c:v>
                  </c:pt>
                  <c:pt idx="95">
                    <c:v>3.0099999999999998E-2</c:v>
                  </c:pt>
                  <c:pt idx="96">
                    <c:v>2.8199999999999999E-2</c:v>
                  </c:pt>
                  <c:pt idx="97">
                    <c:v>2.47E-2</c:v>
                  </c:pt>
                  <c:pt idx="98">
                    <c:v>2.5899999999999999E-2</c:v>
                  </c:pt>
                  <c:pt idx="99">
                    <c:v>2.5000000000000001E-2</c:v>
                  </c:pt>
                  <c:pt idx="100">
                    <c:v>2.3300000000000001E-2</c:v>
                  </c:pt>
                  <c:pt idx="101">
                    <c:v>2.6100000000000002E-2</c:v>
                  </c:pt>
                  <c:pt idx="102">
                    <c:v>2.52E-2</c:v>
                  </c:pt>
                  <c:pt idx="103">
                    <c:v>2.6100000000000002E-2</c:v>
                  </c:pt>
                  <c:pt idx="104">
                    <c:v>2.3099999999999999E-2</c:v>
                  </c:pt>
                  <c:pt idx="105">
                    <c:v>2.3099999999999999E-2</c:v>
                  </c:pt>
                  <c:pt idx="106">
                    <c:v>2.35E-2</c:v>
                  </c:pt>
                  <c:pt idx="107">
                    <c:v>2.6599999999999999E-2</c:v>
                  </c:pt>
                  <c:pt idx="108">
                    <c:v>2.5600000000000001E-2</c:v>
                  </c:pt>
                  <c:pt idx="109">
                    <c:v>2.4899999999999999E-2</c:v>
                  </c:pt>
                  <c:pt idx="110">
                    <c:v>2.86E-2</c:v>
                  </c:pt>
                  <c:pt idx="111">
                    <c:v>2.2200000000000001E-2</c:v>
                  </c:pt>
                  <c:pt idx="112">
                    <c:v>1.9300000000000001E-2</c:v>
                  </c:pt>
                  <c:pt idx="113">
                    <c:v>1.66E-2</c:v>
                  </c:pt>
                  <c:pt idx="114">
                    <c:v>1.7600000000000001E-2</c:v>
                  </c:pt>
                  <c:pt idx="115">
                    <c:v>1.95E-2</c:v>
                  </c:pt>
                  <c:pt idx="116">
                    <c:v>1.8700000000000001E-2</c:v>
                  </c:pt>
                  <c:pt idx="117">
                    <c:v>2.3E-2</c:v>
                  </c:pt>
                  <c:pt idx="118">
                    <c:v>2.1399999999999999E-2</c:v>
                  </c:pt>
                  <c:pt idx="119">
                    <c:v>2.2700000000000001E-2</c:v>
                  </c:pt>
                  <c:pt idx="120">
                    <c:v>2.3400000000000001E-2</c:v>
                  </c:pt>
                  <c:pt idx="121">
                    <c:v>2.0500000000000001E-2</c:v>
                  </c:pt>
                  <c:pt idx="122">
                    <c:v>2.2200000000000001E-2</c:v>
                  </c:pt>
                  <c:pt idx="123">
                    <c:v>2.1999999999999999E-2</c:v>
                  </c:pt>
                  <c:pt idx="124">
                    <c:v>2.1700000000000001E-2</c:v>
                  </c:pt>
                  <c:pt idx="125">
                    <c:v>2.18E-2</c:v>
                  </c:pt>
                  <c:pt idx="126">
                    <c:v>1.9900000000000001E-2</c:v>
                  </c:pt>
                  <c:pt idx="127">
                    <c:v>1.7299999999999999E-2</c:v>
                  </c:pt>
                  <c:pt idx="128">
                    <c:v>1.6899999999999998E-2</c:v>
                  </c:pt>
                  <c:pt idx="129">
                    <c:v>1.06E-2</c:v>
                  </c:pt>
                  <c:pt idx="130">
                    <c:v>1.0800000000000001E-2</c:v>
                  </c:pt>
                  <c:pt idx="131">
                    <c:v>8.2000000000000007E-3</c:v>
                  </c:pt>
                  <c:pt idx="132">
                    <c:v>1.0999999999999999E-2</c:v>
                  </c:pt>
                  <c:pt idx="133">
                    <c:v>7.1999999999999998E-3</c:v>
                  </c:pt>
                  <c:pt idx="134">
                    <c:v>7.0000000000000001E-3</c:v>
                  </c:pt>
                  <c:pt idx="135">
                    <c:v>1.26E-2</c:v>
                  </c:pt>
                  <c:pt idx="136">
                    <c:v>1.21E-2</c:v>
                  </c:pt>
                  <c:pt idx="137">
                    <c:v>1.3599999999999999E-2</c:v>
                  </c:pt>
                  <c:pt idx="138">
                    <c:v>1.4800000000000001E-2</c:v>
                  </c:pt>
                  <c:pt idx="139">
                    <c:v>1.1900000000000001E-2</c:v>
                  </c:pt>
                  <c:pt idx="140">
                    <c:v>1.0800000000000001E-2</c:v>
                  </c:pt>
                  <c:pt idx="141">
                    <c:v>1.5699999999999999E-2</c:v>
                  </c:pt>
                  <c:pt idx="142">
                    <c:v>1.11E-2</c:v>
                  </c:pt>
                  <c:pt idx="143">
                    <c:v>8.3999999999999995E-3</c:v>
                  </c:pt>
                  <c:pt idx="144">
                    <c:v>8.0000000000000002E-3</c:v>
                  </c:pt>
                  <c:pt idx="145">
                    <c:v>6.1000000000000004E-3</c:v>
                  </c:pt>
                  <c:pt idx="146">
                    <c:v>5.1000000000000004E-3</c:v>
                  </c:pt>
                  <c:pt idx="147">
                    <c:v>5.9999999999999995E-4</c:v>
                  </c:pt>
                  <c:pt idx="148">
                    <c:v>6.6E-3</c:v>
                  </c:pt>
                  <c:pt idx="149">
                    <c:v>2.8E-3</c:v>
                  </c:pt>
                  <c:pt idx="150">
                    <c:v>2.0000000000000001E-4</c:v>
                  </c:pt>
                  <c:pt idx="151">
                    <c:v>2.3E-3</c:v>
                  </c:pt>
                  <c:pt idx="152">
                    <c:v>1.6000000000000001E-3</c:v>
                  </c:pt>
                  <c:pt idx="153">
                    <c:v>1.4E-3</c:v>
                  </c:pt>
                  <c:pt idx="154">
                    <c:v>1.1000000000000001E-3</c:v>
                  </c:pt>
                  <c:pt idx="155">
                    <c:v>5.1000000000000004E-3</c:v>
                  </c:pt>
                  <c:pt idx="156">
                    <c:v>1.1999999999999999E-3</c:v>
                  </c:pt>
                  <c:pt idx="157">
                    <c:v>1.6000000000000001E-3</c:v>
                  </c:pt>
                  <c:pt idx="158">
                    <c:v>5.5999999999999999E-3</c:v>
                  </c:pt>
                  <c:pt idx="159">
                    <c:v>2.0999999999999999E-3</c:v>
                  </c:pt>
                  <c:pt idx="160">
                    <c:v>3.8E-3</c:v>
                  </c:pt>
                </c:numCache>
              </c:numRef>
            </c:minus>
            <c:spPr>
              <a:ln>
                <a:solidFill>
                  <a:schemeClr val="accent1">
                    <a:alpha val="50000"/>
                  </a:schemeClr>
                </a:solidFill>
              </a:ln>
            </c:spPr>
          </c:errBars>
          <c:xVal>
            <c:numRef>
              <c:f>WT4FN!$A$2:$A$174</c:f>
              <c:numCache>
                <c:formatCode>General</c:formatCode>
                <c:ptCount val="173"/>
                <c:pt idx="0">
                  <c:v>0</c:v>
                </c:pt>
                <c:pt idx="1">
                  <c:v>3.5999999999999999E-3</c:v>
                </c:pt>
                <c:pt idx="2">
                  <c:v>0.23080000000000001</c:v>
                </c:pt>
                <c:pt idx="3">
                  <c:v>0.48080000000000001</c:v>
                </c:pt>
                <c:pt idx="4">
                  <c:v>0.73109999999999997</c:v>
                </c:pt>
                <c:pt idx="5">
                  <c:v>0.98140000000000005</c:v>
                </c:pt>
                <c:pt idx="6">
                  <c:v>1.2317</c:v>
                </c:pt>
                <c:pt idx="7">
                  <c:v>1.4819</c:v>
                </c:pt>
                <c:pt idx="8">
                  <c:v>1.7322</c:v>
                </c:pt>
                <c:pt idx="9">
                  <c:v>1.9824999999999999</c:v>
                </c:pt>
                <c:pt idx="10">
                  <c:v>2.2328000000000001</c:v>
                </c:pt>
                <c:pt idx="11">
                  <c:v>2.4830999999999999</c:v>
                </c:pt>
                <c:pt idx="12">
                  <c:v>2.7332999999999998</c:v>
                </c:pt>
                <c:pt idx="13">
                  <c:v>2.9836</c:v>
                </c:pt>
                <c:pt idx="14">
                  <c:v>3.2339000000000002</c:v>
                </c:pt>
                <c:pt idx="15">
                  <c:v>3.4842</c:v>
                </c:pt>
                <c:pt idx="16">
                  <c:v>3.7343999999999999</c:v>
                </c:pt>
                <c:pt idx="17">
                  <c:v>3.9847000000000001</c:v>
                </c:pt>
                <c:pt idx="18">
                  <c:v>4.2350000000000003</c:v>
                </c:pt>
                <c:pt idx="19">
                  <c:v>4.4852999999999996</c:v>
                </c:pt>
                <c:pt idx="20">
                  <c:v>4.7355999999999998</c:v>
                </c:pt>
                <c:pt idx="21">
                  <c:v>4.9858000000000002</c:v>
                </c:pt>
                <c:pt idx="22">
                  <c:v>5.2361000000000004</c:v>
                </c:pt>
                <c:pt idx="23">
                  <c:v>5.4863999999999997</c:v>
                </c:pt>
                <c:pt idx="24">
                  <c:v>5.7366999999999999</c:v>
                </c:pt>
                <c:pt idx="25">
                  <c:v>5.9869000000000003</c:v>
                </c:pt>
                <c:pt idx="26">
                  <c:v>6.2371999999999996</c:v>
                </c:pt>
                <c:pt idx="27">
                  <c:v>6.4874999999999998</c:v>
                </c:pt>
                <c:pt idx="28">
                  <c:v>6.7378</c:v>
                </c:pt>
                <c:pt idx="29">
                  <c:v>6.9881000000000002</c:v>
                </c:pt>
                <c:pt idx="30">
                  <c:v>7.2382999999999997</c:v>
                </c:pt>
                <c:pt idx="31">
                  <c:v>7.4885999999999999</c:v>
                </c:pt>
                <c:pt idx="32">
                  <c:v>7.7389000000000001</c:v>
                </c:pt>
                <c:pt idx="33">
                  <c:v>7.9892000000000003</c:v>
                </c:pt>
                <c:pt idx="34">
                  <c:v>8.2393999999999998</c:v>
                </c:pt>
                <c:pt idx="35">
                  <c:v>8.4896999999999991</c:v>
                </c:pt>
                <c:pt idx="36">
                  <c:v>8.74</c:v>
                </c:pt>
                <c:pt idx="37">
                  <c:v>8.9902999999999995</c:v>
                </c:pt>
                <c:pt idx="38">
                  <c:v>9.2406000000000006</c:v>
                </c:pt>
                <c:pt idx="39">
                  <c:v>9.4908000000000001</c:v>
                </c:pt>
                <c:pt idx="40">
                  <c:v>9.7410999999999994</c:v>
                </c:pt>
                <c:pt idx="41">
                  <c:v>9.9914000000000005</c:v>
                </c:pt>
                <c:pt idx="42">
                  <c:v>10.2417</c:v>
                </c:pt>
                <c:pt idx="43">
                  <c:v>10.491899999999999</c:v>
                </c:pt>
                <c:pt idx="44">
                  <c:v>10.7422</c:v>
                </c:pt>
                <c:pt idx="45">
                  <c:v>10.9925</c:v>
                </c:pt>
                <c:pt idx="46">
                  <c:v>11.242800000000001</c:v>
                </c:pt>
                <c:pt idx="47">
                  <c:v>11.4931</c:v>
                </c:pt>
                <c:pt idx="48">
                  <c:v>11.7433</c:v>
                </c:pt>
                <c:pt idx="49">
                  <c:v>11.993600000000001</c:v>
                </c:pt>
                <c:pt idx="50">
                  <c:v>12.2439</c:v>
                </c:pt>
                <c:pt idx="51">
                  <c:v>12.494199999999999</c:v>
                </c:pt>
                <c:pt idx="52">
                  <c:v>12.744400000000001</c:v>
                </c:pt>
                <c:pt idx="53">
                  <c:v>12.9947</c:v>
                </c:pt>
                <c:pt idx="54">
                  <c:v>13.244999999999999</c:v>
                </c:pt>
                <c:pt idx="55">
                  <c:v>13.4953</c:v>
                </c:pt>
                <c:pt idx="56">
                  <c:v>13.7456</c:v>
                </c:pt>
                <c:pt idx="57">
                  <c:v>13.995799999999999</c:v>
                </c:pt>
                <c:pt idx="58">
                  <c:v>14.2461</c:v>
                </c:pt>
                <c:pt idx="59">
                  <c:v>14.4964</c:v>
                </c:pt>
                <c:pt idx="60">
                  <c:v>14.746700000000001</c:v>
                </c:pt>
                <c:pt idx="61">
                  <c:v>14.9969</c:v>
                </c:pt>
                <c:pt idx="62">
                  <c:v>15.247199999999999</c:v>
                </c:pt>
                <c:pt idx="63">
                  <c:v>15.4975</c:v>
                </c:pt>
                <c:pt idx="64">
                  <c:v>15.7478</c:v>
                </c:pt>
                <c:pt idx="65">
                  <c:v>15.998100000000001</c:v>
                </c:pt>
                <c:pt idx="66">
                  <c:v>16.2483</c:v>
                </c:pt>
                <c:pt idx="67">
                  <c:v>16.4986</c:v>
                </c:pt>
                <c:pt idx="68">
                  <c:v>16.748899999999999</c:v>
                </c:pt>
                <c:pt idx="69">
                  <c:v>16.999199999999998</c:v>
                </c:pt>
                <c:pt idx="70">
                  <c:v>17.249400000000001</c:v>
                </c:pt>
                <c:pt idx="71">
                  <c:v>17.499700000000001</c:v>
                </c:pt>
                <c:pt idx="72">
                  <c:v>17.749700000000001</c:v>
                </c:pt>
                <c:pt idx="73">
                  <c:v>18</c:v>
                </c:pt>
                <c:pt idx="74">
                  <c:v>18.250299999999999</c:v>
                </c:pt>
                <c:pt idx="75">
                  <c:v>18.500599999999999</c:v>
                </c:pt>
                <c:pt idx="76">
                  <c:v>18.750800000000002</c:v>
                </c:pt>
                <c:pt idx="77">
                  <c:v>19.001100000000001</c:v>
                </c:pt>
                <c:pt idx="78">
                  <c:v>19.2514</c:v>
                </c:pt>
                <c:pt idx="79">
                  <c:v>19.5017</c:v>
                </c:pt>
                <c:pt idx="80">
                  <c:v>19.751899999999999</c:v>
                </c:pt>
                <c:pt idx="81">
                  <c:v>20.002199999999998</c:v>
                </c:pt>
                <c:pt idx="82">
                  <c:v>20.252500000000001</c:v>
                </c:pt>
                <c:pt idx="83">
                  <c:v>20.502800000000001</c:v>
                </c:pt>
                <c:pt idx="84">
                  <c:v>20.7531</c:v>
                </c:pt>
                <c:pt idx="85">
                  <c:v>21.003299999999999</c:v>
                </c:pt>
                <c:pt idx="86">
                  <c:v>21.253599999999999</c:v>
                </c:pt>
                <c:pt idx="87">
                  <c:v>21.503900000000002</c:v>
                </c:pt>
                <c:pt idx="88">
                  <c:v>21.754200000000001</c:v>
                </c:pt>
                <c:pt idx="89">
                  <c:v>22.0044</c:v>
                </c:pt>
                <c:pt idx="90">
                  <c:v>22.2547</c:v>
                </c:pt>
                <c:pt idx="91">
                  <c:v>22.504999999999999</c:v>
                </c:pt>
                <c:pt idx="92">
                  <c:v>22.755299999999998</c:v>
                </c:pt>
                <c:pt idx="93">
                  <c:v>23.005600000000001</c:v>
                </c:pt>
                <c:pt idx="94">
                  <c:v>23.255800000000001</c:v>
                </c:pt>
                <c:pt idx="95">
                  <c:v>23.4819</c:v>
                </c:pt>
                <c:pt idx="96">
                  <c:v>23.732199999999999</c:v>
                </c:pt>
                <c:pt idx="97">
                  <c:v>23.982500000000002</c:v>
                </c:pt>
                <c:pt idx="98">
                  <c:v>24.232800000000001</c:v>
                </c:pt>
                <c:pt idx="99">
                  <c:v>24.4831</c:v>
                </c:pt>
                <c:pt idx="100">
                  <c:v>24.7333</c:v>
                </c:pt>
                <c:pt idx="101">
                  <c:v>24.983599999999999</c:v>
                </c:pt>
                <c:pt idx="102">
                  <c:v>25.233899999999998</c:v>
                </c:pt>
                <c:pt idx="103">
                  <c:v>25.484200000000001</c:v>
                </c:pt>
                <c:pt idx="104">
                  <c:v>25.734400000000001</c:v>
                </c:pt>
                <c:pt idx="105">
                  <c:v>25.9847</c:v>
                </c:pt>
                <c:pt idx="106">
                  <c:v>26.234999999999999</c:v>
                </c:pt>
                <c:pt idx="107">
                  <c:v>26.485299999999999</c:v>
                </c:pt>
                <c:pt idx="108">
                  <c:v>26.735600000000002</c:v>
                </c:pt>
                <c:pt idx="109">
                  <c:v>26.985800000000001</c:v>
                </c:pt>
                <c:pt idx="110">
                  <c:v>27.2361</c:v>
                </c:pt>
                <c:pt idx="111">
                  <c:v>27.4864</c:v>
                </c:pt>
                <c:pt idx="112">
                  <c:v>27.736699999999999</c:v>
                </c:pt>
                <c:pt idx="113">
                  <c:v>27.986899999999999</c:v>
                </c:pt>
                <c:pt idx="114">
                  <c:v>28.237200000000001</c:v>
                </c:pt>
                <c:pt idx="115">
                  <c:v>28.487500000000001</c:v>
                </c:pt>
                <c:pt idx="116">
                  <c:v>28.7378</c:v>
                </c:pt>
                <c:pt idx="117">
                  <c:v>28.988099999999999</c:v>
                </c:pt>
                <c:pt idx="118">
                  <c:v>29.238299999999999</c:v>
                </c:pt>
                <c:pt idx="119">
                  <c:v>29.488600000000002</c:v>
                </c:pt>
                <c:pt idx="120">
                  <c:v>29.738900000000001</c:v>
                </c:pt>
                <c:pt idx="121">
                  <c:v>29.9892</c:v>
                </c:pt>
                <c:pt idx="122">
                  <c:v>30.2394</c:v>
                </c:pt>
                <c:pt idx="123">
                  <c:v>30.489699999999999</c:v>
                </c:pt>
                <c:pt idx="124">
                  <c:v>30.74</c:v>
                </c:pt>
                <c:pt idx="125">
                  <c:v>30.990300000000001</c:v>
                </c:pt>
                <c:pt idx="126">
                  <c:v>31.240600000000001</c:v>
                </c:pt>
                <c:pt idx="127">
                  <c:v>31.4908</c:v>
                </c:pt>
                <c:pt idx="128">
                  <c:v>31.741099999999999</c:v>
                </c:pt>
                <c:pt idx="129">
                  <c:v>31.991399999999999</c:v>
                </c:pt>
                <c:pt idx="130">
                  <c:v>32.241700000000002</c:v>
                </c:pt>
                <c:pt idx="131">
                  <c:v>32.491900000000001</c:v>
                </c:pt>
                <c:pt idx="132">
                  <c:v>32.742199999999997</c:v>
                </c:pt>
                <c:pt idx="133">
                  <c:v>32.9925</c:v>
                </c:pt>
                <c:pt idx="134">
                  <c:v>33.242800000000003</c:v>
                </c:pt>
                <c:pt idx="135">
                  <c:v>33.493099999999998</c:v>
                </c:pt>
                <c:pt idx="136">
                  <c:v>33.743299999999998</c:v>
                </c:pt>
                <c:pt idx="137">
                  <c:v>33.993600000000001</c:v>
                </c:pt>
                <c:pt idx="138">
                  <c:v>34.243899999999996</c:v>
                </c:pt>
                <c:pt idx="139">
                  <c:v>34.494199999999999</c:v>
                </c:pt>
                <c:pt idx="140">
                  <c:v>34.744399999999999</c:v>
                </c:pt>
                <c:pt idx="141">
                  <c:v>34.994700000000002</c:v>
                </c:pt>
                <c:pt idx="142">
                  <c:v>35.244999999999997</c:v>
                </c:pt>
                <c:pt idx="143">
                  <c:v>35.4953</c:v>
                </c:pt>
                <c:pt idx="144">
                  <c:v>35.745600000000003</c:v>
                </c:pt>
                <c:pt idx="145">
                  <c:v>35.995800000000003</c:v>
                </c:pt>
                <c:pt idx="146">
                  <c:v>36.246099999999998</c:v>
                </c:pt>
                <c:pt idx="147">
                  <c:v>36.496400000000001</c:v>
                </c:pt>
                <c:pt idx="148">
                  <c:v>36.746699999999997</c:v>
                </c:pt>
                <c:pt idx="149">
                  <c:v>36.996899999999997</c:v>
                </c:pt>
                <c:pt idx="150">
                  <c:v>37.247199999999999</c:v>
                </c:pt>
                <c:pt idx="151">
                  <c:v>37.497500000000002</c:v>
                </c:pt>
                <c:pt idx="152">
                  <c:v>37.747799999999998</c:v>
                </c:pt>
                <c:pt idx="153">
                  <c:v>37.998100000000001</c:v>
                </c:pt>
                <c:pt idx="154">
                  <c:v>38.2483</c:v>
                </c:pt>
                <c:pt idx="155">
                  <c:v>38.498600000000003</c:v>
                </c:pt>
                <c:pt idx="156">
                  <c:v>38.748899999999999</c:v>
                </c:pt>
                <c:pt idx="157">
                  <c:v>38.999200000000002</c:v>
                </c:pt>
                <c:pt idx="158">
                  <c:v>39.249400000000001</c:v>
                </c:pt>
                <c:pt idx="159">
                  <c:v>39.499699999999997</c:v>
                </c:pt>
                <c:pt idx="160">
                  <c:v>39.75</c:v>
                </c:pt>
              </c:numCache>
            </c:numRef>
          </c:xVal>
          <c:yVal>
            <c:numRef>
              <c:f>WT4FN!$B$2:$B$174</c:f>
              <c:numCache>
                <c:formatCode>General</c:formatCode>
                <c:ptCount val="173"/>
                <c:pt idx="0">
                  <c:v>1</c:v>
                </c:pt>
                <c:pt idx="1">
                  <c:v>1.0013000000000001</c:v>
                </c:pt>
                <c:pt idx="2">
                  <c:v>1.0026999999999999</c:v>
                </c:pt>
                <c:pt idx="3">
                  <c:v>1.0046999999999999</c:v>
                </c:pt>
                <c:pt idx="4">
                  <c:v>1.0075000000000001</c:v>
                </c:pt>
                <c:pt idx="5">
                  <c:v>1.01</c:v>
                </c:pt>
                <c:pt idx="6">
                  <c:v>1.014</c:v>
                </c:pt>
                <c:pt idx="7">
                  <c:v>1.0173000000000001</c:v>
                </c:pt>
                <c:pt idx="8">
                  <c:v>1.0204</c:v>
                </c:pt>
                <c:pt idx="9">
                  <c:v>1.0245</c:v>
                </c:pt>
                <c:pt idx="10">
                  <c:v>1.0282</c:v>
                </c:pt>
                <c:pt idx="11">
                  <c:v>1.0286999999999999</c:v>
                </c:pt>
                <c:pt idx="12">
                  <c:v>1.0327</c:v>
                </c:pt>
                <c:pt idx="13">
                  <c:v>1.0341</c:v>
                </c:pt>
                <c:pt idx="14">
                  <c:v>1.0363</c:v>
                </c:pt>
                <c:pt idx="15">
                  <c:v>1.0383</c:v>
                </c:pt>
                <c:pt idx="16">
                  <c:v>1.0421</c:v>
                </c:pt>
                <c:pt idx="17">
                  <c:v>1.0445</c:v>
                </c:pt>
                <c:pt idx="18">
                  <c:v>1.0479000000000001</c:v>
                </c:pt>
                <c:pt idx="19">
                  <c:v>1.0489999999999999</c:v>
                </c:pt>
                <c:pt idx="20">
                  <c:v>1.0519000000000001</c:v>
                </c:pt>
                <c:pt idx="21">
                  <c:v>1.0536000000000001</c:v>
                </c:pt>
                <c:pt idx="22">
                  <c:v>1.0568</c:v>
                </c:pt>
                <c:pt idx="23">
                  <c:v>1.0596000000000001</c:v>
                </c:pt>
                <c:pt idx="24">
                  <c:v>1.0619000000000001</c:v>
                </c:pt>
                <c:pt idx="25">
                  <c:v>1.0629999999999999</c:v>
                </c:pt>
                <c:pt idx="26">
                  <c:v>1.0659000000000001</c:v>
                </c:pt>
                <c:pt idx="27">
                  <c:v>1.0676000000000001</c:v>
                </c:pt>
                <c:pt idx="28">
                  <c:v>1.071</c:v>
                </c:pt>
                <c:pt idx="29">
                  <c:v>1.0741000000000001</c:v>
                </c:pt>
                <c:pt idx="30">
                  <c:v>1.0764</c:v>
                </c:pt>
                <c:pt idx="31">
                  <c:v>1.0793999999999999</c:v>
                </c:pt>
                <c:pt idx="32">
                  <c:v>1.0823</c:v>
                </c:pt>
                <c:pt idx="33">
                  <c:v>1.0834999999999999</c:v>
                </c:pt>
                <c:pt idx="34">
                  <c:v>1.0852999999999999</c:v>
                </c:pt>
                <c:pt idx="35">
                  <c:v>1.0876999999999999</c:v>
                </c:pt>
                <c:pt idx="36">
                  <c:v>1.0885</c:v>
                </c:pt>
                <c:pt idx="37">
                  <c:v>1.0901000000000001</c:v>
                </c:pt>
                <c:pt idx="38">
                  <c:v>1.0926</c:v>
                </c:pt>
                <c:pt idx="39">
                  <c:v>1.0949</c:v>
                </c:pt>
                <c:pt idx="40">
                  <c:v>1.0948</c:v>
                </c:pt>
                <c:pt idx="41">
                  <c:v>1.0972999999999999</c:v>
                </c:pt>
                <c:pt idx="42">
                  <c:v>1.1005</c:v>
                </c:pt>
                <c:pt idx="43">
                  <c:v>1.1012</c:v>
                </c:pt>
                <c:pt idx="44">
                  <c:v>1.1046</c:v>
                </c:pt>
                <c:pt idx="45">
                  <c:v>1.1055999999999999</c:v>
                </c:pt>
                <c:pt idx="46">
                  <c:v>1.1081000000000001</c:v>
                </c:pt>
                <c:pt idx="47">
                  <c:v>1.1117999999999999</c:v>
                </c:pt>
                <c:pt idx="48">
                  <c:v>1.1136999999999999</c:v>
                </c:pt>
                <c:pt idx="49">
                  <c:v>1.1152</c:v>
                </c:pt>
                <c:pt idx="50">
                  <c:v>1.1169</c:v>
                </c:pt>
                <c:pt idx="51">
                  <c:v>1.1193</c:v>
                </c:pt>
                <c:pt idx="52">
                  <c:v>1.1203000000000001</c:v>
                </c:pt>
                <c:pt idx="53">
                  <c:v>1.1226</c:v>
                </c:pt>
                <c:pt idx="54">
                  <c:v>1.1253</c:v>
                </c:pt>
                <c:pt idx="55">
                  <c:v>1.1283000000000001</c:v>
                </c:pt>
                <c:pt idx="56">
                  <c:v>1.1311</c:v>
                </c:pt>
                <c:pt idx="57">
                  <c:v>1.1316999999999999</c:v>
                </c:pt>
                <c:pt idx="58">
                  <c:v>1.1354</c:v>
                </c:pt>
                <c:pt idx="59">
                  <c:v>1.1377999999999999</c:v>
                </c:pt>
                <c:pt idx="60">
                  <c:v>1.1402000000000001</c:v>
                </c:pt>
                <c:pt idx="61">
                  <c:v>1.1444000000000001</c:v>
                </c:pt>
                <c:pt idx="62">
                  <c:v>1.1473</c:v>
                </c:pt>
                <c:pt idx="63">
                  <c:v>1.1500999999999999</c:v>
                </c:pt>
                <c:pt idx="64">
                  <c:v>1.1514</c:v>
                </c:pt>
                <c:pt idx="65">
                  <c:v>1.1548</c:v>
                </c:pt>
                <c:pt idx="66">
                  <c:v>1.1589</c:v>
                </c:pt>
                <c:pt idx="67">
                  <c:v>1.1621999999999999</c:v>
                </c:pt>
                <c:pt idx="68">
                  <c:v>1.1672</c:v>
                </c:pt>
                <c:pt idx="69">
                  <c:v>1.1693</c:v>
                </c:pt>
                <c:pt idx="70">
                  <c:v>1.1734</c:v>
                </c:pt>
                <c:pt idx="71">
                  <c:v>1.1763999999999999</c:v>
                </c:pt>
                <c:pt idx="72">
                  <c:v>1.1811</c:v>
                </c:pt>
                <c:pt idx="73">
                  <c:v>1.1835</c:v>
                </c:pt>
                <c:pt idx="74">
                  <c:v>1.1863999999999999</c:v>
                </c:pt>
                <c:pt idx="75">
                  <c:v>1.1898</c:v>
                </c:pt>
                <c:pt idx="76">
                  <c:v>1.1919</c:v>
                </c:pt>
                <c:pt idx="77">
                  <c:v>1.1955</c:v>
                </c:pt>
                <c:pt idx="78">
                  <c:v>1.1977</c:v>
                </c:pt>
                <c:pt idx="79">
                  <c:v>1.2018</c:v>
                </c:pt>
                <c:pt idx="80">
                  <c:v>1.2043999999999999</c:v>
                </c:pt>
                <c:pt idx="81">
                  <c:v>1.206</c:v>
                </c:pt>
                <c:pt idx="82">
                  <c:v>1.2091000000000001</c:v>
                </c:pt>
                <c:pt idx="83">
                  <c:v>1.2130000000000001</c:v>
                </c:pt>
                <c:pt idx="84">
                  <c:v>1.2146999999999999</c:v>
                </c:pt>
                <c:pt idx="85">
                  <c:v>1.2159</c:v>
                </c:pt>
                <c:pt idx="86">
                  <c:v>1.2204999999999999</c:v>
                </c:pt>
                <c:pt idx="87">
                  <c:v>1.2255</c:v>
                </c:pt>
                <c:pt idx="88">
                  <c:v>1.2275</c:v>
                </c:pt>
                <c:pt idx="89">
                  <c:v>1.2345999999999999</c:v>
                </c:pt>
                <c:pt idx="90">
                  <c:v>1.2385999999999999</c:v>
                </c:pt>
                <c:pt idx="91">
                  <c:v>1.2413000000000001</c:v>
                </c:pt>
                <c:pt idx="92">
                  <c:v>1.2426999999999999</c:v>
                </c:pt>
                <c:pt idx="93">
                  <c:v>1.2445999999999999</c:v>
                </c:pt>
                <c:pt idx="94">
                  <c:v>1.2481</c:v>
                </c:pt>
                <c:pt idx="95">
                  <c:v>1.2484999999999999</c:v>
                </c:pt>
                <c:pt idx="96">
                  <c:v>1.2513000000000001</c:v>
                </c:pt>
                <c:pt idx="97">
                  <c:v>1.2557</c:v>
                </c:pt>
                <c:pt idx="98">
                  <c:v>1.2566999999999999</c:v>
                </c:pt>
                <c:pt idx="99">
                  <c:v>1.2611000000000001</c:v>
                </c:pt>
                <c:pt idx="100">
                  <c:v>1.2666999999999999</c:v>
                </c:pt>
                <c:pt idx="101">
                  <c:v>1.2705</c:v>
                </c:pt>
                <c:pt idx="102">
                  <c:v>1.272</c:v>
                </c:pt>
                <c:pt idx="103">
                  <c:v>1.2768999999999999</c:v>
                </c:pt>
                <c:pt idx="104">
                  <c:v>1.2817000000000001</c:v>
                </c:pt>
                <c:pt idx="105">
                  <c:v>1.2881</c:v>
                </c:pt>
                <c:pt idx="106">
                  <c:v>1.2901</c:v>
                </c:pt>
                <c:pt idx="107">
                  <c:v>1.2946</c:v>
                </c:pt>
                <c:pt idx="108">
                  <c:v>1.3005</c:v>
                </c:pt>
                <c:pt idx="109">
                  <c:v>1.3051999999999999</c:v>
                </c:pt>
                <c:pt idx="110">
                  <c:v>1.3106</c:v>
                </c:pt>
                <c:pt idx="111">
                  <c:v>1.3206</c:v>
                </c:pt>
                <c:pt idx="112">
                  <c:v>1.3278000000000001</c:v>
                </c:pt>
                <c:pt idx="113">
                  <c:v>1.3363</c:v>
                </c:pt>
                <c:pt idx="114">
                  <c:v>1.3440000000000001</c:v>
                </c:pt>
                <c:pt idx="115">
                  <c:v>1.3496999999999999</c:v>
                </c:pt>
                <c:pt idx="116">
                  <c:v>1.3551</c:v>
                </c:pt>
                <c:pt idx="117">
                  <c:v>1.3638999999999999</c:v>
                </c:pt>
                <c:pt idx="118">
                  <c:v>1.3718999999999999</c:v>
                </c:pt>
                <c:pt idx="119">
                  <c:v>1.3816999999999999</c:v>
                </c:pt>
                <c:pt idx="120">
                  <c:v>1.3935999999999999</c:v>
                </c:pt>
                <c:pt idx="121">
                  <c:v>1.3993</c:v>
                </c:pt>
                <c:pt idx="122">
                  <c:v>1.4065000000000001</c:v>
                </c:pt>
                <c:pt idx="123">
                  <c:v>1.4189000000000001</c:v>
                </c:pt>
                <c:pt idx="124">
                  <c:v>1.4253</c:v>
                </c:pt>
                <c:pt idx="125">
                  <c:v>1.4321999999999999</c:v>
                </c:pt>
                <c:pt idx="126">
                  <c:v>1.4449000000000001</c:v>
                </c:pt>
                <c:pt idx="127">
                  <c:v>1.4560999999999999</c:v>
                </c:pt>
                <c:pt idx="128">
                  <c:v>1.4656</c:v>
                </c:pt>
                <c:pt idx="129">
                  <c:v>1.4725999999999999</c:v>
                </c:pt>
                <c:pt idx="130">
                  <c:v>1.4811000000000001</c:v>
                </c:pt>
                <c:pt idx="131">
                  <c:v>1.4904999999999999</c:v>
                </c:pt>
                <c:pt idx="132">
                  <c:v>1.5023</c:v>
                </c:pt>
                <c:pt idx="133">
                  <c:v>1.5105999999999999</c:v>
                </c:pt>
                <c:pt idx="134">
                  <c:v>1.5194000000000001</c:v>
                </c:pt>
                <c:pt idx="135">
                  <c:v>1.5304</c:v>
                </c:pt>
                <c:pt idx="136">
                  <c:v>1.5410999999999999</c:v>
                </c:pt>
                <c:pt idx="137">
                  <c:v>1.552</c:v>
                </c:pt>
                <c:pt idx="138">
                  <c:v>1.5597000000000001</c:v>
                </c:pt>
                <c:pt idx="139">
                  <c:v>1.5673999999999999</c:v>
                </c:pt>
                <c:pt idx="140">
                  <c:v>1.5769</c:v>
                </c:pt>
                <c:pt idx="141">
                  <c:v>1.5866</c:v>
                </c:pt>
                <c:pt idx="142">
                  <c:v>1.5952999999999999</c:v>
                </c:pt>
                <c:pt idx="143">
                  <c:v>1.6075999999999999</c:v>
                </c:pt>
                <c:pt idx="144">
                  <c:v>1.6212</c:v>
                </c:pt>
                <c:pt idx="145">
                  <c:v>1.6286</c:v>
                </c:pt>
                <c:pt idx="146">
                  <c:v>1.6356999999999999</c:v>
                </c:pt>
                <c:pt idx="147">
                  <c:v>1.6433</c:v>
                </c:pt>
                <c:pt idx="148">
                  <c:v>1.6560999999999999</c:v>
                </c:pt>
                <c:pt idx="149">
                  <c:v>1.6640999999999999</c:v>
                </c:pt>
                <c:pt idx="150">
                  <c:v>1.6736</c:v>
                </c:pt>
                <c:pt idx="151">
                  <c:v>1.6839</c:v>
                </c:pt>
                <c:pt idx="152">
                  <c:v>1.6934</c:v>
                </c:pt>
                <c:pt idx="153">
                  <c:v>1.7040999999999999</c:v>
                </c:pt>
                <c:pt idx="154">
                  <c:v>1.7121</c:v>
                </c:pt>
                <c:pt idx="155">
                  <c:v>1.7229000000000001</c:v>
                </c:pt>
                <c:pt idx="156">
                  <c:v>1.7274</c:v>
                </c:pt>
                <c:pt idx="157">
                  <c:v>1.7374000000000001</c:v>
                </c:pt>
                <c:pt idx="158">
                  <c:v>1.7477</c:v>
                </c:pt>
                <c:pt idx="159">
                  <c:v>1.7582</c:v>
                </c:pt>
                <c:pt idx="160">
                  <c:v>1.766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WT4FN!$C$1</c:f>
              <c:strCache>
                <c:ptCount val="1"/>
                <c:pt idx="0">
                  <c:v>WT4 Dox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WT4FN!$E$2:$E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1.5E-3</c:v>
                  </c:pt>
                  <c:pt idx="2">
                    <c:v>2.7000000000000001E-3</c:v>
                  </c:pt>
                  <c:pt idx="3">
                    <c:v>1.5E-3</c:v>
                  </c:pt>
                  <c:pt idx="4">
                    <c:v>3.0000000000000001E-3</c:v>
                  </c:pt>
                  <c:pt idx="5">
                    <c:v>4.4000000000000003E-3</c:v>
                  </c:pt>
                  <c:pt idx="6">
                    <c:v>4.3E-3</c:v>
                  </c:pt>
                  <c:pt idx="7">
                    <c:v>3.0000000000000001E-3</c:v>
                  </c:pt>
                  <c:pt idx="8">
                    <c:v>2.5999999999999999E-3</c:v>
                  </c:pt>
                  <c:pt idx="9">
                    <c:v>4.7000000000000002E-3</c:v>
                  </c:pt>
                  <c:pt idx="10">
                    <c:v>2.0999999999999999E-3</c:v>
                  </c:pt>
                  <c:pt idx="11">
                    <c:v>3.3999999999999998E-3</c:v>
                  </c:pt>
                  <c:pt idx="12">
                    <c:v>5.1000000000000004E-3</c:v>
                  </c:pt>
                  <c:pt idx="13">
                    <c:v>4.8999999999999998E-3</c:v>
                  </c:pt>
                  <c:pt idx="14">
                    <c:v>3.0999999999999999E-3</c:v>
                  </c:pt>
                  <c:pt idx="15">
                    <c:v>4.0000000000000001E-3</c:v>
                  </c:pt>
                  <c:pt idx="16">
                    <c:v>4.1000000000000003E-3</c:v>
                  </c:pt>
                  <c:pt idx="17">
                    <c:v>3.7000000000000002E-3</c:v>
                  </c:pt>
                  <c:pt idx="18">
                    <c:v>2.2000000000000001E-3</c:v>
                  </c:pt>
                  <c:pt idx="19">
                    <c:v>2E-3</c:v>
                  </c:pt>
                  <c:pt idx="20">
                    <c:v>2E-3</c:v>
                  </c:pt>
                  <c:pt idx="21">
                    <c:v>0</c:v>
                  </c:pt>
                  <c:pt idx="22">
                    <c:v>1E-3</c:v>
                  </c:pt>
                  <c:pt idx="23">
                    <c:v>4.7000000000000002E-3</c:v>
                  </c:pt>
                  <c:pt idx="24">
                    <c:v>7.7000000000000002E-3</c:v>
                  </c:pt>
                  <c:pt idx="25">
                    <c:v>6.4000000000000003E-3</c:v>
                  </c:pt>
                  <c:pt idx="26">
                    <c:v>6.4999999999999997E-3</c:v>
                  </c:pt>
                  <c:pt idx="27">
                    <c:v>5.5999999999999999E-3</c:v>
                  </c:pt>
                  <c:pt idx="28">
                    <c:v>5.7000000000000002E-3</c:v>
                  </c:pt>
                  <c:pt idx="29">
                    <c:v>6.3E-3</c:v>
                  </c:pt>
                  <c:pt idx="30">
                    <c:v>5.5999999999999999E-3</c:v>
                  </c:pt>
                  <c:pt idx="31">
                    <c:v>6.1000000000000004E-3</c:v>
                  </c:pt>
                  <c:pt idx="32">
                    <c:v>7.1000000000000004E-3</c:v>
                  </c:pt>
                  <c:pt idx="33">
                    <c:v>8.2000000000000007E-3</c:v>
                  </c:pt>
                  <c:pt idx="34">
                    <c:v>5.7000000000000002E-3</c:v>
                  </c:pt>
                  <c:pt idx="35">
                    <c:v>8.9999999999999993E-3</c:v>
                  </c:pt>
                  <c:pt idx="36">
                    <c:v>7.0000000000000001E-3</c:v>
                  </c:pt>
                  <c:pt idx="37">
                    <c:v>8.0000000000000002E-3</c:v>
                  </c:pt>
                  <c:pt idx="38">
                    <c:v>6.8999999999999999E-3</c:v>
                  </c:pt>
                  <c:pt idx="39">
                    <c:v>7.7999999999999996E-3</c:v>
                  </c:pt>
                  <c:pt idx="40">
                    <c:v>5.7999999999999996E-3</c:v>
                  </c:pt>
                  <c:pt idx="41">
                    <c:v>6.7999999999999996E-3</c:v>
                  </c:pt>
                  <c:pt idx="42">
                    <c:v>5.3E-3</c:v>
                  </c:pt>
                  <c:pt idx="43">
                    <c:v>4.1000000000000003E-3</c:v>
                  </c:pt>
                  <c:pt idx="44">
                    <c:v>4.7999999999999996E-3</c:v>
                  </c:pt>
                  <c:pt idx="45">
                    <c:v>5.8999999999999999E-3</c:v>
                  </c:pt>
                  <c:pt idx="46">
                    <c:v>3.5000000000000001E-3</c:v>
                  </c:pt>
                  <c:pt idx="47">
                    <c:v>3.8999999999999998E-3</c:v>
                  </c:pt>
                  <c:pt idx="48">
                    <c:v>1E-3</c:v>
                  </c:pt>
                  <c:pt idx="49">
                    <c:v>2.0000000000000001E-4</c:v>
                  </c:pt>
                  <c:pt idx="50">
                    <c:v>1.4E-3</c:v>
                  </c:pt>
                  <c:pt idx="51">
                    <c:v>3.5000000000000001E-3</c:v>
                  </c:pt>
                  <c:pt idx="52">
                    <c:v>4.7999999999999996E-3</c:v>
                  </c:pt>
                  <c:pt idx="53">
                    <c:v>1E-4</c:v>
                  </c:pt>
                  <c:pt idx="54">
                    <c:v>8.0000000000000004E-4</c:v>
                  </c:pt>
                  <c:pt idx="55">
                    <c:v>1.4E-3</c:v>
                  </c:pt>
                  <c:pt idx="56">
                    <c:v>1.6000000000000001E-3</c:v>
                  </c:pt>
                  <c:pt idx="57">
                    <c:v>2.3999999999999998E-3</c:v>
                  </c:pt>
                  <c:pt idx="58">
                    <c:v>6.9999999999999999E-4</c:v>
                  </c:pt>
                  <c:pt idx="59">
                    <c:v>2.5000000000000001E-3</c:v>
                  </c:pt>
                  <c:pt idx="60">
                    <c:v>3.2000000000000002E-3</c:v>
                  </c:pt>
                  <c:pt idx="61">
                    <c:v>1.5E-3</c:v>
                  </c:pt>
                  <c:pt idx="62">
                    <c:v>4.4999999999999997E-3</c:v>
                  </c:pt>
                  <c:pt idx="63">
                    <c:v>2.8999999999999998E-3</c:v>
                  </c:pt>
                  <c:pt idx="64">
                    <c:v>2E-3</c:v>
                  </c:pt>
                  <c:pt idx="65">
                    <c:v>1E-3</c:v>
                  </c:pt>
                  <c:pt idx="66">
                    <c:v>3.0000000000000001E-3</c:v>
                  </c:pt>
                  <c:pt idx="67">
                    <c:v>4.5999999999999999E-3</c:v>
                  </c:pt>
                  <c:pt idx="68">
                    <c:v>4.7000000000000002E-3</c:v>
                  </c:pt>
                  <c:pt idx="69">
                    <c:v>1.1000000000000001E-3</c:v>
                  </c:pt>
                  <c:pt idx="70">
                    <c:v>5.0000000000000001E-4</c:v>
                  </c:pt>
                  <c:pt idx="71">
                    <c:v>5.0000000000000001E-4</c:v>
                  </c:pt>
                  <c:pt idx="72">
                    <c:v>3.3999999999999998E-3</c:v>
                  </c:pt>
                  <c:pt idx="73">
                    <c:v>1.6000000000000001E-3</c:v>
                  </c:pt>
                  <c:pt idx="74">
                    <c:v>1.1000000000000001E-3</c:v>
                  </c:pt>
                  <c:pt idx="75">
                    <c:v>2.9999999999999997E-4</c:v>
                  </c:pt>
                  <c:pt idx="76">
                    <c:v>1.6000000000000001E-3</c:v>
                  </c:pt>
                  <c:pt idx="77">
                    <c:v>1.2999999999999999E-3</c:v>
                  </c:pt>
                  <c:pt idx="78">
                    <c:v>4.3E-3</c:v>
                  </c:pt>
                  <c:pt idx="79">
                    <c:v>5.0000000000000001E-4</c:v>
                  </c:pt>
                  <c:pt idx="80">
                    <c:v>1.1999999999999999E-3</c:v>
                  </c:pt>
                  <c:pt idx="81">
                    <c:v>1.1000000000000001E-3</c:v>
                  </c:pt>
                  <c:pt idx="82">
                    <c:v>1.4E-3</c:v>
                  </c:pt>
                  <c:pt idx="83">
                    <c:v>6.9999999999999999E-4</c:v>
                  </c:pt>
                  <c:pt idx="84">
                    <c:v>2.3E-3</c:v>
                  </c:pt>
                  <c:pt idx="85">
                    <c:v>1.6999999999999999E-3</c:v>
                  </c:pt>
                  <c:pt idx="86">
                    <c:v>2E-3</c:v>
                  </c:pt>
                  <c:pt idx="87">
                    <c:v>3.3999999999999998E-3</c:v>
                  </c:pt>
                  <c:pt idx="88">
                    <c:v>1.9E-3</c:v>
                  </c:pt>
                  <c:pt idx="89">
                    <c:v>2.2000000000000001E-3</c:v>
                  </c:pt>
                  <c:pt idx="90">
                    <c:v>1.9E-3</c:v>
                  </c:pt>
                  <c:pt idx="91">
                    <c:v>3.0999999999999999E-3</c:v>
                  </c:pt>
                  <c:pt idx="92">
                    <c:v>2.8E-3</c:v>
                  </c:pt>
                  <c:pt idx="93">
                    <c:v>2.0000000000000001E-4</c:v>
                  </c:pt>
                  <c:pt idx="94">
                    <c:v>3.0000000000000001E-3</c:v>
                  </c:pt>
                  <c:pt idx="95">
                    <c:v>7.1999999999999998E-3</c:v>
                  </c:pt>
                  <c:pt idx="96">
                    <c:v>7.7000000000000002E-3</c:v>
                  </c:pt>
                  <c:pt idx="97">
                    <c:v>1.4200000000000001E-2</c:v>
                  </c:pt>
                  <c:pt idx="98">
                    <c:v>1.24E-2</c:v>
                  </c:pt>
                  <c:pt idx="99">
                    <c:v>1.29E-2</c:v>
                  </c:pt>
                  <c:pt idx="100">
                    <c:v>1.4E-2</c:v>
                  </c:pt>
                  <c:pt idx="101">
                    <c:v>1.3299999999999999E-2</c:v>
                  </c:pt>
                  <c:pt idx="102">
                    <c:v>1.3599999999999999E-2</c:v>
                  </c:pt>
                  <c:pt idx="103">
                    <c:v>1.35E-2</c:v>
                  </c:pt>
                  <c:pt idx="104">
                    <c:v>1.18E-2</c:v>
                  </c:pt>
                  <c:pt idx="105">
                    <c:v>1.7100000000000001E-2</c:v>
                  </c:pt>
                  <c:pt idx="106">
                    <c:v>1.5299999999999999E-2</c:v>
                  </c:pt>
                  <c:pt idx="107">
                    <c:v>1.35E-2</c:v>
                  </c:pt>
                  <c:pt idx="108">
                    <c:v>1.18E-2</c:v>
                  </c:pt>
                  <c:pt idx="109">
                    <c:v>1.5299999999999999E-2</c:v>
                  </c:pt>
                  <c:pt idx="110">
                    <c:v>1.61E-2</c:v>
                  </c:pt>
                  <c:pt idx="111">
                    <c:v>1.9599999999999999E-2</c:v>
                  </c:pt>
                  <c:pt idx="112">
                    <c:v>2.3199999999999998E-2</c:v>
                  </c:pt>
                  <c:pt idx="113">
                    <c:v>2.5499999999999998E-2</c:v>
                  </c:pt>
                  <c:pt idx="114">
                    <c:v>2.5700000000000001E-2</c:v>
                  </c:pt>
                  <c:pt idx="115">
                    <c:v>2.9600000000000001E-2</c:v>
                  </c:pt>
                  <c:pt idx="116">
                    <c:v>2.6700000000000002E-2</c:v>
                  </c:pt>
                  <c:pt idx="117">
                    <c:v>2.6499999999999999E-2</c:v>
                  </c:pt>
                  <c:pt idx="118">
                    <c:v>3.0800000000000001E-2</c:v>
                  </c:pt>
                  <c:pt idx="119">
                    <c:v>3.4200000000000001E-2</c:v>
                  </c:pt>
                  <c:pt idx="120">
                    <c:v>3.6499999999999998E-2</c:v>
                  </c:pt>
                  <c:pt idx="121">
                    <c:v>3.7100000000000001E-2</c:v>
                  </c:pt>
                  <c:pt idx="122">
                    <c:v>3.8699999999999998E-2</c:v>
                  </c:pt>
                  <c:pt idx="123">
                    <c:v>4.41E-2</c:v>
                  </c:pt>
                  <c:pt idx="124">
                    <c:v>4.4999999999999998E-2</c:v>
                  </c:pt>
                  <c:pt idx="125">
                    <c:v>4.48E-2</c:v>
                  </c:pt>
                  <c:pt idx="126">
                    <c:v>4.8000000000000001E-2</c:v>
                  </c:pt>
                  <c:pt idx="127">
                    <c:v>4.9799999999999997E-2</c:v>
                  </c:pt>
                  <c:pt idx="128">
                    <c:v>4.8800000000000003E-2</c:v>
                  </c:pt>
                  <c:pt idx="129">
                    <c:v>5.0700000000000002E-2</c:v>
                  </c:pt>
                  <c:pt idx="130">
                    <c:v>5.57E-2</c:v>
                  </c:pt>
                  <c:pt idx="131">
                    <c:v>5.3900000000000003E-2</c:v>
                  </c:pt>
                  <c:pt idx="132">
                    <c:v>5.4699999999999999E-2</c:v>
                  </c:pt>
                  <c:pt idx="133">
                    <c:v>5.6099999999999997E-2</c:v>
                  </c:pt>
                  <c:pt idx="134">
                    <c:v>5.9900000000000002E-2</c:v>
                  </c:pt>
                  <c:pt idx="135">
                    <c:v>5.8400000000000001E-2</c:v>
                  </c:pt>
                  <c:pt idx="136">
                    <c:v>6.1800000000000001E-2</c:v>
                  </c:pt>
                  <c:pt idx="137">
                    <c:v>5.7599999999999998E-2</c:v>
                  </c:pt>
                  <c:pt idx="138">
                    <c:v>6.2300000000000001E-2</c:v>
                  </c:pt>
                  <c:pt idx="139">
                    <c:v>5.9499999999999997E-2</c:v>
                  </c:pt>
                  <c:pt idx="140">
                    <c:v>6.5199999999999994E-2</c:v>
                  </c:pt>
                  <c:pt idx="141">
                    <c:v>6.6799999999999998E-2</c:v>
                  </c:pt>
                  <c:pt idx="142">
                    <c:v>7.0699999999999999E-2</c:v>
                  </c:pt>
                  <c:pt idx="143">
                    <c:v>6.7199999999999996E-2</c:v>
                  </c:pt>
                  <c:pt idx="144">
                    <c:v>6.8599999999999994E-2</c:v>
                  </c:pt>
                  <c:pt idx="145">
                    <c:v>7.3300000000000004E-2</c:v>
                  </c:pt>
                  <c:pt idx="146">
                    <c:v>7.3800000000000004E-2</c:v>
                  </c:pt>
                  <c:pt idx="147">
                    <c:v>7.1999999999999995E-2</c:v>
                  </c:pt>
                  <c:pt idx="148">
                    <c:v>7.6600000000000001E-2</c:v>
                  </c:pt>
                  <c:pt idx="149">
                    <c:v>8.0100000000000005E-2</c:v>
                  </c:pt>
                  <c:pt idx="150">
                    <c:v>8.0699999999999994E-2</c:v>
                  </c:pt>
                  <c:pt idx="151">
                    <c:v>8.4900000000000003E-2</c:v>
                  </c:pt>
                  <c:pt idx="152">
                    <c:v>8.5199999999999998E-2</c:v>
                  </c:pt>
                  <c:pt idx="153">
                    <c:v>8.7300000000000003E-2</c:v>
                  </c:pt>
                  <c:pt idx="154">
                    <c:v>8.9800000000000005E-2</c:v>
                  </c:pt>
                  <c:pt idx="155">
                    <c:v>9.35E-2</c:v>
                  </c:pt>
                  <c:pt idx="156">
                    <c:v>8.6499999999999994E-2</c:v>
                  </c:pt>
                  <c:pt idx="157">
                    <c:v>8.8400000000000006E-2</c:v>
                  </c:pt>
                  <c:pt idx="158">
                    <c:v>8.8499999999999995E-2</c:v>
                  </c:pt>
                  <c:pt idx="159">
                    <c:v>8.9499999999999996E-2</c:v>
                  </c:pt>
                  <c:pt idx="160">
                    <c:v>8.2299999999999998E-2</c:v>
                  </c:pt>
                </c:numCache>
              </c:numRef>
            </c:plus>
            <c:minus>
              <c:numRef>
                <c:f>WT4FN!$E$2:$E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1.5E-3</c:v>
                  </c:pt>
                  <c:pt idx="2">
                    <c:v>2.7000000000000001E-3</c:v>
                  </c:pt>
                  <c:pt idx="3">
                    <c:v>1.5E-3</c:v>
                  </c:pt>
                  <c:pt idx="4">
                    <c:v>3.0000000000000001E-3</c:v>
                  </c:pt>
                  <c:pt idx="5">
                    <c:v>4.4000000000000003E-3</c:v>
                  </c:pt>
                  <c:pt idx="6">
                    <c:v>4.3E-3</c:v>
                  </c:pt>
                  <c:pt idx="7">
                    <c:v>3.0000000000000001E-3</c:v>
                  </c:pt>
                  <c:pt idx="8">
                    <c:v>2.5999999999999999E-3</c:v>
                  </c:pt>
                  <c:pt idx="9">
                    <c:v>4.7000000000000002E-3</c:v>
                  </c:pt>
                  <c:pt idx="10">
                    <c:v>2.0999999999999999E-3</c:v>
                  </c:pt>
                  <c:pt idx="11">
                    <c:v>3.3999999999999998E-3</c:v>
                  </c:pt>
                  <c:pt idx="12">
                    <c:v>5.1000000000000004E-3</c:v>
                  </c:pt>
                  <c:pt idx="13">
                    <c:v>4.8999999999999998E-3</c:v>
                  </c:pt>
                  <c:pt idx="14">
                    <c:v>3.0999999999999999E-3</c:v>
                  </c:pt>
                  <c:pt idx="15">
                    <c:v>4.0000000000000001E-3</c:v>
                  </c:pt>
                  <c:pt idx="16">
                    <c:v>4.1000000000000003E-3</c:v>
                  </c:pt>
                  <c:pt idx="17">
                    <c:v>3.7000000000000002E-3</c:v>
                  </c:pt>
                  <c:pt idx="18">
                    <c:v>2.2000000000000001E-3</c:v>
                  </c:pt>
                  <c:pt idx="19">
                    <c:v>2E-3</c:v>
                  </c:pt>
                  <c:pt idx="20">
                    <c:v>2E-3</c:v>
                  </c:pt>
                  <c:pt idx="21">
                    <c:v>0</c:v>
                  </c:pt>
                  <c:pt idx="22">
                    <c:v>1E-3</c:v>
                  </c:pt>
                  <c:pt idx="23">
                    <c:v>4.7000000000000002E-3</c:v>
                  </c:pt>
                  <c:pt idx="24">
                    <c:v>7.7000000000000002E-3</c:v>
                  </c:pt>
                  <c:pt idx="25">
                    <c:v>6.4000000000000003E-3</c:v>
                  </c:pt>
                  <c:pt idx="26">
                    <c:v>6.4999999999999997E-3</c:v>
                  </c:pt>
                  <c:pt idx="27">
                    <c:v>5.5999999999999999E-3</c:v>
                  </c:pt>
                  <c:pt idx="28">
                    <c:v>5.7000000000000002E-3</c:v>
                  </c:pt>
                  <c:pt idx="29">
                    <c:v>6.3E-3</c:v>
                  </c:pt>
                  <c:pt idx="30">
                    <c:v>5.5999999999999999E-3</c:v>
                  </c:pt>
                  <c:pt idx="31">
                    <c:v>6.1000000000000004E-3</c:v>
                  </c:pt>
                  <c:pt idx="32">
                    <c:v>7.1000000000000004E-3</c:v>
                  </c:pt>
                  <c:pt idx="33">
                    <c:v>8.2000000000000007E-3</c:v>
                  </c:pt>
                  <c:pt idx="34">
                    <c:v>5.7000000000000002E-3</c:v>
                  </c:pt>
                  <c:pt idx="35">
                    <c:v>8.9999999999999993E-3</c:v>
                  </c:pt>
                  <c:pt idx="36">
                    <c:v>7.0000000000000001E-3</c:v>
                  </c:pt>
                  <c:pt idx="37">
                    <c:v>8.0000000000000002E-3</c:v>
                  </c:pt>
                  <c:pt idx="38">
                    <c:v>6.8999999999999999E-3</c:v>
                  </c:pt>
                  <c:pt idx="39">
                    <c:v>7.7999999999999996E-3</c:v>
                  </c:pt>
                  <c:pt idx="40">
                    <c:v>5.7999999999999996E-3</c:v>
                  </c:pt>
                  <c:pt idx="41">
                    <c:v>6.7999999999999996E-3</c:v>
                  </c:pt>
                  <c:pt idx="42">
                    <c:v>5.3E-3</c:v>
                  </c:pt>
                  <c:pt idx="43">
                    <c:v>4.1000000000000003E-3</c:v>
                  </c:pt>
                  <c:pt idx="44">
                    <c:v>4.7999999999999996E-3</c:v>
                  </c:pt>
                  <c:pt idx="45">
                    <c:v>5.8999999999999999E-3</c:v>
                  </c:pt>
                  <c:pt idx="46">
                    <c:v>3.5000000000000001E-3</c:v>
                  </c:pt>
                  <c:pt idx="47">
                    <c:v>3.8999999999999998E-3</c:v>
                  </c:pt>
                  <c:pt idx="48">
                    <c:v>1E-3</c:v>
                  </c:pt>
                  <c:pt idx="49">
                    <c:v>2.0000000000000001E-4</c:v>
                  </c:pt>
                  <c:pt idx="50">
                    <c:v>1.4E-3</c:v>
                  </c:pt>
                  <c:pt idx="51">
                    <c:v>3.5000000000000001E-3</c:v>
                  </c:pt>
                  <c:pt idx="52">
                    <c:v>4.7999999999999996E-3</c:v>
                  </c:pt>
                  <c:pt idx="53">
                    <c:v>1E-4</c:v>
                  </c:pt>
                  <c:pt idx="54">
                    <c:v>8.0000000000000004E-4</c:v>
                  </c:pt>
                  <c:pt idx="55">
                    <c:v>1.4E-3</c:v>
                  </c:pt>
                  <c:pt idx="56">
                    <c:v>1.6000000000000001E-3</c:v>
                  </c:pt>
                  <c:pt idx="57">
                    <c:v>2.3999999999999998E-3</c:v>
                  </c:pt>
                  <c:pt idx="58">
                    <c:v>6.9999999999999999E-4</c:v>
                  </c:pt>
                  <c:pt idx="59">
                    <c:v>2.5000000000000001E-3</c:v>
                  </c:pt>
                  <c:pt idx="60">
                    <c:v>3.2000000000000002E-3</c:v>
                  </c:pt>
                  <c:pt idx="61">
                    <c:v>1.5E-3</c:v>
                  </c:pt>
                  <c:pt idx="62">
                    <c:v>4.4999999999999997E-3</c:v>
                  </c:pt>
                  <c:pt idx="63">
                    <c:v>2.8999999999999998E-3</c:v>
                  </c:pt>
                  <c:pt idx="64">
                    <c:v>2E-3</c:v>
                  </c:pt>
                  <c:pt idx="65">
                    <c:v>1E-3</c:v>
                  </c:pt>
                  <c:pt idx="66">
                    <c:v>3.0000000000000001E-3</c:v>
                  </c:pt>
                  <c:pt idx="67">
                    <c:v>4.5999999999999999E-3</c:v>
                  </c:pt>
                  <c:pt idx="68">
                    <c:v>4.7000000000000002E-3</c:v>
                  </c:pt>
                  <c:pt idx="69">
                    <c:v>1.1000000000000001E-3</c:v>
                  </c:pt>
                  <c:pt idx="70">
                    <c:v>5.0000000000000001E-4</c:v>
                  </c:pt>
                  <c:pt idx="71">
                    <c:v>5.0000000000000001E-4</c:v>
                  </c:pt>
                  <c:pt idx="72">
                    <c:v>3.3999999999999998E-3</c:v>
                  </c:pt>
                  <c:pt idx="73">
                    <c:v>1.6000000000000001E-3</c:v>
                  </c:pt>
                  <c:pt idx="74">
                    <c:v>1.1000000000000001E-3</c:v>
                  </c:pt>
                  <c:pt idx="75">
                    <c:v>2.9999999999999997E-4</c:v>
                  </c:pt>
                  <c:pt idx="76">
                    <c:v>1.6000000000000001E-3</c:v>
                  </c:pt>
                  <c:pt idx="77">
                    <c:v>1.2999999999999999E-3</c:v>
                  </c:pt>
                  <c:pt idx="78">
                    <c:v>4.3E-3</c:v>
                  </c:pt>
                  <c:pt idx="79">
                    <c:v>5.0000000000000001E-4</c:v>
                  </c:pt>
                  <c:pt idx="80">
                    <c:v>1.1999999999999999E-3</c:v>
                  </c:pt>
                  <c:pt idx="81">
                    <c:v>1.1000000000000001E-3</c:v>
                  </c:pt>
                  <c:pt idx="82">
                    <c:v>1.4E-3</c:v>
                  </c:pt>
                  <c:pt idx="83">
                    <c:v>6.9999999999999999E-4</c:v>
                  </c:pt>
                  <c:pt idx="84">
                    <c:v>2.3E-3</c:v>
                  </c:pt>
                  <c:pt idx="85">
                    <c:v>1.6999999999999999E-3</c:v>
                  </c:pt>
                  <c:pt idx="86">
                    <c:v>2E-3</c:v>
                  </c:pt>
                  <c:pt idx="87">
                    <c:v>3.3999999999999998E-3</c:v>
                  </c:pt>
                  <c:pt idx="88">
                    <c:v>1.9E-3</c:v>
                  </c:pt>
                  <c:pt idx="89">
                    <c:v>2.2000000000000001E-3</c:v>
                  </c:pt>
                  <c:pt idx="90">
                    <c:v>1.9E-3</c:v>
                  </c:pt>
                  <c:pt idx="91">
                    <c:v>3.0999999999999999E-3</c:v>
                  </c:pt>
                  <c:pt idx="92">
                    <c:v>2.8E-3</c:v>
                  </c:pt>
                  <c:pt idx="93">
                    <c:v>2.0000000000000001E-4</c:v>
                  </c:pt>
                  <c:pt idx="94">
                    <c:v>3.0000000000000001E-3</c:v>
                  </c:pt>
                  <c:pt idx="95">
                    <c:v>7.1999999999999998E-3</c:v>
                  </c:pt>
                  <c:pt idx="96">
                    <c:v>7.7000000000000002E-3</c:v>
                  </c:pt>
                  <c:pt idx="97">
                    <c:v>1.4200000000000001E-2</c:v>
                  </c:pt>
                  <c:pt idx="98">
                    <c:v>1.24E-2</c:v>
                  </c:pt>
                  <c:pt idx="99">
                    <c:v>1.29E-2</c:v>
                  </c:pt>
                  <c:pt idx="100">
                    <c:v>1.4E-2</c:v>
                  </c:pt>
                  <c:pt idx="101">
                    <c:v>1.3299999999999999E-2</c:v>
                  </c:pt>
                  <c:pt idx="102">
                    <c:v>1.3599999999999999E-2</c:v>
                  </c:pt>
                  <c:pt idx="103">
                    <c:v>1.35E-2</c:v>
                  </c:pt>
                  <c:pt idx="104">
                    <c:v>1.18E-2</c:v>
                  </c:pt>
                  <c:pt idx="105">
                    <c:v>1.7100000000000001E-2</c:v>
                  </c:pt>
                  <c:pt idx="106">
                    <c:v>1.5299999999999999E-2</c:v>
                  </c:pt>
                  <c:pt idx="107">
                    <c:v>1.35E-2</c:v>
                  </c:pt>
                  <c:pt idx="108">
                    <c:v>1.18E-2</c:v>
                  </c:pt>
                  <c:pt idx="109">
                    <c:v>1.5299999999999999E-2</c:v>
                  </c:pt>
                  <c:pt idx="110">
                    <c:v>1.61E-2</c:v>
                  </c:pt>
                  <c:pt idx="111">
                    <c:v>1.9599999999999999E-2</c:v>
                  </c:pt>
                  <c:pt idx="112">
                    <c:v>2.3199999999999998E-2</c:v>
                  </c:pt>
                  <c:pt idx="113">
                    <c:v>2.5499999999999998E-2</c:v>
                  </c:pt>
                  <c:pt idx="114">
                    <c:v>2.5700000000000001E-2</c:v>
                  </c:pt>
                  <c:pt idx="115">
                    <c:v>2.9600000000000001E-2</c:v>
                  </c:pt>
                  <c:pt idx="116">
                    <c:v>2.6700000000000002E-2</c:v>
                  </c:pt>
                  <c:pt idx="117">
                    <c:v>2.6499999999999999E-2</c:v>
                  </c:pt>
                  <c:pt idx="118">
                    <c:v>3.0800000000000001E-2</c:v>
                  </c:pt>
                  <c:pt idx="119">
                    <c:v>3.4200000000000001E-2</c:v>
                  </c:pt>
                  <c:pt idx="120">
                    <c:v>3.6499999999999998E-2</c:v>
                  </c:pt>
                  <c:pt idx="121">
                    <c:v>3.7100000000000001E-2</c:v>
                  </c:pt>
                  <c:pt idx="122">
                    <c:v>3.8699999999999998E-2</c:v>
                  </c:pt>
                  <c:pt idx="123">
                    <c:v>4.41E-2</c:v>
                  </c:pt>
                  <c:pt idx="124">
                    <c:v>4.4999999999999998E-2</c:v>
                  </c:pt>
                  <c:pt idx="125">
                    <c:v>4.48E-2</c:v>
                  </c:pt>
                  <c:pt idx="126">
                    <c:v>4.8000000000000001E-2</c:v>
                  </c:pt>
                  <c:pt idx="127">
                    <c:v>4.9799999999999997E-2</c:v>
                  </c:pt>
                  <c:pt idx="128">
                    <c:v>4.8800000000000003E-2</c:v>
                  </c:pt>
                  <c:pt idx="129">
                    <c:v>5.0700000000000002E-2</c:v>
                  </c:pt>
                  <c:pt idx="130">
                    <c:v>5.57E-2</c:v>
                  </c:pt>
                  <c:pt idx="131">
                    <c:v>5.3900000000000003E-2</c:v>
                  </c:pt>
                  <c:pt idx="132">
                    <c:v>5.4699999999999999E-2</c:v>
                  </c:pt>
                  <c:pt idx="133">
                    <c:v>5.6099999999999997E-2</c:v>
                  </c:pt>
                  <c:pt idx="134">
                    <c:v>5.9900000000000002E-2</c:v>
                  </c:pt>
                  <c:pt idx="135">
                    <c:v>5.8400000000000001E-2</c:v>
                  </c:pt>
                  <c:pt idx="136">
                    <c:v>6.1800000000000001E-2</c:v>
                  </c:pt>
                  <c:pt idx="137">
                    <c:v>5.7599999999999998E-2</c:v>
                  </c:pt>
                  <c:pt idx="138">
                    <c:v>6.2300000000000001E-2</c:v>
                  </c:pt>
                  <c:pt idx="139">
                    <c:v>5.9499999999999997E-2</c:v>
                  </c:pt>
                  <c:pt idx="140">
                    <c:v>6.5199999999999994E-2</c:v>
                  </c:pt>
                  <c:pt idx="141">
                    <c:v>6.6799999999999998E-2</c:v>
                  </c:pt>
                  <c:pt idx="142">
                    <c:v>7.0699999999999999E-2</c:v>
                  </c:pt>
                  <c:pt idx="143">
                    <c:v>6.7199999999999996E-2</c:v>
                  </c:pt>
                  <c:pt idx="144">
                    <c:v>6.8599999999999994E-2</c:v>
                  </c:pt>
                  <c:pt idx="145">
                    <c:v>7.3300000000000004E-2</c:v>
                  </c:pt>
                  <c:pt idx="146">
                    <c:v>7.3800000000000004E-2</c:v>
                  </c:pt>
                  <c:pt idx="147">
                    <c:v>7.1999999999999995E-2</c:v>
                  </c:pt>
                  <c:pt idx="148">
                    <c:v>7.6600000000000001E-2</c:v>
                  </c:pt>
                  <c:pt idx="149">
                    <c:v>8.0100000000000005E-2</c:v>
                  </c:pt>
                  <c:pt idx="150">
                    <c:v>8.0699999999999994E-2</c:v>
                  </c:pt>
                  <c:pt idx="151">
                    <c:v>8.4900000000000003E-2</c:v>
                  </c:pt>
                  <c:pt idx="152">
                    <c:v>8.5199999999999998E-2</c:v>
                  </c:pt>
                  <c:pt idx="153">
                    <c:v>8.7300000000000003E-2</c:v>
                  </c:pt>
                  <c:pt idx="154">
                    <c:v>8.9800000000000005E-2</c:v>
                  </c:pt>
                  <c:pt idx="155">
                    <c:v>9.35E-2</c:v>
                  </c:pt>
                  <c:pt idx="156">
                    <c:v>8.6499999999999994E-2</c:v>
                  </c:pt>
                  <c:pt idx="157">
                    <c:v>8.8400000000000006E-2</c:v>
                  </c:pt>
                  <c:pt idx="158">
                    <c:v>8.8499999999999995E-2</c:v>
                  </c:pt>
                  <c:pt idx="159">
                    <c:v>8.9499999999999996E-2</c:v>
                  </c:pt>
                  <c:pt idx="160">
                    <c:v>8.2299999999999998E-2</c:v>
                  </c:pt>
                </c:numCache>
              </c:numRef>
            </c:minus>
            <c:spPr>
              <a:ln>
                <a:solidFill>
                  <a:srgbClr val="C00000">
                    <a:alpha val="50000"/>
                  </a:srgbClr>
                </a:solidFill>
              </a:ln>
            </c:spPr>
          </c:errBars>
          <c:xVal>
            <c:numRef>
              <c:f>WT4FN!$A$2:$A$174</c:f>
              <c:numCache>
                <c:formatCode>General</c:formatCode>
                <c:ptCount val="173"/>
                <c:pt idx="0">
                  <c:v>0</c:v>
                </c:pt>
                <c:pt idx="1">
                  <c:v>3.5999999999999999E-3</c:v>
                </c:pt>
                <c:pt idx="2">
                  <c:v>0.23080000000000001</c:v>
                </c:pt>
                <c:pt idx="3">
                  <c:v>0.48080000000000001</c:v>
                </c:pt>
                <c:pt idx="4">
                  <c:v>0.73109999999999997</c:v>
                </c:pt>
                <c:pt idx="5">
                  <c:v>0.98140000000000005</c:v>
                </c:pt>
                <c:pt idx="6">
                  <c:v>1.2317</c:v>
                </c:pt>
                <c:pt idx="7">
                  <c:v>1.4819</c:v>
                </c:pt>
                <c:pt idx="8">
                  <c:v>1.7322</c:v>
                </c:pt>
                <c:pt idx="9">
                  <c:v>1.9824999999999999</c:v>
                </c:pt>
                <c:pt idx="10">
                  <c:v>2.2328000000000001</c:v>
                </c:pt>
                <c:pt idx="11">
                  <c:v>2.4830999999999999</c:v>
                </c:pt>
                <c:pt idx="12">
                  <c:v>2.7332999999999998</c:v>
                </c:pt>
                <c:pt idx="13">
                  <c:v>2.9836</c:v>
                </c:pt>
                <c:pt idx="14">
                  <c:v>3.2339000000000002</c:v>
                </c:pt>
                <c:pt idx="15">
                  <c:v>3.4842</c:v>
                </c:pt>
                <c:pt idx="16">
                  <c:v>3.7343999999999999</c:v>
                </c:pt>
                <c:pt idx="17">
                  <c:v>3.9847000000000001</c:v>
                </c:pt>
                <c:pt idx="18">
                  <c:v>4.2350000000000003</c:v>
                </c:pt>
                <c:pt idx="19">
                  <c:v>4.4852999999999996</c:v>
                </c:pt>
                <c:pt idx="20">
                  <c:v>4.7355999999999998</c:v>
                </c:pt>
                <c:pt idx="21">
                  <c:v>4.9858000000000002</c:v>
                </c:pt>
                <c:pt idx="22">
                  <c:v>5.2361000000000004</c:v>
                </c:pt>
                <c:pt idx="23">
                  <c:v>5.4863999999999997</c:v>
                </c:pt>
                <c:pt idx="24">
                  <c:v>5.7366999999999999</c:v>
                </c:pt>
                <c:pt idx="25">
                  <c:v>5.9869000000000003</c:v>
                </c:pt>
                <c:pt idx="26">
                  <c:v>6.2371999999999996</c:v>
                </c:pt>
                <c:pt idx="27">
                  <c:v>6.4874999999999998</c:v>
                </c:pt>
                <c:pt idx="28">
                  <c:v>6.7378</c:v>
                </c:pt>
                <c:pt idx="29">
                  <c:v>6.9881000000000002</c:v>
                </c:pt>
                <c:pt idx="30">
                  <c:v>7.2382999999999997</c:v>
                </c:pt>
                <c:pt idx="31">
                  <c:v>7.4885999999999999</c:v>
                </c:pt>
                <c:pt idx="32">
                  <c:v>7.7389000000000001</c:v>
                </c:pt>
                <c:pt idx="33">
                  <c:v>7.9892000000000003</c:v>
                </c:pt>
                <c:pt idx="34">
                  <c:v>8.2393999999999998</c:v>
                </c:pt>
                <c:pt idx="35">
                  <c:v>8.4896999999999991</c:v>
                </c:pt>
                <c:pt idx="36">
                  <c:v>8.74</c:v>
                </c:pt>
                <c:pt idx="37">
                  <c:v>8.9902999999999995</c:v>
                </c:pt>
                <c:pt idx="38">
                  <c:v>9.2406000000000006</c:v>
                </c:pt>
                <c:pt idx="39">
                  <c:v>9.4908000000000001</c:v>
                </c:pt>
                <c:pt idx="40">
                  <c:v>9.7410999999999994</c:v>
                </c:pt>
                <c:pt idx="41">
                  <c:v>9.9914000000000005</c:v>
                </c:pt>
                <c:pt idx="42">
                  <c:v>10.2417</c:v>
                </c:pt>
                <c:pt idx="43">
                  <c:v>10.491899999999999</c:v>
                </c:pt>
                <c:pt idx="44">
                  <c:v>10.7422</c:v>
                </c:pt>
                <c:pt idx="45">
                  <c:v>10.9925</c:v>
                </c:pt>
                <c:pt idx="46">
                  <c:v>11.242800000000001</c:v>
                </c:pt>
                <c:pt idx="47">
                  <c:v>11.4931</c:v>
                </c:pt>
                <c:pt idx="48">
                  <c:v>11.7433</c:v>
                </c:pt>
                <c:pt idx="49">
                  <c:v>11.993600000000001</c:v>
                </c:pt>
                <c:pt idx="50">
                  <c:v>12.2439</c:v>
                </c:pt>
                <c:pt idx="51">
                  <c:v>12.494199999999999</c:v>
                </c:pt>
                <c:pt idx="52">
                  <c:v>12.744400000000001</c:v>
                </c:pt>
                <c:pt idx="53">
                  <c:v>12.9947</c:v>
                </c:pt>
                <c:pt idx="54">
                  <c:v>13.244999999999999</c:v>
                </c:pt>
                <c:pt idx="55">
                  <c:v>13.4953</c:v>
                </c:pt>
                <c:pt idx="56">
                  <c:v>13.7456</c:v>
                </c:pt>
                <c:pt idx="57">
                  <c:v>13.995799999999999</c:v>
                </c:pt>
                <c:pt idx="58">
                  <c:v>14.2461</c:v>
                </c:pt>
                <c:pt idx="59">
                  <c:v>14.4964</c:v>
                </c:pt>
                <c:pt idx="60">
                  <c:v>14.746700000000001</c:v>
                </c:pt>
                <c:pt idx="61">
                  <c:v>14.9969</c:v>
                </c:pt>
                <c:pt idx="62">
                  <c:v>15.247199999999999</c:v>
                </c:pt>
                <c:pt idx="63">
                  <c:v>15.4975</c:v>
                </c:pt>
                <c:pt idx="64">
                  <c:v>15.7478</c:v>
                </c:pt>
                <c:pt idx="65">
                  <c:v>15.998100000000001</c:v>
                </c:pt>
                <c:pt idx="66">
                  <c:v>16.2483</c:v>
                </c:pt>
                <c:pt idx="67">
                  <c:v>16.4986</c:v>
                </c:pt>
                <c:pt idx="68">
                  <c:v>16.748899999999999</c:v>
                </c:pt>
                <c:pt idx="69">
                  <c:v>16.999199999999998</c:v>
                </c:pt>
                <c:pt idx="70">
                  <c:v>17.249400000000001</c:v>
                </c:pt>
                <c:pt idx="71">
                  <c:v>17.499700000000001</c:v>
                </c:pt>
                <c:pt idx="72">
                  <c:v>17.749700000000001</c:v>
                </c:pt>
                <c:pt idx="73">
                  <c:v>18</c:v>
                </c:pt>
                <c:pt idx="74">
                  <c:v>18.250299999999999</c:v>
                </c:pt>
                <c:pt idx="75">
                  <c:v>18.500599999999999</c:v>
                </c:pt>
                <c:pt idx="76">
                  <c:v>18.750800000000002</c:v>
                </c:pt>
                <c:pt idx="77">
                  <c:v>19.001100000000001</c:v>
                </c:pt>
                <c:pt idx="78">
                  <c:v>19.2514</c:v>
                </c:pt>
                <c:pt idx="79">
                  <c:v>19.5017</c:v>
                </c:pt>
                <c:pt idx="80">
                  <c:v>19.751899999999999</c:v>
                </c:pt>
                <c:pt idx="81">
                  <c:v>20.002199999999998</c:v>
                </c:pt>
                <c:pt idx="82">
                  <c:v>20.252500000000001</c:v>
                </c:pt>
                <c:pt idx="83">
                  <c:v>20.502800000000001</c:v>
                </c:pt>
                <c:pt idx="84">
                  <c:v>20.7531</c:v>
                </c:pt>
                <c:pt idx="85">
                  <c:v>21.003299999999999</c:v>
                </c:pt>
                <c:pt idx="86">
                  <c:v>21.253599999999999</c:v>
                </c:pt>
                <c:pt idx="87">
                  <c:v>21.503900000000002</c:v>
                </c:pt>
                <c:pt idx="88">
                  <c:v>21.754200000000001</c:v>
                </c:pt>
                <c:pt idx="89">
                  <c:v>22.0044</c:v>
                </c:pt>
                <c:pt idx="90">
                  <c:v>22.2547</c:v>
                </c:pt>
                <c:pt idx="91">
                  <c:v>22.504999999999999</c:v>
                </c:pt>
                <c:pt idx="92">
                  <c:v>22.755299999999998</c:v>
                </c:pt>
                <c:pt idx="93">
                  <c:v>23.005600000000001</c:v>
                </c:pt>
                <c:pt idx="94">
                  <c:v>23.255800000000001</c:v>
                </c:pt>
                <c:pt idx="95">
                  <c:v>23.4819</c:v>
                </c:pt>
                <c:pt idx="96">
                  <c:v>23.732199999999999</c:v>
                </c:pt>
                <c:pt idx="97">
                  <c:v>23.982500000000002</c:v>
                </c:pt>
                <c:pt idx="98">
                  <c:v>24.232800000000001</c:v>
                </c:pt>
                <c:pt idx="99">
                  <c:v>24.4831</c:v>
                </c:pt>
                <c:pt idx="100">
                  <c:v>24.7333</c:v>
                </c:pt>
                <c:pt idx="101">
                  <c:v>24.983599999999999</c:v>
                </c:pt>
                <c:pt idx="102">
                  <c:v>25.233899999999998</c:v>
                </c:pt>
                <c:pt idx="103">
                  <c:v>25.484200000000001</c:v>
                </c:pt>
                <c:pt idx="104">
                  <c:v>25.734400000000001</c:v>
                </c:pt>
                <c:pt idx="105">
                  <c:v>25.9847</c:v>
                </c:pt>
                <c:pt idx="106">
                  <c:v>26.234999999999999</c:v>
                </c:pt>
                <c:pt idx="107">
                  <c:v>26.485299999999999</c:v>
                </c:pt>
                <c:pt idx="108">
                  <c:v>26.735600000000002</c:v>
                </c:pt>
                <c:pt idx="109">
                  <c:v>26.985800000000001</c:v>
                </c:pt>
                <c:pt idx="110">
                  <c:v>27.2361</c:v>
                </c:pt>
                <c:pt idx="111">
                  <c:v>27.4864</c:v>
                </c:pt>
                <c:pt idx="112">
                  <c:v>27.736699999999999</c:v>
                </c:pt>
                <c:pt idx="113">
                  <c:v>27.986899999999999</c:v>
                </c:pt>
                <c:pt idx="114">
                  <c:v>28.237200000000001</c:v>
                </c:pt>
                <c:pt idx="115">
                  <c:v>28.487500000000001</c:v>
                </c:pt>
                <c:pt idx="116">
                  <c:v>28.7378</c:v>
                </c:pt>
                <c:pt idx="117">
                  <c:v>28.988099999999999</c:v>
                </c:pt>
                <c:pt idx="118">
                  <c:v>29.238299999999999</c:v>
                </c:pt>
                <c:pt idx="119">
                  <c:v>29.488600000000002</c:v>
                </c:pt>
                <c:pt idx="120">
                  <c:v>29.738900000000001</c:v>
                </c:pt>
                <c:pt idx="121">
                  <c:v>29.9892</c:v>
                </c:pt>
                <c:pt idx="122">
                  <c:v>30.2394</c:v>
                </c:pt>
                <c:pt idx="123">
                  <c:v>30.489699999999999</c:v>
                </c:pt>
                <c:pt idx="124">
                  <c:v>30.74</c:v>
                </c:pt>
                <c:pt idx="125">
                  <c:v>30.990300000000001</c:v>
                </c:pt>
                <c:pt idx="126">
                  <c:v>31.240600000000001</c:v>
                </c:pt>
                <c:pt idx="127">
                  <c:v>31.4908</c:v>
                </c:pt>
                <c:pt idx="128">
                  <c:v>31.741099999999999</c:v>
                </c:pt>
                <c:pt idx="129">
                  <c:v>31.991399999999999</c:v>
                </c:pt>
                <c:pt idx="130">
                  <c:v>32.241700000000002</c:v>
                </c:pt>
                <c:pt idx="131">
                  <c:v>32.491900000000001</c:v>
                </c:pt>
                <c:pt idx="132">
                  <c:v>32.742199999999997</c:v>
                </c:pt>
                <c:pt idx="133">
                  <c:v>32.9925</c:v>
                </c:pt>
                <c:pt idx="134">
                  <c:v>33.242800000000003</c:v>
                </c:pt>
                <c:pt idx="135">
                  <c:v>33.493099999999998</c:v>
                </c:pt>
                <c:pt idx="136">
                  <c:v>33.743299999999998</c:v>
                </c:pt>
                <c:pt idx="137">
                  <c:v>33.993600000000001</c:v>
                </c:pt>
                <c:pt idx="138">
                  <c:v>34.243899999999996</c:v>
                </c:pt>
                <c:pt idx="139">
                  <c:v>34.494199999999999</c:v>
                </c:pt>
                <c:pt idx="140">
                  <c:v>34.744399999999999</c:v>
                </c:pt>
                <c:pt idx="141">
                  <c:v>34.994700000000002</c:v>
                </c:pt>
                <c:pt idx="142">
                  <c:v>35.244999999999997</c:v>
                </c:pt>
                <c:pt idx="143">
                  <c:v>35.4953</c:v>
                </c:pt>
                <c:pt idx="144">
                  <c:v>35.745600000000003</c:v>
                </c:pt>
                <c:pt idx="145">
                  <c:v>35.995800000000003</c:v>
                </c:pt>
                <c:pt idx="146">
                  <c:v>36.246099999999998</c:v>
                </c:pt>
                <c:pt idx="147">
                  <c:v>36.496400000000001</c:v>
                </c:pt>
                <c:pt idx="148">
                  <c:v>36.746699999999997</c:v>
                </c:pt>
                <c:pt idx="149">
                  <c:v>36.996899999999997</c:v>
                </c:pt>
                <c:pt idx="150">
                  <c:v>37.247199999999999</c:v>
                </c:pt>
                <c:pt idx="151">
                  <c:v>37.497500000000002</c:v>
                </c:pt>
                <c:pt idx="152">
                  <c:v>37.747799999999998</c:v>
                </c:pt>
                <c:pt idx="153">
                  <c:v>37.998100000000001</c:v>
                </c:pt>
                <c:pt idx="154">
                  <c:v>38.2483</c:v>
                </c:pt>
                <c:pt idx="155">
                  <c:v>38.498600000000003</c:v>
                </c:pt>
                <c:pt idx="156">
                  <c:v>38.748899999999999</c:v>
                </c:pt>
                <c:pt idx="157">
                  <c:v>38.999200000000002</c:v>
                </c:pt>
                <c:pt idx="158">
                  <c:v>39.249400000000001</c:v>
                </c:pt>
                <c:pt idx="159">
                  <c:v>39.499699999999997</c:v>
                </c:pt>
                <c:pt idx="160">
                  <c:v>39.75</c:v>
                </c:pt>
              </c:numCache>
            </c:numRef>
          </c:xVal>
          <c:yVal>
            <c:numRef>
              <c:f>WT4FN!$C$2:$C$174</c:f>
              <c:numCache>
                <c:formatCode>General</c:formatCode>
                <c:ptCount val="173"/>
                <c:pt idx="0">
                  <c:v>1</c:v>
                </c:pt>
                <c:pt idx="1">
                  <c:v>0.99950000000000006</c:v>
                </c:pt>
                <c:pt idx="2">
                  <c:v>0.99890000000000001</c:v>
                </c:pt>
                <c:pt idx="3">
                  <c:v>1.0006999999999999</c:v>
                </c:pt>
                <c:pt idx="4">
                  <c:v>1.0014000000000001</c:v>
                </c:pt>
                <c:pt idx="5">
                  <c:v>1.0049999999999999</c:v>
                </c:pt>
                <c:pt idx="6">
                  <c:v>1.0073000000000001</c:v>
                </c:pt>
                <c:pt idx="7">
                  <c:v>1.0098</c:v>
                </c:pt>
                <c:pt idx="8">
                  <c:v>1.0116000000000001</c:v>
                </c:pt>
                <c:pt idx="9">
                  <c:v>1.0135000000000001</c:v>
                </c:pt>
                <c:pt idx="10">
                  <c:v>1.0152000000000001</c:v>
                </c:pt>
                <c:pt idx="11">
                  <c:v>1.0187999999999999</c:v>
                </c:pt>
                <c:pt idx="12">
                  <c:v>1.0206999999999999</c:v>
                </c:pt>
                <c:pt idx="13">
                  <c:v>1.0237000000000001</c:v>
                </c:pt>
                <c:pt idx="14">
                  <c:v>1.0265</c:v>
                </c:pt>
                <c:pt idx="15">
                  <c:v>1.0270999999999999</c:v>
                </c:pt>
                <c:pt idx="16">
                  <c:v>1.0298</c:v>
                </c:pt>
                <c:pt idx="17">
                  <c:v>1.0328999999999999</c:v>
                </c:pt>
                <c:pt idx="18">
                  <c:v>1.0367</c:v>
                </c:pt>
                <c:pt idx="19">
                  <c:v>1.0381</c:v>
                </c:pt>
                <c:pt idx="20">
                  <c:v>1.0418000000000001</c:v>
                </c:pt>
                <c:pt idx="21">
                  <c:v>1.0444</c:v>
                </c:pt>
                <c:pt idx="22">
                  <c:v>1.0482</c:v>
                </c:pt>
                <c:pt idx="23">
                  <c:v>1.0524</c:v>
                </c:pt>
                <c:pt idx="24">
                  <c:v>1.0568</c:v>
                </c:pt>
                <c:pt idx="25">
                  <c:v>1.0601</c:v>
                </c:pt>
                <c:pt idx="26">
                  <c:v>1.0637000000000001</c:v>
                </c:pt>
                <c:pt idx="27">
                  <c:v>1.0677000000000001</c:v>
                </c:pt>
                <c:pt idx="28">
                  <c:v>1.0710999999999999</c:v>
                </c:pt>
                <c:pt idx="29">
                  <c:v>1.0716000000000001</c:v>
                </c:pt>
                <c:pt idx="30">
                  <c:v>1.0757000000000001</c:v>
                </c:pt>
                <c:pt idx="31">
                  <c:v>1.0806</c:v>
                </c:pt>
                <c:pt idx="32">
                  <c:v>1.0810999999999999</c:v>
                </c:pt>
                <c:pt idx="33">
                  <c:v>1.0855999999999999</c:v>
                </c:pt>
                <c:pt idx="34">
                  <c:v>1.0855999999999999</c:v>
                </c:pt>
                <c:pt idx="35">
                  <c:v>1.0884</c:v>
                </c:pt>
                <c:pt idx="36">
                  <c:v>1.0914999999999999</c:v>
                </c:pt>
                <c:pt idx="37">
                  <c:v>1.0931</c:v>
                </c:pt>
                <c:pt idx="38">
                  <c:v>1.0955999999999999</c:v>
                </c:pt>
                <c:pt idx="39">
                  <c:v>1.0964</c:v>
                </c:pt>
                <c:pt idx="40">
                  <c:v>1.1027</c:v>
                </c:pt>
                <c:pt idx="41">
                  <c:v>1.1052999999999999</c:v>
                </c:pt>
                <c:pt idx="42">
                  <c:v>1.1067</c:v>
                </c:pt>
                <c:pt idx="43">
                  <c:v>1.1100000000000001</c:v>
                </c:pt>
                <c:pt idx="44">
                  <c:v>1.1127</c:v>
                </c:pt>
                <c:pt idx="45">
                  <c:v>1.1163000000000001</c:v>
                </c:pt>
                <c:pt idx="46">
                  <c:v>1.1164000000000001</c:v>
                </c:pt>
                <c:pt idx="47">
                  <c:v>1.1198999999999999</c:v>
                </c:pt>
                <c:pt idx="48">
                  <c:v>1.1234</c:v>
                </c:pt>
                <c:pt idx="49">
                  <c:v>1.1255999999999999</c:v>
                </c:pt>
                <c:pt idx="50">
                  <c:v>1.1279999999999999</c:v>
                </c:pt>
                <c:pt idx="51">
                  <c:v>1.1318999999999999</c:v>
                </c:pt>
                <c:pt idx="52">
                  <c:v>1.1324000000000001</c:v>
                </c:pt>
                <c:pt idx="53">
                  <c:v>1.1361000000000001</c:v>
                </c:pt>
                <c:pt idx="54">
                  <c:v>1.1364000000000001</c:v>
                </c:pt>
                <c:pt idx="55">
                  <c:v>1.1397999999999999</c:v>
                </c:pt>
                <c:pt idx="56">
                  <c:v>1.1423000000000001</c:v>
                </c:pt>
                <c:pt idx="57">
                  <c:v>1.1439999999999999</c:v>
                </c:pt>
                <c:pt idx="58">
                  <c:v>1.1471</c:v>
                </c:pt>
                <c:pt idx="59">
                  <c:v>1.1508</c:v>
                </c:pt>
                <c:pt idx="60">
                  <c:v>1.1527000000000001</c:v>
                </c:pt>
                <c:pt idx="61">
                  <c:v>1.1563000000000001</c:v>
                </c:pt>
                <c:pt idx="62">
                  <c:v>1.1585000000000001</c:v>
                </c:pt>
                <c:pt idx="63">
                  <c:v>1.1615</c:v>
                </c:pt>
                <c:pt idx="64">
                  <c:v>1.1673</c:v>
                </c:pt>
                <c:pt idx="65">
                  <c:v>1.1667000000000001</c:v>
                </c:pt>
                <c:pt idx="66">
                  <c:v>1.1715</c:v>
                </c:pt>
                <c:pt idx="67">
                  <c:v>1.1754</c:v>
                </c:pt>
                <c:pt idx="68">
                  <c:v>1.1779999999999999</c:v>
                </c:pt>
                <c:pt idx="69">
                  <c:v>1.1831</c:v>
                </c:pt>
                <c:pt idx="70">
                  <c:v>1.1871</c:v>
                </c:pt>
                <c:pt idx="71">
                  <c:v>1.1906000000000001</c:v>
                </c:pt>
                <c:pt idx="72">
                  <c:v>1.1932</c:v>
                </c:pt>
                <c:pt idx="73">
                  <c:v>1.1962999999999999</c:v>
                </c:pt>
                <c:pt idx="74">
                  <c:v>1.2010000000000001</c:v>
                </c:pt>
                <c:pt idx="75">
                  <c:v>1.2059</c:v>
                </c:pt>
                <c:pt idx="76">
                  <c:v>1.2093</c:v>
                </c:pt>
                <c:pt idx="77">
                  <c:v>1.2142999999999999</c:v>
                </c:pt>
                <c:pt idx="78">
                  <c:v>1.2163999999999999</c:v>
                </c:pt>
                <c:pt idx="79">
                  <c:v>1.2184999999999999</c:v>
                </c:pt>
                <c:pt idx="80">
                  <c:v>1.22</c:v>
                </c:pt>
                <c:pt idx="81">
                  <c:v>1.2222999999999999</c:v>
                </c:pt>
                <c:pt idx="82">
                  <c:v>1.2262999999999999</c:v>
                </c:pt>
                <c:pt idx="83">
                  <c:v>1.2290000000000001</c:v>
                </c:pt>
                <c:pt idx="84">
                  <c:v>1.2319</c:v>
                </c:pt>
                <c:pt idx="85">
                  <c:v>1.236</c:v>
                </c:pt>
                <c:pt idx="86">
                  <c:v>1.2375</c:v>
                </c:pt>
                <c:pt idx="87">
                  <c:v>1.2405999999999999</c:v>
                </c:pt>
                <c:pt idx="88">
                  <c:v>1.2444999999999999</c:v>
                </c:pt>
                <c:pt idx="89">
                  <c:v>1.2464999999999999</c:v>
                </c:pt>
                <c:pt idx="90">
                  <c:v>1.2477</c:v>
                </c:pt>
                <c:pt idx="91">
                  <c:v>1.2504999999999999</c:v>
                </c:pt>
                <c:pt idx="92">
                  <c:v>1.2544999999999999</c:v>
                </c:pt>
                <c:pt idx="93">
                  <c:v>1.2592000000000001</c:v>
                </c:pt>
                <c:pt idx="94">
                  <c:v>1.2625</c:v>
                </c:pt>
                <c:pt idx="95">
                  <c:v>1.2634000000000001</c:v>
                </c:pt>
                <c:pt idx="96">
                  <c:v>1.2663</c:v>
                </c:pt>
                <c:pt idx="97">
                  <c:v>1.2695000000000001</c:v>
                </c:pt>
                <c:pt idx="98">
                  <c:v>1.2738</c:v>
                </c:pt>
                <c:pt idx="99">
                  <c:v>1.2779</c:v>
                </c:pt>
                <c:pt idx="100">
                  <c:v>1.2835000000000001</c:v>
                </c:pt>
                <c:pt idx="101">
                  <c:v>1.2905</c:v>
                </c:pt>
                <c:pt idx="102">
                  <c:v>1.2944</c:v>
                </c:pt>
                <c:pt idx="103">
                  <c:v>1.3009999999999999</c:v>
                </c:pt>
                <c:pt idx="104">
                  <c:v>1.3067</c:v>
                </c:pt>
                <c:pt idx="105">
                  <c:v>1.3149999999999999</c:v>
                </c:pt>
                <c:pt idx="106">
                  <c:v>1.3233999999999999</c:v>
                </c:pt>
                <c:pt idx="107">
                  <c:v>1.3304</c:v>
                </c:pt>
                <c:pt idx="108">
                  <c:v>1.3364</c:v>
                </c:pt>
                <c:pt idx="109">
                  <c:v>1.341</c:v>
                </c:pt>
                <c:pt idx="110">
                  <c:v>1.3474999999999999</c:v>
                </c:pt>
                <c:pt idx="111">
                  <c:v>1.3516999999999999</c:v>
                </c:pt>
                <c:pt idx="112">
                  <c:v>1.3603000000000001</c:v>
                </c:pt>
                <c:pt idx="113">
                  <c:v>1.3706</c:v>
                </c:pt>
                <c:pt idx="114">
                  <c:v>1.3798999999999999</c:v>
                </c:pt>
                <c:pt idx="115">
                  <c:v>1.389</c:v>
                </c:pt>
                <c:pt idx="116">
                  <c:v>1.3965000000000001</c:v>
                </c:pt>
                <c:pt idx="117">
                  <c:v>1.4074</c:v>
                </c:pt>
                <c:pt idx="118">
                  <c:v>1.4134</c:v>
                </c:pt>
                <c:pt idx="119">
                  <c:v>1.4262999999999999</c:v>
                </c:pt>
                <c:pt idx="120">
                  <c:v>1.4333</c:v>
                </c:pt>
                <c:pt idx="121">
                  <c:v>1.4430000000000001</c:v>
                </c:pt>
                <c:pt idx="122">
                  <c:v>1.4529000000000001</c:v>
                </c:pt>
                <c:pt idx="123">
                  <c:v>1.4602999999999999</c:v>
                </c:pt>
                <c:pt idx="124">
                  <c:v>1.4698</c:v>
                </c:pt>
                <c:pt idx="125">
                  <c:v>1.4785999999999999</c:v>
                </c:pt>
                <c:pt idx="126">
                  <c:v>1.4883999999999999</c:v>
                </c:pt>
                <c:pt idx="127">
                  <c:v>1.4974000000000001</c:v>
                </c:pt>
                <c:pt idx="128">
                  <c:v>1.5074000000000001</c:v>
                </c:pt>
                <c:pt idx="129">
                  <c:v>1.5138</c:v>
                </c:pt>
                <c:pt idx="130">
                  <c:v>1.5238</c:v>
                </c:pt>
                <c:pt idx="131">
                  <c:v>1.5330999999999999</c:v>
                </c:pt>
                <c:pt idx="132">
                  <c:v>1.5416000000000001</c:v>
                </c:pt>
                <c:pt idx="133">
                  <c:v>1.5492999999999999</c:v>
                </c:pt>
                <c:pt idx="134">
                  <c:v>1.5561</c:v>
                </c:pt>
                <c:pt idx="135">
                  <c:v>1.5686</c:v>
                </c:pt>
                <c:pt idx="136">
                  <c:v>1.5757000000000001</c:v>
                </c:pt>
                <c:pt idx="137">
                  <c:v>1.5860000000000001</c:v>
                </c:pt>
                <c:pt idx="138">
                  <c:v>1.5914999999999999</c:v>
                </c:pt>
                <c:pt idx="139">
                  <c:v>1.605</c:v>
                </c:pt>
                <c:pt idx="140">
                  <c:v>1.6148</c:v>
                </c:pt>
                <c:pt idx="141">
                  <c:v>1.6189</c:v>
                </c:pt>
                <c:pt idx="142">
                  <c:v>1.6236999999999999</c:v>
                </c:pt>
                <c:pt idx="143">
                  <c:v>1.6321000000000001</c:v>
                </c:pt>
                <c:pt idx="144">
                  <c:v>1.639</c:v>
                </c:pt>
                <c:pt idx="145">
                  <c:v>1.6501999999999999</c:v>
                </c:pt>
                <c:pt idx="146">
                  <c:v>1.6563000000000001</c:v>
                </c:pt>
                <c:pt idx="147">
                  <c:v>1.6658999999999999</c:v>
                </c:pt>
                <c:pt idx="148">
                  <c:v>1.6744000000000001</c:v>
                </c:pt>
                <c:pt idx="149">
                  <c:v>1.6848000000000001</c:v>
                </c:pt>
                <c:pt idx="150">
                  <c:v>1.6937</c:v>
                </c:pt>
                <c:pt idx="151">
                  <c:v>1.7008000000000001</c:v>
                </c:pt>
                <c:pt idx="152">
                  <c:v>1.7057</c:v>
                </c:pt>
                <c:pt idx="153">
                  <c:v>1.7138</c:v>
                </c:pt>
                <c:pt idx="154">
                  <c:v>1.7181</c:v>
                </c:pt>
                <c:pt idx="155">
                  <c:v>1.7291000000000001</c:v>
                </c:pt>
                <c:pt idx="156">
                  <c:v>1.7381</c:v>
                </c:pt>
                <c:pt idx="157">
                  <c:v>1.7470000000000001</c:v>
                </c:pt>
                <c:pt idx="158">
                  <c:v>1.7494000000000001</c:v>
                </c:pt>
                <c:pt idx="159">
                  <c:v>1.7585999999999999</c:v>
                </c:pt>
                <c:pt idx="160">
                  <c:v>1.767200000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9248896"/>
        <c:axId val="109250816"/>
      </c:scatterChart>
      <c:valAx>
        <c:axId val="109248896"/>
        <c:scaling>
          <c:orientation val="minMax"/>
          <c:max val="4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ou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109250816"/>
        <c:crosses val="autoZero"/>
        <c:crossBetween val="midCat"/>
      </c:valAx>
      <c:valAx>
        <c:axId val="109250816"/>
        <c:scaling>
          <c:orientation val="minMax"/>
          <c:min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1092488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24363487866098452"/>
          <c:y val="8.6510700585503739E-2"/>
          <c:w val="0.35030511811023624"/>
          <c:h val="0.19465808328013051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34546357381002"/>
          <c:y val="5.1400554097404488E-2"/>
          <c:w val="0.75258246435411791"/>
          <c:h val="0.75759623797025377"/>
        </c:manualLayout>
      </c:layout>
      <c:scatterChart>
        <c:scatterStyle val="smoothMarker"/>
        <c:varyColors val="0"/>
        <c:ser>
          <c:idx val="0"/>
          <c:order val="0"/>
          <c:tx>
            <c:strRef>
              <c:f>WT4Gel!$B$1</c:f>
              <c:strCache>
                <c:ptCount val="1"/>
                <c:pt idx="0">
                  <c:v>WT4 Con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WT4Gel!$D$2:$D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2.0999999999999999E-3</c:v>
                  </c:pt>
                  <c:pt idx="2">
                    <c:v>2.8500000000000001E-3</c:v>
                  </c:pt>
                  <c:pt idx="3">
                    <c:v>1.8500000000000001E-3</c:v>
                  </c:pt>
                  <c:pt idx="4">
                    <c:v>2.9499999999999999E-3</c:v>
                  </c:pt>
                  <c:pt idx="5">
                    <c:v>2.8E-3</c:v>
                  </c:pt>
                  <c:pt idx="6">
                    <c:v>2.8999999999999998E-3</c:v>
                  </c:pt>
                  <c:pt idx="7">
                    <c:v>2.7499999999999998E-3</c:v>
                  </c:pt>
                  <c:pt idx="8">
                    <c:v>2.8999999999999998E-3</c:v>
                  </c:pt>
                  <c:pt idx="9">
                    <c:v>3.2000000000000002E-3</c:v>
                  </c:pt>
                  <c:pt idx="10">
                    <c:v>3.15E-3</c:v>
                  </c:pt>
                  <c:pt idx="11">
                    <c:v>2.5999999999999999E-3</c:v>
                  </c:pt>
                  <c:pt idx="12">
                    <c:v>3.0000000000000001E-3</c:v>
                  </c:pt>
                  <c:pt idx="13">
                    <c:v>3.3E-3</c:v>
                  </c:pt>
                  <c:pt idx="14">
                    <c:v>3.4499999999999999E-3</c:v>
                  </c:pt>
                  <c:pt idx="15">
                    <c:v>3.5500000000000002E-3</c:v>
                  </c:pt>
                  <c:pt idx="16">
                    <c:v>3.7000000000000002E-3</c:v>
                  </c:pt>
                  <c:pt idx="17">
                    <c:v>4.0499999999999998E-3</c:v>
                  </c:pt>
                  <c:pt idx="18">
                    <c:v>4.4000000000000003E-3</c:v>
                  </c:pt>
                  <c:pt idx="19">
                    <c:v>3.3999999999999998E-3</c:v>
                  </c:pt>
                  <c:pt idx="20">
                    <c:v>4.1999999999999997E-3</c:v>
                  </c:pt>
                  <c:pt idx="21">
                    <c:v>4.0000000000000001E-3</c:v>
                  </c:pt>
                  <c:pt idx="22">
                    <c:v>4.15E-3</c:v>
                  </c:pt>
                  <c:pt idx="23">
                    <c:v>4.3499999999999997E-3</c:v>
                  </c:pt>
                  <c:pt idx="24">
                    <c:v>4.8500000000000001E-3</c:v>
                  </c:pt>
                  <c:pt idx="25">
                    <c:v>4.7000000000000002E-3</c:v>
                  </c:pt>
                  <c:pt idx="26">
                    <c:v>4.9500000000000004E-3</c:v>
                  </c:pt>
                  <c:pt idx="27">
                    <c:v>4.3E-3</c:v>
                  </c:pt>
                  <c:pt idx="28">
                    <c:v>4.9500000000000004E-3</c:v>
                  </c:pt>
                  <c:pt idx="29">
                    <c:v>4.7000000000000002E-3</c:v>
                  </c:pt>
                  <c:pt idx="30">
                    <c:v>4.5999999999999999E-3</c:v>
                  </c:pt>
                  <c:pt idx="31">
                    <c:v>4.9500000000000004E-3</c:v>
                  </c:pt>
                  <c:pt idx="32">
                    <c:v>4.7499999999999999E-3</c:v>
                  </c:pt>
                  <c:pt idx="33">
                    <c:v>5.1500000000000001E-3</c:v>
                  </c:pt>
                  <c:pt idx="34">
                    <c:v>4.3E-3</c:v>
                  </c:pt>
                  <c:pt idx="35">
                    <c:v>4.5999999999999999E-3</c:v>
                  </c:pt>
                  <c:pt idx="36">
                    <c:v>4.6499999999999996E-3</c:v>
                  </c:pt>
                  <c:pt idx="37">
                    <c:v>4.9500000000000004E-3</c:v>
                  </c:pt>
                  <c:pt idx="38">
                    <c:v>4.5999999999999999E-3</c:v>
                  </c:pt>
                  <c:pt idx="39">
                    <c:v>4.7999999999999996E-3</c:v>
                  </c:pt>
                  <c:pt idx="40">
                    <c:v>4.7999999999999996E-3</c:v>
                  </c:pt>
                  <c:pt idx="41">
                    <c:v>5.3E-3</c:v>
                  </c:pt>
                  <c:pt idx="42">
                    <c:v>4.8500000000000001E-3</c:v>
                  </c:pt>
                  <c:pt idx="43">
                    <c:v>4.0499999999999998E-3</c:v>
                  </c:pt>
                  <c:pt idx="44">
                    <c:v>4.7499999999999999E-3</c:v>
                  </c:pt>
                  <c:pt idx="45">
                    <c:v>4.1000000000000003E-3</c:v>
                  </c:pt>
                  <c:pt idx="46">
                    <c:v>5.2500000000000003E-3</c:v>
                  </c:pt>
                  <c:pt idx="47">
                    <c:v>4.3E-3</c:v>
                  </c:pt>
                  <c:pt idx="48">
                    <c:v>3.7000000000000002E-3</c:v>
                  </c:pt>
                  <c:pt idx="49">
                    <c:v>4.15E-3</c:v>
                  </c:pt>
                  <c:pt idx="50">
                    <c:v>4.0499999999999998E-3</c:v>
                  </c:pt>
                  <c:pt idx="51">
                    <c:v>4.6499999999999996E-3</c:v>
                  </c:pt>
                  <c:pt idx="52">
                    <c:v>4.8999999999999998E-3</c:v>
                  </c:pt>
                  <c:pt idx="53">
                    <c:v>4.7499999999999999E-3</c:v>
                  </c:pt>
                  <c:pt idx="54">
                    <c:v>4.4999999999999997E-3</c:v>
                  </c:pt>
                  <c:pt idx="55">
                    <c:v>4.6499999999999996E-3</c:v>
                  </c:pt>
                  <c:pt idx="56">
                    <c:v>7.45E-3</c:v>
                  </c:pt>
                  <c:pt idx="57">
                    <c:v>7.3499999999999998E-3</c:v>
                  </c:pt>
                  <c:pt idx="58">
                    <c:v>7.9500000000000005E-3</c:v>
                  </c:pt>
                  <c:pt idx="59">
                    <c:v>7.7999999999999996E-3</c:v>
                  </c:pt>
                  <c:pt idx="60">
                    <c:v>8.3000000000000001E-3</c:v>
                  </c:pt>
                  <c:pt idx="61">
                    <c:v>8.5000000000000006E-3</c:v>
                  </c:pt>
                  <c:pt idx="62">
                    <c:v>8.6E-3</c:v>
                  </c:pt>
                  <c:pt idx="63">
                    <c:v>7.8499999999999993E-3</c:v>
                  </c:pt>
                  <c:pt idx="64">
                    <c:v>8.3499999999999998E-3</c:v>
                  </c:pt>
                  <c:pt idx="65">
                    <c:v>8.6E-3</c:v>
                  </c:pt>
                  <c:pt idx="66">
                    <c:v>8.6499999999999997E-3</c:v>
                  </c:pt>
                  <c:pt idx="67">
                    <c:v>9.3500000000000007E-3</c:v>
                  </c:pt>
                  <c:pt idx="68">
                    <c:v>9.0500000000000008E-3</c:v>
                  </c:pt>
                  <c:pt idx="69">
                    <c:v>9.1500000000000001E-3</c:v>
                  </c:pt>
                  <c:pt idx="70">
                    <c:v>9.2999999999999992E-3</c:v>
                  </c:pt>
                  <c:pt idx="71">
                    <c:v>1.01E-2</c:v>
                  </c:pt>
                  <c:pt idx="72">
                    <c:v>1.01E-2</c:v>
                  </c:pt>
                  <c:pt idx="73">
                    <c:v>1.0500000000000001E-2</c:v>
                  </c:pt>
                  <c:pt idx="74">
                    <c:v>1.04E-2</c:v>
                  </c:pt>
                  <c:pt idx="75">
                    <c:v>1.0500000000000001E-2</c:v>
                  </c:pt>
                  <c:pt idx="76">
                    <c:v>1.11E-2</c:v>
                  </c:pt>
                  <c:pt idx="77">
                    <c:v>1.1350000000000001E-2</c:v>
                  </c:pt>
                  <c:pt idx="78">
                    <c:v>1.1299999999999999E-2</c:v>
                  </c:pt>
                  <c:pt idx="79">
                    <c:v>1.2200000000000001E-2</c:v>
                  </c:pt>
                  <c:pt idx="80">
                    <c:v>1.35E-2</c:v>
                  </c:pt>
                  <c:pt idx="81">
                    <c:v>1.3899999999999999E-2</c:v>
                  </c:pt>
                  <c:pt idx="82">
                    <c:v>1.375E-2</c:v>
                  </c:pt>
                  <c:pt idx="83">
                    <c:v>1.485E-2</c:v>
                  </c:pt>
                  <c:pt idx="84">
                    <c:v>1.52E-2</c:v>
                  </c:pt>
                  <c:pt idx="85">
                    <c:v>1.61E-2</c:v>
                  </c:pt>
                  <c:pt idx="86">
                    <c:v>1.67E-2</c:v>
                  </c:pt>
                  <c:pt idx="87">
                    <c:v>1.7250000000000001E-2</c:v>
                  </c:pt>
                  <c:pt idx="88">
                    <c:v>1.7399999999999999E-2</c:v>
                  </c:pt>
                  <c:pt idx="89">
                    <c:v>1.7999999999999999E-2</c:v>
                  </c:pt>
                  <c:pt idx="90">
                    <c:v>1.8149999999999999E-2</c:v>
                  </c:pt>
                  <c:pt idx="91">
                    <c:v>1.83E-2</c:v>
                  </c:pt>
                  <c:pt idx="92">
                    <c:v>1.8550000000000001E-2</c:v>
                  </c:pt>
                  <c:pt idx="93">
                    <c:v>1.8149999999999999E-2</c:v>
                  </c:pt>
                  <c:pt idx="94">
                    <c:v>1.8700000000000001E-2</c:v>
                  </c:pt>
                  <c:pt idx="95">
                    <c:v>1.9050000000000001E-2</c:v>
                  </c:pt>
                  <c:pt idx="96">
                    <c:v>1.9300000000000001E-2</c:v>
                  </c:pt>
                  <c:pt idx="97">
                    <c:v>2.0049999999999998E-2</c:v>
                  </c:pt>
                  <c:pt idx="98">
                    <c:v>2.035E-2</c:v>
                  </c:pt>
                  <c:pt idx="99">
                    <c:v>2.1250000000000002E-2</c:v>
                  </c:pt>
                  <c:pt idx="100">
                    <c:v>2.06E-2</c:v>
                  </c:pt>
                  <c:pt idx="101">
                    <c:v>2.1100000000000001E-2</c:v>
                  </c:pt>
                  <c:pt idx="102">
                    <c:v>2.2450000000000001E-2</c:v>
                  </c:pt>
                  <c:pt idx="103">
                    <c:v>2.18E-2</c:v>
                  </c:pt>
                  <c:pt idx="104">
                    <c:v>2.3449999999999999E-2</c:v>
                  </c:pt>
                  <c:pt idx="105">
                    <c:v>2.385E-2</c:v>
                  </c:pt>
                  <c:pt idx="106">
                    <c:v>2.4400000000000002E-2</c:v>
                  </c:pt>
                  <c:pt idx="107">
                    <c:v>2.4299999999999999E-2</c:v>
                  </c:pt>
                  <c:pt idx="108">
                    <c:v>2.46E-2</c:v>
                  </c:pt>
                  <c:pt idx="109">
                    <c:v>2.5350000000000001E-2</c:v>
                  </c:pt>
                  <c:pt idx="110">
                    <c:v>2.7099999999999999E-2</c:v>
                  </c:pt>
                  <c:pt idx="111">
                    <c:v>2.8500000000000001E-2</c:v>
                  </c:pt>
                  <c:pt idx="112">
                    <c:v>2.92E-2</c:v>
                  </c:pt>
                  <c:pt idx="113">
                    <c:v>3.0300000000000001E-2</c:v>
                  </c:pt>
                  <c:pt idx="114">
                    <c:v>3.2099999999999997E-2</c:v>
                  </c:pt>
                  <c:pt idx="115">
                    <c:v>3.3149999999999999E-2</c:v>
                  </c:pt>
                  <c:pt idx="116">
                    <c:v>3.4599999999999999E-2</c:v>
                  </c:pt>
                  <c:pt idx="117">
                    <c:v>3.5299999999999998E-2</c:v>
                  </c:pt>
                  <c:pt idx="118">
                    <c:v>3.7350000000000001E-2</c:v>
                  </c:pt>
                  <c:pt idx="119">
                    <c:v>3.8350000000000002E-2</c:v>
                  </c:pt>
                  <c:pt idx="120">
                    <c:v>4.02E-2</c:v>
                  </c:pt>
                  <c:pt idx="121">
                    <c:v>4.0550000000000003E-2</c:v>
                  </c:pt>
                  <c:pt idx="122">
                    <c:v>4.0800000000000003E-2</c:v>
                  </c:pt>
                  <c:pt idx="123">
                    <c:v>4.1300000000000003E-2</c:v>
                  </c:pt>
                  <c:pt idx="124">
                    <c:v>4.2750000000000003E-2</c:v>
                  </c:pt>
                  <c:pt idx="125">
                    <c:v>4.4200000000000003E-2</c:v>
                  </c:pt>
                  <c:pt idx="126">
                    <c:v>4.6249999999999999E-2</c:v>
                  </c:pt>
                  <c:pt idx="127">
                    <c:v>4.7899999999999998E-2</c:v>
                  </c:pt>
                  <c:pt idx="128">
                    <c:v>4.895E-2</c:v>
                  </c:pt>
                  <c:pt idx="129">
                    <c:v>5.1549999999999999E-2</c:v>
                  </c:pt>
                  <c:pt idx="130">
                    <c:v>5.2749999999999998E-2</c:v>
                  </c:pt>
                  <c:pt idx="131">
                    <c:v>5.5550000000000002E-2</c:v>
                  </c:pt>
                  <c:pt idx="132">
                    <c:v>5.6950000000000001E-2</c:v>
                  </c:pt>
                  <c:pt idx="133">
                    <c:v>5.7849999999999999E-2</c:v>
                  </c:pt>
                  <c:pt idx="134">
                    <c:v>6.1499999999999999E-2</c:v>
                  </c:pt>
                  <c:pt idx="135">
                    <c:v>6.2649999999999997E-2</c:v>
                  </c:pt>
                  <c:pt idx="136">
                    <c:v>6.4049999999999996E-2</c:v>
                  </c:pt>
                  <c:pt idx="137">
                    <c:v>6.6299999999999998E-2</c:v>
                  </c:pt>
                  <c:pt idx="138">
                    <c:v>6.83E-2</c:v>
                  </c:pt>
                  <c:pt idx="139">
                    <c:v>6.9949999999999998E-2</c:v>
                  </c:pt>
                  <c:pt idx="140">
                    <c:v>7.5149999999999995E-2</c:v>
                  </c:pt>
                  <c:pt idx="141">
                    <c:v>7.6100000000000001E-2</c:v>
                  </c:pt>
                  <c:pt idx="142">
                    <c:v>7.8750000000000001E-2</c:v>
                  </c:pt>
                  <c:pt idx="143">
                    <c:v>8.0199999999999994E-2</c:v>
                  </c:pt>
                  <c:pt idx="144">
                    <c:v>8.3049999999999999E-2</c:v>
                  </c:pt>
                  <c:pt idx="145">
                    <c:v>8.5449999999999998E-2</c:v>
                  </c:pt>
                  <c:pt idx="146">
                    <c:v>8.7400000000000005E-2</c:v>
                  </c:pt>
                  <c:pt idx="147">
                    <c:v>8.8900000000000007E-2</c:v>
                  </c:pt>
                  <c:pt idx="148">
                    <c:v>9.1950000000000004E-2</c:v>
                  </c:pt>
                  <c:pt idx="149">
                    <c:v>9.4450000000000006E-2</c:v>
                  </c:pt>
                  <c:pt idx="150">
                    <c:v>9.7299999999999998E-2</c:v>
                  </c:pt>
                  <c:pt idx="151">
                    <c:v>9.9599999999999994E-2</c:v>
                  </c:pt>
                  <c:pt idx="152">
                    <c:v>0.10305</c:v>
                  </c:pt>
                  <c:pt idx="153">
                    <c:v>0.10630000000000001</c:v>
                  </c:pt>
                  <c:pt idx="154">
                    <c:v>0.1087</c:v>
                  </c:pt>
                  <c:pt idx="155">
                    <c:v>0.1084</c:v>
                  </c:pt>
                  <c:pt idx="156">
                    <c:v>0.112</c:v>
                  </c:pt>
                  <c:pt idx="157">
                    <c:v>0.11645</c:v>
                  </c:pt>
                  <c:pt idx="158">
                    <c:v>0.11890000000000001</c:v>
                  </c:pt>
                  <c:pt idx="159">
                    <c:v>0.1198</c:v>
                  </c:pt>
                  <c:pt idx="160">
                    <c:v>0.12145</c:v>
                  </c:pt>
                </c:numCache>
              </c:numRef>
            </c:plus>
            <c:minus>
              <c:numRef>
                <c:f>WT4Gel!$D$2:$D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2.0999999999999999E-3</c:v>
                  </c:pt>
                  <c:pt idx="2">
                    <c:v>2.8500000000000001E-3</c:v>
                  </c:pt>
                  <c:pt idx="3">
                    <c:v>1.8500000000000001E-3</c:v>
                  </c:pt>
                  <c:pt idx="4">
                    <c:v>2.9499999999999999E-3</c:v>
                  </c:pt>
                  <c:pt idx="5">
                    <c:v>2.8E-3</c:v>
                  </c:pt>
                  <c:pt idx="6">
                    <c:v>2.8999999999999998E-3</c:v>
                  </c:pt>
                  <c:pt idx="7">
                    <c:v>2.7499999999999998E-3</c:v>
                  </c:pt>
                  <c:pt idx="8">
                    <c:v>2.8999999999999998E-3</c:v>
                  </c:pt>
                  <c:pt idx="9">
                    <c:v>3.2000000000000002E-3</c:v>
                  </c:pt>
                  <c:pt idx="10">
                    <c:v>3.15E-3</c:v>
                  </c:pt>
                  <c:pt idx="11">
                    <c:v>2.5999999999999999E-3</c:v>
                  </c:pt>
                  <c:pt idx="12">
                    <c:v>3.0000000000000001E-3</c:v>
                  </c:pt>
                  <c:pt idx="13">
                    <c:v>3.3E-3</c:v>
                  </c:pt>
                  <c:pt idx="14">
                    <c:v>3.4499999999999999E-3</c:v>
                  </c:pt>
                  <c:pt idx="15">
                    <c:v>3.5500000000000002E-3</c:v>
                  </c:pt>
                  <c:pt idx="16">
                    <c:v>3.7000000000000002E-3</c:v>
                  </c:pt>
                  <c:pt idx="17">
                    <c:v>4.0499999999999998E-3</c:v>
                  </c:pt>
                  <c:pt idx="18">
                    <c:v>4.4000000000000003E-3</c:v>
                  </c:pt>
                  <c:pt idx="19">
                    <c:v>3.3999999999999998E-3</c:v>
                  </c:pt>
                  <c:pt idx="20">
                    <c:v>4.1999999999999997E-3</c:v>
                  </c:pt>
                  <c:pt idx="21">
                    <c:v>4.0000000000000001E-3</c:v>
                  </c:pt>
                  <c:pt idx="22">
                    <c:v>4.15E-3</c:v>
                  </c:pt>
                  <c:pt idx="23">
                    <c:v>4.3499999999999997E-3</c:v>
                  </c:pt>
                  <c:pt idx="24">
                    <c:v>4.8500000000000001E-3</c:v>
                  </c:pt>
                  <c:pt idx="25">
                    <c:v>4.7000000000000002E-3</c:v>
                  </c:pt>
                  <c:pt idx="26">
                    <c:v>4.9500000000000004E-3</c:v>
                  </c:pt>
                  <c:pt idx="27">
                    <c:v>4.3E-3</c:v>
                  </c:pt>
                  <c:pt idx="28">
                    <c:v>4.9500000000000004E-3</c:v>
                  </c:pt>
                  <c:pt idx="29">
                    <c:v>4.7000000000000002E-3</c:v>
                  </c:pt>
                  <c:pt idx="30">
                    <c:v>4.5999999999999999E-3</c:v>
                  </c:pt>
                  <c:pt idx="31">
                    <c:v>4.9500000000000004E-3</c:v>
                  </c:pt>
                  <c:pt idx="32">
                    <c:v>4.7499999999999999E-3</c:v>
                  </c:pt>
                  <c:pt idx="33">
                    <c:v>5.1500000000000001E-3</c:v>
                  </c:pt>
                  <c:pt idx="34">
                    <c:v>4.3E-3</c:v>
                  </c:pt>
                  <c:pt idx="35">
                    <c:v>4.5999999999999999E-3</c:v>
                  </c:pt>
                  <c:pt idx="36">
                    <c:v>4.6499999999999996E-3</c:v>
                  </c:pt>
                  <c:pt idx="37">
                    <c:v>4.9500000000000004E-3</c:v>
                  </c:pt>
                  <c:pt idx="38">
                    <c:v>4.5999999999999999E-3</c:v>
                  </c:pt>
                  <c:pt idx="39">
                    <c:v>4.7999999999999996E-3</c:v>
                  </c:pt>
                  <c:pt idx="40">
                    <c:v>4.7999999999999996E-3</c:v>
                  </c:pt>
                  <c:pt idx="41">
                    <c:v>5.3E-3</c:v>
                  </c:pt>
                  <c:pt idx="42">
                    <c:v>4.8500000000000001E-3</c:v>
                  </c:pt>
                  <c:pt idx="43">
                    <c:v>4.0499999999999998E-3</c:v>
                  </c:pt>
                  <c:pt idx="44">
                    <c:v>4.7499999999999999E-3</c:v>
                  </c:pt>
                  <c:pt idx="45">
                    <c:v>4.1000000000000003E-3</c:v>
                  </c:pt>
                  <c:pt idx="46">
                    <c:v>5.2500000000000003E-3</c:v>
                  </c:pt>
                  <c:pt idx="47">
                    <c:v>4.3E-3</c:v>
                  </c:pt>
                  <c:pt idx="48">
                    <c:v>3.7000000000000002E-3</c:v>
                  </c:pt>
                  <c:pt idx="49">
                    <c:v>4.15E-3</c:v>
                  </c:pt>
                  <c:pt idx="50">
                    <c:v>4.0499999999999998E-3</c:v>
                  </c:pt>
                  <c:pt idx="51">
                    <c:v>4.6499999999999996E-3</c:v>
                  </c:pt>
                  <c:pt idx="52">
                    <c:v>4.8999999999999998E-3</c:v>
                  </c:pt>
                  <c:pt idx="53">
                    <c:v>4.7499999999999999E-3</c:v>
                  </c:pt>
                  <c:pt idx="54">
                    <c:v>4.4999999999999997E-3</c:v>
                  </c:pt>
                  <c:pt idx="55">
                    <c:v>4.6499999999999996E-3</c:v>
                  </c:pt>
                  <c:pt idx="56">
                    <c:v>7.45E-3</c:v>
                  </c:pt>
                  <c:pt idx="57">
                    <c:v>7.3499999999999998E-3</c:v>
                  </c:pt>
                  <c:pt idx="58">
                    <c:v>7.9500000000000005E-3</c:v>
                  </c:pt>
                  <c:pt idx="59">
                    <c:v>7.7999999999999996E-3</c:v>
                  </c:pt>
                  <c:pt idx="60">
                    <c:v>8.3000000000000001E-3</c:v>
                  </c:pt>
                  <c:pt idx="61">
                    <c:v>8.5000000000000006E-3</c:v>
                  </c:pt>
                  <c:pt idx="62">
                    <c:v>8.6E-3</c:v>
                  </c:pt>
                  <c:pt idx="63">
                    <c:v>7.8499999999999993E-3</c:v>
                  </c:pt>
                  <c:pt idx="64">
                    <c:v>8.3499999999999998E-3</c:v>
                  </c:pt>
                  <c:pt idx="65">
                    <c:v>8.6E-3</c:v>
                  </c:pt>
                  <c:pt idx="66">
                    <c:v>8.6499999999999997E-3</c:v>
                  </c:pt>
                  <c:pt idx="67">
                    <c:v>9.3500000000000007E-3</c:v>
                  </c:pt>
                  <c:pt idx="68">
                    <c:v>9.0500000000000008E-3</c:v>
                  </c:pt>
                  <c:pt idx="69">
                    <c:v>9.1500000000000001E-3</c:v>
                  </c:pt>
                  <c:pt idx="70">
                    <c:v>9.2999999999999992E-3</c:v>
                  </c:pt>
                  <c:pt idx="71">
                    <c:v>1.01E-2</c:v>
                  </c:pt>
                  <c:pt idx="72">
                    <c:v>1.01E-2</c:v>
                  </c:pt>
                  <c:pt idx="73">
                    <c:v>1.0500000000000001E-2</c:v>
                  </c:pt>
                  <c:pt idx="74">
                    <c:v>1.04E-2</c:v>
                  </c:pt>
                  <c:pt idx="75">
                    <c:v>1.0500000000000001E-2</c:v>
                  </c:pt>
                  <c:pt idx="76">
                    <c:v>1.11E-2</c:v>
                  </c:pt>
                  <c:pt idx="77">
                    <c:v>1.1350000000000001E-2</c:v>
                  </c:pt>
                  <c:pt idx="78">
                    <c:v>1.1299999999999999E-2</c:v>
                  </c:pt>
                  <c:pt idx="79">
                    <c:v>1.2200000000000001E-2</c:v>
                  </c:pt>
                  <c:pt idx="80">
                    <c:v>1.35E-2</c:v>
                  </c:pt>
                  <c:pt idx="81">
                    <c:v>1.3899999999999999E-2</c:v>
                  </c:pt>
                  <c:pt idx="82">
                    <c:v>1.375E-2</c:v>
                  </c:pt>
                  <c:pt idx="83">
                    <c:v>1.485E-2</c:v>
                  </c:pt>
                  <c:pt idx="84">
                    <c:v>1.52E-2</c:v>
                  </c:pt>
                  <c:pt idx="85">
                    <c:v>1.61E-2</c:v>
                  </c:pt>
                  <c:pt idx="86">
                    <c:v>1.67E-2</c:v>
                  </c:pt>
                  <c:pt idx="87">
                    <c:v>1.7250000000000001E-2</c:v>
                  </c:pt>
                  <c:pt idx="88">
                    <c:v>1.7399999999999999E-2</c:v>
                  </c:pt>
                  <c:pt idx="89">
                    <c:v>1.7999999999999999E-2</c:v>
                  </c:pt>
                  <c:pt idx="90">
                    <c:v>1.8149999999999999E-2</c:v>
                  </c:pt>
                  <c:pt idx="91">
                    <c:v>1.83E-2</c:v>
                  </c:pt>
                  <c:pt idx="92">
                    <c:v>1.8550000000000001E-2</c:v>
                  </c:pt>
                  <c:pt idx="93">
                    <c:v>1.8149999999999999E-2</c:v>
                  </c:pt>
                  <c:pt idx="94">
                    <c:v>1.8700000000000001E-2</c:v>
                  </c:pt>
                  <c:pt idx="95">
                    <c:v>1.9050000000000001E-2</c:v>
                  </c:pt>
                  <c:pt idx="96">
                    <c:v>1.9300000000000001E-2</c:v>
                  </c:pt>
                  <c:pt idx="97">
                    <c:v>2.0049999999999998E-2</c:v>
                  </c:pt>
                  <c:pt idx="98">
                    <c:v>2.035E-2</c:v>
                  </c:pt>
                  <c:pt idx="99">
                    <c:v>2.1250000000000002E-2</c:v>
                  </c:pt>
                  <c:pt idx="100">
                    <c:v>2.06E-2</c:v>
                  </c:pt>
                  <c:pt idx="101">
                    <c:v>2.1100000000000001E-2</c:v>
                  </c:pt>
                  <c:pt idx="102">
                    <c:v>2.2450000000000001E-2</c:v>
                  </c:pt>
                  <c:pt idx="103">
                    <c:v>2.18E-2</c:v>
                  </c:pt>
                  <c:pt idx="104">
                    <c:v>2.3449999999999999E-2</c:v>
                  </c:pt>
                  <c:pt idx="105">
                    <c:v>2.385E-2</c:v>
                  </c:pt>
                  <c:pt idx="106">
                    <c:v>2.4400000000000002E-2</c:v>
                  </c:pt>
                  <c:pt idx="107">
                    <c:v>2.4299999999999999E-2</c:v>
                  </c:pt>
                  <c:pt idx="108">
                    <c:v>2.46E-2</c:v>
                  </c:pt>
                  <c:pt idx="109">
                    <c:v>2.5350000000000001E-2</c:v>
                  </c:pt>
                  <c:pt idx="110">
                    <c:v>2.7099999999999999E-2</c:v>
                  </c:pt>
                  <c:pt idx="111">
                    <c:v>2.8500000000000001E-2</c:v>
                  </c:pt>
                  <c:pt idx="112">
                    <c:v>2.92E-2</c:v>
                  </c:pt>
                  <c:pt idx="113">
                    <c:v>3.0300000000000001E-2</c:v>
                  </c:pt>
                  <c:pt idx="114">
                    <c:v>3.2099999999999997E-2</c:v>
                  </c:pt>
                  <c:pt idx="115">
                    <c:v>3.3149999999999999E-2</c:v>
                  </c:pt>
                  <c:pt idx="116">
                    <c:v>3.4599999999999999E-2</c:v>
                  </c:pt>
                  <c:pt idx="117">
                    <c:v>3.5299999999999998E-2</c:v>
                  </c:pt>
                  <c:pt idx="118">
                    <c:v>3.7350000000000001E-2</c:v>
                  </c:pt>
                  <c:pt idx="119">
                    <c:v>3.8350000000000002E-2</c:v>
                  </c:pt>
                  <c:pt idx="120">
                    <c:v>4.02E-2</c:v>
                  </c:pt>
                  <c:pt idx="121">
                    <c:v>4.0550000000000003E-2</c:v>
                  </c:pt>
                  <c:pt idx="122">
                    <c:v>4.0800000000000003E-2</c:v>
                  </c:pt>
                  <c:pt idx="123">
                    <c:v>4.1300000000000003E-2</c:v>
                  </c:pt>
                  <c:pt idx="124">
                    <c:v>4.2750000000000003E-2</c:v>
                  </c:pt>
                  <c:pt idx="125">
                    <c:v>4.4200000000000003E-2</c:v>
                  </c:pt>
                  <c:pt idx="126">
                    <c:v>4.6249999999999999E-2</c:v>
                  </c:pt>
                  <c:pt idx="127">
                    <c:v>4.7899999999999998E-2</c:v>
                  </c:pt>
                  <c:pt idx="128">
                    <c:v>4.895E-2</c:v>
                  </c:pt>
                  <c:pt idx="129">
                    <c:v>5.1549999999999999E-2</c:v>
                  </c:pt>
                  <c:pt idx="130">
                    <c:v>5.2749999999999998E-2</c:v>
                  </c:pt>
                  <c:pt idx="131">
                    <c:v>5.5550000000000002E-2</c:v>
                  </c:pt>
                  <c:pt idx="132">
                    <c:v>5.6950000000000001E-2</c:v>
                  </c:pt>
                  <c:pt idx="133">
                    <c:v>5.7849999999999999E-2</c:v>
                  </c:pt>
                  <c:pt idx="134">
                    <c:v>6.1499999999999999E-2</c:v>
                  </c:pt>
                  <c:pt idx="135">
                    <c:v>6.2649999999999997E-2</c:v>
                  </c:pt>
                  <c:pt idx="136">
                    <c:v>6.4049999999999996E-2</c:v>
                  </c:pt>
                  <c:pt idx="137">
                    <c:v>6.6299999999999998E-2</c:v>
                  </c:pt>
                  <c:pt idx="138">
                    <c:v>6.83E-2</c:v>
                  </c:pt>
                  <c:pt idx="139">
                    <c:v>6.9949999999999998E-2</c:v>
                  </c:pt>
                  <c:pt idx="140">
                    <c:v>7.5149999999999995E-2</c:v>
                  </c:pt>
                  <c:pt idx="141">
                    <c:v>7.6100000000000001E-2</c:v>
                  </c:pt>
                  <c:pt idx="142">
                    <c:v>7.8750000000000001E-2</c:v>
                  </c:pt>
                  <c:pt idx="143">
                    <c:v>8.0199999999999994E-2</c:v>
                  </c:pt>
                  <c:pt idx="144">
                    <c:v>8.3049999999999999E-2</c:v>
                  </c:pt>
                  <c:pt idx="145">
                    <c:v>8.5449999999999998E-2</c:v>
                  </c:pt>
                  <c:pt idx="146">
                    <c:v>8.7400000000000005E-2</c:v>
                  </c:pt>
                  <c:pt idx="147">
                    <c:v>8.8900000000000007E-2</c:v>
                  </c:pt>
                  <c:pt idx="148">
                    <c:v>9.1950000000000004E-2</c:v>
                  </c:pt>
                  <c:pt idx="149">
                    <c:v>9.4450000000000006E-2</c:v>
                  </c:pt>
                  <c:pt idx="150">
                    <c:v>9.7299999999999998E-2</c:v>
                  </c:pt>
                  <c:pt idx="151">
                    <c:v>9.9599999999999994E-2</c:v>
                  </c:pt>
                  <c:pt idx="152">
                    <c:v>0.10305</c:v>
                  </c:pt>
                  <c:pt idx="153">
                    <c:v>0.10630000000000001</c:v>
                  </c:pt>
                  <c:pt idx="154">
                    <c:v>0.1087</c:v>
                  </c:pt>
                  <c:pt idx="155">
                    <c:v>0.1084</c:v>
                  </c:pt>
                  <c:pt idx="156">
                    <c:v>0.112</c:v>
                  </c:pt>
                  <c:pt idx="157">
                    <c:v>0.11645</c:v>
                  </c:pt>
                  <c:pt idx="158">
                    <c:v>0.11890000000000001</c:v>
                  </c:pt>
                  <c:pt idx="159">
                    <c:v>0.1198</c:v>
                  </c:pt>
                  <c:pt idx="160">
                    <c:v>0.12145</c:v>
                  </c:pt>
                </c:numCache>
              </c:numRef>
            </c:minus>
            <c:spPr>
              <a:ln>
                <a:solidFill>
                  <a:schemeClr val="accent1">
                    <a:alpha val="50000"/>
                  </a:schemeClr>
                </a:solidFill>
              </a:ln>
            </c:spPr>
          </c:errBars>
          <c:xVal>
            <c:numRef>
              <c:f>WT4Gel!$A$2:$A$174</c:f>
              <c:numCache>
                <c:formatCode>General</c:formatCode>
                <c:ptCount val="173"/>
                <c:pt idx="0">
                  <c:v>0</c:v>
                </c:pt>
                <c:pt idx="1">
                  <c:v>3.5999999999999999E-3</c:v>
                </c:pt>
                <c:pt idx="2">
                  <c:v>0.23080000000000001</c:v>
                </c:pt>
                <c:pt idx="3">
                  <c:v>0.48080000000000001</c:v>
                </c:pt>
                <c:pt idx="4">
                  <c:v>0.73109999999999997</c:v>
                </c:pt>
                <c:pt idx="5">
                  <c:v>0.98140000000000005</c:v>
                </c:pt>
                <c:pt idx="6">
                  <c:v>1.2317</c:v>
                </c:pt>
                <c:pt idx="7">
                  <c:v>1.4819</c:v>
                </c:pt>
                <c:pt idx="8">
                  <c:v>1.7322</c:v>
                </c:pt>
                <c:pt idx="9">
                  <c:v>1.9824999999999999</c:v>
                </c:pt>
                <c:pt idx="10">
                  <c:v>2.2328000000000001</c:v>
                </c:pt>
                <c:pt idx="11">
                  <c:v>2.4830999999999999</c:v>
                </c:pt>
                <c:pt idx="12">
                  <c:v>2.7332999999999998</c:v>
                </c:pt>
                <c:pt idx="13">
                  <c:v>2.9836</c:v>
                </c:pt>
                <c:pt idx="14">
                  <c:v>3.2339000000000002</c:v>
                </c:pt>
                <c:pt idx="15">
                  <c:v>3.4842</c:v>
                </c:pt>
                <c:pt idx="16">
                  <c:v>3.7343999999999999</c:v>
                </c:pt>
                <c:pt idx="17">
                  <c:v>3.9847000000000001</c:v>
                </c:pt>
                <c:pt idx="18">
                  <c:v>4.2350000000000003</c:v>
                </c:pt>
                <c:pt idx="19">
                  <c:v>4.4852999999999996</c:v>
                </c:pt>
                <c:pt idx="20">
                  <c:v>4.7355999999999998</c:v>
                </c:pt>
                <c:pt idx="21">
                  <c:v>4.9858000000000002</c:v>
                </c:pt>
                <c:pt idx="22">
                  <c:v>5.2361000000000004</c:v>
                </c:pt>
                <c:pt idx="23">
                  <c:v>5.4863999999999997</c:v>
                </c:pt>
                <c:pt idx="24">
                  <c:v>5.7366999999999999</c:v>
                </c:pt>
                <c:pt idx="25">
                  <c:v>5.9869000000000003</c:v>
                </c:pt>
                <c:pt idx="26">
                  <c:v>6.2371999999999996</c:v>
                </c:pt>
                <c:pt idx="27">
                  <c:v>6.4874999999999998</c:v>
                </c:pt>
                <c:pt idx="28">
                  <c:v>6.7378</c:v>
                </c:pt>
                <c:pt idx="29">
                  <c:v>6.9881000000000002</c:v>
                </c:pt>
                <c:pt idx="30">
                  <c:v>7.2382999999999997</c:v>
                </c:pt>
                <c:pt idx="31">
                  <c:v>7.4885999999999999</c:v>
                </c:pt>
                <c:pt idx="32">
                  <c:v>7.7389000000000001</c:v>
                </c:pt>
                <c:pt idx="33">
                  <c:v>7.9892000000000003</c:v>
                </c:pt>
                <c:pt idx="34">
                  <c:v>8.2393999999999998</c:v>
                </c:pt>
                <c:pt idx="35">
                  <c:v>8.4896999999999991</c:v>
                </c:pt>
                <c:pt idx="36">
                  <c:v>8.74</c:v>
                </c:pt>
                <c:pt idx="37">
                  <c:v>8.9902999999999995</c:v>
                </c:pt>
                <c:pt idx="38">
                  <c:v>9.2406000000000006</c:v>
                </c:pt>
                <c:pt idx="39">
                  <c:v>9.4908000000000001</c:v>
                </c:pt>
                <c:pt idx="40">
                  <c:v>9.7410999999999994</c:v>
                </c:pt>
                <c:pt idx="41">
                  <c:v>9.9914000000000005</c:v>
                </c:pt>
                <c:pt idx="42">
                  <c:v>10.2417</c:v>
                </c:pt>
                <c:pt idx="43">
                  <c:v>10.491899999999999</c:v>
                </c:pt>
                <c:pt idx="44">
                  <c:v>10.7422</c:v>
                </c:pt>
                <c:pt idx="45">
                  <c:v>10.9925</c:v>
                </c:pt>
                <c:pt idx="46">
                  <c:v>11.242800000000001</c:v>
                </c:pt>
                <c:pt idx="47">
                  <c:v>11.4931</c:v>
                </c:pt>
                <c:pt idx="48">
                  <c:v>11.7433</c:v>
                </c:pt>
                <c:pt idx="49">
                  <c:v>11.993600000000001</c:v>
                </c:pt>
                <c:pt idx="50">
                  <c:v>12.2439</c:v>
                </c:pt>
                <c:pt idx="51">
                  <c:v>12.494199999999999</c:v>
                </c:pt>
                <c:pt idx="52">
                  <c:v>12.744400000000001</c:v>
                </c:pt>
                <c:pt idx="53">
                  <c:v>12.9947</c:v>
                </c:pt>
                <c:pt idx="54">
                  <c:v>13.244999999999999</c:v>
                </c:pt>
                <c:pt idx="55">
                  <c:v>13.4953</c:v>
                </c:pt>
                <c:pt idx="56">
                  <c:v>13.7456</c:v>
                </c:pt>
                <c:pt idx="57">
                  <c:v>13.995799999999999</c:v>
                </c:pt>
                <c:pt idx="58">
                  <c:v>14.2461</c:v>
                </c:pt>
                <c:pt idx="59">
                  <c:v>14.4964</c:v>
                </c:pt>
                <c:pt idx="60">
                  <c:v>14.746700000000001</c:v>
                </c:pt>
                <c:pt idx="61">
                  <c:v>14.9969</c:v>
                </c:pt>
                <c:pt idx="62">
                  <c:v>15.247199999999999</c:v>
                </c:pt>
                <c:pt idx="63">
                  <c:v>15.4975</c:v>
                </c:pt>
                <c:pt idx="64">
                  <c:v>15.7478</c:v>
                </c:pt>
                <c:pt idx="65">
                  <c:v>15.998100000000001</c:v>
                </c:pt>
                <c:pt idx="66">
                  <c:v>16.2483</c:v>
                </c:pt>
                <c:pt idx="67">
                  <c:v>16.4986</c:v>
                </c:pt>
                <c:pt idx="68">
                  <c:v>16.748899999999999</c:v>
                </c:pt>
                <c:pt idx="69">
                  <c:v>16.999199999999998</c:v>
                </c:pt>
                <c:pt idx="70">
                  <c:v>17.249400000000001</c:v>
                </c:pt>
                <c:pt idx="71">
                  <c:v>17.499700000000001</c:v>
                </c:pt>
                <c:pt idx="72">
                  <c:v>17.749700000000001</c:v>
                </c:pt>
                <c:pt idx="73">
                  <c:v>18</c:v>
                </c:pt>
                <c:pt idx="74">
                  <c:v>18.250299999999999</c:v>
                </c:pt>
                <c:pt idx="75">
                  <c:v>18.500599999999999</c:v>
                </c:pt>
                <c:pt idx="76">
                  <c:v>18.750800000000002</c:v>
                </c:pt>
                <c:pt idx="77">
                  <c:v>19.001100000000001</c:v>
                </c:pt>
                <c:pt idx="78">
                  <c:v>19.2514</c:v>
                </c:pt>
                <c:pt idx="79">
                  <c:v>19.5017</c:v>
                </c:pt>
                <c:pt idx="80">
                  <c:v>19.751899999999999</c:v>
                </c:pt>
                <c:pt idx="81">
                  <c:v>20.002199999999998</c:v>
                </c:pt>
                <c:pt idx="82">
                  <c:v>20.252500000000001</c:v>
                </c:pt>
                <c:pt idx="83">
                  <c:v>20.502800000000001</c:v>
                </c:pt>
                <c:pt idx="84">
                  <c:v>20.7531</c:v>
                </c:pt>
                <c:pt idx="85">
                  <c:v>21.003299999999999</c:v>
                </c:pt>
                <c:pt idx="86">
                  <c:v>21.253599999999999</c:v>
                </c:pt>
                <c:pt idx="87">
                  <c:v>21.503900000000002</c:v>
                </c:pt>
                <c:pt idx="88">
                  <c:v>21.754200000000001</c:v>
                </c:pt>
                <c:pt idx="89">
                  <c:v>22.0044</c:v>
                </c:pt>
                <c:pt idx="90">
                  <c:v>22.2547</c:v>
                </c:pt>
                <c:pt idx="91">
                  <c:v>22.504999999999999</c:v>
                </c:pt>
                <c:pt idx="92">
                  <c:v>22.755299999999998</c:v>
                </c:pt>
                <c:pt idx="93">
                  <c:v>23.005600000000001</c:v>
                </c:pt>
                <c:pt idx="94">
                  <c:v>23.255800000000001</c:v>
                </c:pt>
                <c:pt idx="95">
                  <c:v>23.4819</c:v>
                </c:pt>
                <c:pt idx="96">
                  <c:v>23.732199999999999</c:v>
                </c:pt>
                <c:pt idx="97">
                  <c:v>23.982500000000002</c:v>
                </c:pt>
                <c:pt idx="98">
                  <c:v>24.232800000000001</c:v>
                </c:pt>
                <c:pt idx="99">
                  <c:v>24.4831</c:v>
                </c:pt>
                <c:pt idx="100">
                  <c:v>24.7333</c:v>
                </c:pt>
                <c:pt idx="101">
                  <c:v>24.983599999999999</c:v>
                </c:pt>
                <c:pt idx="102">
                  <c:v>25.233899999999998</c:v>
                </c:pt>
                <c:pt idx="103">
                  <c:v>25.484200000000001</c:v>
                </c:pt>
                <c:pt idx="104">
                  <c:v>25.734400000000001</c:v>
                </c:pt>
                <c:pt idx="105">
                  <c:v>25.9847</c:v>
                </c:pt>
                <c:pt idx="106">
                  <c:v>26.234999999999999</c:v>
                </c:pt>
                <c:pt idx="107">
                  <c:v>26.485299999999999</c:v>
                </c:pt>
                <c:pt idx="108">
                  <c:v>26.735600000000002</c:v>
                </c:pt>
                <c:pt idx="109">
                  <c:v>26.985800000000001</c:v>
                </c:pt>
                <c:pt idx="110">
                  <c:v>27.2361</c:v>
                </c:pt>
                <c:pt idx="111">
                  <c:v>27.4864</c:v>
                </c:pt>
                <c:pt idx="112">
                  <c:v>27.736699999999999</c:v>
                </c:pt>
                <c:pt idx="113">
                  <c:v>27.986899999999999</c:v>
                </c:pt>
                <c:pt idx="114">
                  <c:v>28.237200000000001</c:v>
                </c:pt>
                <c:pt idx="115">
                  <c:v>28.487500000000001</c:v>
                </c:pt>
                <c:pt idx="116">
                  <c:v>28.7378</c:v>
                </c:pt>
                <c:pt idx="117">
                  <c:v>28.988099999999999</c:v>
                </c:pt>
                <c:pt idx="118">
                  <c:v>29.238299999999999</c:v>
                </c:pt>
                <c:pt idx="119">
                  <c:v>29.488600000000002</c:v>
                </c:pt>
                <c:pt idx="120">
                  <c:v>29.738900000000001</c:v>
                </c:pt>
                <c:pt idx="121">
                  <c:v>29.9892</c:v>
                </c:pt>
                <c:pt idx="122">
                  <c:v>30.2394</c:v>
                </c:pt>
                <c:pt idx="123">
                  <c:v>30.489699999999999</c:v>
                </c:pt>
                <c:pt idx="124">
                  <c:v>30.74</c:v>
                </c:pt>
                <c:pt idx="125">
                  <c:v>30.990300000000001</c:v>
                </c:pt>
                <c:pt idx="126">
                  <c:v>31.240600000000001</c:v>
                </c:pt>
                <c:pt idx="127">
                  <c:v>31.4908</c:v>
                </c:pt>
                <c:pt idx="128">
                  <c:v>31.741099999999999</c:v>
                </c:pt>
                <c:pt idx="129">
                  <c:v>31.991399999999999</c:v>
                </c:pt>
                <c:pt idx="130">
                  <c:v>32.241700000000002</c:v>
                </c:pt>
                <c:pt idx="131">
                  <c:v>32.491900000000001</c:v>
                </c:pt>
                <c:pt idx="132">
                  <c:v>32.742199999999997</c:v>
                </c:pt>
                <c:pt idx="133">
                  <c:v>32.9925</c:v>
                </c:pt>
                <c:pt idx="134">
                  <c:v>33.242800000000003</c:v>
                </c:pt>
                <c:pt idx="135">
                  <c:v>33.493099999999998</c:v>
                </c:pt>
                <c:pt idx="136">
                  <c:v>33.743299999999998</c:v>
                </c:pt>
                <c:pt idx="137">
                  <c:v>33.993600000000001</c:v>
                </c:pt>
                <c:pt idx="138">
                  <c:v>34.243899999999996</c:v>
                </c:pt>
                <c:pt idx="139">
                  <c:v>34.494199999999999</c:v>
                </c:pt>
                <c:pt idx="140">
                  <c:v>34.744399999999999</c:v>
                </c:pt>
                <c:pt idx="141">
                  <c:v>34.994700000000002</c:v>
                </c:pt>
                <c:pt idx="142">
                  <c:v>35.244999999999997</c:v>
                </c:pt>
                <c:pt idx="143">
                  <c:v>35.4953</c:v>
                </c:pt>
                <c:pt idx="144">
                  <c:v>35.745600000000003</c:v>
                </c:pt>
                <c:pt idx="145">
                  <c:v>35.995800000000003</c:v>
                </c:pt>
                <c:pt idx="146">
                  <c:v>36.246099999999998</c:v>
                </c:pt>
                <c:pt idx="147">
                  <c:v>36.496400000000001</c:v>
                </c:pt>
                <c:pt idx="148">
                  <c:v>36.746699999999997</c:v>
                </c:pt>
                <c:pt idx="149">
                  <c:v>36.996899999999997</c:v>
                </c:pt>
                <c:pt idx="150">
                  <c:v>37.247199999999999</c:v>
                </c:pt>
                <c:pt idx="151">
                  <c:v>37.497500000000002</c:v>
                </c:pt>
                <c:pt idx="152">
                  <c:v>37.747799999999998</c:v>
                </c:pt>
                <c:pt idx="153">
                  <c:v>37.998100000000001</c:v>
                </c:pt>
                <c:pt idx="154">
                  <c:v>38.2483</c:v>
                </c:pt>
                <c:pt idx="155">
                  <c:v>38.498600000000003</c:v>
                </c:pt>
                <c:pt idx="156">
                  <c:v>38.748899999999999</c:v>
                </c:pt>
                <c:pt idx="157">
                  <c:v>38.999200000000002</c:v>
                </c:pt>
                <c:pt idx="158">
                  <c:v>39.249400000000001</c:v>
                </c:pt>
                <c:pt idx="159">
                  <c:v>39.499699999999997</c:v>
                </c:pt>
                <c:pt idx="160">
                  <c:v>39.75</c:v>
                </c:pt>
              </c:numCache>
            </c:numRef>
          </c:xVal>
          <c:yVal>
            <c:numRef>
              <c:f>WT4Gel!$B$2:$B$162</c:f>
              <c:numCache>
                <c:formatCode>General</c:formatCode>
                <c:ptCount val="161"/>
                <c:pt idx="0">
                  <c:v>1</c:v>
                </c:pt>
                <c:pt idx="1">
                  <c:v>1.0021</c:v>
                </c:pt>
                <c:pt idx="2">
                  <c:v>1.0041</c:v>
                </c:pt>
                <c:pt idx="3">
                  <c:v>1.0047999999999999</c:v>
                </c:pt>
                <c:pt idx="4">
                  <c:v>1.0059</c:v>
                </c:pt>
                <c:pt idx="5">
                  <c:v>1.0071000000000001</c:v>
                </c:pt>
                <c:pt idx="6">
                  <c:v>1.0074000000000001</c:v>
                </c:pt>
                <c:pt idx="7">
                  <c:v>1.0084</c:v>
                </c:pt>
                <c:pt idx="8">
                  <c:v>1.0082</c:v>
                </c:pt>
                <c:pt idx="9">
                  <c:v>1.0103</c:v>
                </c:pt>
                <c:pt idx="10">
                  <c:v>1.0128999999999999</c:v>
                </c:pt>
                <c:pt idx="11">
                  <c:v>1.0108999999999999</c:v>
                </c:pt>
                <c:pt idx="12">
                  <c:v>1.0119</c:v>
                </c:pt>
                <c:pt idx="13">
                  <c:v>1.0124</c:v>
                </c:pt>
                <c:pt idx="14">
                  <c:v>1.0138</c:v>
                </c:pt>
                <c:pt idx="15">
                  <c:v>1.0154000000000001</c:v>
                </c:pt>
                <c:pt idx="16">
                  <c:v>1.0165999999999999</c:v>
                </c:pt>
                <c:pt idx="17">
                  <c:v>1.0163</c:v>
                </c:pt>
                <c:pt idx="18">
                  <c:v>1.0173000000000001</c:v>
                </c:pt>
                <c:pt idx="19">
                  <c:v>1.0181</c:v>
                </c:pt>
                <c:pt idx="20">
                  <c:v>1.0177</c:v>
                </c:pt>
                <c:pt idx="21">
                  <c:v>1.0186999999999999</c:v>
                </c:pt>
                <c:pt idx="22">
                  <c:v>1.0189999999999999</c:v>
                </c:pt>
                <c:pt idx="23">
                  <c:v>1.0198</c:v>
                </c:pt>
                <c:pt idx="24">
                  <c:v>1.0195000000000001</c:v>
                </c:pt>
                <c:pt idx="25">
                  <c:v>1.0201</c:v>
                </c:pt>
                <c:pt idx="26">
                  <c:v>1.02</c:v>
                </c:pt>
                <c:pt idx="27">
                  <c:v>1.0195000000000001</c:v>
                </c:pt>
                <c:pt idx="28">
                  <c:v>1.02</c:v>
                </c:pt>
                <c:pt idx="29">
                  <c:v>1.0225</c:v>
                </c:pt>
                <c:pt idx="30">
                  <c:v>1.0222</c:v>
                </c:pt>
                <c:pt idx="31">
                  <c:v>1.0212000000000001</c:v>
                </c:pt>
                <c:pt idx="32">
                  <c:v>1.0221</c:v>
                </c:pt>
                <c:pt idx="33">
                  <c:v>1.0221</c:v>
                </c:pt>
                <c:pt idx="34">
                  <c:v>1.0238</c:v>
                </c:pt>
                <c:pt idx="35">
                  <c:v>1.0235000000000001</c:v>
                </c:pt>
                <c:pt idx="36">
                  <c:v>1.0224</c:v>
                </c:pt>
                <c:pt idx="37">
                  <c:v>1.0238</c:v>
                </c:pt>
                <c:pt idx="38">
                  <c:v>1.0234000000000001</c:v>
                </c:pt>
                <c:pt idx="39">
                  <c:v>1.0232000000000001</c:v>
                </c:pt>
                <c:pt idx="40">
                  <c:v>1.0216000000000001</c:v>
                </c:pt>
                <c:pt idx="41">
                  <c:v>1.0215000000000001</c:v>
                </c:pt>
                <c:pt idx="42">
                  <c:v>1.0238</c:v>
                </c:pt>
                <c:pt idx="43">
                  <c:v>1.0222</c:v>
                </c:pt>
                <c:pt idx="44">
                  <c:v>1.0217000000000001</c:v>
                </c:pt>
                <c:pt idx="45">
                  <c:v>1.0218</c:v>
                </c:pt>
                <c:pt idx="46">
                  <c:v>1.0235000000000001</c:v>
                </c:pt>
                <c:pt idx="47">
                  <c:v>1.0236000000000001</c:v>
                </c:pt>
                <c:pt idx="48">
                  <c:v>1.0215000000000001</c:v>
                </c:pt>
                <c:pt idx="49">
                  <c:v>1.0229999999999999</c:v>
                </c:pt>
                <c:pt idx="50">
                  <c:v>1.0232000000000001</c:v>
                </c:pt>
                <c:pt idx="51">
                  <c:v>1.0234000000000001</c:v>
                </c:pt>
                <c:pt idx="52">
                  <c:v>1.0239</c:v>
                </c:pt>
                <c:pt idx="53">
                  <c:v>1.0223</c:v>
                </c:pt>
                <c:pt idx="54">
                  <c:v>1.0229999999999999</c:v>
                </c:pt>
                <c:pt idx="55">
                  <c:v>1.0232000000000001</c:v>
                </c:pt>
                <c:pt idx="56">
                  <c:v>1.0279</c:v>
                </c:pt>
                <c:pt idx="57">
                  <c:v>1.0266</c:v>
                </c:pt>
                <c:pt idx="58">
                  <c:v>1.0285</c:v>
                </c:pt>
                <c:pt idx="59">
                  <c:v>1.0267999999999999</c:v>
                </c:pt>
                <c:pt idx="60">
                  <c:v>1.0289999999999999</c:v>
                </c:pt>
                <c:pt idx="61">
                  <c:v>1.0286</c:v>
                </c:pt>
                <c:pt idx="62">
                  <c:v>1.0294000000000001</c:v>
                </c:pt>
                <c:pt idx="63">
                  <c:v>1.0288999999999999</c:v>
                </c:pt>
                <c:pt idx="64">
                  <c:v>1.0275000000000001</c:v>
                </c:pt>
                <c:pt idx="65">
                  <c:v>1.0287999999999999</c:v>
                </c:pt>
                <c:pt idx="66">
                  <c:v>1.0281</c:v>
                </c:pt>
                <c:pt idx="67">
                  <c:v>1.0293000000000001</c:v>
                </c:pt>
                <c:pt idx="68">
                  <c:v>1.0286</c:v>
                </c:pt>
                <c:pt idx="69">
                  <c:v>1.0281</c:v>
                </c:pt>
                <c:pt idx="70">
                  <c:v>1.0289999999999999</c:v>
                </c:pt>
                <c:pt idx="71">
                  <c:v>1.0309999999999999</c:v>
                </c:pt>
                <c:pt idx="72">
                  <c:v>1.0308999999999999</c:v>
                </c:pt>
                <c:pt idx="73">
                  <c:v>1.0317000000000001</c:v>
                </c:pt>
                <c:pt idx="74">
                  <c:v>1.0322</c:v>
                </c:pt>
                <c:pt idx="75">
                  <c:v>1.0322</c:v>
                </c:pt>
                <c:pt idx="76">
                  <c:v>1.0328999999999999</c:v>
                </c:pt>
                <c:pt idx="77">
                  <c:v>1.0325</c:v>
                </c:pt>
                <c:pt idx="78">
                  <c:v>1.0327999999999999</c:v>
                </c:pt>
                <c:pt idx="79">
                  <c:v>1.0353000000000001</c:v>
                </c:pt>
                <c:pt idx="80">
                  <c:v>1.0357000000000001</c:v>
                </c:pt>
                <c:pt idx="81">
                  <c:v>1.0348999999999999</c:v>
                </c:pt>
                <c:pt idx="82">
                  <c:v>1.0358000000000001</c:v>
                </c:pt>
                <c:pt idx="83">
                  <c:v>1.0367999999999999</c:v>
                </c:pt>
                <c:pt idx="84">
                  <c:v>1.0376000000000001</c:v>
                </c:pt>
                <c:pt idx="85">
                  <c:v>1.0390999999999999</c:v>
                </c:pt>
                <c:pt idx="86">
                  <c:v>1.04</c:v>
                </c:pt>
                <c:pt idx="87">
                  <c:v>1.0404</c:v>
                </c:pt>
                <c:pt idx="88">
                  <c:v>1.0405</c:v>
                </c:pt>
                <c:pt idx="89">
                  <c:v>1.0421</c:v>
                </c:pt>
                <c:pt idx="90">
                  <c:v>1.0434000000000001</c:v>
                </c:pt>
                <c:pt idx="91">
                  <c:v>1.0451999999999999</c:v>
                </c:pt>
                <c:pt idx="92">
                  <c:v>1.0488</c:v>
                </c:pt>
                <c:pt idx="93">
                  <c:v>1.0491999999999999</c:v>
                </c:pt>
                <c:pt idx="94">
                  <c:v>1.0519000000000001</c:v>
                </c:pt>
                <c:pt idx="95">
                  <c:v>1.0541</c:v>
                </c:pt>
                <c:pt idx="96">
                  <c:v>1.0524</c:v>
                </c:pt>
                <c:pt idx="97">
                  <c:v>1.0543</c:v>
                </c:pt>
                <c:pt idx="98">
                  <c:v>1.0567</c:v>
                </c:pt>
                <c:pt idx="99">
                  <c:v>1.0568</c:v>
                </c:pt>
                <c:pt idx="100">
                  <c:v>1.056</c:v>
                </c:pt>
                <c:pt idx="101">
                  <c:v>1.0570999999999999</c:v>
                </c:pt>
                <c:pt idx="102">
                  <c:v>1.0603</c:v>
                </c:pt>
                <c:pt idx="103">
                  <c:v>1.0618000000000001</c:v>
                </c:pt>
                <c:pt idx="104">
                  <c:v>1.0650999999999999</c:v>
                </c:pt>
                <c:pt idx="105">
                  <c:v>1.0698000000000001</c:v>
                </c:pt>
                <c:pt idx="106">
                  <c:v>1.07</c:v>
                </c:pt>
                <c:pt idx="107">
                  <c:v>1.0713999999999999</c:v>
                </c:pt>
                <c:pt idx="108">
                  <c:v>1.073</c:v>
                </c:pt>
                <c:pt idx="109">
                  <c:v>1.0739000000000001</c:v>
                </c:pt>
                <c:pt idx="110">
                  <c:v>1.0780000000000001</c:v>
                </c:pt>
                <c:pt idx="111">
                  <c:v>1.0826</c:v>
                </c:pt>
                <c:pt idx="112">
                  <c:v>1.0839000000000001</c:v>
                </c:pt>
                <c:pt idx="113">
                  <c:v>1.0867</c:v>
                </c:pt>
                <c:pt idx="114">
                  <c:v>1.0905</c:v>
                </c:pt>
                <c:pt idx="115">
                  <c:v>1.0961000000000001</c:v>
                </c:pt>
                <c:pt idx="116">
                  <c:v>1.1003000000000001</c:v>
                </c:pt>
                <c:pt idx="117">
                  <c:v>1.1017999999999999</c:v>
                </c:pt>
                <c:pt idx="118">
                  <c:v>1.1082000000000001</c:v>
                </c:pt>
                <c:pt idx="119">
                  <c:v>1.1121000000000001</c:v>
                </c:pt>
                <c:pt idx="120">
                  <c:v>1.1172</c:v>
                </c:pt>
                <c:pt idx="121">
                  <c:v>1.1203000000000001</c:v>
                </c:pt>
                <c:pt idx="122">
                  <c:v>1.1233</c:v>
                </c:pt>
                <c:pt idx="123">
                  <c:v>1.1293</c:v>
                </c:pt>
                <c:pt idx="124">
                  <c:v>1.1343000000000001</c:v>
                </c:pt>
                <c:pt idx="125">
                  <c:v>1.1387</c:v>
                </c:pt>
                <c:pt idx="126">
                  <c:v>1.1462000000000001</c:v>
                </c:pt>
                <c:pt idx="127">
                  <c:v>1.1504000000000001</c:v>
                </c:pt>
                <c:pt idx="128">
                  <c:v>1.1556999999999999</c:v>
                </c:pt>
                <c:pt idx="129">
                  <c:v>1.1639999999999999</c:v>
                </c:pt>
                <c:pt idx="130">
                  <c:v>1.169</c:v>
                </c:pt>
                <c:pt idx="131">
                  <c:v>1.1754</c:v>
                </c:pt>
                <c:pt idx="132">
                  <c:v>1.1812</c:v>
                </c:pt>
                <c:pt idx="133">
                  <c:v>1.1881999999999999</c:v>
                </c:pt>
                <c:pt idx="134">
                  <c:v>1.1950000000000001</c:v>
                </c:pt>
                <c:pt idx="135">
                  <c:v>1.1996</c:v>
                </c:pt>
                <c:pt idx="136">
                  <c:v>1.2085999999999999</c:v>
                </c:pt>
                <c:pt idx="137">
                  <c:v>1.2141</c:v>
                </c:pt>
                <c:pt idx="138">
                  <c:v>1.2229000000000001</c:v>
                </c:pt>
                <c:pt idx="139">
                  <c:v>1.2283999999999999</c:v>
                </c:pt>
                <c:pt idx="140">
                  <c:v>1.238</c:v>
                </c:pt>
                <c:pt idx="141">
                  <c:v>1.2477</c:v>
                </c:pt>
                <c:pt idx="142">
                  <c:v>1.2525999999999999</c:v>
                </c:pt>
                <c:pt idx="143">
                  <c:v>1.2607999999999999</c:v>
                </c:pt>
                <c:pt idx="144">
                  <c:v>1.2689999999999999</c:v>
                </c:pt>
                <c:pt idx="145">
                  <c:v>1.2750999999999999</c:v>
                </c:pt>
                <c:pt idx="146">
                  <c:v>1.2843</c:v>
                </c:pt>
                <c:pt idx="147">
                  <c:v>1.2949999999999999</c:v>
                </c:pt>
                <c:pt idx="148">
                  <c:v>1.3069999999999999</c:v>
                </c:pt>
                <c:pt idx="149">
                  <c:v>1.3151999999999999</c:v>
                </c:pt>
                <c:pt idx="150">
                  <c:v>1.3243</c:v>
                </c:pt>
                <c:pt idx="151">
                  <c:v>1.3285</c:v>
                </c:pt>
                <c:pt idx="152">
                  <c:v>1.3387</c:v>
                </c:pt>
                <c:pt idx="153">
                  <c:v>1.3472</c:v>
                </c:pt>
                <c:pt idx="154">
                  <c:v>1.3581000000000001</c:v>
                </c:pt>
                <c:pt idx="155">
                  <c:v>1.3697999999999999</c:v>
                </c:pt>
                <c:pt idx="156">
                  <c:v>1.3792</c:v>
                </c:pt>
                <c:pt idx="157">
                  <c:v>1.3944000000000001</c:v>
                </c:pt>
                <c:pt idx="158">
                  <c:v>1.4037999999999999</c:v>
                </c:pt>
                <c:pt idx="159">
                  <c:v>1.4124000000000001</c:v>
                </c:pt>
                <c:pt idx="160">
                  <c:v>1.418900000000000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WT4Gel!$C$1</c:f>
              <c:strCache>
                <c:ptCount val="1"/>
                <c:pt idx="0">
                  <c:v>WT4 Dox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WT4Gel!$E$2:$E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8.9999999999999998E-4</c:v>
                  </c:pt>
                  <c:pt idx="2">
                    <c:v>1.2999999999999999E-3</c:v>
                  </c:pt>
                  <c:pt idx="3">
                    <c:v>1.9E-3</c:v>
                  </c:pt>
                  <c:pt idx="4">
                    <c:v>3.0999999999999999E-3</c:v>
                  </c:pt>
                  <c:pt idx="5">
                    <c:v>2.8999999999999998E-3</c:v>
                  </c:pt>
                  <c:pt idx="6">
                    <c:v>3.2000000000000002E-3</c:v>
                  </c:pt>
                  <c:pt idx="7">
                    <c:v>3.0999999999999999E-3</c:v>
                  </c:pt>
                  <c:pt idx="8">
                    <c:v>3.8E-3</c:v>
                  </c:pt>
                  <c:pt idx="9">
                    <c:v>3.65E-3</c:v>
                  </c:pt>
                  <c:pt idx="10">
                    <c:v>4.9500000000000004E-3</c:v>
                  </c:pt>
                  <c:pt idx="11">
                    <c:v>7.1500000000000001E-3</c:v>
                  </c:pt>
                  <c:pt idx="12">
                    <c:v>7.1500000000000001E-3</c:v>
                  </c:pt>
                  <c:pt idx="13">
                    <c:v>7.4000000000000003E-3</c:v>
                  </c:pt>
                  <c:pt idx="14">
                    <c:v>7.9500000000000005E-3</c:v>
                  </c:pt>
                  <c:pt idx="15">
                    <c:v>9.4500000000000001E-3</c:v>
                  </c:pt>
                  <c:pt idx="16">
                    <c:v>8.8500000000000002E-3</c:v>
                  </c:pt>
                  <c:pt idx="17">
                    <c:v>9.4500000000000001E-3</c:v>
                  </c:pt>
                  <c:pt idx="18">
                    <c:v>8.3499999999999998E-3</c:v>
                  </c:pt>
                  <c:pt idx="19">
                    <c:v>8.7500000000000008E-3</c:v>
                  </c:pt>
                  <c:pt idx="20">
                    <c:v>9.4000000000000004E-3</c:v>
                  </c:pt>
                  <c:pt idx="21">
                    <c:v>8.6999999999999994E-3</c:v>
                  </c:pt>
                  <c:pt idx="22">
                    <c:v>8.1499999999999993E-3</c:v>
                  </c:pt>
                  <c:pt idx="23">
                    <c:v>8.8999999999999999E-3</c:v>
                  </c:pt>
                  <c:pt idx="24">
                    <c:v>8.3499999999999998E-3</c:v>
                  </c:pt>
                  <c:pt idx="25">
                    <c:v>8.2000000000000007E-3</c:v>
                  </c:pt>
                  <c:pt idx="26">
                    <c:v>7.45E-3</c:v>
                  </c:pt>
                  <c:pt idx="27">
                    <c:v>7.5500000000000003E-3</c:v>
                  </c:pt>
                  <c:pt idx="28">
                    <c:v>9.5499999999999995E-3</c:v>
                  </c:pt>
                  <c:pt idx="29">
                    <c:v>1.01E-2</c:v>
                  </c:pt>
                  <c:pt idx="30">
                    <c:v>1.03E-2</c:v>
                  </c:pt>
                  <c:pt idx="31">
                    <c:v>9.1000000000000004E-3</c:v>
                  </c:pt>
                  <c:pt idx="32">
                    <c:v>1.0500000000000001E-2</c:v>
                  </c:pt>
                  <c:pt idx="33">
                    <c:v>9.9000000000000008E-3</c:v>
                  </c:pt>
                  <c:pt idx="34">
                    <c:v>8.8999999999999999E-3</c:v>
                  </c:pt>
                  <c:pt idx="35">
                    <c:v>9.4000000000000004E-3</c:v>
                  </c:pt>
                  <c:pt idx="36">
                    <c:v>8.8999999999999999E-3</c:v>
                  </c:pt>
                  <c:pt idx="37">
                    <c:v>9.5999999999999992E-3</c:v>
                  </c:pt>
                  <c:pt idx="38">
                    <c:v>9.1999999999999998E-3</c:v>
                  </c:pt>
                  <c:pt idx="39">
                    <c:v>9.4000000000000004E-3</c:v>
                  </c:pt>
                  <c:pt idx="40">
                    <c:v>8.9499999999999996E-3</c:v>
                  </c:pt>
                  <c:pt idx="41">
                    <c:v>8.5500000000000003E-3</c:v>
                  </c:pt>
                  <c:pt idx="42">
                    <c:v>8.9499999999999996E-3</c:v>
                  </c:pt>
                  <c:pt idx="43">
                    <c:v>8.3000000000000001E-3</c:v>
                  </c:pt>
                  <c:pt idx="44">
                    <c:v>8.5000000000000006E-3</c:v>
                  </c:pt>
                  <c:pt idx="45">
                    <c:v>7.9500000000000005E-3</c:v>
                  </c:pt>
                  <c:pt idx="46">
                    <c:v>9.1999999999999998E-3</c:v>
                  </c:pt>
                  <c:pt idx="47">
                    <c:v>9.75E-3</c:v>
                  </c:pt>
                  <c:pt idx="48">
                    <c:v>8.3999999999999995E-3</c:v>
                  </c:pt>
                  <c:pt idx="49">
                    <c:v>9.2499999999999995E-3</c:v>
                  </c:pt>
                  <c:pt idx="50">
                    <c:v>9.6500000000000006E-3</c:v>
                  </c:pt>
                  <c:pt idx="51">
                    <c:v>9.4999999999999998E-3</c:v>
                  </c:pt>
                  <c:pt idx="52">
                    <c:v>9.7000000000000003E-3</c:v>
                  </c:pt>
                  <c:pt idx="53">
                    <c:v>8.8500000000000002E-3</c:v>
                  </c:pt>
                  <c:pt idx="54">
                    <c:v>8.1499999999999993E-3</c:v>
                  </c:pt>
                  <c:pt idx="55">
                    <c:v>8.2000000000000007E-3</c:v>
                  </c:pt>
                  <c:pt idx="56">
                    <c:v>8.6E-3</c:v>
                  </c:pt>
                  <c:pt idx="57">
                    <c:v>8.5500000000000003E-3</c:v>
                  </c:pt>
                  <c:pt idx="58">
                    <c:v>8.7500000000000008E-3</c:v>
                  </c:pt>
                  <c:pt idx="59">
                    <c:v>8.9499999999999996E-3</c:v>
                  </c:pt>
                  <c:pt idx="60">
                    <c:v>1.005E-2</c:v>
                  </c:pt>
                  <c:pt idx="61">
                    <c:v>9.8499999999999994E-3</c:v>
                  </c:pt>
                  <c:pt idx="62">
                    <c:v>1.025E-2</c:v>
                  </c:pt>
                  <c:pt idx="63">
                    <c:v>1.0800000000000001E-2</c:v>
                  </c:pt>
                  <c:pt idx="64">
                    <c:v>9.4500000000000001E-3</c:v>
                  </c:pt>
                  <c:pt idx="65">
                    <c:v>9.4500000000000001E-3</c:v>
                  </c:pt>
                  <c:pt idx="66">
                    <c:v>1.0149999999999999E-2</c:v>
                  </c:pt>
                  <c:pt idx="67">
                    <c:v>9.5999999999999992E-3</c:v>
                  </c:pt>
                  <c:pt idx="68">
                    <c:v>9.7999999999999997E-3</c:v>
                  </c:pt>
                  <c:pt idx="69">
                    <c:v>9.5499999999999995E-3</c:v>
                  </c:pt>
                  <c:pt idx="70">
                    <c:v>1.095E-2</c:v>
                  </c:pt>
                  <c:pt idx="71">
                    <c:v>1.2E-2</c:v>
                  </c:pt>
                  <c:pt idx="72">
                    <c:v>1.2449999999999999E-2</c:v>
                  </c:pt>
                  <c:pt idx="73">
                    <c:v>1.23E-2</c:v>
                  </c:pt>
                  <c:pt idx="74">
                    <c:v>1.24E-2</c:v>
                  </c:pt>
                  <c:pt idx="75">
                    <c:v>1.11E-2</c:v>
                  </c:pt>
                  <c:pt idx="76">
                    <c:v>1.285E-2</c:v>
                  </c:pt>
                  <c:pt idx="77">
                    <c:v>1.17E-2</c:v>
                  </c:pt>
                  <c:pt idx="78">
                    <c:v>1.115E-2</c:v>
                  </c:pt>
                  <c:pt idx="79">
                    <c:v>1.2699999999999999E-2</c:v>
                  </c:pt>
                  <c:pt idx="80">
                    <c:v>1.295E-2</c:v>
                  </c:pt>
                  <c:pt idx="81">
                    <c:v>1.26E-2</c:v>
                  </c:pt>
                  <c:pt idx="82">
                    <c:v>1.18E-2</c:v>
                  </c:pt>
                  <c:pt idx="83">
                    <c:v>1.2149999999999999E-2</c:v>
                  </c:pt>
                  <c:pt idx="84">
                    <c:v>1.21E-2</c:v>
                  </c:pt>
                  <c:pt idx="85">
                    <c:v>1.26E-2</c:v>
                  </c:pt>
                  <c:pt idx="86">
                    <c:v>1.3350000000000001E-2</c:v>
                  </c:pt>
                  <c:pt idx="87">
                    <c:v>1.35E-2</c:v>
                  </c:pt>
                  <c:pt idx="88">
                    <c:v>1.32E-2</c:v>
                  </c:pt>
                  <c:pt idx="89">
                    <c:v>1.32E-2</c:v>
                  </c:pt>
                  <c:pt idx="90">
                    <c:v>1.4800000000000001E-2</c:v>
                  </c:pt>
                  <c:pt idx="91">
                    <c:v>1.5049999999999999E-2</c:v>
                  </c:pt>
                  <c:pt idx="92">
                    <c:v>1.4800000000000001E-2</c:v>
                  </c:pt>
                  <c:pt idx="93">
                    <c:v>1.575E-2</c:v>
                  </c:pt>
                  <c:pt idx="94">
                    <c:v>1.6199999999999999E-2</c:v>
                  </c:pt>
                  <c:pt idx="95">
                    <c:v>1.83E-2</c:v>
                  </c:pt>
                  <c:pt idx="96">
                    <c:v>1.8350000000000002E-2</c:v>
                  </c:pt>
                  <c:pt idx="97">
                    <c:v>1.7749999999999998E-2</c:v>
                  </c:pt>
                  <c:pt idx="98">
                    <c:v>1.915E-2</c:v>
                  </c:pt>
                  <c:pt idx="99">
                    <c:v>1.9550000000000001E-2</c:v>
                  </c:pt>
                  <c:pt idx="100">
                    <c:v>2.0400000000000001E-2</c:v>
                  </c:pt>
                  <c:pt idx="101">
                    <c:v>2.155E-2</c:v>
                  </c:pt>
                  <c:pt idx="102">
                    <c:v>2.12E-2</c:v>
                  </c:pt>
                  <c:pt idx="103">
                    <c:v>2.2749999999999999E-2</c:v>
                  </c:pt>
                  <c:pt idx="104">
                    <c:v>2.41E-2</c:v>
                  </c:pt>
                  <c:pt idx="105">
                    <c:v>2.5499999999999998E-2</c:v>
                  </c:pt>
                  <c:pt idx="106">
                    <c:v>2.53E-2</c:v>
                  </c:pt>
                  <c:pt idx="107">
                    <c:v>2.5049999999999999E-2</c:v>
                  </c:pt>
                  <c:pt idx="108">
                    <c:v>2.58E-2</c:v>
                  </c:pt>
                  <c:pt idx="109">
                    <c:v>2.7199999999999998E-2</c:v>
                  </c:pt>
                  <c:pt idx="110">
                    <c:v>2.7E-2</c:v>
                  </c:pt>
                  <c:pt idx="111">
                    <c:v>2.835E-2</c:v>
                  </c:pt>
                  <c:pt idx="112">
                    <c:v>2.8850000000000001E-2</c:v>
                  </c:pt>
                  <c:pt idx="113">
                    <c:v>2.9700000000000001E-2</c:v>
                  </c:pt>
                  <c:pt idx="114">
                    <c:v>3.0450000000000001E-2</c:v>
                  </c:pt>
                  <c:pt idx="115">
                    <c:v>3.125E-2</c:v>
                  </c:pt>
                  <c:pt idx="116">
                    <c:v>3.2149999999999998E-2</c:v>
                  </c:pt>
                  <c:pt idx="117">
                    <c:v>3.3649999999999999E-2</c:v>
                  </c:pt>
                  <c:pt idx="118">
                    <c:v>3.4750000000000003E-2</c:v>
                  </c:pt>
                  <c:pt idx="119">
                    <c:v>3.4950000000000002E-2</c:v>
                  </c:pt>
                  <c:pt idx="120">
                    <c:v>3.6600000000000001E-2</c:v>
                  </c:pt>
                  <c:pt idx="121">
                    <c:v>3.6499999999999998E-2</c:v>
                  </c:pt>
                  <c:pt idx="122">
                    <c:v>3.7400000000000003E-2</c:v>
                  </c:pt>
                  <c:pt idx="123">
                    <c:v>3.9300000000000002E-2</c:v>
                  </c:pt>
                  <c:pt idx="124">
                    <c:v>4.0149999999999998E-2</c:v>
                  </c:pt>
                  <c:pt idx="125">
                    <c:v>4.095E-2</c:v>
                  </c:pt>
                  <c:pt idx="126">
                    <c:v>4.24E-2</c:v>
                  </c:pt>
                  <c:pt idx="127">
                    <c:v>4.3950000000000003E-2</c:v>
                  </c:pt>
                  <c:pt idx="128">
                    <c:v>4.5100000000000001E-2</c:v>
                  </c:pt>
                  <c:pt idx="129">
                    <c:v>4.8000000000000001E-2</c:v>
                  </c:pt>
                  <c:pt idx="130">
                    <c:v>4.9250000000000002E-2</c:v>
                  </c:pt>
                  <c:pt idx="131">
                    <c:v>4.9549999999999997E-2</c:v>
                  </c:pt>
                  <c:pt idx="132">
                    <c:v>5.0849999999999999E-2</c:v>
                  </c:pt>
                  <c:pt idx="133">
                    <c:v>5.3449999999999998E-2</c:v>
                  </c:pt>
                  <c:pt idx="134">
                    <c:v>5.6099999999999997E-2</c:v>
                  </c:pt>
                  <c:pt idx="135">
                    <c:v>5.6899999999999999E-2</c:v>
                  </c:pt>
                  <c:pt idx="136">
                    <c:v>5.9549999999999999E-2</c:v>
                  </c:pt>
                  <c:pt idx="137">
                    <c:v>5.9049999999999998E-2</c:v>
                  </c:pt>
                  <c:pt idx="138">
                    <c:v>6.1350000000000002E-2</c:v>
                  </c:pt>
                  <c:pt idx="139">
                    <c:v>6.3200000000000006E-2</c:v>
                  </c:pt>
                  <c:pt idx="140">
                    <c:v>6.3750000000000001E-2</c:v>
                  </c:pt>
                  <c:pt idx="141">
                    <c:v>6.7000000000000004E-2</c:v>
                  </c:pt>
                  <c:pt idx="142">
                    <c:v>6.8699999999999997E-2</c:v>
                  </c:pt>
                  <c:pt idx="143">
                    <c:v>7.145E-2</c:v>
                  </c:pt>
                  <c:pt idx="144">
                    <c:v>7.1849999999999997E-2</c:v>
                  </c:pt>
                  <c:pt idx="145">
                    <c:v>7.4399999999999994E-2</c:v>
                  </c:pt>
                  <c:pt idx="146">
                    <c:v>7.46E-2</c:v>
                  </c:pt>
                  <c:pt idx="147">
                    <c:v>7.6649999999999996E-2</c:v>
                  </c:pt>
                  <c:pt idx="148">
                    <c:v>8.0049999999999996E-2</c:v>
                  </c:pt>
                  <c:pt idx="149">
                    <c:v>8.1549999999999997E-2</c:v>
                  </c:pt>
                  <c:pt idx="150">
                    <c:v>8.2650000000000001E-2</c:v>
                  </c:pt>
                  <c:pt idx="151">
                    <c:v>8.3900000000000002E-2</c:v>
                  </c:pt>
                  <c:pt idx="152">
                    <c:v>8.8450000000000001E-2</c:v>
                  </c:pt>
                  <c:pt idx="153">
                    <c:v>9.0399999999999994E-2</c:v>
                  </c:pt>
                  <c:pt idx="154">
                    <c:v>9.2100000000000001E-2</c:v>
                  </c:pt>
                  <c:pt idx="155">
                    <c:v>9.4600000000000004E-2</c:v>
                  </c:pt>
                  <c:pt idx="156">
                    <c:v>9.8000000000000004E-2</c:v>
                  </c:pt>
                  <c:pt idx="157">
                    <c:v>9.98E-2</c:v>
                  </c:pt>
                  <c:pt idx="158">
                    <c:v>0.10295</c:v>
                  </c:pt>
                  <c:pt idx="159">
                    <c:v>0.10115</c:v>
                  </c:pt>
                  <c:pt idx="160">
                    <c:v>0.10245</c:v>
                  </c:pt>
                </c:numCache>
              </c:numRef>
            </c:plus>
            <c:minus>
              <c:numRef>
                <c:f>WT4Gel!$E$2:$E$162</c:f>
                <c:numCache>
                  <c:formatCode>General</c:formatCode>
                  <c:ptCount val="161"/>
                  <c:pt idx="0">
                    <c:v>0</c:v>
                  </c:pt>
                  <c:pt idx="1">
                    <c:v>8.9999999999999998E-4</c:v>
                  </c:pt>
                  <c:pt idx="2">
                    <c:v>1.2999999999999999E-3</c:v>
                  </c:pt>
                  <c:pt idx="3">
                    <c:v>1.9E-3</c:v>
                  </c:pt>
                  <c:pt idx="4">
                    <c:v>3.0999999999999999E-3</c:v>
                  </c:pt>
                  <c:pt idx="5">
                    <c:v>2.8999999999999998E-3</c:v>
                  </c:pt>
                  <c:pt idx="6">
                    <c:v>3.2000000000000002E-3</c:v>
                  </c:pt>
                  <c:pt idx="7">
                    <c:v>3.0999999999999999E-3</c:v>
                  </c:pt>
                  <c:pt idx="8">
                    <c:v>3.8E-3</c:v>
                  </c:pt>
                  <c:pt idx="9">
                    <c:v>3.65E-3</c:v>
                  </c:pt>
                  <c:pt idx="10">
                    <c:v>4.9500000000000004E-3</c:v>
                  </c:pt>
                  <c:pt idx="11">
                    <c:v>7.1500000000000001E-3</c:v>
                  </c:pt>
                  <c:pt idx="12">
                    <c:v>7.1500000000000001E-3</c:v>
                  </c:pt>
                  <c:pt idx="13">
                    <c:v>7.4000000000000003E-3</c:v>
                  </c:pt>
                  <c:pt idx="14">
                    <c:v>7.9500000000000005E-3</c:v>
                  </c:pt>
                  <c:pt idx="15">
                    <c:v>9.4500000000000001E-3</c:v>
                  </c:pt>
                  <c:pt idx="16">
                    <c:v>8.8500000000000002E-3</c:v>
                  </c:pt>
                  <c:pt idx="17">
                    <c:v>9.4500000000000001E-3</c:v>
                  </c:pt>
                  <c:pt idx="18">
                    <c:v>8.3499999999999998E-3</c:v>
                  </c:pt>
                  <c:pt idx="19">
                    <c:v>8.7500000000000008E-3</c:v>
                  </c:pt>
                  <c:pt idx="20">
                    <c:v>9.4000000000000004E-3</c:v>
                  </c:pt>
                  <c:pt idx="21">
                    <c:v>8.6999999999999994E-3</c:v>
                  </c:pt>
                  <c:pt idx="22">
                    <c:v>8.1499999999999993E-3</c:v>
                  </c:pt>
                  <c:pt idx="23">
                    <c:v>8.8999999999999999E-3</c:v>
                  </c:pt>
                  <c:pt idx="24">
                    <c:v>8.3499999999999998E-3</c:v>
                  </c:pt>
                  <c:pt idx="25">
                    <c:v>8.2000000000000007E-3</c:v>
                  </c:pt>
                  <c:pt idx="26">
                    <c:v>7.45E-3</c:v>
                  </c:pt>
                  <c:pt idx="27">
                    <c:v>7.5500000000000003E-3</c:v>
                  </c:pt>
                  <c:pt idx="28">
                    <c:v>9.5499999999999995E-3</c:v>
                  </c:pt>
                  <c:pt idx="29">
                    <c:v>1.01E-2</c:v>
                  </c:pt>
                  <c:pt idx="30">
                    <c:v>1.03E-2</c:v>
                  </c:pt>
                  <c:pt idx="31">
                    <c:v>9.1000000000000004E-3</c:v>
                  </c:pt>
                  <c:pt idx="32">
                    <c:v>1.0500000000000001E-2</c:v>
                  </c:pt>
                  <c:pt idx="33">
                    <c:v>9.9000000000000008E-3</c:v>
                  </c:pt>
                  <c:pt idx="34">
                    <c:v>8.8999999999999999E-3</c:v>
                  </c:pt>
                  <c:pt idx="35">
                    <c:v>9.4000000000000004E-3</c:v>
                  </c:pt>
                  <c:pt idx="36">
                    <c:v>8.8999999999999999E-3</c:v>
                  </c:pt>
                  <c:pt idx="37">
                    <c:v>9.5999999999999992E-3</c:v>
                  </c:pt>
                  <c:pt idx="38">
                    <c:v>9.1999999999999998E-3</c:v>
                  </c:pt>
                  <c:pt idx="39">
                    <c:v>9.4000000000000004E-3</c:v>
                  </c:pt>
                  <c:pt idx="40">
                    <c:v>8.9499999999999996E-3</c:v>
                  </c:pt>
                  <c:pt idx="41">
                    <c:v>8.5500000000000003E-3</c:v>
                  </c:pt>
                  <c:pt idx="42">
                    <c:v>8.9499999999999996E-3</c:v>
                  </c:pt>
                  <c:pt idx="43">
                    <c:v>8.3000000000000001E-3</c:v>
                  </c:pt>
                  <c:pt idx="44">
                    <c:v>8.5000000000000006E-3</c:v>
                  </c:pt>
                  <c:pt idx="45">
                    <c:v>7.9500000000000005E-3</c:v>
                  </c:pt>
                  <c:pt idx="46">
                    <c:v>9.1999999999999998E-3</c:v>
                  </c:pt>
                  <c:pt idx="47">
                    <c:v>9.75E-3</c:v>
                  </c:pt>
                  <c:pt idx="48">
                    <c:v>8.3999999999999995E-3</c:v>
                  </c:pt>
                  <c:pt idx="49">
                    <c:v>9.2499999999999995E-3</c:v>
                  </c:pt>
                  <c:pt idx="50">
                    <c:v>9.6500000000000006E-3</c:v>
                  </c:pt>
                  <c:pt idx="51">
                    <c:v>9.4999999999999998E-3</c:v>
                  </c:pt>
                  <c:pt idx="52">
                    <c:v>9.7000000000000003E-3</c:v>
                  </c:pt>
                  <c:pt idx="53">
                    <c:v>8.8500000000000002E-3</c:v>
                  </c:pt>
                  <c:pt idx="54">
                    <c:v>8.1499999999999993E-3</c:v>
                  </c:pt>
                  <c:pt idx="55">
                    <c:v>8.2000000000000007E-3</c:v>
                  </c:pt>
                  <c:pt idx="56">
                    <c:v>8.6E-3</c:v>
                  </c:pt>
                  <c:pt idx="57">
                    <c:v>8.5500000000000003E-3</c:v>
                  </c:pt>
                  <c:pt idx="58">
                    <c:v>8.7500000000000008E-3</c:v>
                  </c:pt>
                  <c:pt idx="59">
                    <c:v>8.9499999999999996E-3</c:v>
                  </c:pt>
                  <c:pt idx="60">
                    <c:v>1.005E-2</c:v>
                  </c:pt>
                  <c:pt idx="61">
                    <c:v>9.8499999999999994E-3</c:v>
                  </c:pt>
                  <c:pt idx="62">
                    <c:v>1.025E-2</c:v>
                  </c:pt>
                  <c:pt idx="63">
                    <c:v>1.0800000000000001E-2</c:v>
                  </c:pt>
                  <c:pt idx="64">
                    <c:v>9.4500000000000001E-3</c:v>
                  </c:pt>
                  <c:pt idx="65">
                    <c:v>9.4500000000000001E-3</c:v>
                  </c:pt>
                  <c:pt idx="66">
                    <c:v>1.0149999999999999E-2</c:v>
                  </c:pt>
                  <c:pt idx="67">
                    <c:v>9.5999999999999992E-3</c:v>
                  </c:pt>
                  <c:pt idx="68">
                    <c:v>9.7999999999999997E-3</c:v>
                  </c:pt>
                  <c:pt idx="69">
                    <c:v>9.5499999999999995E-3</c:v>
                  </c:pt>
                  <c:pt idx="70">
                    <c:v>1.095E-2</c:v>
                  </c:pt>
                  <c:pt idx="71">
                    <c:v>1.2E-2</c:v>
                  </c:pt>
                  <c:pt idx="72">
                    <c:v>1.2449999999999999E-2</c:v>
                  </c:pt>
                  <c:pt idx="73">
                    <c:v>1.23E-2</c:v>
                  </c:pt>
                  <c:pt idx="74">
                    <c:v>1.24E-2</c:v>
                  </c:pt>
                  <c:pt idx="75">
                    <c:v>1.11E-2</c:v>
                  </c:pt>
                  <c:pt idx="76">
                    <c:v>1.285E-2</c:v>
                  </c:pt>
                  <c:pt idx="77">
                    <c:v>1.17E-2</c:v>
                  </c:pt>
                  <c:pt idx="78">
                    <c:v>1.115E-2</c:v>
                  </c:pt>
                  <c:pt idx="79">
                    <c:v>1.2699999999999999E-2</c:v>
                  </c:pt>
                  <c:pt idx="80">
                    <c:v>1.295E-2</c:v>
                  </c:pt>
                  <c:pt idx="81">
                    <c:v>1.26E-2</c:v>
                  </c:pt>
                  <c:pt idx="82">
                    <c:v>1.18E-2</c:v>
                  </c:pt>
                  <c:pt idx="83">
                    <c:v>1.2149999999999999E-2</c:v>
                  </c:pt>
                  <c:pt idx="84">
                    <c:v>1.21E-2</c:v>
                  </c:pt>
                  <c:pt idx="85">
                    <c:v>1.26E-2</c:v>
                  </c:pt>
                  <c:pt idx="86">
                    <c:v>1.3350000000000001E-2</c:v>
                  </c:pt>
                  <c:pt idx="87">
                    <c:v>1.35E-2</c:v>
                  </c:pt>
                  <c:pt idx="88">
                    <c:v>1.32E-2</c:v>
                  </c:pt>
                  <c:pt idx="89">
                    <c:v>1.32E-2</c:v>
                  </c:pt>
                  <c:pt idx="90">
                    <c:v>1.4800000000000001E-2</c:v>
                  </c:pt>
                  <c:pt idx="91">
                    <c:v>1.5049999999999999E-2</c:v>
                  </c:pt>
                  <c:pt idx="92">
                    <c:v>1.4800000000000001E-2</c:v>
                  </c:pt>
                  <c:pt idx="93">
                    <c:v>1.575E-2</c:v>
                  </c:pt>
                  <c:pt idx="94">
                    <c:v>1.6199999999999999E-2</c:v>
                  </c:pt>
                  <c:pt idx="95">
                    <c:v>1.83E-2</c:v>
                  </c:pt>
                  <c:pt idx="96">
                    <c:v>1.8350000000000002E-2</c:v>
                  </c:pt>
                  <c:pt idx="97">
                    <c:v>1.7749999999999998E-2</c:v>
                  </c:pt>
                  <c:pt idx="98">
                    <c:v>1.915E-2</c:v>
                  </c:pt>
                  <c:pt idx="99">
                    <c:v>1.9550000000000001E-2</c:v>
                  </c:pt>
                  <c:pt idx="100">
                    <c:v>2.0400000000000001E-2</c:v>
                  </c:pt>
                  <c:pt idx="101">
                    <c:v>2.155E-2</c:v>
                  </c:pt>
                  <c:pt idx="102">
                    <c:v>2.12E-2</c:v>
                  </c:pt>
                  <c:pt idx="103">
                    <c:v>2.2749999999999999E-2</c:v>
                  </c:pt>
                  <c:pt idx="104">
                    <c:v>2.41E-2</c:v>
                  </c:pt>
                  <c:pt idx="105">
                    <c:v>2.5499999999999998E-2</c:v>
                  </c:pt>
                  <c:pt idx="106">
                    <c:v>2.53E-2</c:v>
                  </c:pt>
                  <c:pt idx="107">
                    <c:v>2.5049999999999999E-2</c:v>
                  </c:pt>
                  <c:pt idx="108">
                    <c:v>2.58E-2</c:v>
                  </c:pt>
                  <c:pt idx="109">
                    <c:v>2.7199999999999998E-2</c:v>
                  </c:pt>
                  <c:pt idx="110">
                    <c:v>2.7E-2</c:v>
                  </c:pt>
                  <c:pt idx="111">
                    <c:v>2.835E-2</c:v>
                  </c:pt>
                  <c:pt idx="112">
                    <c:v>2.8850000000000001E-2</c:v>
                  </c:pt>
                  <c:pt idx="113">
                    <c:v>2.9700000000000001E-2</c:v>
                  </c:pt>
                  <c:pt idx="114">
                    <c:v>3.0450000000000001E-2</c:v>
                  </c:pt>
                  <c:pt idx="115">
                    <c:v>3.125E-2</c:v>
                  </c:pt>
                  <c:pt idx="116">
                    <c:v>3.2149999999999998E-2</c:v>
                  </c:pt>
                  <c:pt idx="117">
                    <c:v>3.3649999999999999E-2</c:v>
                  </c:pt>
                  <c:pt idx="118">
                    <c:v>3.4750000000000003E-2</c:v>
                  </c:pt>
                  <c:pt idx="119">
                    <c:v>3.4950000000000002E-2</c:v>
                  </c:pt>
                  <c:pt idx="120">
                    <c:v>3.6600000000000001E-2</c:v>
                  </c:pt>
                  <c:pt idx="121">
                    <c:v>3.6499999999999998E-2</c:v>
                  </c:pt>
                  <c:pt idx="122">
                    <c:v>3.7400000000000003E-2</c:v>
                  </c:pt>
                  <c:pt idx="123">
                    <c:v>3.9300000000000002E-2</c:v>
                  </c:pt>
                  <c:pt idx="124">
                    <c:v>4.0149999999999998E-2</c:v>
                  </c:pt>
                  <c:pt idx="125">
                    <c:v>4.095E-2</c:v>
                  </c:pt>
                  <c:pt idx="126">
                    <c:v>4.24E-2</c:v>
                  </c:pt>
                  <c:pt idx="127">
                    <c:v>4.3950000000000003E-2</c:v>
                  </c:pt>
                  <c:pt idx="128">
                    <c:v>4.5100000000000001E-2</c:v>
                  </c:pt>
                  <c:pt idx="129">
                    <c:v>4.8000000000000001E-2</c:v>
                  </c:pt>
                  <c:pt idx="130">
                    <c:v>4.9250000000000002E-2</c:v>
                  </c:pt>
                  <c:pt idx="131">
                    <c:v>4.9549999999999997E-2</c:v>
                  </c:pt>
                  <c:pt idx="132">
                    <c:v>5.0849999999999999E-2</c:v>
                  </c:pt>
                  <c:pt idx="133">
                    <c:v>5.3449999999999998E-2</c:v>
                  </c:pt>
                  <c:pt idx="134">
                    <c:v>5.6099999999999997E-2</c:v>
                  </c:pt>
                  <c:pt idx="135">
                    <c:v>5.6899999999999999E-2</c:v>
                  </c:pt>
                  <c:pt idx="136">
                    <c:v>5.9549999999999999E-2</c:v>
                  </c:pt>
                  <c:pt idx="137">
                    <c:v>5.9049999999999998E-2</c:v>
                  </c:pt>
                  <c:pt idx="138">
                    <c:v>6.1350000000000002E-2</c:v>
                  </c:pt>
                  <c:pt idx="139">
                    <c:v>6.3200000000000006E-2</c:v>
                  </c:pt>
                  <c:pt idx="140">
                    <c:v>6.3750000000000001E-2</c:v>
                  </c:pt>
                  <c:pt idx="141">
                    <c:v>6.7000000000000004E-2</c:v>
                  </c:pt>
                  <c:pt idx="142">
                    <c:v>6.8699999999999997E-2</c:v>
                  </c:pt>
                  <c:pt idx="143">
                    <c:v>7.145E-2</c:v>
                  </c:pt>
                  <c:pt idx="144">
                    <c:v>7.1849999999999997E-2</c:v>
                  </c:pt>
                  <c:pt idx="145">
                    <c:v>7.4399999999999994E-2</c:v>
                  </c:pt>
                  <c:pt idx="146">
                    <c:v>7.46E-2</c:v>
                  </c:pt>
                  <c:pt idx="147">
                    <c:v>7.6649999999999996E-2</c:v>
                  </c:pt>
                  <c:pt idx="148">
                    <c:v>8.0049999999999996E-2</c:v>
                  </c:pt>
                  <c:pt idx="149">
                    <c:v>8.1549999999999997E-2</c:v>
                  </c:pt>
                  <c:pt idx="150">
                    <c:v>8.2650000000000001E-2</c:v>
                  </c:pt>
                  <c:pt idx="151">
                    <c:v>8.3900000000000002E-2</c:v>
                  </c:pt>
                  <c:pt idx="152">
                    <c:v>8.8450000000000001E-2</c:v>
                  </c:pt>
                  <c:pt idx="153">
                    <c:v>9.0399999999999994E-2</c:v>
                  </c:pt>
                  <c:pt idx="154">
                    <c:v>9.2100000000000001E-2</c:v>
                  </c:pt>
                  <c:pt idx="155">
                    <c:v>9.4600000000000004E-2</c:v>
                  </c:pt>
                  <c:pt idx="156">
                    <c:v>9.8000000000000004E-2</c:v>
                  </c:pt>
                  <c:pt idx="157">
                    <c:v>9.98E-2</c:v>
                  </c:pt>
                  <c:pt idx="158">
                    <c:v>0.10295</c:v>
                  </c:pt>
                  <c:pt idx="159">
                    <c:v>0.10115</c:v>
                  </c:pt>
                  <c:pt idx="160">
                    <c:v>0.10245</c:v>
                  </c:pt>
                </c:numCache>
              </c:numRef>
            </c:minus>
            <c:spPr>
              <a:ln>
                <a:solidFill>
                  <a:srgbClr val="C00000">
                    <a:alpha val="50000"/>
                  </a:srgbClr>
                </a:solidFill>
              </a:ln>
            </c:spPr>
          </c:errBars>
          <c:xVal>
            <c:numRef>
              <c:f>WT4FN!$A$2:$A$174</c:f>
              <c:numCache>
                <c:formatCode>General</c:formatCode>
                <c:ptCount val="173"/>
                <c:pt idx="0">
                  <c:v>0</c:v>
                </c:pt>
                <c:pt idx="1">
                  <c:v>3.5999999999999999E-3</c:v>
                </c:pt>
                <c:pt idx="2">
                  <c:v>0.23080000000000001</c:v>
                </c:pt>
                <c:pt idx="3">
                  <c:v>0.48080000000000001</c:v>
                </c:pt>
                <c:pt idx="4">
                  <c:v>0.73109999999999997</c:v>
                </c:pt>
                <c:pt idx="5">
                  <c:v>0.98140000000000005</c:v>
                </c:pt>
                <c:pt idx="6">
                  <c:v>1.2317</c:v>
                </c:pt>
                <c:pt idx="7">
                  <c:v>1.4819</c:v>
                </c:pt>
                <c:pt idx="8">
                  <c:v>1.7322</c:v>
                </c:pt>
                <c:pt idx="9">
                  <c:v>1.9824999999999999</c:v>
                </c:pt>
                <c:pt idx="10">
                  <c:v>2.2328000000000001</c:v>
                </c:pt>
                <c:pt idx="11">
                  <c:v>2.4830999999999999</c:v>
                </c:pt>
                <c:pt idx="12">
                  <c:v>2.7332999999999998</c:v>
                </c:pt>
                <c:pt idx="13">
                  <c:v>2.9836</c:v>
                </c:pt>
                <c:pt idx="14">
                  <c:v>3.2339000000000002</c:v>
                </c:pt>
                <c:pt idx="15">
                  <c:v>3.4842</c:v>
                </c:pt>
                <c:pt idx="16">
                  <c:v>3.7343999999999999</c:v>
                </c:pt>
                <c:pt idx="17">
                  <c:v>3.9847000000000001</c:v>
                </c:pt>
                <c:pt idx="18">
                  <c:v>4.2350000000000003</c:v>
                </c:pt>
                <c:pt idx="19">
                  <c:v>4.4852999999999996</c:v>
                </c:pt>
                <c:pt idx="20">
                  <c:v>4.7355999999999998</c:v>
                </c:pt>
                <c:pt idx="21">
                  <c:v>4.9858000000000002</c:v>
                </c:pt>
                <c:pt idx="22">
                  <c:v>5.2361000000000004</c:v>
                </c:pt>
                <c:pt idx="23">
                  <c:v>5.4863999999999997</c:v>
                </c:pt>
                <c:pt idx="24">
                  <c:v>5.7366999999999999</c:v>
                </c:pt>
                <c:pt idx="25">
                  <c:v>5.9869000000000003</c:v>
                </c:pt>
                <c:pt idx="26">
                  <c:v>6.2371999999999996</c:v>
                </c:pt>
                <c:pt idx="27">
                  <c:v>6.4874999999999998</c:v>
                </c:pt>
                <c:pt idx="28">
                  <c:v>6.7378</c:v>
                </c:pt>
                <c:pt idx="29">
                  <c:v>6.9881000000000002</c:v>
                </c:pt>
                <c:pt idx="30">
                  <c:v>7.2382999999999997</c:v>
                </c:pt>
                <c:pt idx="31">
                  <c:v>7.4885999999999999</c:v>
                </c:pt>
                <c:pt idx="32">
                  <c:v>7.7389000000000001</c:v>
                </c:pt>
                <c:pt idx="33">
                  <c:v>7.9892000000000003</c:v>
                </c:pt>
                <c:pt idx="34">
                  <c:v>8.2393999999999998</c:v>
                </c:pt>
                <c:pt idx="35">
                  <c:v>8.4896999999999991</c:v>
                </c:pt>
                <c:pt idx="36">
                  <c:v>8.74</c:v>
                </c:pt>
                <c:pt idx="37">
                  <c:v>8.9902999999999995</c:v>
                </c:pt>
                <c:pt idx="38">
                  <c:v>9.2406000000000006</c:v>
                </c:pt>
                <c:pt idx="39">
                  <c:v>9.4908000000000001</c:v>
                </c:pt>
                <c:pt idx="40">
                  <c:v>9.7410999999999994</c:v>
                </c:pt>
                <c:pt idx="41">
                  <c:v>9.9914000000000005</c:v>
                </c:pt>
                <c:pt idx="42">
                  <c:v>10.2417</c:v>
                </c:pt>
                <c:pt idx="43">
                  <c:v>10.491899999999999</c:v>
                </c:pt>
                <c:pt idx="44">
                  <c:v>10.7422</c:v>
                </c:pt>
                <c:pt idx="45">
                  <c:v>10.9925</c:v>
                </c:pt>
                <c:pt idx="46">
                  <c:v>11.242800000000001</c:v>
                </c:pt>
                <c:pt idx="47">
                  <c:v>11.4931</c:v>
                </c:pt>
                <c:pt idx="48">
                  <c:v>11.7433</c:v>
                </c:pt>
                <c:pt idx="49">
                  <c:v>11.993600000000001</c:v>
                </c:pt>
                <c:pt idx="50">
                  <c:v>12.2439</c:v>
                </c:pt>
                <c:pt idx="51">
                  <c:v>12.494199999999999</c:v>
                </c:pt>
                <c:pt idx="52">
                  <c:v>12.744400000000001</c:v>
                </c:pt>
                <c:pt idx="53">
                  <c:v>12.9947</c:v>
                </c:pt>
                <c:pt idx="54">
                  <c:v>13.244999999999999</c:v>
                </c:pt>
                <c:pt idx="55">
                  <c:v>13.4953</c:v>
                </c:pt>
                <c:pt idx="56">
                  <c:v>13.7456</c:v>
                </c:pt>
                <c:pt idx="57">
                  <c:v>13.995799999999999</c:v>
                </c:pt>
                <c:pt idx="58">
                  <c:v>14.2461</c:v>
                </c:pt>
                <c:pt idx="59">
                  <c:v>14.4964</c:v>
                </c:pt>
                <c:pt idx="60">
                  <c:v>14.746700000000001</c:v>
                </c:pt>
                <c:pt idx="61">
                  <c:v>14.9969</c:v>
                </c:pt>
                <c:pt idx="62">
                  <c:v>15.247199999999999</c:v>
                </c:pt>
                <c:pt idx="63">
                  <c:v>15.4975</c:v>
                </c:pt>
                <c:pt idx="64">
                  <c:v>15.7478</c:v>
                </c:pt>
                <c:pt idx="65">
                  <c:v>15.998100000000001</c:v>
                </c:pt>
                <c:pt idx="66">
                  <c:v>16.2483</c:v>
                </c:pt>
                <c:pt idx="67">
                  <c:v>16.4986</c:v>
                </c:pt>
                <c:pt idx="68">
                  <c:v>16.748899999999999</c:v>
                </c:pt>
                <c:pt idx="69">
                  <c:v>16.999199999999998</c:v>
                </c:pt>
                <c:pt idx="70">
                  <c:v>17.249400000000001</c:v>
                </c:pt>
                <c:pt idx="71">
                  <c:v>17.499700000000001</c:v>
                </c:pt>
                <c:pt idx="72">
                  <c:v>17.749700000000001</c:v>
                </c:pt>
                <c:pt idx="73">
                  <c:v>18</c:v>
                </c:pt>
                <c:pt idx="74">
                  <c:v>18.250299999999999</c:v>
                </c:pt>
                <c:pt idx="75">
                  <c:v>18.500599999999999</c:v>
                </c:pt>
                <c:pt idx="76">
                  <c:v>18.750800000000002</c:v>
                </c:pt>
                <c:pt idx="77">
                  <c:v>19.001100000000001</c:v>
                </c:pt>
                <c:pt idx="78">
                  <c:v>19.2514</c:v>
                </c:pt>
                <c:pt idx="79">
                  <c:v>19.5017</c:v>
                </c:pt>
                <c:pt idx="80">
                  <c:v>19.751899999999999</c:v>
                </c:pt>
                <c:pt idx="81">
                  <c:v>20.002199999999998</c:v>
                </c:pt>
                <c:pt idx="82">
                  <c:v>20.252500000000001</c:v>
                </c:pt>
                <c:pt idx="83">
                  <c:v>20.502800000000001</c:v>
                </c:pt>
                <c:pt idx="84">
                  <c:v>20.7531</c:v>
                </c:pt>
                <c:pt idx="85">
                  <c:v>21.003299999999999</c:v>
                </c:pt>
                <c:pt idx="86">
                  <c:v>21.253599999999999</c:v>
                </c:pt>
                <c:pt idx="87">
                  <c:v>21.503900000000002</c:v>
                </c:pt>
                <c:pt idx="88">
                  <c:v>21.754200000000001</c:v>
                </c:pt>
                <c:pt idx="89">
                  <c:v>22.0044</c:v>
                </c:pt>
                <c:pt idx="90">
                  <c:v>22.2547</c:v>
                </c:pt>
                <c:pt idx="91">
                  <c:v>22.504999999999999</c:v>
                </c:pt>
                <c:pt idx="92">
                  <c:v>22.755299999999998</c:v>
                </c:pt>
                <c:pt idx="93">
                  <c:v>23.005600000000001</c:v>
                </c:pt>
                <c:pt idx="94">
                  <c:v>23.255800000000001</c:v>
                </c:pt>
                <c:pt idx="95">
                  <c:v>23.4819</c:v>
                </c:pt>
                <c:pt idx="96">
                  <c:v>23.732199999999999</c:v>
                </c:pt>
                <c:pt idx="97">
                  <c:v>23.982500000000002</c:v>
                </c:pt>
                <c:pt idx="98">
                  <c:v>24.232800000000001</c:v>
                </c:pt>
                <c:pt idx="99">
                  <c:v>24.4831</c:v>
                </c:pt>
                <c:pt idx="100">
                  <c:v>24.7333</c:v>
                </c:pt>
                <c:pt idx="101">
                  <c:v>24.983599999999999</c:v>
                </c:pt>
                <c:pt idx="102">
                  <c:v>25.233899999999998</c:v>
                </c:pt>
                <c:pt idx="103">
                  <c:v>25.484200000000001</c:v>
                </c:pt>
                <c:pt idx="104">
                  <c:v>25.734400000000001</c:v>
                </c:pt>
                <c:pt idx="105">
                  <c:v>25.9847</c:v>
                </c:pt>
                <c:pt idx="106">
                  <c:v>26.234999999999999</c:v>
                </c:pt>
                <c:pt idx="107">
                  <c:v>26.485299999999999</c:v>
                </c:pt>
                <c:pt idx="108">
                  <c:v>26.735600000000002</c:v>
                </c:pt>
                <c:pt idx="109">
                  <c:v>26.985800000000001</c:v>
                </c:pt>
                <c:pt idx="110">
                  <c:v>27.2361</c:v>
                </c:pt>
                <c:pt idx="111">
                  <c:v>27.4864</c:v>
                </c:pt>
                <c:pt idx="112">
                  <c:v>27.736699999999999</c:v>
                </c:pt>
                <c:pt idx="113">
                  <c:v>27.986899999999999</c:v>
                </c:pt>
                <c:pt idx="114">
                  <c:v>28.237200000000001</c:v>
                </c:pt>
                <c:pt idx="115">
                  <c:v>28.487500000000001</c:v>
                </c:pt>
                <c:pt idx="116">
                  <c:v>28.7378</c:v>
                </c:pt>
                <c:pt idx="117">
                  <c:v>28.988099999999999</c:v>
                </c:pt>
                <c:pt idx="118">
                  <c:v>29.238299999999999</c:v>
                </c:pt>
                <c:pt idx="119">
                  <c:v>29.488600000000002</c:v>
                </c:pt>
                <c:pt idx="120">
                  <c:v>29.738900000000001</c:v>
                </c:pt>
                <c:pt idx="121">
                  <c:v>29.9892</c:v>
                </c:pt>
                <c:pt idx="122">
                  <c:v>30.2394</c:v>
                </c:pt>
                <c:pt idx="123">
                  <c:v>30.489699999999999</c:v>
                </c:pt>
                <c:pt idx="124">
                  <c:v>30.74</c:v>
                </c:pt>
                <c:pt idx="125">
                  <c:v>30.990300000000001</c:v>
                </c:pt>
                <c:pt idx="126">
                  <c:v>31.240600000000001</c:v>
                </c:pt>
                <c:pt idx="127">
                  <c:v>31.4908</c:v>
                </c:pt>
                <c:pt idx="128">
                  <c:v>31.741099999999999</c:v>
                </c:pt>
                <c:pt idx="129">
                  <c:v>31.991399999999999</c:v>
                </c:pt>
                <c:pt idx="130">
                  <c:v>32.241700000000002</c:v>
                </c:pt>
                <c:pt idx="131">
                  <c:v>32.491900000000001</c:v>
                </c:pt>
                <c:pt idx="132">
                  <c:v>32.742199999999997</c:v>
                </c:pt>
                <c:pt idx="133">
                  <c:v>32.9925</c:v>
                </c:pt>
                <c:pt idx="134">
                  <c:v>33.242800000000003</c:v>
                </c:pt>
                <c:pt idx="135">
                  <c:v>33.493099999999998</c:v>
                </c:pt>
                <c:pt idx="136">
                  <c:v>33.743299999999998</c:v>
                </c:pt>
                <c:pt idx="137">
                  <c:v>33.993600000000001</c:v>
                </c:pt>
                <c:pt idx="138">
                  <c:v>34.243899999999996</c:v>
                </c:pt>
                <c:pt idx="139">
                  <c:v>34.494199999999999</c:v>
                </c:pt>
                <c:pt idx="140">
                  <c:v>34.744399999999999</c:v>
                </c:pt>
                <c:pt idx="141">
                  <c:v>34.994700000000002</c:v>
                </c:pt>
                <c:pt idx="142">
                  <c:v>35.244999999999997</c:v>
                </c:pt>
                <c:pt idx="143">
                  <c:v>35.4953</c:v>
                </c:pt>
                <c:pt idx="144">
                  <c:v>35.745600000000003</c:v>
                </c:pt>
                <c:pt idx="145">
                  <c:v>35.995800000000003</c:v>
                </c:pt>
                <c:pt idx="146">
                  <c:v>36.246099999999998</c:v>
                </c:pt>
                <c:pt idx="147">
                  <c:v>36.496400000000001</c:v>
                </c:pt>
                <c:pt idx="148">
                  <c:v>36.746699999999997</c:v>
                </c:pt>
                <c:pt idx="149">
                  <c:v>36.996899999999997</c:v>
                </c:pt>
                <c:pt idx="150">
                  <c:v>37.247199999999999</c:v>
                </c:pt>
                <c:pt idx="151">
                  <c:v>37.497500000000002</c:v>
                </c:pt>
                <c:pt idx="152">
                  <c:v>37.747799999999998</c:v>
                </c:pt>
                <c:pt idx="153">
                  <c:v>37.998100000000001</c:v>
                </c:pt>
                <c:pt idx="154">
                  <c:v>38.2483</c:v>
                </c:pt>
                <c:pt idx="155">
                  <c:v>38.498600000000003</c:v>
                </c:pt>
                <c:pt idx="156">
                  <c:v>38.748899999999999</c:v>
                </c:pt>
                <c:pt idx="157">
                  <c:v>38.999200000000002</c:v>
                </c:pt>
                <c:pt idx="158">
                  <c:v>39.249400000000001</c:v>
                </c:pt>
                <c:pt idx="159">
                  <c:v>39.499699999999997</c:v>
                </c:pt>
                <c:pt idx="160">
                  <c:v>39.75</c:v>
                </c:pt>
              </c:numCache>
            </c:numRef>
          </c:xVal>
          <c:yVal>
            <c:numRef>
              <c:f>WT4Gel!$C$2:$C$174</c:f>
              <c:numCache>
                <c:formatCode>General</c:formatCode>
                <c:ptCount val="173"/>
                <c:pt idx="0">
                  <c:v>1</c:v>
                </c:pt>
                <c:pt idx="1">
                  <c:v>0.99860000000000004</c:v>
                </c:pt>
                <c:pt idx="2">
                  <c:v>1.0013000000000001</c:v>
                </c:pt>
                <c:pt idx="3">
                  <c:v>1.0024999999999999</c:v>
                </c:pt>
                <c:pt idx="4">
                  <c:v>1.0041</c:v>
                </c:pt>
                <c:pt idx="5">
                  <c:v>1.0033000000000001</c:v>
                </c:pt>
                <c:pt idx="6">
                  <c:v>1.0049999999999999</c:v>
                </c:pt>
                <c:pt idx="7">
                  <c:v>1.0057</c:v>
                </c:pt>
                <c:pt idx="8">
                  <c:v>1.0064</c:v>
                </c:pt>
                <c:pt idx="9">
                  <c:v>1.0057</c:v>
                </c:pt>
                <c:pt idx="10">
                  <c:v>1.0107999999999999</c:v>
                </c:pt>
                <c:pt idx="11">
                  <c:v>1.0139</c:v>
                </c:pt>
                <c:pt idx="12">
                  <c:v>1.0130999999999999</c:v>
                </c:pt>
                <c:pt idx="13">
                  <c:v>1.0145</c:v>
                </c:pt>
                <c:pt idx="14">
                  <c:v>1.0178</c:v>
                </c:pt>
                <c:pt idx="15">
                  <c:v>1.0174000000000001</c:v>
                </c:pt>
                <c:pt idx="16">
                  <c:v>1.0190999999999999</c:v>
                </c:pt>
                <c:pt idx="17">
                  <c:v>1.0182</c:v>
                </c:pt>
                <c:pt idx="18">
                  <c:v>1.0206</c:v>
                </c:pt>
                <c:pt idx="19">
                  <c:v>1.0194000000000001</c:v>
                </c:pt>
                <c:pt idx="20">
                  <c:v>1.0195000000000001</c:v>
                </c:pt>
                <c:pt idx="21">
                  <c:v>1.0218</c:v>
                </c:pt>
                <c:pt idx="22">
                  <c:v>1.0214000000000001</c:v>
                </c:pt>
                <c:pt idx="23">
                  <c:v>1.0209999999999999</c:v>
                </c:pt>
                <c:pt idx="24">
                  <c:v>1.0203</c:v>
                </c:pt>
                <c:pt idx="25">
                  <c:v>1.0229999999999999</c:v>
                </c:pt>
                <c:pt idx="26">
                  <c:v>1.0235000000000001</c:v>
                </c:pt>
                <c:pt idx="27">
                  <c:v>1.0243</c:v>
                </c:pt>
                <c:pt idx="28">
                  <c:v>1.0254000000000001</c:v>
                </c:pt>
                <c:pt idx="29">
                  <c:v>1.0250999999999999</c:v>
                </c:pt>
                <c:pt idx="30">
                  <c:v>1.0254000000000001</c:v>
                </c:pt>
                <c:pt idx="31">
                  <c:v>1.0255000000000001</c:v>
                </c:pt>
                <c:pt idx="32">
                  <c:v>1.0254000000000001</c:v>
                </c:pt>
                <c:pt idx="33">
                  <c:v>1.0246</c:v>
                </c:pt>
                <c:pt idx="34">
                  <c:v>1.0273000000000001</c:v>
                </c:pt>
                <c:pt idx="35">
                  <c:v>1.0262</c:v>
                </c:pt>
                <c:pt idx="36">
                  <c:v>1.0287999999999999</c:v>
                </c:pt>
                <c:pt idx="37">
                  <c:v>1.0285</c:v>
                </c:pt>
                <c:pt idx="38">
                  <c:v>1.028</c:v>
                </c:pt>
                <c:pt idx="39">
                  <c:v>1.0277000000000001</c:v>
                </c:pt>
                <c:pt idx="40">
                  <c:v>1.028</c:v>
                </c:pt>
                <c:pt idx="41">
                  <c:v>1.0270999999999999</c:v>
                </c:pt>
                <c:pt idx="42">
                  <c:v>1.0267999999999999</c:v>
                </c:pt>
                <c:pt idx="43">
                  <c:v>1.0274000000000001</c:v>
                </c:pt>
                <c:pt idx="44">
                  <c:v>1.026</c:v>
                </c:pt>
                <c:pt idx="45">
                  <c:v>1.0270999999999999</c:v>
                </c:pt>
                <c:pt idx="46">
                  <c:v>1.0282</c:v>
                </c:pt>
                <c:pt idx="47">
                  <c:v>1.0283</c:v>
                </c:pt>
                <c:pt idx="48">
                  <c:v>1.0285</c:v>
                </c:pt>
                <c:pt idx="49">
                  <c:v>1.0305</c:v>
                </c:pt>
                <c:pt idx="50">
                  <c:v>1.0311999999999999</c:v>
                </c:pt>
                <c:pt idx="51">
                  <c:v>1.0288999999999999</c:v>
                </c:pt>
                <c:pt idx="52">
                  <c:v>1.0288999999999999</c:v>
                </c:pt>
                <c:pt idx="53">
                  <c:v>1.0305</c:v>
                </c:pt>
                <c:pt idx="54">
                  <c:v>1.03</c:v>
                </c:pt>
                <c:pt idx="55">
                  <c:v>1.0303</c:v>
                </c:pt>
                <c:pt idx="56">
                  <c:v>1.0291999999999999</c:v>
                </c:pt>
                <c:pt idx="57">
                  <c:v>1.0306999999999999</c:v>
                </c:pt>
                <c:pt idx="58">
                  <c:v>1.0289999999999999</c:v>
                </c:pt>
                <c:pt idx="59">
                  <c:v>1.028</c:v>
                </c:pt>
                <c:pt idx="60">
                  <c:v>1.0309999999999999</c:v>
                </c:pt>
                <c:pt idx="61">
                  <c:v>1.0297000000000001</c:v>
                </c:pt>
                <c:pt idx="62">
                  <c:v>1.0303</c:v>
                </c:pt>
                <c:pt idx="63">
                  <c:v>1.0307999999999999</c:v>
                </c:pt>
                <c:pt idx="64">
                  <c:v>1.0285</c:v>
                </c:pt>
                <c:pt idx="65">
                  <c:v>1.0321</c:v>
                </c:pt>
                <c:pt idx="66">
                  <c:v>1.0326</c:v>
                </c:pt>
                <c:pt idx="67">
                  <c:v>1.0326</c:v>
                </c:pt>
                <c:pt idx="68">
                  <c:v>1.0316000000000001</c:v>
                </c:pt>
                <c:pt idx="69">
                  <c:v>1.0313000000000001</c:v>
                </c:pt>
                <c:pt idx="70">
                  <c:v>1.0324</c:v>
                </c:pt>
                <c:pt idx="71">
                  <c:v>1.0344</c:v>
                </c:pt>
                <c:pt idx="72">
                  <c:v>1.0351999999999999</c:v>
                </c:pt>
                <c:pt idx="73">
                  <c:v>1.0365</c:v>
                </c:pt>
                <c:pt idx="74">
                  <c:v>1.0365</c:v>
                </c:pt>
                <c:pt idx="75">
                  <c:v>1.0373000000000001</c:v>
                </c:pt>
                <c:pt idx="76">
                  <c:v>1.0391999999999999</c:v>
                </c:pt>
                <c:pt idx="77">
                  <c:v>1.0377000000000001</c:v>
                </c:pt>
                <c:pt idx="78">
                  <c:v>1.0387</c:v>
                </c:pt>
                <c:pt idx="79">
                  <c:v>1.0401</c:v>
                </c:pt>
                <c:pt idx="80">
                  <c:v>1.0418000000000001</c:v>
                </c:pt>
                <c:pt idx="81">
                  <c:v>1.042</c:v>
                </c:pt>
                <c:pt idx="82">
                  <c:v>1.0427999999999999</c:v>
                </c:pt>
                <c:pt idx="83">
                  <c:v>1.0434000000000001</c:v>
                </c:pt>
                <c:pt idx="84">
                  <c:v>1.0431999999999999</c:v>
                </c:pt>
                <c:pt idx="85">
                  <c:v>1.0436000000000001</c:v>
                </c:pt>
                <c:pt idx="86">
                  <c:v>1.0472999999999999</c:v>
                </c:pt>
                <c:pt idx="87">
                  <c:v>1.0476000000000001</c:v>
                </c:pt>
                <c:pt idx="88">
                  <c:v>1.0457000000000001</c:v>
                </c:pt>
                <c:pt idx="89">
                  <c:v>1.0464</c:v>
                </c:pt>
                <c:pt idx="90">
                  <c:v>1.0507</c:v>
                </c:pt>
                <c:pt idx="91">
                  <c:v>1.0505</c:v>
                </c:pt>
                <c:pt idx="92">
                  <c:v>1.0543</c:v>
                </c:pt>
                <c:pt idx="93">
                  <c:v>1.0567</c:v>
                </c:pt>
                <c:pt idx="94">
                  <c:v>1.0561</c:v>
                </c:pt>
                <c:pt idx="95">
                  <c:v>1.0596000000000001</c:v>
                </c:pt>
                <c:pt idx="96">
                  <c:v>1.0606</c:v>
                </c:pt>
                <c:pt idx="97">
                  <c:v>1.0606</c:v>
                </c:pt>
                <c:pt idx="98">
                  <c:v>1.0623</c:v>
                </c:pt>
                <c:pt idx="99">
                  <c:v>1.0659000000000001</c:v>
                </c:pt>
                <c:pt idx="100">
                  <c:v>1.0685</c:v>
                </c:pt>
                <c:pt idx="101">
                  <c:v>1.0692999999999999</c:v>
                </c:pt>
                <c:pt idx="102">
                  <c:v>1.0714999999999999</c:v>
                </c:pt>
                <c:pt idx="103">
                  <c:v>1.0730999999999999</c:v>
                </c:pt>
                <c:pt idx="104">
                  <c:v>1.0788</c:v>
                </c:pt>
                <c:pt idx="105">
                  <c:v>1.0834999999999999</c:v>
                </c:pt>
                <c:pt idx="106">
                  <c:v>1.0847</c:v>
                </c:pt>
                <c:pt idx="107">
                  <c:v>1.0845</c:v>
                </c:pt>
                <c:pt idx="108">
                  <c:v>1.0882000000000001</c:v>
                </c:pt>
                <c:pt idx="109">
                  <c:v>1.0895999999999999</c:v>
                </c:pt>
                <c:pt idx="110">
                  <c:v>1.0912999999999999</c:v>
                </c:pt>
                <c:pt idx="111">
                  <c:v>1.0958000000000001</c:v>
                </c:pt>
                <c:pt idx="112">
                  <c:v>1.0999000000000001</c:v>
                </c:pt>
                <c:pt idx="113">
                  <c:v>1.1052999999999999</c:v>
                </c:pt>
                <c:pt idx="114">
                  <c:v>1.1082000000000001</c:v>
                </c:pt>
                <c:pt idx="115">
                  <c:v>1.1106</c:v>
                </c:pt>
                <c:pt idx="116">
                  <c:v>1.1151</c:v>
                </c:pt>
                <c:pt idx="117">
                  <c:v>1.1202000000000001</c:v>
                </c:pt>
                <c:pt idx="118">
                  <c:v>1.1273</c:v>
                </c:pt>
                <c:pt idx="119">
                  <c:v>1.1302000000000001</c:v>
                </c:pt>
                <c:pt idx="120">
                  <c:v>1.1363000000000001</c:v>
                </c:pt>
                <c:pt idx="121">
                  <c:v>1.1398999999999999</c:v>
                </c:pt>
                <c:pt idx="122">
                  <c:v>1.1438999999999999</c:v>
                </c:pt>
                <c:pt idx="123">
                  <c:v>1.1496</c:v>
                </c:pt>
                <c:pt idx="124">
                  <c:v>1.1538999999999999</c:v>
                </c:pt>
                <c:pt idx="125">
                  <c:v>1.1606000000000001</c:v>
                </c:pt>
                <c:pt idx="126">
                  <c:v>1.1685000000000001</c:v>
                </c:pt>
                <c:pt idx="127">
                  <c:v>1.1741999999999999</c:v>
                </c:pt>
                <c:pt idx="128">
                  <c:v>1.1781999999999999</c:v>
                </c:pt>
                <c:pt idx="129">
                  <c:v>1.1854</c:v>
                </c:pt>
                <c:pt idx="130">
                  <c:v>1.1881999999999999</c:v>
                </c:pt>
                <c:pt idx="131">
                  <c:v>1.1963999999999999</c:v>
                </c:pt>
                <c:pt idx="132">
                  <c:v>1.2034</c:v>
                </c:pt>
                <c:pt idx="133">
                  <c:v>1.2123999999999999</c:v>
                </c:pt>
                <c:pt idx="134">
                  <c:v>1.2189000000000001</c:v>
                </c:pt>
                <c:pt idx="135">
                  <c:v>1.2245999999999999</c:v>
                </c:pt>
                <c:pt idx="136">
                  <c:v>1.2323999999999999</c:v>
                </c:pt>
                <c:pt idx="137">
                  <c:v>1.2382</c:v>
                </c:pt>
                <c:pt idx="138">
                  <c:v>1.2444</c:v>
                </c:pt>
                <c:pt idx="139">
                  <c:v>1.2533000000000001</c:v>
                </c:pt>
                <c:pt idx="140">
                  <c:v>1.2645999999999999</c:v>
                </c:pt>
                <c:pt idx="141">
                  <c:v>1.27</c:v>
                </c:pt>
                <c:pt idx="142">
                  <c:v>1.2785</c:v>
                </c:pt>
                <c:pt idx="143">
                  <c:v>1.2894000000000001</c:v>
                </c:pt>
                <c:pt idx="144">
                  <c:v>1.2970999999999999</c:v>
                </c:pt>
                <c:pt idx="145">
                  <c:v>1.3067</c:v>
                </c:pt>
                <c:pt idx="146">
                  <c:v>1.3145</c:v>
                </c:pt>
                <c:pt idx="147">
                  <c:v>1.3225</c:v>
                </c:pt>
                <c:pt idx="148">
                  <c:v>1.3303</c:v>
                </c:pt>
                <c:pt idx="149">
                  <c:v>1.3389</c:v>
                </c:pt>
                <c:pt idx="150">
                  <c:v>1.3504</c:v>
                </c:pt>
                <c:pt idx="151">
                  <c:v>1.3559000000000001</c:v>
                </c:pt>
                <c:pt idx="152">
                  <c:v>1.3689</c:v>
                </c:pt>
                <c:pt idx="153">
                  <c:v>1.3772</c:v>
                </c:pt>
                <c:pt idx="154">
                  <c:v>1.3874</c:v>
                </c:pt>
                <c:pt idx="155">
                  <c:v>1.3975</c:v>
                </c:pt>
                <c:pt idx="156">
                  <c:v>1.4107000000000001</c:v>
                </c:pt>
                <c:pt idx="157">
                  <c:v>1.4178999999999999</c:v>
                </c:pt>
                <c:pt idx="158">
                  <c:v>1.4279999999999999</c:v>
                </c:pt>
                <c:pt idx="159">
                  <c:v>1.4370000000000001</c:v>
                </c:pt>
                <c:pt idx="160">
                  <c:v>1.443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055296"/>
        <c:axId val="32057216"/>
      </c:scatterChart>
      <c:valAx>
        <c:axId val="32055296"/>
        <c:scaling>
          <c:orientation val="minMax"/>
          <c:max val="4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ou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32057216"/>
        <c:crosses val="autoZero"/>
        <c:crossBetween val="midCat"/>
      </c:valAx>
      <c:valAx>
        <c:axId val="32057216"/>
        <c:scaling>
          <c:orientation val="minMax"/>
          <c:min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32055296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17010525746137403"/>
          <c:y val="7.3690037892021179E-2"/>
          <c:w val="0.40095765056394977"/>
          <c:h val="0.27543105188774486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962618309075001"/>
          <c:y val="2.8491129330483173E-2"/>
          <c:w val="0.73198997852541159"/>
          <c:h val="0.7344480898221055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H$23</c:f>
              <c:strCache>
                <c:ptCount val="1"/>
                <c:pt idx="0">
                  <c:v>WT14 Con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Sheet3!$E$1:$E$116</c:f>
                <c:numCache>
                  <c:formatCode>General</c:formatCode>
                  <c:ptCount val="116"/>
                  <c:pt idx="0">
                    <c:v>0</c:v>
                  </c:pt>
                  <c:pt idx="1">
                    <c:v>7.5000000000000002E-4</c:v>
                  </c:pt>
                  <c:pt idx="2">
                    <c:v>1.6999999999999999E-3</c:v>
                  </c:pt>
                  <c:pt idx="3">
                    <c:v>2.0500000000000002E-3</c:v>
                  </c:pt>
                  <c:pt idx="4">
                    <c:v>2.65E-3</c:v>
                  </c:pt>
                  <c:pt idx="5">
                    <c:v>3.9500000000000004E-3</c:v>
                  </c:pt>
                  <c:pt idx="6">
                    <c:v>4.3E-3</c:v>
                  </c:pt>
                  <c:pt idx="7">
                    <c:v>4.9500000000000004E-3</c:v>
                  </c:pt>
                  <c:pt idx="8">
                    <c:v>4.4999999999999997E-3</c:v>
                  </c:pt>
                  <c:pt idx="9">
                    <c:v>5.5500000000000002E-3</c:v>
                  </c:pt>
                  <c:pt idx="10">
                    <c:v>7.6499999999999997E-3</c:v>
                  </c:pt>
                  <c:pt idx="11">
                    <c:v>8.5000000000000006E-3</c:v>
                  </c:pt>
                  <c:pt idx="12">
                    <c:v>8.6E-3</c:v>
                  </c:pt>
                  <c:pt idx="13">
                    <c:v>9.0500000000000008E-3</c:v>
                  </c:pt>
                  <c:pt idx="14">
                    <c:v>1.0800000000000001E-2</c:v>
                  </c:pt>
                  <c:pt idx="15">
                    <c:v>1.1650000000000001E-2</c:v>
                  </c:pt>
                  <c:pt idx="16">
                    <c:v>1.125E-2</c:v>
                  </c:pt>
                  <c:pt idx="17">
                    <c:v>1.1900000000000001E-2</c:v>
                  </c:pt>
                  <c:pt idx="18">
                    <c:v>1.235E-2</c:v>
                  </c:pt>
                  <c:pt idx="19">
                    <c:v>1.325E-2</c:v>
                  </c:pt>
                  <c:pt idx="20">
                    <c:v>1.41E-2</c:v>
                  </c:pt>
                  <c:pt idx="21">
                    <c:v>1.46E-2</c:v>
                  </c:pt>
                  <c:pt idx="22">
                    <c:v>1.5900000000000001E-2</c:v>
                  </c:pt>
                  <c:pt idx="23">
                    <c:v>1.6549999999999999E-2</c:v>
                  </c:pt>
                  <c:pt idx="24">
                    <c:v>1.7749999999999998E-2</c:v>
                  </c:pt>
                  <c:pt idx="25">
                    <c:v>1.805E-2</c:v>
                  </c:pt>
                  <c:pt idx="26">
                    <c:v>1.8599999999999998E-2</c:v>
                  </c:pt>
                  <c:pt idx="27">
                    <c:v>2.0199999999999999E-2</c:v>
                  </c:pt>
                  <c:pt idx="28">
                    <c:v>2.035E-2</c:v>
                  </c:pt>
                  <c:pt idx="29">
                    <c:v>1.9949999999999999E-2</c:v>
                  </c:pt>
                  <c:pt idx="30">
                    <c:v>2.085E-2</c:v>
                  </c:pt>
                  <c:pt idx="31">
                    <c:v>2.1999999999999999E-2</c:v>
                  </c:pt>
                  <c:pt idx="32">
                    <c:v>2.3699999999999999E-2</c:v>
                  </c:pt>
                  <c:pt idx="33">
                    <c:v>2.435E-2</c:v>
                  </c:pt>
                  <c:pt idx="34">
                    <c:v>2.5000000000000001E-2</c:v>
                  </c:pt>
                  <c:pt idx="35">
                    <c:v>2.52E-2</c:v>
                  </c:pt>
                  <c:pt idx="36">
                    <c:v>2.6749999999999999E-2</c:v>
                  </c:pt>
                  <c:pt idx="37">
                    <c:v>2.6800000000000001E-2</c:v>
                  </c:pt>
                  <c:pt idx="38">
                    <c:v>2.7949999999999999E-2</c:v>
                  </c:pt>
                  <c:pt idx="39">
                    <c:v>2.9149999999999999E-2</c:v>
                  </c:pt>
                  <c:pt idx="40">
                    <c:v>3.0249999999999999E-2</c:v>
                  </c:pt>
                  <c:pt idx="41">
                    <c:v>3.0249999999999999E-2</c:v>
                  </c:pt>
                  <c:pt idx="42">
                    <c:v>3.1199999999999999E-2</c:v>
                  </c:pt>
                  <c:pt idx="43">
                    <c:v>3.2000000000000001E-2</c:v>
                  </c:pt>
                  <c:pt idx="44">
                    <c:v>3.245E-2</c:v>
                  </c:pt>
                  <c:pt idx="45">
                    <c:v>3.2899999999999999E-2</c:v>
                  </c:pt>
                  <c:pt idx="46">
                    <c:v>3.3349999999999998E-2</c:v>
                  </c:pt>
                  <c:pt idx="47">
                    <c:v>3.4299999999999997E-2</c:v>
                  </c:pt>
                  <c:pt idx="48">
                    <c:v>3.5650000000000001E-2</c:v>
                  </c:pt>
                  <c:pt idx="49">
                    <c:v>3.5900000000000001E-2</c:v>
                  </c:pt>
                  <c:pt idx="50">
                    <c:v>3.5999999999999997E-2</c:v>
                  </c:pt>
                  <c:pt idx="51">
                    <c:v>3.7350000000000001E-2</c:v>
                  </c:pt>
                  <c:pt idx="52">
                    <c:v>3.8600000000000002E-2</c:v>
                  </c:pt>
                  <c:pt idx="53">
                    <c:v>3.875E-2</c:v>
                  </c:pt>
                  <c:pt idx="54">
                    <c:v>3.9E-2</c:v>
                  </c:pt>
                  <c:pt idx="55">
                    <c:v>4.0050000000000002E-2</c:v>
                  </c:pt>
                  <c:pt idx="56">
                    <c:v>4.0050000000000002E-2</c:v>
                  </c:pt>
                  <c:pt idx="57">
                    <c:v>4.1050000000000003E-2</c:v>
                  </c:pt>
                  <c:pt idx="58">
                    <c:v>4.095E-2</c:v>
                  </c:pt>
                  <c:pt idx="59">
                    <c:v>4.1599999999999998E-2</c:v>
                  </c:pt>
                  <c:pt idx="60">
                    <c:v>4.2099999999999999E-2</c:v>
                  </c:pt>
                  <c:pt idx="61">
                    <c:v>4.2549999999999998E-2</c:v>
                  </c:pt>
                  <c:pt idx="62">
                    <c:v>4.3150000000000001E-2</c:v>
                  </c:pt>
                  <c:pt idx="63">
                    <c:v>4.385E-2</c:v>
                  </c:pt>
                  <c:pt idx="64">
                    <c:v>4.4850000000000001E-2</c:v>
                  </c:pt>
                  <c:pt idx="65">
                    <c:v>4.5949999999999998E-2</c:v>
                  </c:pt>
                  <c:pt idx="66">
                    <c:v>4.65E-2</c:v>
                  </c:pt>
                  <c:pt idx="67">
                    <c:v>4.6800000000000001E-2</c:v>
                  </c:pt>
                  <c:pt idx="68">
                    <c:v>4.7849999999999997E-2</c:v>
                  </c:pt>
                  <c:pt idx="69">
                    <c:v>4.7550000000000002E-2</c:v>
                  </c:pt>
                  <c:pt idx="70">
                    <c:v>4.8550000000000003E-2</c:v>
                  </c:pt>
                  <c:pt idx="71">
                    <c:v>4.8800000000000003E-2</c:v>
                  </c:pt>
                  <c:pt idx="72">
                    <c:v>4.8899999999999999E-2</c:v>
                  </c:pt>
                  <c:pt idx="73">
                    <c:v>4.9399999999999999E-2</c:v>
                  </c:pt>
                  <c:pt idx="74">
                    <c:v>5.0599999999999999E-2</c:v>
                  </c:pt>
                  <c:pt idx="75">
                    <c:v>4.9500000000000002E-2</c:v>
                  </c:pt>
                  <c:pt idx="76">
                    <c:v>5.0200000000000002E-2</c:v>
                  </c:pt>
                  <c:pt idx="77">
                    <c:v>4.9700000000000001E-2</c:v>
                  </c:pt>
                  <c:pt idx="78">
                    <c:v>5.0750000000000003E-2</c:v>
                  </c:pt>
                  <c:pt idx="79">
                    <c:v>5.0500000000000003E-2</c:v>
                  </c:pt>
                  <c:pt idx="80">
                    <c:v>5.0799999999999998E-2</c:v>
                  </c:pt>
                  <c:pt idx="81">
                    <c:v>5.0799999999999998E-2</c:v>
                  </c:pt>
                  <c:pt idx="82">
                    <c:v>5.0700000000000002E-2</c:v>
                  </c:pt>
                  <c:pt idx="83">
                    <c:v>5.1200000000000002E-2</c:v>
                  </c:pt>
                  <c:pt idx="84">
                    <c:v>5.2449999999999997E-2</c:v>
                  </c:pt>
                  <c:pt idx="85">
                    <c:v>5.1900000000000002E-2</c:v>
                  </c:pt>
                  <c:pt idx="86">
                    <c:v>5.1950000000000003E-2</c:v>
                  </c:pt>
                  <c:pt idx="87">
                    <c:v>5.2449999999999997E-2</c:v>
                  </c:pt>
                  <c:pt idx="88">
                    <c:v>5.1700000000000003E-2</c:v>
                  </c:pt>
                  <c:pt idx="89">
                    <c:v>5.16E-2</c:v>
                  </c:pt>
                  <c:pt idx="90">
                    <c:v>5.1799999999999999E-2</c:v>
                  </c:pt>
                  <c:pt idx="91">
                    <c:v>5.1150000000000001E-2</c:v>
                  </c:pt>
                  <c:pt idx="92">
                    <c:v>5.1249999999999997E-2</c:v>
                  </c:pt>
                  <c:pt idx="93">
                    <c:v>5.1450000000000003E-2</c:v>
                  </c:pt>
                  <c:pt idx="94">
                    <c:v>5.0849999999999999E-2</c:v>
                  </c:pt>
                  <c:pt idx="95">
                    <c:v>0.05</c:v>
                  </c:pt>
                  <c:pt idx="96">
                    <c:v>4.9250000000000002E-2</c:v>
                  </c:pt>
                  <c:pt idx="97">
                    <c:v>5.0049999999999997E-2</c:v>
                  </c:pt>
                  <c:pt idx="98">
                    <c:v>4.9349999999999998E-2</c:v>
                  </c:pt>
                  <c:pt idx="99">
                    <c:v>4.9599999999999998E-2</c:v>
                  </c:pt>
                  <c:pt idx="100">
                    <c:v>5.0200000000000002E-2</c:v>
                  </c:pt>
                  <c:pt idx="101">
                    <c:v>5.04E-2</c:v>
                  </c:pt>
                  <c:pt idx="102">
                    <c:v>5.04E-2</c:v>
                  </c:pt>
                  <c:pt idx="103">
                    <c:v>4.9549999999999997E-2</c:v>
                  </c:pt>
                  <c:pt idx="104">
                    <c:v>4.895E-2</c:v>
                  </c:pt>
                  <c:pt idx="105">
                    <c:v>4.9099999999999998E-2</c:v>
                  </c:pt>
                  <c:pt idx="106">
                    <c:v>4.82E-2</c:v>
                  </c:pt>
                  <c:pt idx="107">
                    <c:v>4.87E-2</c:v>
                  </c:pt>
                  <c:pt idx="108">
                    <c:v>4.965E-2</c:v>
                  </c:pt>
                  <c:pt idx="109">
                    <c:v>4.9299999999999997E-2</c:v>
                  </c:pt>
                  <c:pt idx="110">
                    <c:v>5.015E-2</c:v>
                  </c:pt>
                  <c:pt idx="111">
                    <c:v>4.9299999999999997E-2</c:v>
                  </c:pt>
                  <c:pt idx="112">
                    <c:v>4.845E-2</c:v>
                  </c:pt>
                  <c:pt idx="113">
                    <c:v>4.8000000000000001E-2</c:v>
                  </c:pt>
                  <c:pt idx="114">
                    <c:v>4.7699999999999999E-2</c:v>
                  </c:pt>
                  <c:pt idx="115">
                    <c:v>4.8399999999999999E-2</c:v>
                  </c:pt>
                </c:numCache>
              </c:numRef>
            </c:plus>
            <c:minus>
              <c:numRef>
                <c:f>Sheet3!$E$1:$E$116</c:f>
                <c:numCache>
                  <c:formatCode>General</c:formatCode>
                  <c:ptCount val="116"/>
                  <c:pt idx="0">
                    <c:v>0</c:v>
                  </c:pt>
                  <c:pt idx="1">
                    <c:v>7.5000000000000002E-4</c:v>
                  </c:pt>
                  <c:pt idx="2">
                    <c:v>1.6999999999999999E-3</c:v>
                  </c:pt>
                  <c:pt idx="3">
                    <c:v>2.0500000000000002E-3</c:v>
                  </c:pt>
                  <c:pt idx="4">
                    <c:v>2.65E-3</c:v>
                  </c:pt>
                  <c:pt idx="5">
                    <c:v>3.9500000000000004E-3</c:v>
                  </c:pt>
                  <c:pt idx="6">
                    <c:v>4.3E-3</c:v>
                  </c:pt>
                  <c:pt idx="7">
                    <c:v>4.9500000000000004E-3</c:v>
                  </c:pt>
                  <c:pt idx="8">
                    <c:v>4.4999999999999997E-3</c:v>
                  </c:pt>
                  <c:pt idx="9">
                    <c:v>5.5500000000000002E-3</c:v>
                  </c:pt>
                  <c:pt idx="10">
                    <c:v>7.6499999999999997E-3</c:v>
                  </c:pt>
                  <c:pt idx="11">
                    <c:v>8.5000000000000006E-3</c:v>
                  </c:pt>
                  <c:pt idx="12">
                    <c:v>8.6E-3</c:v>
                  </c:pt>
                  <c:pt idx="13">
                    <c:v>9.0500000000000008E-3</c:v>
                  </c:pt>
                  <c:pt idx="14">
                    <c:v>1.0800000000000001E-2</c:v>
                  </c:pt>
                  <c:pt idx="15">
                    <c:v>1.1650000000000001E-2</c:v>
                  </c:pt>
                  <c:pt idx="16">
                    <c:v>1.125E-2</c:v>
                  </c:pt>
                  <c:pt idx="17">
                    <c:v>1.1900000000000001E-2</c:v>
                  </c:pt>
                  <c:pt idx="18">
                    <c:v>1.235E-2</c:v>
                  </c:pt>
                  <c:pt idx="19">
                    <c:v>1.325E-2</c:v>
                  </c:pt>
                  <c:pt idx="20">
                    <c:v>1.41E-2</c:v>
                  </c:pt>
                  <c:pt idx="21">
                    <c:v>1.46E-2</c:v>
                  </c:pt>
                  <c:pt idx="22">
                    <c:v>1.5900000000000001E-2</c:v>
                  </c:pt>
                  <c:pt idx="23">
                    <c:v>1.6549999999999999E-2</c:v>
                  </c:pt>
                  <c:pt idx="24">
                    <c:v>1.7749999999999998E-2</c:v>
                  </c:pt>
                  <c:pt idx="25">
                    <c:v>1.805E-2</c:v>
                  </c:pt>
                  <c:pt idx="26">
                    <c:v>1.8599999999999998E-2</c:v>
                  </c:pt>
                  <c:pt idx="27">
                    <c:v>2.0199999999999999E-2</c:v>
                  </c:pt>
                  <c:pt idx="28">
                    <c:v>2.035E-2</c:v>
                  </c:pt>
                  <c:pt idx="29">
                    <c:v>1.9949999999999999E-2</c:v>
                  </c:pt>
                  <c:pt idx="30">
                    <c:v>2.085E-2</c:v>
                  </c:pt>
                  <c:pt idx="31">
                    <c:v>2.1999999999999999E-2</c:v>
                  </c:pt>
                  <c:pt idx="32">
                    <c:v>2.3699999999999999E-2</c:v>
                  </c:pt>
                  <c:pt idx="33">
                    <c:v>2.435E-2</c:v>
                  </c:pt>
                  <c:pt idx="34">
                    <c:v>2.5000000000000001E-2</c:v>
                  </c:pt>
                  <c:pt idx="35">
                    <c:v>2.52E-2</c:v>
                  </c:pt>
                  <c:pt idx="36">
                    <c:v>2.6749999999999999E-2</c:v>
                  </c:pt>
                  <c:pt idx="37">
                    <c:v>2.6800000000000001E-2</c:v>
                  </c:pt>
                  <c:pt idx="38">
                    <c:v>2.7949999999999999E-2</c:v>
                  </c:pt>
                  <c:pt idx="39">
                    <c:v>2.9149999999999999E-2</c:v>
                  </c:pt>
                  <c:pt idx="40">
                    <c:v>3.0249999999999999E-2</c:v>
                  </c:pt>
                  <c:pt idx="41">
                    <c:v>3.0249999999999999E-2</c:v>
                  </c:pt>
                  <c:pt idx="42">
                    <c:v>3.1199999999999999E-2</c:v>
                  </c:pt>
                  <c:pt idx="43">
                    <c:v>3.2000000000000001E-2</c:v>
                  </c:pt>
                  <c:pt idx="44">
                    <c:v>3.245E-2</c:v>
                  </c:pt>
                  <c:pt idx="45">
                    <c:v>3.2899999999999999E-2</c:v>
                  </c:pt>
                  <c:pt idx="46">
                    <c:v>3.3349999999999998E-2</c:v>
                  </c:pt>
                  <c:pt idx="47">
                    <c:v>3.4299999999999997E-2</c:v>
                  </c:pt>
                  <c:pt idx="48">
                    <c:v>3.5650000000000001E-2</c:v>
                  </c:pt>
                  <c:pt idx="49">
                    <c:v>3.5900000000000001E-2</c:v>
                  </c:pt>
                  <c:pt idx="50">
                    <c:v>3.5999999999999997E-2</c:v>
                  </c:pt>
                  <c:pt idx="51">
                    <c:v>3.7350000000000001E-2</c:v>
                  </c:pt>
                  <c:pt idx="52">
                    <c:v>3.8600000000000002E-2</c:v>
                  </c:pt>
                  <c:pt idx="53">
                    <c:v>3.875E-2</c:v>
                  </c:pt>
                  <c:pt idx="54">
                    <c:v>3.9E-2</c:v>
                  </c:pt>
                  <c:pt idx="55">
                    <c:v>4.0050000000000002E-2</c:v>
                  </c:pt>
                  <c:pt idx="56">
                    <c:v>4.0050000000000002E-2</c:v>
                  </c:pt>
                  <c:pt idx="57">
                    <c:v>4.1050000000000003E-2</c:v>
                  </c:pt>
                  <c:pt idx="58">
                    <c:v>4.095E-2</c:v>
                  </c:pt>
                  <c:pt idx="59">
                    <c:v>4.1599999999999998E-2</c:v>
                  </c:pt>
                  <c:pt idx="60">
                    <c:v>4.2099999999999999E-2</c:v>
                  </c:pt>
                  <c:pt idx="61">
                    <c:v>4.2549999999999998E-2</c:v>
                  </c:pt>
                  <c:pt idx="62">
                    <c:v>4.3150000000000001E-2</c:v>
                  </c:pt>
                  <c:pt idx="63">
                    <c:v>4.385E-2</c:v>
                  </c:pt>
                  <c:pt idx="64">
                    <c:v>4.4850000000000001E-2</c:v>
                  </c:pt>
                  <c:pt idx="65">
                    <c:v>4.5949999999999998E-2</c:v>
                  </c:pt>
                  <c:pt idx="66">
                    <c:v>4.65E-2</c:v>
                  </c:pt>
                  <c:pt idx="67">
                    <c:v>4.6800000000000001E-2</c:v>
                  </c:pt>
                  <c:pt idx="68">
                    <c:v>4.7849999999999997E-2</c:v>
                  </c:pt>
                  <c:pt idx="69">
                    <c:v>4.7550000000000002E-2</c:v>
                  </c:pt>
                  <c:pt idx="70">
                    <c:v>4.8550000000000003E-2</c:v>
                  </c:pt>
                  <c:pt idx="71">
                    <c:v>4.8800000000000003E-2</c:v>
                  </c:pt>
                  <c:pt idx="72">
                    <c:v>4.8899999999999999E-2</c:v>
                  </c:pt>
                  <c:pt idx="73">
                    <c:v>4.9399999999999999E-2</c:v>
                  </c:pt>
                  <c:pt idx="74">
                    <c:v>5.0599999999999999E-2</c:v>
                  </c:pt>
                  <c:pt idx="75">
                    <c:v>4.9500000000000002E-2</c:v>
                  </c:pt>
                  <c:pt idx="76">
                    <c:v>5.0200000000000002E-2</c:v>
                  </c:pt>
                  <c:pt idx="77">
                    <c:v>4.9700000000000001E-2</c:v>
                  </c:pt>
                  <c:pt idx="78">
                    <c:v>5.0750000000000003E-2</c:v>
                  </c:pt>
                  <c:pt idx="79">
                    <c:v>5.0500000000000003E-2</c:v>
                  </c:pt>
                  <c:pt idx="80">
                    <c:v>5.0799999999999998E-2</c:v>
                  </c:pt>
                  <c:pt idx="81">
                    <c:v>5.0799999999999998E-2</c:v>
                  </c:pt>
                  <c:pt idx="82">
                    <c:v>5.0700000000000002E-2</c:v>
                  </c:pt>
                  <c:pt idx="83">
                    <c:v>5.1200000000000002E-2</c:v>
                  </c:pt>
                  <c:pt idx="84">
                    <c:v>5.2449999999999997E-2</c:v>
                  </c:pt>
                  <c:pt idx="85">
                    <c:v>5.1900000000000002E-2</c:v>
                  </c:pt>
                  <c:pt idx="86">
                    <c:v>5.1950000000000003E-2</c:v>
                  </c:pt>
                  <c:pt idx="87">
                    <c:v>5.2449999999999997E-2</c:v>
                  </c:pt>
                  <c:pt idx="88">
                    <c:v>5.1700000000000003E-2</c:v>
                  </c:pt>
                  <c:pt idx="89">
                    <c:v>5.16E-2</c:v>
                  </c:pt>
                  <c:pt idx="90">
                    <c:v>5.1799999999999999E-2</c:v>
                  </c:pt>
                  <c:pt idx="91">
                    <c:v>5.1150000000000001E-2</c:v>
                  </c:pt>
                  <c:pt idx="92">
                    <c:v>5.1249999999999997E-2</c:v>
                  </c:pt>
                  <c:pt idx="93">
                    <c:v>5.1450000000000003E-2</c:v>
                  </c:pt>
                  <c:pt idx="94">
                    <c:v>5.0849999999999999E-2</c:v>
                  </c:pt>
                  <c:pt idx="95">
                    <c:v>0.05</c:v>
                  </c:pt>
                  <c:pt idx="96">
                    <c:v>4.9250000000000002E-2</c:v>
                  </c:pt>
                  <c:pt idx="97">
                    <c:v>5.0049999999999997E-2</c:v>
                  </c:pt>
                  <c:pt idx="98">
                    <c:v>4.9349999999999998E-2</c:v>
                  </c:pt>
                  <c:pt idx="99">
                    <c:v>4.9599999999999998E-2</c:v>
                  </c:pt>
                  <c:pt idx="100">
                    <c:v>5.0200000000000002E-2</c:v>
                  </c:pt>
                  <c:pt idx="101">
                    <c:v>5.04E-2</c:v>
                  </c:pt>
                  <c:pt idx="102">
                    <c:v>5.04E-2</c:v>
                  </c:pt>
                  <c:pt idx="103">
                    <c:v>4.9549999999999997E-2</c:v>
                  </c:pt>
                  <c:pt idx="104">
                    <c:v>4.895E-2</c:v>
                  </c:pt>
                  <c:pt idx="105">
                    <c:v>4.9099999999999998E-2</c:v>
                  </c:pt>
                  <c:pt idx="106">
                    <c:v>4.82E-2</c:v>
                  </c:pt>
                  <c:pt idx="107">
                    <c:v>4.87E-2</c:v>
                  </c:pt>
                  <c:pt idx="108">
                    <c:v>4.965E-2</c:v>
                  </c:pt>
                  <c:pt idx="109">
                    <c:v>4.9299999999999997E-2</c:v>
                  </c:pt>
                  <c:pt idx="110">
                    <c:v>5.015E-2</c:v>
                  </c:pt>
                  <c:pt idx="111">
                    <c:v>4.9299999999999997E-2</c:v>
                  </c:pt>
                  <c:pt idx="112">
                    <c:v>4.845E-2</c:v>
                  </c:pt>
                  <c:pt idx="113">
                    <c:v>4.8000000000000001E-2</c:v>
                  </c:pt>
                  <c:pt idx="114">
                    <c:v>4.7699999999999999E-2</c:v>
                  </c:pt>
                  <c:pt idx="115">
                    <c:v>4.8399999999999999E-2</c:v>
                  </c:pt>
                </c:numCache>
              </c:numRef>
            </c:minus>
            <c:spPr>
              <a:ln>
                <a:solidFill>
                  <a:schemeClr val="tx2">
                    <a:alpha val="50000"/>
                  </a:schemeClr>
                </a:solidFill>
              </a:ln>
            </c:spPr>
          </c:errBars>
          <c:xVal>
            <c:numRef>
              <c:f>Sheet3!$A$1:$A$116</c:f>
              <c:numCache>
                <c:formatCode>General</c:formatCode>
                <c:ptCount val="116"/>
                <c:pt idx="0">
                  <c:v>0</c:v>
                </c:pt>
                <c:pt idx="1">
                  <c:v>3.0999999999999999E-3</c:v>
                </c:pt>
                <c:pt idx="2">
                  <c:v>0.58860000000000001</c:v>
                </c:pt>
                <c:pt idx="3">
                  <c:v>0.83860000000000001</c:v>
                </c:pt>
                <c:pt idx="4">
                  <c:v>1.0886</c:v>
                </c:pt>
                <c:pt idx="5">
                  <c:v>1.3389</c:v>
                </c:pt>
                <c:pt idx="6">
                  <c:v>1.5889</c:v>
                </c:pt>
                <c:pt idx="7">
                  <c:v>1.8389</c:v>
                </c:pt>
                <c:pt idx="8">
                  <c:v>2.0891999999999999</c:v>
                </c:pt>
                <c:pt idx="9">
                  <c:v>2.3393999999999999</c:v>
                </c:pt>
                <c:pt idx="10">
                  <c:v>2.5897000000000001</c:v>
                </c:pt>
                <c:pt idx="11">
                  <c:v>2.84</c:v>
                </c:pt>
                <c:pt idx="12">
                  <c:v>3.0903</c:v>
                </c:pt>
                <c:pt idx="13">
                  <c:v>3.3405999999999998</c:v>
                </c:pt>
                <c:pt idx="14">
                  <c:v>3.5908000000000002</c:v>
                </c:pt>
                <c:pt idx="15">
                  <c:v>3.8411</c:v>
                </c:pt>
                <c:pt idx="16">
                  <c:v>4.0914000000000001</c:v>
                </c:pt>
                <c:pt idx="17">
                  <c:v>4.3417000000000003</c:v>
                </c:pt>
                <c:pt idx="18">
                  <c:v>4.5918999999999999</c:v>
                </c:pt>
                <c:pt idx="19">
                  <c:v>4.8422000000000001</c:v>
                </c:pt>
                <c:pt idx="20">
                  <c:v>5.0925000000000002</c:v>
                </c:pt>
                <c:pt idx="21">
                  <c:v>5.3428000000000004</c:v>
                </c:pt>
                <c:pt idx="22">
                  <c:v>5.5930999999999997</c:v>
                </c:pt>
                <c:pt idx="23">
                  <c:v>5.8433000000000002</c:v>
                </c:pt>
                <c:pt idx="24">
                  <c:v>6.0936000000000003</c:v>
                </c:pt>
                <c:pt idx="25">
                  <c:v>6.3438999999999997</c:v>
                </c:pt>
                <c:pt idx="26">
                  <c:v>6.5941999999999998</c:v>
                </c:pt>
                <c:pt idx="27">
                  <c:v>6.8444000000000003</c:v>
                </c:pt>
                <c:pt idx="28">
                  <c:v>7.0946999999999996</c:v>
                </c:pt>
                <c:pt idx="29">
                  <c:v>7.3449999999999998</c:v>
                </c:pt>
                <c:pt idx="30">
                  <c:v>7.5952999999999999</c:v>
                </c:pt>
                <c:pt idx="31">
                  <c:v>7.8456000000000001</c:v>
                </c:pt>
                <c:pt idx="32">
                  <c:v>8.0958000000000006</c:v>
                </c:pt>
                <c:pt idx="33">
                  <c:v>8.3460999999999999</c:v>
                </c:pt>
                <c:pt idx="34">
                  <c:v>8.5963999999999992</c:v>
                </c:pt>
                <c:pt idx="35">
                  <c:v>8.8467000000000002</c:v>
                </c:pt>
                <c:pt idx="36">
                  <c:v>9.0968999999999998</c:v>
                </c:pt>
                <c:pt idx="37">
                  <c:v>9.3472000000000008</c:v>
                </c:pt>
                <c:pt idx="38">
                  <c:v>9.5975000000000001</c:v>
                </c:pt>
                <c:pt idx="39">
                  <c:v>9.8477999999999994</c:v>
                </c:pt>
                <c:pt idx="40">
                  <c:v>10.098100000000001</c:v>
                </c:pt>
                <c:pt idx="41">
                  <c:v>10.3483</c:v>
                </c:pt>
                <c:pt idx="42">
                  <c:v>10.598599999999999</c:v>
                </c:pt>
                <c:pt idx="43">
                  <c:v>10.8489</c:v>
                </c:pt>
                <c:pt idx="44">
                  <c:v>11.0992</c:v>
                </c:pt>
                <c:pt idx="45">
                  <c:v>11.349399999999999</c:v>
                </c:pt>
                <c:pt idx="46">
                  <c:v>11.5997</c:v>
                </c:pt>
                <c:pt idx="47">
                  <c:v>11.85</c:v>
                </c:pt>
                <c:pt idx="48">
                  <c:v>12.100300000000001</c:v>
                </c:pt>
                <c:pt idx="49">
                  <c:v>12.3506</c:v>
                </c:pt>
                <c:pt idx="50">
                  <c:v>12.6008</c:v>
                </c:pt>
                <c:pt idx="51">
                  <c:v>12.851100000000001</c:v>
                </c:pt>
                <c:pt idx="52">
                  <c:v>13.1014</c:v>
                </c:pt>
                <c:pt idx="53">
                  <c:v>13.351699999999999</c:v>
                </c:pt>
                <c:pt idx="54">
                  <c:v>13.601900000000001</c:v>
                </c:pt>
                <c:pt idx="55">
                  <c:v>13.8522</c:v>
                </c:pt>
                <c:pt idx="56">
                  <c:v>14.102499999999999</c:v>
                </c:pt>
                <c:pt idx="57">
                  <c:v>14.3528</c:v>
                </c:pt>
                <c:pt idx="58">
                  <c:v>14.6031</c:v>
                </c:pt>
                <c:pt idx="59">
                  <c:v>14.853300000000001</c:v>
                </c:pt>
                <c:pt idx="60">
                  <c:v>15.1036</c:v>
                </c:pt>
                <c:pt idx="61">
                  <c:v>15.353899999999999</c:v>
                </c:pt>
                <c:pt idx="62">
                  <c:v>15.604200000000001</c:v>
                </c:pt>
                <c:pt idx="63">
                  <c:v>15.8544</c:v>
                </c:pt>
                <c:pt idx="64">
                  <c:v>16.104700000000001</c:v>
                </c:pt>
                <c:pt idx="65">
                  <c:v>16.355</c:v>
                </c:pt>
                <c:pt idx="66">
                  <c:v>16.6053</c:v>
                </c:pt>
                <c:pt idx="67">
                  <c:v>16.855599999999999</c:v>
                </c:pt>
                <c:pt idx="68">
                  <c:v>17.105799999999999</c:v>
                </c:pt>
                <c:pt idx="69">
                  <c:v>17.356100000000001</c:v>
                </c:pt>
                <c:pt idx="70">
                  <c:v>17.606400000000001</c:v>
                </c:pt>
                <c:pt idx="71">
                  <c:v>17.8567</c:v>
                </c:pt>
                <c:pt idx="72">
                  <c:v>18.1069</c:v>
                </c:pt>
                <c:pt idx="73">
                  <c:v>18.357199999999999</c:v>
                </c:pt>
                <c:pt idx="74">
                  <c:v>18.607500000000002</c:v>
                </c:pt>
                <c:pt idx="75">
                  <c:v>18.857800000000001</c:v>
                </c:pt>
                <c:pt idx="76">
                  <c:v>19.1081</c:v>
                </c:pt>
                <c:pt idx="77">
                  <c:v>19.3583</c:v>
                </c:pt>
                <c:pt idx="78">
                  <c:v>19.608599999999999</c:v>
                </c:pt>
                <c:pt idx="79">
                  <c:v>19.858899999999998</c:v>
                </c:pt>
                <c:pt idx="80">
                  <c:v>20.109200000000001</c:v>
                </c:pt>
                <c:pt idx="81">
                  <c:v>20.359400000000001</c:v>
                </c:pt>
                <c:pt idx="82">
                  <c:v>20.6097</c:v>
                </c:pt>
                <c:pt idx="83">
                  <c:v>20.86</c:v>
                </c:pt>
                <c:pt idx="84">
                  <c:v>21.110299999999999</c:v>
                </c:pt>
                <c:pt idx="85">
                  <c:v>21.360600000000002</c:v>
                </c:pt>
                <c:pt idx="86">
                  <c:v>21.610800000000001</c:v>
                </c:pt>
                <c:pt idx="87">
                  <c:v>21.8611</c:v>
                </c:pt>
                <c:pt idx="88">
                  <c:v>22.1114</c:v>
                </c:pt>
                <c:pt idx="89">
                  <c:v>22.361699999999999</c:v>
                </c:pt>
                <c:pt idx="90">
                  <c:v>22.611899999999999</c:v>
                </c:pt>
                <c:pt idx="91">
                  <c:v>22.862200000000001</c:v>
                </c:pt>
                <c:pt idx="92">
                  <c:v>23.112500000000001</c:v>
                </c:pt>
                <c:pt idx="93">
                  <c:v>23.3628</c:v>
                </c:pt>
                <c:pt idx="94">
                  <c:v>23.613099999999999</c:v>
                </c:pt>
                <c:pt idx="95">
                  <c:v>23.863299999999999</c:v>
                </c:pt>
                <c:pt idx="96">
                  <c:v>24.113600000000002</c:v>
                </c:pt>
                <c:pt idx="97">
                  <c:v>24.363900000000001</c:v>
                </c:pt>
                <c:pt idx="98">
                  <c:v>24.6142</c:v>
                </c:pt>
                <c:pt idx="99">
                  <c:v>24.8644</c:v>
                </c:pt>
                <c:pt idx="100">
                  <c:v>25.114699999999999</c:v>
                </c:pt>
                <c:pt idx="101">
                  <c:v>25.364999999999998</c:v>
                </c:pt>
                <c:pt idx="102">
                  <c:v>25.615300000000001</c:v>
                </c:pt>
                <c:pt idx="103">
                  <c:v>25.865600000000001</c:v>
                </c:pt>
                <c:pt idx="104">
                  <c:v>26.1158</c:v>
                </c:pt>
                <c:pt idx="105">
                  <c:v>26.366099999999999</c:v>
                </c:pt>
                <c:pt idx="106">
                  <c:v>26.616399999999999</c:v>
                </c:pt>
                <c:pt idx="107">
                  <c:v>26.866700000000002</c:v>
                </c:pt>
                <c:pt idx="108">
                  <c:v>27.116900000000001</c:v>
                </c:pt>
                <c:pt idx="109">
                  <c:v>27.3672</c:v>
                </c:pt>
                <c:pt idx="110">
                  <c:v>27.6175</c:v>
                </c:pt>
                <c:pt idx="111">
                  <c:v>27.867799999999999</c:v>
                </c:pt>
                <c:pt idx="112">
                  <c:v>28.118099999999998</c:v>
                </c:pt>
                <c:pt idx="113">
                  <c:v>28.368300000000001</c:v>
                </c:pt>
                <c:pt idx="114">
                  <c:v>28.618600000000001</c:v>
                </c:pt>
                <c:pt idx="115">
                  <c:v>28.8689</c:v>
                </c:pt>
              </c:numCache>
            </c:numRef>
          </c:xVal>
          <c:yVal>
            <c:numRef>
              <c:f>Sheet3!$B$1:$B$116</c:f>
              <c:numCache>
                <c:formatCode>General</c:formatCode>
                <c:ptCount val="116"/>
                <c:pt idx="0">
                  <c:v>1</c:v>
                </c:pt>
                <c:pt idx="1">
                  <c:v>1.0028999999999999</c:v>
                </c:pt>
                <c:pt idx="2">
                  <c:v>1.0061</c:v>
                </c:pt>
                <c:pt idx="3">
                  <c:v>1.0095000000000001</c:v>
                </c:pt>
                <c:pt idx="4">
                  <c:v>1.0115000000000001</c:v>
                </c:pt>
                <c:pt idx="5">
                  <c:v>1.0146999999999999</c:v>
                </c:pt>
                <c:pt idx="6">
                  <c:v>1.0199</c:v>
                </c:pt>
                <c:pt idx="7">
                  <c:v>1.0210999999999999</c:v>
                </c:pt>
                <c:pt idx="8">
                  <c:v>1.0230999999999999</c:v>
                </c:pt>
                <c:pt idx="9">
                  <c:v>1.0270999999999999</c:v>
                </c:pt>
                <c:pt idx="10">
                  <c:v>1.0339</c:v>
                </c:pt>
                <c:pt idx="11">
                  <c:v>1.0384</c:v>
                </c:pt>
                <c:pt idx="12">
                  <c:v>1.0448999999999999</c:v>
                </c:pt>
                <c:pt idx="13">
                  <c:v>1.0501</c:v>
                </c:pt>
                <c:pt idx="14">
                  <c:v>1.0571999999999999</c:v>
                </c:pt>
                <c:pt idx="15">
                  <c:v>1.0647</c:v>
                </c:pt>
                <c:pt idx="16">
                  <c:v>1.0717000000000001</c:v>
                </c:pt>
                <c:pt idx="17">
                  <c:v>1.079</c:v>
                </c:pt>
                <c:pt idx="18">
                  <c:v>1.0847</c:v>
                </c:pt>
                <c:pt idx="19">
                  <c:v>1.0913999999999999</c:v>
                </c:pt>
                <c:pt idx="20">
                  <c:v>1.0960000000000001</c:v>
                </c:pt>
                <c:pt idx="21">
                  <c:v>1.1025</c:v>
                </c:pt>
                <c:pt idx="22">
                  <c:v>1.1095999999999999</c:v>
                </c:pt>
                <c:pt idx="23">
                  <c:v>1.1160000000000001</c:v>
                </c:pt>
                <c:pt idx="24">
                  <c:v>1.1222000000000001</c:v>
                </c:pt>
                <c:pt idx="25">
                  <c:v>1.1292</c:v>
                </c:pt>
                <c:pt idx="26">
                  <c:v>1.1352</c:v>
                </c:pt>
                <c:pt idx="27">
                  <c:v>1.1417999999999999</c:v>
                </c:pt>
                <c:pt idx="28">
                  <c:v>1.1478999999999999</c:v>
                </c:pt>
                <c:pt idx="29">
                  <c:v>1.1526000000000001</c:v>
                </c:pt>
                <c:pt idx="30">
                  <c:v>1.1589</c:v>
                </c:pt>
                <c:pt idx="31">
                  <c:v>1.1639999999999999</c:v>
                </c:pt>
                <c:pt idx="32">
                  <c:v>1.1709000000000001</c:v>
                </c:pt>
                <c:pt idx="33">
                  <c:v>1.1746000000000001</c:v>
                </c:pt>
                <c:pt idx="34">
                  <c:v>1.1796</c:v>
                </c:pt>
                <c:pt idx="35">
                  <c:v>1.1850000000000001</c:v>
                </c:pt>
                <c:pt idx="36">
                  <c:v>1.1909000000000001</c:v>
                </c:pt>
                <c:pt idx="37">
                  <c:v>1.1946000000000001</c:v>
                </c:pt>
                <c:pt idx="38">
                  <c:v>1.1992</c:v>
                </c:pt>
                <c:pt idx="39">
                  <c:v>1.2048000000000001</c:v>
                </c:pt>
                <c:pt idx="40">
                  <c:v>1.2091000000000001</c:v>
                </c:pt>
                <c:pt idx="41">
                  <c:v>1.2133</c:v>
                </c:pt>
                <c:pt idx="42">
                  <c:v>1.2171000000000001</c:v>
                </c:pt>
                <c:pt idx="43">
                  <c:v>1.2222999999999999</c:v>
                </c:pt>
                <c:pt idx="44">
                  <c:v>1.228</c:v>
                </c:pt>
                <c:pt idx="45">
                  <c:v>1.2337</c:v>
                </c:pt>
                <c:pt idx="46">
                  <c:v>1.2366999999999999</c:v>
                </c:pt>
                <c:pt idx="47">
                  <c:v>1.2414000000000001</c:v>
                </c:pt>
                <c:pt idx="48">
                  <c:v>1.2462</c:v>
                </c:pt>
                <c:pt idx="49">
                  <c:v>1.2513000000000001</c:v>
                </c:pt>
                <c:pt idx="50">
                  <c:v>1.2561</c:v>
                </c:pt>
                <c:pt idx="51">
                  <c:v>1.2608999999999999</c:v>
                </c:pt>
                <c:pt idx="52">
                  <c:v>1.2653000000000001</c:v>
                </c:pt>
                <c:pt idx="53">
                  <c:v>1.2693000000000001</c:v>
                </c:pt>
                <c:pt idx="54">
                  <c:v>1.2743</c:v>
                </c:pt>
                <c:pt idx="55">
                  <c:v>1.2787999999999999</c:v>
                </c:pt>
                <c:pt idx="56">
                  <c:v>1.2822</c:v>
                </c:pt>
                <c:pt idx="57">
                  <c:v>1.2864</c:v>
                </c:pt>
                <c:pt idx="58">
                  <c:v>1.288</c:v>
                </c:pt>
                <c:pt idx="59">
                  <c:v>1.2942</c:v>
                </c:pt>
                <c:pt idx="60">
                  <c:v>1.2976000000000001</c:v>
                </c:pt>
                <c:pt idx="61">
                  <c:v>1.3019000000000001</c:v>
                </c:pt>
                <c:pt idx="62">
                  <c:v>1.3048</c:v>
                </c:pt>
                <c:pt idx="63">
                  <c:v>1.3099000000000001</c:v>
                </c:pt>
                <c:pt idx="64">
                  <c:v>1.3140000000000001</c:v>
                </c:pt>
                <c:pt idx="65">
                  <c:v>1.3171999999999999</c:v>
                </c:pt>
                <c:pt idx="66">
                  <c:v>1.3219000000000001</c:v>
                </c:pt>
                <c:pt idx="67">
                  <c:v>1.3240000000000001</c:v>
                </c:pt>
                <c:pt idx="68">
                  <c:v>1.3277000000000001</c:v>
                </c:pt>
                <c:pt idx="69">
                  <c:v>1.3299000000000001</c:v>
                </c:pt>
                <c:pt idx="70">
                  <c:v>1.3329</c:v>
                </c:pt>
                <c:pt idx="71">
                  <c:v>1.3369</c:v>
                </c:pt>
                <c:pt idx="72">
                  <c:v>1.3402000000000001</c:v>
                </c:pt>
                <c:pt idx="73">
                  <c:v>1.3431</c:v>
                </c:pt>
                <c:pt idx="74">
                  <c:v>1.3467</c:v>
                </c:pt>
                <c:pt idx="75">
                  <c:v>1.3508</c:v>
                </c:pt>
                <c:pt idx="76">
                  <c:v>1.3533999999999999</c:v>
                </c:pt>
                <c:pt idx="77">
                  <c:v>1.3552</c:v>
                </c:pt>
                <c:pt idx="78">
                  <c:v>1.3586</c:v>
                </c:pt>
                <c:pt idx="79">
                  <c:v>1.3613999999999999</c:v>
                </c:pt>
                <c:pt idx="80">
                  <c:v>1.3634999999999999</c:v>
                </c:pt>
                <c:pt idx="81">
                  <c:v>1.3671</c:v>
                </c:pt>
                <c:pt idx="82">
                  <c:v>1.3693</c:v>
                </c:pt>
                <c:pt idx="83">
                  <c:v>1.3712</c:v>
                </c:pt>
                <c:pt idx="84">
                  <c:v>1.3753</c:v>
                </c:pt>
                <c:pt idx="85">
                  <c:v>1.3765000000000001</c:v>
                </c:pt>
                <c:pt idx="86">
                  <c:v>1.3796999999999999</c:v>
                </c:pt>
                <c:pt idx="87">
                  <c:v>1.3821000000000001</c:v>
                </c:pt>
                <c:pt idx="88">
                  <c:v>1.3848</c:v>
                </c:pt>
                <c:pt idx="89">
                  <c:v>1.3849</c:v>
                </c:pt>
                <c:pt idx="90">
                  <c:v>1.3888</c:v>
                </c:pt>
                <c:pt idx="91">
                  <c:v>1.3885000000000001</c:v>
                </c:pt>
                <c:pt idx="92">
                  <c:v>1.3939999999999999</c:v>
                </c:pt>
                <c:pt idx="93">
                  <c:v>1.3962000000000001</c:v>
                </c:pt>
                <c:pt idx="94">
                  <c:v>1.3983000000000001</c:v>
                </c:pt>
                <c:pt idx="95">
                  <c:v>1.4007000000000001</c:v>
                </c:pt>
                <c:pt idx="96">
                  <c:v>1.4006000000000001</c:v>
                </c:pt>
                <c:pt idx="97">
                  <c:v>1.4035</c:v>
                </c:pt>
                <c:pt idx="98">
                  <c:v>1.4033</c:v>
                </c:pt>
                <c:pt idx="99">
                  <c:v>1.4068000000000001</c:v>
                </c:pt>
                <c:pt idx="100">
                  <c:v>1.4106000000000001</c:v>
                </c:pt>
                <c:pt idx="101">
                  <c:v>1.411</c:v>
                </c:pt>
                <c:pt idx="102">
                  <c:v>1.4151</c:v>
                </c:pt>
                <c:pt idx="103">
                  <c:v>1.4167000000000001</c:v>
                </c:pt>
                <c:pt idx="104">
                  <c:v>1.4193</c:v>
                </c:pt>
                <c:pt idx="105">
                  <c:v>1.4216</c:v>
                </c:pt>
                <c:pt idx="106">
                  <c:v>1.423</c:v>
                </c:pt>
                <c:pt idx="107">
                  <c:v>1.4261999999999999</c:v>
                </c:pt>
                <c:pt idx="108">
                  <c:v>1.4280999999999999</c:v>
                </c:pt>
                <c:pt idx="109">
                  <c:v>1.4305000000000001</c:v>
                </c:pt>
                <c:pt idx="110">
                  <c:v>1.4343999999999999</c:v>
                </c:pt>
                <c:pt idx="111">
                  <c:v>1.4374</c:v>
                </c:pt>
                <c:pt idx="112">
                  <c:v>1.4399</c:v>
                </c:pt>
                <c:pt idx="113">
                  <c:v>1.4404999999999999</c:v>
                </c:pt>
                <c:pt idx="114">
                  <c:v>1.4434</c:v>
                </c:pt>
                <c:pt idx="115">
                  <c:v>1.4469000000000001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H$24</c:f>
              <c:strCache>
                <c:ptCount val="1"/>
                <c:pt idx="0">
                  <c:v>WT14 Dox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Sheet3!$F$1:$F$116</c:f>
                <c:numCache>
                  <c:formatCode>General</c:formatCode>
                  <c:ptCount val="116"/>
                  <c:pt idx="0">
                    <c:v>0</c:v>
                  </c:pt>
                  <c:pt idx="1">
                    <c:v>1.0499999999999999E-3</c:v>
                  </c:pt>
                  <c:pt idx="2">
                    <c:v>1.035E-2</c:v>
                  </c:pt>
                  <c:pt idx="3">
                    <c:v>9.9000000000000008E-3</c:v>
                  </c:pt>
                  <c:pt idx="4">
                    <c:v>9.4500000000000001E-3</c:v>
                  </c:pt>
                  <c:pt idx="5">
                    <c:v>1.005E-2</c:v>
                  </c:pt>
                  <c:pt idx="6">
                    <c:v>9.9500000000000005E-3</c:v>
                  </c:pt>
                  <c:pt idx="7">
                    <c:v>1.125E-2</c:v>
                  </c:pt>
                  <c:pt idx="8">
                    <c:v>1.0999999999999999E-2</c:v>
                  </c:pt>
                  <c:pt idx="9">
                    <c:v>1.1299999999999999E-2</c:v>
                  </c:pt>
                  <c:pt idx="10">
                    <c:v>1.2E-2</c:v>
                  </c:pt>
                  <c:pt idx="11">
                    <c:v>1.21E-2</c:v>
                  </c:pt>
                  <c:pt idx="12">
                    <c:v>1.26E-2</c:v>
                  </c:pt>
                  <c:pt idx="13">
                    <c:v>1.32E-2</c:v>
                  </c:pt>
                  <c:pt idx="14">
                    <c:v>1.3350000000000001E-2</c:v>
                  </c:pt>
                  <c:pt idx="15">
                    <c:v>1.4250000000000001E-2</c:v>
                  </c:pt>
                  <c:pt idx="16">
                    <c:v>1.4749999999999999E-2</c:v>
                  </c:pt>
                  <c:pt idx="17">
                    <c:v>1.5299999999999999E-2</c:v>
                  </c:pt>
                  <c:pt idx="18">
                    <c:v>1.635E-2</c:v>
                  </c:pt>
                  <c:pt idx="19">
                    <c:v>1.6449999999999999E-2</c:v>
                  </c:pt>
                  <c:pt idx="20">
                    <c:v>1.6899999999999998E-2</c:v>
                  </c:pt>
                  <c:pt idx="21">
                    <c:v>1.7999999999999999E-2</c:v>
                  </c:pt>
                  <c:pt idx="22">
                    <c:v>1.83E-2</c:v>
                  </c:pt>
                  <c:pt idx="23">
                    <c:v>1.9199999999999998E-2</c:v>
                  </c:pt>
                  <c:pt idx="24">
                    <c:v>2.0250000000000001E-2</c:v>
                  </c:pt>
                  <c:pt idx="25">
                    <c:v>2.0250000000000001E-2</c:v>
                  </c:pt>
                  <c:pt idx="26">
                    <c:v>2.1100000000000001E-2</c:v>
                  </c:pt>
                  <c:pt idx="27">
                    <c:v>2.145E-2</c:v>
                  </c:pt>
                  <c:pt idx="28">
                    <c:v>2.1850000000000001E-2</c:v>
                  </c:pt>
                  <c:pt idx="29">
                    <c:v>2.24E-2</c:v>
                  </c:pt>
                  <c:pt idx="30">
                    <c:v>2.2550000000000001E-2</c:v>
                  </c:pt>
                  <c:pt idx="31">
                    <c:v>2.3599999999999999E-2</c:v>
                  </c:pt>
                  <c:pt idx="32">
                    <c:v>2.435E-2</c:v>
                  </c:pt>
                  <c:pt idx="33">
                    <c:v>2.5049999999999999E-2</c:v>
                  </c:pt>
                  <c:pt idx="34">
                    <c:v>2.5399999999999999E-2</c:v>
                  </c:pt>
                  <c:pt idx="35">
                    <c:v>2.605E-2</c:v>
                  </c:pt>
                  <c:pt idx="36">
                    <c:v>2.6349999999999998E-2</c:v>
                  </c:pt>
                  <c:pt idx="37">
                    <c:v>2.7E-2</c:v>
                  </c:pt>
                  <c:pt idx="38">
                    <c:v>2.8400000000000002E-2</c:v>
                  </c:pt>
                  <c:pt idx="39">
                    <c:v>2.9000000000000001E-2</c:v>
                  </c:pt>
                  <c:pt idx="40">
                    <c:v>2.9600000000000001E-2</c:v>
                  </c:pt>
                  <c:pt idx="41">
                    <c:v>3.0300000000000001E-2</c:v>
                  </c:pt>
                  <c:pt idx="42">
                    <c:v>3.0800000000000001E-2</c:v>
                  </c:pt>
                  <c:pt idx="43">
                    <c:v>3.1649999999999998E-2</c:v>
                  </c:pt>
                  <c:pt idx="44">
                    <c:v>3.245E-2</c:v>
                  </c:pt>
                  <c:pt idx="45">
                    <c:v>3.2750000000000001E-2</c:v>
                  </c:pt>
                  <c:pt idx="46">
                    <c:v>3.3300000000000003E-2</c:v>
                  </c:pt>
                  <c:pt idx="47">
                    <c:v>3.44E-2</c:v>
                  </c:pt>
                  <c:pt idx="48">
                    <c:v>3.4599999999999999E-2</c:v>
                  </c:pt>
                  <c:pt idx="49">
                    <c:v>3.465E-2</c:v>
                  </c:pt>
                  <c:pt idx="50">
                    <c:v>3.5200000000000002E-2</c:v>
                  </c:pt>
                  <c:pt idx="51">
                    <c:v>3.6200000000000003E-2</c:v>
                  </c:pt>
                  <c:pt idx="52">
                    <c:v>3.6499999999999998E-2</c:v>
                  </c:pt>
                  <c:pt idx="53">
                    <c:v>3.7150000000000002E-2</c:v>
                  </c:pt>
                  <c:pt idx="54">
                    <c:v>3.8649999999999997E-2</c:v>
                  </c:pt>
                  <c:pt idx="55">
                    <c:v>3.8600000000000002E-2</c:v>
                  </c:pt>
                  <c:pt idx="56">
                    <c:v>3.9100000000000003E-2</c:v>
                  </c:pt>
                  <c:pt idx="57">
                    <c:v>3.9849999999999997E-2</c:v>
                  </c:pt>
                  <c:pt idx="58">
                    <c:v>4.1000000000000002E-2</c:v>
                  </c:pt>
                  <c:pt idx="59">
                    <c:v>4.1450000000000001E-2</c:v>
                  </c:pt>
                  <c:pt idx="60">
                    <c:v>4.2500000000000003E-2</c:v>
                  </c:pt>
                  <c:pt idx="61">
                    <c:v>4.2849999999999999E-2</c:v>
                  </c:pt>
                  <c:pt idx="62">
                    <c:v>4.335E-2</c:v>
                  </c:pt>
                  <c:pt idx="63">
                    <c:v>4.4400000000000002E-2</c:v>
                  </c:pt>
                  <c:pt idx="64">
                    <c:v>4.505E-2</c:v>
                  </c:pt>
                  <c:pt idx="65">
                    <c:v>4.5350000000000001E-2</c:v>
                  </c:pt>
                  <c:pt idx="66">
                    <c:v>4.6449999999999998E-2</c:v>
                  </c:pt>
                  <c:pt idx="67">
                    <c:v>4.7149999999999997E-2</c:v>
                  </c:pt>
                  <c:pt idx="68">
                    <c:v>4.6949999999999999E-2</c:v>
                  </c:pt>
                  <c:pt idx="69">
                    <c:v>4.7500000000000001E-2</c:v>
                  </c:pt>
                  <c:pt idx="70">
                    <c:v>4.82E-2</c:v>
                  </c:pt>
                  <c:pt idx="71">
                    <c:v>4.87E-2</c:v>
                  </c:pt>
                  <c:pt idx="72">
                    <c:v>4.8250000000000001E-2</c:v>
                  </c:pt>
                  <c:pt idx="73">
                    <c:v>4.9950000000000001E-2</c:v>
                  </c:pt>
                  <c:pt idx="74">
                    <c:v>5.0450000000000002E-2</c:v>
                  </c:pt>
                  <c:pt idx="75">
                    <c:v>5.1049999999999998E-2</c:v>
                  </c:pt>
                  <c:pt idx="76">
                    <c:v>5.16E-2</c:v>
                  </c:pt>
                  <c:pt idx="77">
                    <c:v>5.1499999999999997E-2</c:v>
                  </c:pt>
                  <c:pt idx="78">
                    <c:v>5.1299999999999998E-2</c:v>
                  </c:pt>
                  <c:pt idx="79">
                    <c:v>5.185E-2</c:v>
                  </c:pt>
                  <c:pt idx="80">
                    <c:v>5.1749999999999997E-2</c:v>
                  </c:pt>
                  <c:pt idx="81">
                    <c:v>5.1299999999999998E-2</c:v>
                  </c:pt>
                  <c:pt idx="82">
                    <c:v>5.0700000000000002E-2</c:v>
                  </c:pt>
                  <c:pt idx="83">
                    <c:v>5.11E-2</c:v>
                  </c:pt>
                  <c:pt idx="84">
                    <c:v>5.1299999999999998E-2</c:v>
                  </c:pt>
                  <c:pt idx="85">
                    <c:v>5.185E-2</c:v>
                  </c:pt>
                  <c:pt idx="86">
                    <c:v>5.2150000000000002E-2</c:v>
                  </c:pt>
                  <c:pt idx="87">
                    <c:v>5.2350000000000001E-2</c:v>
                  </c:pt>
                  <c:pt idx="88">
                    <c:v>5.2499999999999998E-2</c:v>
                  </c:pt>
                  <c:pt idx="89">
                    <c:v>5.3199999999999997E-2</c:v>
                  </c:pt>
                  <c:pt idx="90">
                    <c:v>5.3400000000000003E-2</c:v>
                  </c:pt>
                  <c:pt idx="91">
                    <c:v>5.3749999999999999E-2</c:v>
                  </c:pt>
                  <c:pt idx="92">
                    <c:v>5.3699999999999998E-2</c:v>
                  </c:pt>
                  <c:pt idx="93">
                    <c:v>5.4050000000000001E-2</c:v>
                  </c:pt>
                  <c:pt idx="94">
                    <c:v>5.3949999999999998E-2</c:v>
                  </c:pt>
                  <c:pt idx="95">
                    <c:v>5.4100000000000002E-2</c:v>
                  </c:pt>
                  <c:pt idx="96">
                    <c:v>5.4199999999999998E-2</c:v>
                  </c:pt>
                  <c:pt idx="97">
                    <c:v>5.4449999999999998E-2</c:v>
                  </c:pt>
                  <c:pt idx="98">
                    <c:v>5.4800000000000001E-2</c:v>
                  </c:pt>
                  <c:pt idx="99">
                    <c:v>5.4399999999999997E-2</c:v>
                  </c:pt>
                  <c:pt idx="100">
                    <c:v>5.5050000000000002E-2</c:v>
                  </c:pt>
                  <c:pt idx="101">
                    <c:v>5.5300000000000002E-2</c:v>
                  </c:pt>
                  <c:pt idx="102">
                    <c:v>5.5199999999999999E-2</c:v>
                  </c:pt>
                  <c:pt idx="103">
                    <c:v>5.5800000000000002E-2</c:v>
                  </c:pt>
                  <c:pt idx="104">
                    <c:v>5.6149999999999999E-2</c:v>
                  </c:pt>
                  <c:pt idx="105">
                    <c:v>5.6599999999999998E-2</c:v>
                  </c:pt>
                  <c:pt idx="106">
                    <c:v>5.6750000000000002E-2</c:v>
                  </c:pt>
                  <c:pt idx="107">
                    <c:v>5.645E-2</c:v>
                  </c:pt>
                  <c:pt idx="108">
                    <c:v>5.57E-2</c:v>
                  </c:pt>
                  <c:pt idx="109">
                    <c:v>5.5899999999999998E-2</c:v>
                  </c:pt>
                  <c:pt idx="110">
                    <c:v>5.6149999999999999E-2</c:v>
                  </c:pt>
                  <c:pt idx="111">
                    <c:v>5.6000000000000001E-2</c:v>
                  </c:pt>
                  <c:pt idx="112">
                    <c:v>5.525E-2</c:v>
                  </c:pt>
                  <c:pt idx="113">
                    <c:v>5.5449999999999999E-2</c:v>
                  </c:pt>
                  <c:pt idx="114">
                    <c:v>5.5550000000000002E-2</c:v>
                  </c:pt>
                  <c:pt idx="115">
                    <c:v>5.5300000000000002E-2</c:v>
                  </c:pt>
                </c:numCache>
              </c:numRef>
            </c:plus>
            <c:minus>
              <c:numRef>
                <c:f>Sheet3!$F$1:$F$116</c:f>
                <c:numCache>
                  <c:formatCode>General</c:formatCode>
                  <c:ptCount val="116"/>
                  <c:pt idx="0">
                    <c:v>0</c:v>
                  </c:pt>
                  <c:pt idx="1">
                    <c:v>1.0499999999999999E-3</c:v>
                  </c:pt>
                  <c:pt idx="2">
                    <c:v>1.035E-2</c:v>
                  </c:pt>
                  <c:pt idx="3">
                    <c:v>9.9000000000000008E-3</c:v>
                  </c:pt>
                  <c:pt idx="4">
                    <c:v>9.4500000000000001E-3</c:v>
                  </c:pt>
                  <c:pt idx="5">
                    <c:v>1.005E-2</c:v>
                  </c:pt>
                  <c:pt idx="6">
                    <c:v>9.9500000000000005E-3</c:v>
                  </c:pt>
                  <c:pt idx="7">
                    <c:v>1.125E-2</c:v>
                  </c:pt>
                  <c:pt idx="8">
                    <c:v>1.0999999999999999E-2</c:v>
                  </c:pt>
                  <c:pt idx="9">
                    <c:v>1.1299999999999999E-2</c:v>
                  </c:pt>
                  <c:pt idx="10">
                    <c:v>1.2E-2</c:v>
                  </c:pt>
                  <c:pt idx="11">
                    <c:v>1.21E-2</c:v>
                  </c:pt>
                  <c:pt idx="12">
                    <c:v>1.26E-2</c:v>
                  </c:pt>
                  <c:pt idx="13">
                    <c:v>1.32E-2</c:v>
                  </c:pt>
                  <c:pt idx="14">
                    <c:v>1.3350000000000001E-2</c:v>
                  </c:pt>
                  <c:pt idx="15">
                    <c:v>1.4250000000000001E-2</c:v>
                  </c:pt>
                  <c:pt idx="16">
                    <c:v>1.4749999999999999E-2</c:v>
                  </c:pt>
                  <c:pt idx="17">
                    <c:v>1.5299999999999999E-2</c:v>
                  </c:pt>
                  <c:pt idx="18">
                    <c:v>1.635E-2</c:v>
                  </c:pt>
                  <c:pt idx="19">
                    <c:v>1.6449999999999999E-2</c:v>
                  </c:pt>
                  <c:pt idx="20">
                    <c:v>1.6899999999999998E-2</c:v>
                  </c:pt>
                  <c:pt idx="21">
                    <c:v>1.7999999999999999E-2</c:v>
                  </c:pt>
                  <c:pt idx="22">
                    <c:v>1.83E-2</c:v>
                  </c:pt>
                  <c:pt idx="23">
                    <c:v>1.9199999999999998E-2</c:v>
                  </c:pt>
                  <c:pt idx="24">
                    <c:v>2.0250000000000001E-2</c:v>
                  </c:pt>
                  <c:pt idx="25">
                    <c:v>2.0250000000000001E-2</c:v>
                  </c:pt>
                  <c:pt idx="26">
                    <c:v>2.1100000000000001E-2</c:v>
                  </c:pt>
                  <c:pt idx="27">
                    <c:v>2.145E-2</c:v>
                  </c:pt>
                  <c:pt idx="28">
                    <c:v>2.1850000000000001E-2</c:v>
                  </c:pt>
                  <c:pt idx="29">
                    <c:v>2.24E-2</c:v>
                  </c:pt>
                  <c:pt idx="30">
                    <c:v>2.2550000000000001E-2</c:v>
                  </c:pt>
                  <c:pt idx="31">
                    <c:v>2.3599999999999999E-2</c:v>
                  </c:pt>
                  <c:pt idx="32">
                    <c:v>2.435E-2</c:v>
                  </c:pt>
                  <c:pt idx="33">
                    <c:v>2.5049999999999999E-2</c:v>
                  </c:pt>
                  <c:pt idx="34">
                    <c:v>2.5399999999999999E-2</c:v>
                  </c:pt>
                  <c:pt idx="35">
                    <c:v>2.605E-2</c:v>
                  </c:pt>
                  <c:pt idx="36">
                    <c:v>2.6349999999999998E-2</c:v>
                  </c:pt>
                  <c:pt idx="37">
                    <c:v>2.7E-2</c:v>
                  </c:pt>
                  <c:pt idx="38">
                    <c:v>2.8400000000000002E-2</c:v>
                  </c:pt>
                  <c:pt idx="39">
                    <c:v>2.9000000000000001E-2</c:v>
                  </c:pt>
                  <c:pt idx="40">
                    <c:v>2.9600000000000001E-2</c:v>
                  </c:pt>
                  <c:pt idx="41">
                    <c:v>3.0300000000000001E-2</c:v>
                  </c:pt>
                  <c:pt idx="42">
                    <c:v>3.0800000000000001E-2</c:v>
                  </c:pt>
                  <c:pt idx="43">
                    <c:v>3.1649999999999998E-2</c:v>
                  </c:pt>
                  <c:pt idx="44">
                    <c:v>3.245E-2</c:v>
                  </c:pt>
                  <c:pt idx="45">
                    <c:v>3.2750000000000001E-2</c:v>
                  </c:pt>
                  <c:pt idx="46">
                    <c:v>3.3300000000000003E-2</c:v>
                  </c:pt>
                  <c:pt idx="47">
                    <c:v>3.44E-2</c:v>
                  </c:pt>
                  <c:pt idx="48">
                    <c:v>3.4599999999999999E-2</c:v>
                  </c:pt>
                  <c:pt idx="49">
                    <c:v>3.465E-2</c:v>
                  </c:pt>
                  <c:pt idx="50">
                    <c:v>3.5200000000000002E-2</c:v>
                  </c:pt>
                  <c:pt idx="51">
                    <c:v>3.6200000000000003E-2</c:v>
                  </c:pt>
                  <c:pt idx="52">
                    <c:v>3.6499999999999998E-2</c:v>
                  </c:pt>
                  <c:pt idx="53">
                    <c:v>3.7150000000000002E-2</c:v>
                  </c:pt>
                  <c:pt idx="54">
                    <c:v>3.8649999999999997E-2</c:v>
                  </c:pt>
                  <c:pt idx="55">
                    <c:v>3.8600000000000002E-2</c:v>
                  </c:pt>
                  <c:pt idx="56">
                    <c:v>3.9100000000000003E-2</c:v>
                  </c:pt>
                  <c:pt idx="57">
                    <c:v>3.9849999999999997E-2</c:v>
                  </c:pt>
                  <c:pt idx="58">
                    <c:v>4.1000000000000002E-2</c:v>
                  </c:pt>
                  <c:pt idx="59">
                    <c:v>4.1450000000000001E-2</c:v>
                  </c:pt>
                  <c:pt idx="60">
                    <c:v>4.2500000000000003E-2</c:v>
                  </c:pt>
                  <c:pt idx="61">
                    <c:v>4.2849999999999999E-2</c:v>
                  </c:pt>
                  <c:pt idx="62">
                    <c:v>4.335E-2</c:v>
                  </c:pt>
                  <c:pt idx="63">
                    <c:v>4.4400000000000002E-2</c:v>
                  </c:pt>
                  <c:pt idx="64">
                    <c:v>4.505E-2</c:v>
                  </c:pt>
                  <c:pt idx="65">
                    <c:v>4.5350000000000001E-2</c:v>
                  </c:pt>
                  <c:pt idx="66">
                    <c:v>4.6449999999999998E-2</c:v>
                  </c:pt>
                  <c:pt idx="67">
                    <c:v>4.7149999999999997E-2</c:v>
                  </c:pt>
                  <c:pt idx="68">
                    <c:v>4.6949999999999999E-2</c:v>
                  </c:pt>
                  <c:pt idx="69">
                    <c:v>4.7500000000000001E-2</c:v>
                  </c:pt>
                  <c:pt idx="70">
                    <c:v>4.82E-2</c:v>
                  </c:pt>
                  <c:pt idx="71">
                    <c:v>4.87E-2</c:v>
                  </c:pt>
                  <c:pt idx="72">
                    <c:v>4.8250000000000001E-2</c:v>
                  </c:pt>
                  <c:pt idx="73">
                    <c:v>4.9950000000000001E-2</c:v>
                  </c:pt>
                  <c:pt idx="74">
                    <c:v>5.0450000000000002E-2</c:v>
                  </c:pt>
                  <c:pt idx="75">
                    <c:v>5.1049999999999998E-2</c:v>
                  </c:pt>
                  <c:pt idx="76">
                    <c:v>5.16E-2</c:v>
                  </c:pt>
                  <c:pt idx="77">
                    <c:v>5.1499999999999997E-2</c:v>
                  </c:pt>
                  <c:pt idx="78">
                    <c:v>5.1299999999999998E-2</c:v>
                  </c:pt>
                  <c:pt idx="79">
                    <c:v>5.185E-2</c:v>
                  </c:pt>
                  <c:pt idx="80">
                    <c:v>5.1749999999999997E-2</c:v>
                  </c:pt>
                  <c:pt idx="81">
                    <c:v>5.1299999999999998E-2</c:v>
                  </c:pt>
                  <c:pt idx="82">
                    <c:v>5.0700000000000002E-2</c:v>
                  </c:pt>
                  <c:pt idx="83">
                    <c:v>5.11E-2</c:v>
                  </c:pt>
                  <c:pt idx="84">
                    <c:v>5.1299999999999998E-2</c:v>
                  </c:pt>
                  <c:pt idx="85">
                    <c:v>5.185E-2</c:v>
                  </c:pt>
                  <c:pt idx="86">
                    <c:v>5.2150000000000002E-2</c:v>
                  </c:pt>
                  <c:pt idx="87">
                    <c:v>5.2350000000000001E-2</c:v>
                  </c:pt>
                  <c:pt idx="88">
                    <c:v>5.2499999999999998E-2</c:v>
                  </c:pt>
                  <c:pt idx="89">
                    <c:v>5.3199999999999997E-2</c:v>
                  </c:pt>
                  <c:pt idx="90">
                    <c:v>5.3400000000000003E-2</c:v>
                  </c:pt>
                  <c:pt idx="91">
                    <c:v>5.3749999999999999E-2</c:v>
                  </c:pt>
                  <c:pt idx="92">
                    <c:v>5.3699999999999998E-2</c:v>
                  </c:pt>
                  <c:pt idx="93">
                    <c:v>5.4050000000000001E-2</c:v>
                  </c:pt>
                  <c:pt idx="94">
                    <c:v>5.3949999999999998E-2</c:v>
                  </c:pt>
                  <c:pt idx="95">
                    <c:v>5.4100000000000002E-2</c:v>
                  </c:pt>
                  <c:pt idx="96">
                    <c:v>5.4199999999999998E-2</c:v>
                  </c:pt>
                  <c:pt idx="97">
                    <c:v>5.4449999999999998E-2</c:v>
                  </c:pt>
                  <c:pt idx="98">
                    <c:v>5.4800000000000001E-2</c:v>
                  </c:pt>
                  <c:pt idx="99">
                    <c:v>5.4399999999999997E-2</c:v>
                  </c:pt>
                  <c:pt idx="100">
                    <c:v>5.5050000000000002E-2</c:v>
                  </c:pt>
                  <c:pt idx="101">
                    <c:v>5.5300000000000002E-2</c:v>
                  </c:pt>
                  <c:pt idx="102">
                    <c:v>5.5199999999999999E-2</c:v>
                  </c:pt>
                  <c:pt idx="103">
                    <c:v>5.5800000000000002E-2</c:v>
                  </c:pt>
                  <c:pt idx="104">
                    <c:v>5.6149999999999999E-2</c:v>
                  </c:pt>
                  <c:pt idx="105">
                    <c:v>5.6599999999999998E-2</c:v>
                  </c:pt>
                  <c:pt idx="106">
                    <c:v>5.6750000000000002E-2</c:v>
                  </c:pt>
                  <c:pt idx="107">
                    <c:v>5.645E-2</c:v>
                  </c:pt>
                  <c:pt idx="108">
                    <c:v>5.57E-2</c:v>
                  </c:pt>
                  <c:pt idx="109">
                    <c:v>5.5899999999999998E-2</c:v>
                  </c:pt>
                  <c:pt idx="110">
                    <c:v>5.6149999999999999E-2</c:v>
                  </c:pt>
                  <c:pt idx="111">
                    <c:v>5.6000000000000001E-2</c:v>
                  </c:pt>
                  <c:pt idx="112">
                    <c:v>5.525E-2</c:v>
                  </c:pt>
                  <c:pt idx="113">
                    <c:v>5.5449999999999999E-2</c:v>
                  </c:pt>
                  <c:pt idx="114">
                    <c:v>5.5550000000000002E-2</c:v>
                  </c:pt>
                  <c:pt idx="115">
                    <c:v>5.5300000000000002E-2</c:v>
                  </c:pt>
                </c:numCache>
              </c:numRef>
            </c:minus>
            <c:spPr>
              <a:ln>
                <a:solidFill>
                  <a:srgbClr val="FF0000">
                    <a:alpha val="50000"/>
                  </a:srgbClr>
                </a:solidFill>
              </a:ln>
            </c:spPr>
          </c:errBars>
          <c:xVal>
            <c:numRef>
              <c:f>Sheet3!$A$1:$A$116</c:f>
              <c:numCache>
                <c:formatCode>General</c:formatCode>
                <c:ptCount val="116"/>
                <c:pt idx="0">
                  <c:v>0</c:v>
                </c:pt>
                <c:pt idx="1">
                  <c:v>3.0999999999999999E-3</c:v>
                </c:pt>
                <c:pt idx="2">
                  <c:v>0.58860000000000001</c:v>
                </c:pt>
                <c:pt idx="3">
                  <c:v>0.83860000000000001</c:v>
                </c:pt>
                <c:pt idx="4">
                  <c:v>1.0886</c:v>
                </c:pt>
                <c:pt idx="5">
                  <c:v>1.3389</c:v>
                </c:pt>
                <c:pt idx="6">
                  <c:v>1.5889</c:v>
                </c:pt>
                <c:pt idx="7">
                  <c:v>1.8389</c:v>
                </c:pt>
                <c:pt idx="8">
                  <c:v>2.0891999999999999</c:v>
                </c:pt>
                <c:pt idx="9">
                  <c:v>2.3393999999999999</c:v>
                </c:pt>
                <c:pt idx="10">
                  <c:v>2.5897000000000001</c:v>
                </c:pt>
                <c:pt idx="11">
                  <c:v>2.84</c:v>
                </c:pt>
                <c:pt idx="12">
                  <c:v>3.0903</c:v>
                </c:pt>
                <c:pt idx="13">
                  <c:v>3.3405999999999998</c:v>
                </c:pt>
                <c:pt idx="14">
                  <c:v>3.5908000000000002</c:v>
                </c:pt>
                <c:pt idx="15">
                  <c:v>3.8411</c:v>
                </c:pt>
                <c:pt idx="16">
                  <c:v>4.0914000000000001</c:v>
                </c:pt>
                <c:pt idx="17">
                  <c:v>4.3417000000000003</c:v>
                </c:pt>
                <c:pt idx="18">
                  <c:v>4.5918999999999999</c:v>
                </c:pt>
                <c:pt idx="19">
                  <c:v>4.8422000000000001</c:v>
                </c:pt>
                <c:pt idx="20">
                  <c:v>5.0925000000000002</c:v>
                </c:pt>
                <c:pt idx="21">
                  <c:v>5.3428000000000004</c:v>
                </c:pt>
                <c:pt idx="22">
                  <c:v>5.5930999999999997</c:v>
                </c:pt>
                <c:pt idx="23">
                  <c:v>5.8433000000000002</c:v>
                </c:pt>
                <c:pt idx="24">
                  <c:v>6.0936000000000003</c:v>
                </c:pt>
                <c:pt idx="25">
                  <c:v>6.3438999999999997</c:v>
                </c:pt>
                <c:pt idx="26">
                  <c:v>6.5941999999999998</c:v>
                </c:pt>
                <c:pt idx="27">
                  <c:v>6.8444000000000003</c:v>
                </c:pt>
                <c:pt idx="28">
                  <c:v>7.0946999999999996</c:v>
                </c:pt>
                <c:pt idx="29">
                  <c:v>7.3449999999999998</c:v>
                </c:pt>
                <c:pt idx="30">
                  <c:v>7.5952999999999999</c:v>
                </c:pt>
                <c:pt idx="31">
                  <c:v>7.8456000000000001</c:v>
                </c:pt>
                <c:pt idx="32">
                  <c:v>8.0958000000000006</c:v>
                </c:pt>
                <c:pt idx="33">
                  <c:v>8.3460999999999999</c:v>
                </c:pt>
                <c:pt idx="34">
                  <c:v>8.5963999999999992</c:v>
                </c:pt>
                <c:pt idx="35">
                  <c:v>8.8467000000000002</c:v>
                </c:pt>
                <c:pt idx="36">
                  <c:v>9.0968999999999998</c:v>
                </c:pt>
                <c:pt idx="37">
                  <c:v>9.3472000000000008</c:v>
                </c:pt>
                <c:pt idx="38">
                  <c:v>9.5975000000000001</c:v>
                </c:pt>
                <c:pt idx="39">
                  <c:v>9.8477999999999994</c:v>
                </c:pt>
                <c:pt idx="40">
                  <c:v>10.098100000000001</c:v>
                </c:pt>
                <c:pt idx="41">
                  <c:v>10.3483</c:v>
                </c:pt>
                <c:pt idx="42">
                  <c:v>10.598599999999999</c:v>
                </c:pt>
                <c:pt idx="43">
                  <c:v>10.8489</c:v>
                </c:pt>
                <c:pt idx="44">
                  <c:v>11.0992</c:v>
                </c:pt>
                <c:pt idx="45">
                  <c:v>11.349399999999999</c:v>
                </c:pt>
                <c:pt idx="46">
                  <c:v>11.5997</c:v>
                </c:pt>
                <c:pt idx="47">
                  <c:v>11.85</c:v>
                </c:pt>
                <c:pt idx="48">
                  <c:v>12.100300000000001</c:v>
                </c:pt>
                <c:pt idx="49">
                  <c:v>12.3506</c:v>
                </c:pt>
                <c:pt idx="50">
                  <c:v>12.6008</c:v>
                </c:pt>
                <c:pt idx="51">
                  <c:v>12.851100000000001</c:v>
                </c:pt>
                <c:pt idx="52">
                  <c:v>13.1014</c:v>
                </c:pt>
                <c:pt idx="53">
                  <c:v>13.351699999999999</c:v>
                </c:pt>
                <c:pt idx="54">
                  <c:v>13.601900000000001</c:v>
                </c:pt>
                <c:pt idx="55">
                  <c:v>13.8522</c:v>
                </c:pt>
                <c:pt idx="56">
                  <c:v>14.102499999999999</c:v>
                </c:pt>
                <c:pt idx="57">
                  <c:v>14.3528</c:v>
                </c:pt>
                <c:pt idx="58">
                  <c:v>14.6031</c:v>
                </c:pt>
                <c:pt idx="59">
                  <c:v>14.853300000000001</c:v>
                </c:pt>
                <c:pt idx="60">
                  <c:v>15.1036</c:v>
                </c:pt>
                <c:pt idx="61">
                  <c:v>15.353899999999999</c:v>
                </c:pt>
                <c:pt idx="62">
                  <c:v>15.604200000000001</c:v>
                </c:pt>
                <c:pt idx="63">
                  <c:v>15.8544</c:v>
                </c:pt>
                <c:pt idx="64">
                  <c:v>16.104700000000001</c:v>
                </c:pt>
                <c:pt idx="65">
                  <c:v>16.355</c:v>
                </c:pt>
                <c:pt idx="66">
                  <c:v>16.6053</c:v>
                </c:pt>
                <c:pt idx="67">
                  <c:v>16.855599999999999</c:v>
                </c:pt>
                <c:pt idx="68">
                  <c:v>17.105799999999999</c:v>
                </c:pt>
                <c:pt idx="69">
                  <c:v>17.356100000000001</c:v>
                </c:pt>
                <c:pt idx="70">
                  <c:v>17.606400000000001</c:v>
                </c:pt>
                <c:pt idx="71">
                  <c:v>17.8567</c:v>
                </c:pt>
                <c:pt idx="72">
                  <c:v>18.1069</c:v>
                </c:pt>
                <c:pt idx="73">
                  <c:v>18.357199999999999</c:v>
                </c:pt>
                <c:pt idx="74">
                  <c:v>18.607500000000002</c:v>
                </c:pt>
                <c:pt idx="75">
                  <c:v>18.857800000000001</c:v>
                </c:pt>
                <c:pt idx="76">
                  <c:v>19.1081</c:v>
                </c:pt>
                <c:pt idx="77">
                  <c:v>19.3583</c:v>
                </c:pt>
                <c:pt idx="78">
                  <c:v>19.608599999999999</c:v>
                </c:pt>
                <c:pt idx="79">
                  <c:v>19.858899999999998</c:v>
                </c:pt>
                <c:pt idx="80">
                  <c:v>20.109200000000001</c:v>
                </c:pt>
                <c:pt idx="81">
                  <c:v>20.359400000000001</c:v>
                </c:pt>
                <c:pt idx="82">
                  <c:v>20.6097</c:v>
                </c:pt>
                <c:pt idx="83">
                  <c:v>20.86</c:v>
                </c:pt>
                <c:pt idx="84">
                  <c:v>21.110299999999999</c:v>
                </c:pt>
                <c:pt idx="85">
                  <c:v>21.360600000000002</c:v>
                </c:pt>
                <c:pt idx="86">
                  <c:v>21.610800000000001</c:v>
                </c:pt>
                <c:pt idx="87">
                  <c:v>21.8611</c:v>
                </c:pt>
                <c:pt idx="88">
                  <c:v>22.1114</c:v>
                </c:pt>
                <c:pt idx="89">
                  <c:v>22.361699999999999</c:v>
                </c:pt>
                <c:pt idx="90">
                  <c:v>22.611899999999999</c:v>
                </c:pt>
                <c:pt idx="91">
                  <c:v>22.862200000000001</c:v>
                </c:pt>
                <c:pt idx="92">
                  <c:v>23.112500000000001</c:v>
                </c:pt>
                <c:pt idx="93">
                  <c:v>23.3628</c:v>
                </c:pt>
                <c:pt idx="94">
                  <c:v>23.613099999999999</c:v>
                </c:pt>
                <c:pt idx="95">
                  <c:v>23.863299999999999</c:v>
                </c:pt>
                <c:pt idx="96">
                  <c:v>24.113600000000002</c:v>
                </c:pt>
                <c:pt idx="97">
                  <c:v>24.363900000000001</c:v>
                </c:pt>
                <c:pt idx="98">
                  <c:v>24.6142</c:v>
                </c:pt>
                <c:pt idx="99">
                  <c:v>24.8644</c:v>
                </c:pt>
                <c:pt idx="100">
                  <c:v>25.114699999999999</c:v>
                </c:pt>
                <c:pt idx="101">
                  <c:v>25.364999999999998</c:v>
                </c:pt>
                <c:pt idx="102">
                  <c:v>25.615300000000001</c:v>
                </c:pt>
                <c:pt idx="103">
                  <c:v>25.865600000000001</c:v>
                </c:pt>
                <c:pt idx="104">
                  <c:v>26.1158</c:v>
                </c:pt>
                <c:pt idx="105">
                  <c:v>26.366099999999999</c:v>
                </c:pt>
                <c:pt idx="106">
                  <c:v>26.616399999999999</c:v>
                </c:pt>
                <c:pt idx="107">
                  <c:v>26.866700000000002</c:v>
                </c:pt>
                <c:pt idx="108">
                  <c:v>27.116900000000001</c:v>
                </c:pt>
                <c:pt idx="109">
                  <c:v>27.3672</c:v>
                </c:pt>
                <c:pt idx="110">
                  <c:v>27.6175</c:v>
                </c:pt>
                <c:pt idx="111">
                  <c:v>27.867799999999999</c:v>
                </c:pt>
                <c:pt idx="112">
                  <c:v>28.118099999999998</c:v>
                </c:pt>
                <c:pt idx="113">
                  <c:v>28.368300000000001</c:v>
                </c:pt>
                <c:pt idx="114">
                  <c:v>28.618600000000001</c:v>
                </c:pt>
                <c:pt idx="115">
                  <c:v>28.8689</c:v>
                </c:pt>
              </c:numCache>
            </c:numRef>
          </c:xVal>
          <c:yVal>
            <c:numRef>
              <c:f>Sheet3!$C$1:$C$116</c:f>
              <c:numCache>
                <c:formatCode>General</c:formatCode>
                <c:ptCount val="116"/>
                <c:pt idx="0">
                  <c:v>1</c:v>
                </c:pt>
                <c:pt idx="1">
                  <c:v>0.99919999999999998</c:v>
                </c:pt>
                <c:pt idx="2">
                  <c:v>1.0175000000000001</c:v>
                </c:pt>
                <c:pt idx="3">
                  <c:v>1.0186999999999999</c:v>
                </c:pt>
                <c:pt idx="4">
                  <c:v>1.0183</c:v>
                </c:pt>
                <c:pt idx="5">
                  <c:v>1.0215000000000001</c:v>
                </c:pt>
                <c:pt idx="6">
                  <c:v>1.0246</c:v>
                </c:pt>
                <c:pt idx="7">
                  <c:v>1.0277000000000001</c:v>
                </c:pt>
                <c:pt idx="8">
                  <c:v>1.0288999999999999</c:v>
                </c:pt>
                <c:pt idx="9">
                  <c:v>1.032</c:v>
                </c:pt>
                <c:pt idx="10">
                  <c:v>1.0370999999999999</c:v>
                </c:pt>
                <c:pt idx="11">
                  <c:v>1.0403</c:v>
                </c:pt>
                <c:pt idx="12">
                  <c:v>1.0459000000000001</c:v>
                </c:pt>
                <c:pt idx="13">
                  <c:v>1.0505</c:v>
                </c:pt>
                <c:pt idx="14">
                  <c:v>1.0564</c:v>
                </c:pt>
                <c:pt idx="15">
                  <c:v>1.0625</c:v>
                </c:pt>
                <c:pt idx="16">
                  <c:v>1.0674999999999999</c:v>
                </c:pt>
                <c:pt idx="17">
                  <c:v>1.0731999999999999</c:v>
                </c:pt>
                <c:pt idx="18">
                  <c:v>1.0789</c:v>
                </c:pt>
                <c:pt idx="19">
                  <c:v>1.0828</c:v>
                </c:pt>
                <c:pt idx="20">
                  <c:v>1.0896999999999999</c:v>
                </c:pt>
                <c:pt idx="21">
                  <c:v>1.0965</c:v>
                </c:pt>
                <c:pt idx="22">
                  <c:v>1.1037999999999999</c:v>
                </c:pt>
                <c:pt idx="23">
                  <c:v>1.1086</c:v>
                </c:pt>
                <c:pt idx="24">
                  <c:v>1.115</c:v>
                </c:pt>
                <c:pt idx="25">
                  <c:v>1.1213</c:v>
                </c:pt>
                <c:pt idx="26">
                  <c:v>1.1255999999999999</c:v>
                </c:pt>
                <c:pt idx="27">
                  <c:v>1.1315999999999999</c:v>
                </c:pt>
                <c:pt idx="28">
                  <c:v>1.1379999999999999</c:v>
                </c:pt>
                <c:pt idx="29">
                  <c:v>1.1422000000000001</c:v>
                </c:pt>
                <c:pt idx="30">
                  <c:v>1.1469</c:v>
                </c:pt>
                <c:pt idx="31">
                  <c:v>1.1527000000000001</c:v>
                </c:pt>
                <c:pt idx="32">
                  <c:v>1.159</c:v>
                </c:pt>
                <c:pt idx="33">
                  <c:v>1.1620999999999999</c:v>
                </c:pt>
                <c:pt idx="34">
                  <c:v>1.1675</c:v>
                </c:pt>
                <c:pt idx="35">
                  <c:v>1.1718</c:v>
                </c:pt>
                <c:pt idx="36">
                  <c:v>1.1788000000000001</c:v>
                </c:pt>
                <c:pt idx="37">
                  <c:v>1.1821999999999999</c:v>
                </c:pt>
                <c:pt idx="38">
                  <c:v>1.1891</c:v>
                </c:pt>
                <c:pt idx="39">
                  <c:v>1.1950000000000001</c:v>
                </c:pt>
                <c:pt idx="40">
                  <c:v>1.1987000000000001</c:v>
                </c:pt>
                <c:pt idx="41">
                  <c:v>1.2035</c:v>
                </c:pt>
                <c:pt idx="42">
                  <c:v>1.2076</c:v>
                </c:pt>
                <c:pt idx="43">
                  <c:v>1.2139</c:v>
                </c:pt>
                <c:pt idx="44">
                  <c:v>1.2183999999999999</c:v>
                </c:pt>
                <c:pt idx="45">
                  <c:v>1.2230000000000001</c:v>
                </c:pt>
                <c:pt idx="46">
                  <c:v>1.2276</c:v>
                </c:pt>
                <c:pt idx="47">
                  <c:v>1.232</c:v>
                </c:pt>
                <c:pt idx="48">
                  <c:v>1.236</c:v>
                </c:pt>
                <c:pt idx="49">
                  <c:v>1.2391000000000001</c:v>
                </c:pt>
                <c:pt idx="50">
                  <c:v>1.2430000000000001</c:v>
                </c:pt>
                <c:pt idx="51">
                  <c:v>1.2470000000000001</c:v>
                </c:pt>
                <c:pt idx="52">
                  <c:v>1.2529999999999999</c:v>
                </c:pt>
                <c:pt idx="53">
                  <c:v>1.256</c:v>
                </c:pt>
                <c:pt idx="54">
                  <c:v>1.2608999999999999</c:v>
                </c:pt>
                <c:pt idx="55">
                  <c:v>1.2645</c:v>
                </c:pt>
                <c:pt idx="56">
                  <c:v>1.2692000000000001</c:v>
                </c:pt>
                <c:pt idx="57">
                  <c:v>1.2727999999999999</c:v>
                </c:pt>
                <c:pt idx="58">
                  <c:v>1.2765</c:v>
                </c:pt>
                <c:pt idx="59">
                  <c:v>1.2824</c:v>
                </c:pt>
                <c:pt idx="60">
                  <c:v>1.2848999999999999</c:v>
                </c:pt>
                <c:pt idx="61">
                  <c:v>1.2899</c:v>
                </c:pt>
                <c:pt idx="62">
                  <c:v>1.2946</c:v>
                </c:pt>
                <c:pt idx="63">
                  <c:v>1.2996000000000001</c:v>
                </c:pt>
                <c:pt idx="64">
                  <c:v>1.3043</c:v>
                </c:pt>
                <c:pt idx="65">
                  <c:v>1.3071999999999999</c:v>
                </c:pt>
                <c:pt idx="66">
                  <c:v>1.3125</c:v>
                </c:pt>
                <c:pt idx="67">
                  <c:v>1.3139000000000001</c:v>
                </c:pt>
                <c:pt idx="68">
                  <c:v>1.3193999999999999</c:v>
                </c:pt>
                <c:pt idx="69">
                  <c:v>1.3214999999999999</c:v>
                </c:pt>
                <c:pt idx="70">
                  <c:v>1.3241000000000001</c:v>
                </c:pt>
                <c:pt idx="71">
                  <c:v>1.3284</c:v>
                </c:pt>
                <c:pt idx="72">
                  <c:v>1.3313999999999999</c:v>
                </c:pt>
                <c:pt idx="73">
                  <c:v>1.3349</c:v>
                </c:pt>
                <c:pt idx="74">
                  <c:v>1.339</c:v>
                </c:pt>
                <c:pt idx="75">
                  <c:v>1.3444</c:v>
                </c:pt>
                <c:pt idx="76">
                  <c:v>1.3488</c:v>
                </c:pt>
                <c:pt idx="77">
                  <c:v>1.3509</c:v>
                </c:pt>
                <c:pt idx="78">
                  <c:v>1.3542000000000001</c:v>
                </c:pt>
                <c:pt idx="79">
                  <c:v>1.3571</c:v>
                </c:pt>
                <c:pt idx="80">
                  <c:v>1.3580000000000001</c:v>
                </c:pt>
                <c:pt idx="81">
                  <c:v>1.3604000000000001</c:v>
                </c:pt>
                <c:pt idx="82">
                  <c:v>1.3656999999999999</c:v>
                </c:pt>
                <c:pt idx="83">
                  <c:v>1.3663000000000001</c:v>
                </c:pt>
                <c:pt idx="84">
                  <c:v>1.3709</c:v>
                </c:pt>
                <c:pt idx="85">
                  <c:v>1.3749</c:v>
                </c:pt>
                <c:pt idx="86">
                  <c:v>1.3767</c:v>
                </c:pt>
                <c:pt idx="87">
                  <c:v>1.3789</c:v>
                </c:pt>
                <c:pt idx="88">
                  <c:v>1.3793</c:v>
                </c:pt>
                <c:pt idx="89">
                  <c:v>1.3815</c:v>
                </c:pt>
                <c:pt idx="90">
                  <c:v>1.3849</c:v>
                </c:pt>
                <c:pt idx="91">
                  <c:v>1.3855</c:v>
                </c:pt>
                <c:pt idx="92">
                  <c:v>1.3894</c:v>
                </c:pt>
                <c:pt idx="93">
                  <c:v>1.3926000000000001</c:v>
                </c:pt>
                <c:pt idx="94">
                  <c:v>1.3932</c:v>
                </c:pt>
                <c:pt idx="95">
                  <c:v>1.3968</c:v>
                </c:pt>
                <c:pt idx="96">
                  <c:v>1.3971</c:v>
                </c:pt>
                <c:pt idx="97">
                  <c:v>1.4011</c:v>
                </c:pt>
                <c:pt idx="98">
                  <c:v>1.4031</c:v>
                </c:pt>
                <c:pt idx="99">
                  <c:v>1.4057999999999999</c:v>
                </c:pt>
                <c:pt idx="100">
                  <c:v>1.4081999999999999</c:v>
                </c:pt>
                <c:pt idx="101">
                  <c:v>1.41</c:v>
                </c:pt>
                <c:pt idx="102">
                  <c:v>1.4146000000000001</c:v>
                </c:pt>
                <c:pt idx="103">
                  <c:v>1.4145000000000001</c:v>
                </c:pt>
                <c:pt idx="104">
                  <c:v>1.4169</c:v>
                </c:pt>
                <c:pt idx="105">
                  <c:v>1.4200999999999999</c:v>
                </c:pt>
                <c:pt idx="106">
                  <c:v>1.4234</c:v>
                </c:pt>
                <c:pt idx="107">
                  <c:v>1.4256</c:v>
                </c:pt>
                <c:pt idx="108">
                  <c:v>1.4278</c:v>
                </c:pt>
                <c:pt idx="109">
                  <c:v>1.4293</c:v>
                </c:pt>
                <c:pt idx="110">
                  <c:v>1.4329000000000001</c:v>
                </c:pt>
                <c:pt idx="111">
                  <c:v>1.4349000000000001</c:v>
                </c:pt>
                <c:pt idx="112">
                  <c:v>1.4373</c:v>
                </c:pt>
                <c:pt idx="113">
                  <c:v>1.4398</c:v>
                </c:pt>
                <c:pt idx="114">
                  <c:v>1.4413</c:v>
                </c:pt>
                <c:pt idx="115">
                  <c:v>1.4458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750976"/>
        <c:axId val="32761344"/>
      </c:scatterChart>
      <c:valAx>
        <c:axId val="32750976"/>
        <c:scaling>
          <c:orientation val="minMax"/>
          <c:max val="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ours)</a:t>
                </a:r>
              </a:p>
            </c:rich>
          </c:tx>
          <c:layout>
            <c:manualLayout>
              <c:xMode val="edge"/>
              <c:yMode val="edge"/>
              <c:x val="0.41897783610382033"/>
              <c:y val="0.900596810014132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32761344"/>
        <c:crosses val="autoZero"/>
        <c:crossBetween val="midCat"/>
      </c:valAx>
      <c:valAx>
        <c:axId val="32761344"/>
        <c:scaling>
          <c:orientation val="minMax"/>
          <c:min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32750976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23954386383520243"/>
          <c:y val="1.6474325324719024E-2"/>
          <c:w val="0.40174055829228245"/>
          <c:h val="0.16552786571781619"/>
        </c:manualLayout>
      </c:layout>
      <c:overlay val="0"/>
    </c:legend>
    <c:plotVisOnly val="1"/>
    <c:dispBlanksAs val="gap"/>
    <c:showDLblsOverMax val="0"/>
  </c:chart>
  <c:spPr>
    <a:noFill/>
    <a:ln w="25400"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308065364760067"/>
          <c:y val="3.6371890860079838E-2"/>
          <c:w val="0.74094447960592036"/>
          <c:h val="0.7438563670624338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3!$B$1</c:f>
              <c:strCache>
                <c:ptCount val="1"/>
                <c:pt idx="0">
                  <c:v>WT14 Con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Sheet3!$D$2:$D$115</c:f>
                <c:numCache>
                  <c:formatCode>General</c:formatCode>
                  <c:ptCount val="114"/>
                  <c:pt idx="0">
                    <c:v>6.7999999999999996E-3</c:v>
                  </c:pt>
                  <c:pt idx="1">
                    <c:v>8.8500000000000002E-3</c:v>
                  </c:pt>
                  <c:pt idx="2">
                    <c:v>1.1599999999999999E-2</c:v>
                  </c:pt>
                  <c:pt idx="3">
                    <c:v>9.2499999999999995E-3</c:v>
                  </c:pt>
                  <c:pt idx="4">
                    <c:v>8.2500000000000004E-3</c:v>
                  </c:pt>
                  <c:pt idx="5">
                    <c:v>8.3499999999999998E-3</c:v>
                  </c:pt>
                  <c:pt idx="6">
                    <c:v>8.1499999999999993E-3</c:v>
                  </c:pt>
                  <c:pt idx="7">
                    <c:v>8.0999999999999996E-3</c:v>
                  </c:pt>
                  <c:pt idx="8">
                    <c:v>7.9000000000000008E-3</c:v>
                  </c:pt>
                  <c:pt idx="9">
                    <c:v>7.45E-3</c:v>
                  </c:pt>
                  <c:pt idx="10">
                    <c:v>7.0499999999999998E-3</c:v>
                  </c:pt>
                  <c:pt idx="11">
                    <c:v>7.1999999999999998E-3</c:v>
                  </c:pt>
                  <c:pt idx="12">
                    <c:v>8.1499999999999993E-3</c:v>
                  </c:pt>
                  <c:pt idx="13">
                    <c:v>7.9000000000000008E-3</c:v>
                  </c:pt>
                  <c:pt idx="14">
                    <c:v>8.2500000000000004E-3</c:v>
                  </c:pt>
                  <c:pt idx="15">
                    <c:v>8.0499999999999999E-3</c:v>
                  </c:pt>
                  <c:pt idx="16">
                    <c:v>7.9000000000000008E-3</c:v>
                  </c:pt>
                  <c:pt idx="17">
                    <c:v>8.6E-3</c:v>
                  </c:pt>
                  <c:pt idx="18">
                    <c:v>8.8000000000000005E-3</c:v>
                  </c:pt>
                  <c:pt idx="19">
                    <c:v>8.8500000000000002E-3</c:v>
                  </c:pt>
                  <c:pt idx="20">
                    <c:v>9.4500000000000001E-3</c:v>
                  </c:pt>
                  <c:pt idx="21">
                    <c:v>1.0200000000000001E-2</c:v>
                  </c:pt>
                  <c:pt idx="22">
                    <c:v>1.0999999999999999E-2</c:v>
                  </c:pt>
                  <c:pt idx="23">
                    <c:v>1.17E-2</c:v>
                  </c:pt>
                  <c:pt idx="24">
                    <c:v>1.265E-2</c:v>
                  </c:pt>
                  <c:pt idx="25">
                    <c:v>1.405E-2</c:v>
                  </c:pt>
                  <c:pt idx="26">
                    <c:v>1.5949999999999999E-2</c:v>
                  </c:pt>
                  <c:pt idx="27">
                    <c:v>1.5949999999999999E-2</c:v>
                  </c:pt>
                  <c:pt idx="28">
                    <c:v>1.6899999999999998E-2</c:v>
                  </c:pt>
                  <c:pt idx="29">
                    <c:v>1.7999999999999999E-2</c:v>
                  </c:pt>
                  <c:pt idx="30">
                    <c:v>1.8950000000000002E-2</c:v>
                  </c:pt>
                  <c:pt idx="31">
                    <c:v>1.89E-2</c:v>
                  </c:pt>
                  <c:pt idx="32">
                    <c:v>1.9650000000000001E-2</c:v>
                  </c:pt>
                  <c:pt idx="33">
                    <c:v>2.0400000000000001E-2</c:v>
                  </c:pt>
                  <c:pt idx="34">
                    <c:v>2.1100000000000001E-2</c:v>
                  </c:pt>
                  <c:pt idx="35">
                    <c:v>2.155E-2</c:v>
                  </c:pt>
                  <c:pt idx="36">
                    <c:v>2.1749999999999999E-2</c:v>
                  </c:pt>
                  <c:pt idx="37">
                    <c:v>2.205E-2</c:v>
                  </c:pt>
                  <c:pt idx="38">
                    <c:v>2.2599999999999999E-2</c:v>
                  </c:pt>
                  <c:pt idx="39">
                    <c:v>2.2200000000000001E-2</c:v>
                  </c:pt>
                  <c:pt idx="40">
                    <c:v>2.2499999999999999E-2</c:v>
                  </c:pt>
                  <c:pt idx="41">
                    <c:v>2.315E-2</c:v>
                  </c:pt>
                  <c:pt idx="42">
                    <c:v>2.3650000000000001E-2</c:v>
                  </c:pt>
                  <c:pt idx="43">
                    <c:v>2.35E-2</c:v>
                  </c:pt>
                  <c:pt idx="44">
                    <c:v>2.29E-2</c:v>
                  </c:pt>
                  <c:pt idx="45">
                    <c:v>2.4299999999999999E-2</c:v>
                  </c:pt>
                  <c:pt idx="46">
                    <c:v>2.4199999999999999E-2</c:v>
                  </c:pt>
                  <c:pt idx="47">
                    <c:v>2.4400000000000002E-2</c:v>
                  </c:pt>
                  <c:pt idx="48">
                    <c:v>2.4549999999999999E-2</c:v>
                  </c:pt>
                  <c:pt idx="49">
                    <c:v>2.5000000000000001E-2</c:v>
                  </c:pt>
                  <c:pt idx="50">
                    <c:v>2.5399999999999999E-2</c:v>
                  </c:pt>
                  <c:pt idx="51">
                    <c:v>2.555E-2</c:v>
                  </c:pt>
                  <c:pt idx="52">
                    <c:v>2.5399999999999999E-2</c:v>
                  </c:pt>
                  <c:pt idx="53">
                    <c:v>2.58E-2</c:v>
                  </c:pt>
                  <c:pt idx="54">
                    <c:v>2.6100000000000002E-2</c:v>
                  </c:pt>
                  <c:pt idx="55">
                    <c:v>2.6499999999999999E-2</c:v>
                  </c:pt>
                  <c:pt idx="56">
                    <c:v>2.53E-2</c:v>
                  </c:pt>
                  <c:pt idx="57">
                    <c:v>2.6200000000000001E-2</c:v>
                  </c:pt>
                  <c:pt idx="58">
                    <c:v>2.6249999999999999E-2</c:v>
                  </c:pt>
                  <c:pt idx="59">
                    <c:v>2.605E-2</c:v>
                  </c:pt>
                  <c:pt idx="60">
                    <c:v>2.665E-2</c:v>
                  </c:pt>
                  <c:pt idx="61">
                    <c:v>2.75E-2</c:v>
                  </c:pt>
                  <c:pt idx="62">
                    <c:v>2.8250000000000001E-2</c:v>
                  </c:pt>
                  <c:pt idx="63">
                    <c:v>2.9000000000000001E-2</c:v>
                  </c:pt>
                  <c:pt idx="64">
                    <c:v>2.9649999999999999E-2</c:v>
                  </c:pt>
                  <c:pt idx="65">
                    <c:v>3.0249999999999999E-2</c:v>
                  </c:pt>
                  <c:pt idx="66">
                    <c:v>3.075E-2</c:v>
                  </c:pt>
                  <c:pt idx="67">
                    <c:v>3.1399999999999997E-2</c:v>
                  </c:pt>
                  <c:pt idx="68">
                    <c:v>3.1899999999999998E-2</c:v>
                  </c:pt>
                  <c:pt idx="69">
                    <c:v>3.2349999999999997E-2</c:v>
                  </c:pt>
                  <c:pt idx="70">
                    <c:v>3.2349999999999997E-2</c:v>
                  </c:pt>
                  <c:pt idx="71">
                    <c:v>3.2500000000000001E-2</c:v>
                  </c:pt>
                  <c:pt idx="72">
                    <c:v>3.3849999999999998E-2</c:v>
                  </c:pt>
                  <c:pt idx="73">
                    <c:v>3.4200000000000001E-2</c:v>
                  </c:pt>
                  <c:pt idx="74">
                    <c:v>3.49E-2</c:v>
                  </c:pt>
                  <c:pt idx="75">
                    <c:v>3.5200000000000002E-2</c:v>
                  </c:pt>
                  <c:pt idx="76">
                    <c:v>3.6850000000000001E-2</c:v>
                  </c:pt>
                  <c:pt idx="77">
                    <c:v>3.6850000000000001E-2</c:v>
                  </c:pt>
                  <c:pt idx="78">
                    <c:v>3.5950000000000003E-2</c:v>
                  </c:pt>
                  <c:pt idx="79">
                    <c:v>3.6799999999999999E-2</c:v>
                  </c:pt>
                  <c:pt idx="80">
                    <c:v>3.8550000000000001E-2</c:v>
                  </c:pt>
                  <c:pt idx="81">
                    <c:v>3.8850000000000003E-2</c:v>
                  </c:pt>
                  <c:pt idx="82">
                    <c:v>3.9050000000000001E-2</c:v>
                  </c:pt>
                  <c:pt idx="83">
                    <c:v>3.925E-2</c:v>
                  </c:pt>
                  <c:pt idx="84">
                    <c:v>3.9899999999999998E-2</c:v>
                  </c:pt>
                  <c:pt idx="85">
                    <c:v>4.0349999999999997E-2</c:v>
                  </c:pt>
                  <c:pt idx="86">
                    <c:v>4.095E-2</c:v>
                  </c:pt>
                  <c:pt idx="87">
                    <c:v>4.1000000000000002E-2</c:v>
                  </c:pt>
                  <c:pt idx="88">
                    <c:v>4.2000000000000003E-2</c:v>
                  </c:pt>
                  <c:pt idx="89">
                    <c:v>4.1700000000000001E-2</c:v>
                  </c:pt>
                  <c:pt idx="90">
                    <c:v>4.3450000000000003E-2</c:v>
                  </c:pt>
                  <c:pt idx="91">
                    <c:v>4.3499999999999997E-2</c:v>
                  </c:pt>
                  <c:pt idx="92">
                    <c:v>4.4600000000000001E-2</c:v>
                  </c:pt>
                  <c:pt idx="93">
                    <c:v>4.48E-2</c:v>
                  </c:pt>
                  <c:pt idx="94">
                    <c:v>4.41E-2</c:v>
                  </c:pt>
                  <c:pt idx="95">
                    <c:v>4.4350000000000001E-2</c:v>
                  </c:pt>
                  <c:pt idx="96">
                    <c:v>4.4650000000000002E-2</c:v>
                  </c:pt>
                  <c:pt idx="97">
                    <c:v>4.5400000000000003E-2</c:v>
                  </c:pt>
                  <c:pt idx="98">
                    <c:v>4.5749999999999999E-2</c:v>
                  </c:pt>
                  <c:pt idx="99">
                    <c:v>4.6699999999999998E-2</c:v>
                  </c:pt>
                  <c:pt idx="100">
                    <c:v>4.7649999999999998E-2</c:v>
                  </c:pt>
                  <c:pt idx="101">
                    <c:v>4.8099999999999997E-2</c:v>
                  </c:pt>
                  <c:pt idx="102">
                    <c:v>4.9750000000000003E-2</c:v>
                  </c:pt>
                  <c:pt idx="103">
                    <c:v>4.9549999999999997E-2</c:v>
                  </c:pt>
                  <c:pt idx="104">
                    <c:v>4.9099999999999998E-2</c:v>
                  </c:pt>
                  <c:pt idx="105">
                    <c:v>0.05</c:v>
                  </c:pt>
                  <c:pt idx="106">
                    <c:v>5.0549999999999998E-2</c:v>
                  </c:pt>
                  <c:pt idx="107">
                    <c:v>5.0349999999999999E-2</c:v>
                  </c:pt>
                  <c:pt idx="108">
                    <c:v>5.16E-2</c:v>
                  </c:pt>
                  <c:pt idx="109">
                    <c:v>5.2299999999999999E-2</c:v>
                  </c:pt>
                  <c:pt idx="110">
                    <c:v>5.3749999999999999E-2</c:v>
                  </c:pt>
                  <c:pt idx="111">
                    <c:v>5.3999999999999999E-2</c:v>
                  </c:pt>
                  <c:pt idx="112">
                    <c:v>5.3199999999999997E-2</c:v>
                  </c:pt>
                  <c:pt idx="113">
                    <c:v>5.4050000000000001E-2</c:v>
                  </c:pt>
                </c:numCache>
              </c:numRef>
            </c:plus>
            <c:minus>
              <c:numRef>
                <c:f>Sheet3!$D$2:$D$115</c:f>
                <c:numCache>
                  <c:formatCode>General</c:formatCode>
                  <c:ptCount val="114"/>
                  <c:pt idx="0">
                    <c:v>6.7999999999999996E-3</c:v>
                  </c:pt>
                  <c:pt idx="1">
                    <c:v>8.8500000000000002E-3</c:v>
                  </c:pt>
                  <c:pt idx="2">
                    <c:v>1.1599999999999999E-2</c:v>
                  </c:pt>
                  <c:pt idx="3">
                    <c:v>9.2499999999999995E-3</c:v>
                  </c:pt>
                  <c:pt idx="4">
                    <c:v>8.2500000000000004E-3</c:v>
                  </c:pt>
                  <c:pt idx="5">
                    <c:v>8.3499999999999998E-3</c:v>
                  </c:pt>
                  <c:pt idx="6">
                    <c:v>8.1499999999999993E-3</c:v>
                  </c:pt>
                  <c:pt idx="7">
                    <c:v>8.0999999999999996E-3</c:v>
                  </c:pt>
                  <c:pt idx="8">
                    <c:v>7.9000000000000008E-3</c:v>
                  </c:pt>
                  <c:pt idx="9">
                    <c:v>7.45E-3</c:v>
                  </c:pt>
                  <c:pt idx="10">
                    <c:v>7.0499999999999998E-3</c:v>
                  </c:pt>
                  <c:pt idx="11">
                    <c:v>7.1999999999999998E-3</c:v>
                  </c:pt>
                  <c:pt idx="12">
                    <c:v>8.1499999999999993E-3</c:v>
                  </c:pt>
                  <c:pt idx="13">
                    <c:v>7.9000000000000008E-3</c:v>
                  </c:pt>
                  <c:pt idx="14">
                    <c:v>8.2500000000000004E-3</c:v>
                  </c:pt>
                  <c:pt idx="15">
                    <c:v>8.0499999999999999E-3</c:v>
                  </c:pt>
                  <c:pt idx="16">
                    <c:v>7.9000000000000008E-3</c:v>
                  </c:pt>
                  <c:pt idx="17">
                    <c:v>8.6E-3</c:v>
                  </c:pt>
                  <c:pt idx="18">
                    <c:v>8.8000000000000005E-3</c:v>
                  </c:pt>
                  <c:pt idx="19">
                    <c:v>8.8500000000000002E-3</c:v>
                  </c:pt>
                  <c:pt idx="20">
                    <c:v>9.4500000000000001E-3</c:v>
                  </c:pt>
                  <c:pt idx="21">
                    <c:v>1.0200000000000001E-2</c:v>
                  </c:pt>
                  <c:pt idx="22">
                    <c:v>1.0999999999999999E-2</c:v>
                  </c:pt>
                  <c:pt idx="23">
                    <c:v>1.17E-2</c:v>
                  </c:pt>
                  <c:pt idx="24">
                    <c:v>1.265E-2</c:v>
                  </c:pt>
                  <c:pt idx="25">
                    <c:v>1.405E-2</c:v>
                  </c:pt>
                  <c:pt idx="26">
                    <c:v>1.5949999999999999E-2</c:v>
                  </c:pt>
                  <c:pt idx="27">
                    <c:v>1.5949999999999999E-2</c:v>
                  </c:pt>
                  <c:pt idx="28">
                    <c:v>1.6899999999999998E-2</c:v>
                  </c:pt>
                  <c:pt idx="29">
                    <c:v>1.7999999999999999E-2</c:v>
                  </c:pt>
                  <c:pt idx="30">
                    <c:v>1.8950000000000002E-2</c:v>
                  </c:pt>
                  <c:pt idx="31">
                    <c:v>1.89E-2</c:v>
                  </c:pt>
                  <c:pt idx="32">
                    <c:v>1.9650000000000001E-2</c:v>
                  </c:pt>
                  <c:pt idx="33">
                    <c:v>2.0400000000000001E-2</c:v>
                  </c:pt>
                  <c:pt idx="34">
                    <c:v>2.1100000000000001E-2</c:v>
                  </c:pt>
                  <c:pt idx="35">
                    <c:v>2.155E-2</c:v>
                  </c:pt>
                  <c:pt idx="36">
                    <c:v>2.1749999999999999E-2</c:v>
                  </c:pt>
                  <c:pt idx="37">
                    <c:v>2.205E-2</c:v>
                  </c:pt>
                  <c:pt idx="38">
                    <c:v>2.2599999999999999E-2</c:v>
                  </c:pt>
                  <c:pt idx="39">
                    <c:v>2.2200000000000001E-2</c:v>
                  </c:pt>
                  <c:pt idx="40">
                    <c:v>2.2499999999999999E-2</c:v>
                  </c:pt>
                  <c:pt idx="41">
                    <c:v>2.315E-2</c:v>
                  </c:pt>
                  <c:pt idx="42">
                    <c:v>2.3650000000000001E-2</c:v>
                  </c:pt>
                  <c:pt idx="43">
                    <c:v>2.35E-2</c:v>
                  </c:pt>
                  <c:pt idx="44">
                    <c:v>2.29E-2</c:v>
                  </c:pt>
                  <c:pt idx="45">
                    <c:v>2.4299999999999999E-2</c:v>
                  </c:pt>
                  <c:pt idx="46">
                    <c:v>2.4199999999999999E-2</c:v>
                  </c:pt>
                  <c:pt idx="47">
                    <c:v>2.4400000000000002E-2</c:v>
                  </c:pt>
                  <c:pt idx="48">
                    <c:v>2.4549999999999999E-2</c:v>
                  </c:pt>
                  <c:pt idx="49">
                    <c:v>2.5000000000000001E-2</c:v>
                  </c:pt>
                  <c:pt idx="50">
                    <c:v>2.5399999999999999E-2</c:v>
                  </c:pt>
                  <c:pt idx="51">
                    <c:v>2.555E-2</c:v>
                  </c:pt>
                  <c:pt idx="52">
                    <c:v>2.5399999999999999E-2</c:v>
                  </c:pt>
                  <c:pt idx="53">
                    <c:v>2.58E-2</c:v>
                  </c:pt>
                  <c:pt idx="54">
                    <c:v>2.6100000000000002E-2</c:v>
                  </c:pt>
                  <c:pt idx="55">
                    <c:v>2.6499999999999999E-2</c:v>
                  </c:pt>
                  <c:pt idx="56">
                    <c:v>2.53E-2</c:v>
                  </c:pt>
                  <c:pt idx="57">
                    <c:v>2.6200000000000001E-2</c:v>
                  </c:pt>
                  <c:pt idx="58">
                    <c:v>2.6249999999999999E-2</c:v>
                  </c:pt>
                  <c:pt idx="59">
                    <c:v>2.605E-2</c:v>
                  </c:pt>
                  <c:pt idx="60">
                    <c:v>2.665E-2</c:v>
                  </c:pt>
                  <c:pt idx="61">
                    <c:v>2.75E-2</c:v>
                  </c:pt>
                  <c:pt idx="62">
                    <c:v>2.8250000000000001E-2</c:v>
                  </c:pt>
                  <c:pt idx="63">
                    <c:v>2.9000000000000001E-2</c:v>
                  </c:pt>
                  <c:pt idx="64">
                    <c:v>2.9649999999999999E-2</c:v>
                  </c:pt>
                  <c:pt idx="65">
                    <c:v>3.0249999999999999E-2</c:v>
                  </c:pt>
                  <c:pt idx="66">
                    <c:v>3.075E-2</c:v>
                  </c:pt>
                  <c:pt idx="67">
                    <c:v>3.1399999999999997E-2</c:v>
                  </c:pt>
                  <c:pt idx="68">
                    <c:v>3.1899999999999998E-2</c:v>
                  </c:pt>
                  <c:pt idx="69">
                    <c:v>3.2349999999999997E-2</c:v>
                  </c:pt>
                  <c:pt idx="70">
                    <c:v>3.2349999999999997E-2</c:v>
                  </c:pt>
                  <c:pt idx="71">
                    <c:v>3.2500000000000001E-2</c:v>
                  </c:pt>
                  <c:pt idx="72">
                    <c:v>3.3849999999999998E-2</c:v>
                  </c:pt>
                  <c:pt idx="73">
                    <c:v>3.4200000000000001E-2</c:v>
                  </c:pt>
                  <c:pt idx="74">
                    <c:v>3.49E-2</c:v>
                  </c:pt>
                  <c:pt idx="75">
                    <c:v>3.5200000000000002E-2</c:v>
                  </c:pt>
                  <c:pt idx="76">
                    <c:v>3.6850000000000001E-2</c:v>
                  </c:pt>
                  <c:pt idx="77">
                    <c:v>3.6850000000000001E-2</c:v>
                  </c:pt>
                  <c:pt idx="78">
                    <c:v>3.5950000000000003E-2</c:v>
                  </c:pt>
                  <c:pt idx="79">
                    <c:v>3.6799999999999999E-2</c:v>
                  </c:pt>
                  <c:pt idx="80">
                    <c:v>3.8550000000000001E-2</c:v>
                  </c:pt>
                  <c:pt idx="81">
                    <c:v>3.8850000000000003E-2</c:v>
                  </c:pt>
                  <c:pt idx="82">
                    <c:v>3.9050000000000001E-2</c:v>
                  </c:pt>
                  <c:pt idx="83">
                    <c:v>3.925E-2</c:v>
                  </c:pt>
                  <c:pt idx="84">
                    <c:v>3.9899999999999998E-2</c:v>
                  </c:pt>
                  <c:pt idx="85">
                    <c:v>4.0349999999999997E-2</c:v>
                  </c:pt>
                  <c:pt idx="86">
                    <c:v>4.095E-2</c:v>
                  </c:pt>
                  <c:pt idx="87">
                    <c:v>4.1000000000000002E-2</c:v>
                  </c:pt>
                  <c:pt idx="88">
                    <c:v>4.2000000000000003E-2</c:v>
                  </c:pt>
                  <c:pt idx="89">
                    <c:v>4.1700000000000001E-2</c:v>
                  </c:pt>
                  <c:pt idx="90">
                    <c:v>4.3450000000000003E-2</c:v>
                  </c:pt>
                  <c:pt idx="91">
                    <c:v>4.3499999999999997E-2</c:v>
                  </c:pt>
                  <c:pt idx="92">
                    <c:v>4.4600000000000001E-2</c:v>
                  </c:pt>
                  <c:pt idx="93">
                    <c:v>4.48E-2</c:v>
                  </c:pt>
                  <c:pt idx="94">
                    <c:v>4.41E-2</c:v>
                  </c:pt>
                  <c:pt idx="95">
                    <c:v>4.4350000000000001E-2</c:v>
                  </c:pt>
                  <c:pt idx="96">
                    <c:v>4.4650000000000002E-2</c:v>
                  </c:pt>
                  <c:pt idx="97">
                    <c:v>4.5400000000000003E-2</c:v>
                  </c:pt>
                  <c:pt idx="98">
                    <c:v>4.5749999999999999E-2</c:v>
                  </c:pt>
                  <c:pt idx="99">
                    <c:v>4.6699999999999998E-2</c:v>
                  </c:pt>
                  <c:pt idx="100">
                    <c:v>4.7649999999999998E-2</c:v>
                  </c:pt>
                  <c:pt idx="101">
                    <c:v>4.8099999999999997E-2</c:v>
                  </c:pt>
                  <c:pt idx="102">
                    <c:v>4.9750000000000003E-2</c:v>
                  </c:pt>
                  <c:pt idx="103">
                    <c:v>4.9549999999999997E-2</c:v>
                  </c:pt>
                  <c:pt idx="104">
                    <c:v>4.9099999999999998E-2</c:v>
                  </c:pt>
                  <c:pt idx="105">
                    <c:v>0.05</c:v>
                  </c:pt>
                  <c:pt idx="106">
                    <c:v>5.0549999999999998E-2</c:v>
                  </c:pt>
                  <c:pt idx="107">
                    <c:v>5.0349999999999999E-2</c:v>
                  </c:pt>
                  <c:pt idx="108">
                    <c:v>5.16E-2</c:v>
                  </c:pt>
                  <c:pt idx="109">
                    <c:v>5.2299999999999999E-2</c:v>
                  </c:pt>
                  <c:pt idx="110">
                    <c:v>5.3749999999999999E-2</c:v>
                  </c:pt>
                  <c:pt idx="111">
                    <c:v>5.3999999999999999E-2</c:v>
                  </c:pt>
                  <c:pt idx="112">
                    <c:v>5.3199999999999997E-2</c:v>
                  </c:pt>
                  <c:pt idx="113">
                    <c:v>5.4050000000000001E-2</c:v>
                  </c:pt>
                </c:numCache>
              </c:numRef>
            </c:minus>
            <c:spPr>
              <a:ln>
                <a:solidFill>
                  <a:schemeClr val="tx2">
                    <a:alpha val="50000"/>
                  </a:schemeClr>
                </a:solidFill>
              </a:ln>
            </c:spPr>
          </c:errBars>
          <c:xVal>
            <c:numRef>
              <c:f>Sheet3!$A$2:$A$115</c:f>
              <c:numCache>
                <c:formatCode>General</c:formatCode>
                <c:ptCount val="114"/>
                <c:pt idx="0">
                  <c:v>0</c:v>
                </c:pt>
                <c:pt idx="1">
                  <c:v>3.0999999999999999E-3</c:v>
                </c:pt>
                <c:pt idx="2">
                  <c:v>0.58860000000000001</c:v>
                </c:pt>
                <c:pt idx="3">
                  <c:v>0.83860000000000001</c:v>
                </c:pt>
                <c:pt idx="4">
                  <c:v>1.0886</c:v>
                </c:pt>
                <c:pt idx="5">
                  <c:v>1.3389</c:v>
                </c:pt>
                <c:pt idx="6">
                  <c:v>1.5889</c:v>
                </c:pt>
                <c:pt idx="7">
                  <c:v>1.8389</c:v>
                </c:pt>
                <c:pt idx="8">
                  <c:v>2.0891999999999999</c:v>
                </c:pt>
                <c:pt idx="9">
                  <c:v>2.3393999999999999</c:v>
                </c:pt>
                <c:pt idx="10">
                  <c:v>2.5897000000000001</c:v>
                </c:pt>
                <c:pt idx="11">
                  <c:v>2.84</c:v>
                </c:pt>
                <c:pt idx="12">
                  <c:v>3.0903</c:v>
                </c:pt>
                <c:pt idx="13">
                  <c:v>3.3405999999999998</c:v>
                </c:pt>
                <c:pt idx="14">
                  <c:v>3.5908000000000002</c:v>
                </c:pt>
                <c:pt idx="15">
                  <c:v>3.8411</c:v>
                </c:pt>
                <c:pt idx="16">
                  <c:v>4.0914000000000001</c:v>
                </c:pt>
                <c:pt idx="17">
                  <c:v>4.3417000000000003</c:v>
                </c:pt>
                <c:pt idx="18">
                  <c:v>4.5918999999999999</c:v>
                </c:pt>
                <c:pt idx="19">
                  <c:v>4.8422000000000001</c:v>
                </c:pt>
                <c:pt idx="20">
                  <c:v>5.0925000000000002</c:v>
                </c:pt>
                <c:pt idx="21">
                  <c:v>5.3428000000000004</c:v>
                </c:pt>
                <c:pt idx="22">
                  <c:v>5.5930999999999997</c:v>
                </c:pt>
                <c:pt idx="23">
                  <c:v>5.8433000000000002</c:v>
                </c:pt>
                <c:pt idx="24">
                  <c:v>6.0936000000000003</c:v>
                </c:pt>
                <c:pt idx="25">
                  <c:v>6.3438999999999997</c:v>
                </c:pt>
                <c:pt idx="26">
                  <c:v>6.5941999999999998</c:v>
                </c:pt>
                <c:pt idx="27">
                  <c:v>6.8444000000000003</c:v>
                </c:pt>
                <c:pt idx="28">
                  <c:v>7.0946999999999996</c:v>
                </c:pt>
                <c:pt idx="29">
                  <c:v>7.3449999999999998</c:v>
                </c:pt>
                <c:pt idx="30">
                  <c:v>7.5952999999999999</c:v>
                </c:pt>
                <c:pt idx="31">
                  <c:v>7.8456000000000001</c:v>
                </c:pt>
                <c:pt idx="32">
                  <c:v>8.0958000000000006</c:v>
                </c:pt>
                <c:pt idx="33">
                  <c:v>8.3460999999999999</c:v>
                </c:pt>
                <c:pt idx="34">
                  <c:v>8.5963999999999992</c:v>
                </c:pt>
                <c:pt idx="35">
                  <c:v>8.8467000000000002</c:v>
                </c:pt>
                <c:pt idx="36">
                  <c:v>9.0968999999999998</c:v>
                </c:pt>
                <c:pt idx="37">
                  <c:v>9.3472000000000008</c:v>
                </c:pt>
                <c:pt idx="38">
                  <c:v>9.5975000000000001</c:v>
                </c:pt>
                <c:pt idx="39">
                  <c:v>9.8477999999999994</c:v>
                </c:pt>
                <c:pt idx="40">
                  <c:v>10.098100000000001</c:v>
                </c:pt>
                <c:pt idx="41">
                  <c:v>10.3483</c:v>
                </c:pt>
                <c:pt idx="42">
                  <c:v>10.598599999999999</c:v>
                </c:pt>
                <c:pt idx="43">
                  <c:v>10.8489</c:v>
                </c:pt>
                <c:pt idx="44">
                  <c:v>11.0992</c:v>
                </c:pt>
                <c:pt idx="45">
                  <c:v>11.349399999999999</c:v>
                </c:pt>
                <c:pt idx="46">
                  <c:v>11.5997</c:v>
                </c:pt>
                <c:pt idx="47">
                  <c:v>11.85</c:v>
                </c:pt>
                <c:pt idx="48">
                  <c:v>12.100300000000001</c:v>
                </c:pt>
                <c:pt idx="49">
                  <c:v>12.3506</c:v>
                </c:pt>
                <c:pt idx="50">
                  <c:v>12.6008</c:v>
                </c:pt>
                <c:pt idx="51">
                  <c:v>12.851100000000001</c:v>
                </c:pt>
                <c:pt idx="52">
                  <c:v>13.1014</c:v>
                </c:pt>
                <c:pt idx="53">
                  <c:v>13.351699999999999</c:v>
                </c:pt>
                <c:pt idx="54">
                  <c:v>13.601900000000001</c:v>
                </c:pt>
                <c:pt idx="55">
                  <c:v>13.8522</c:v>
                </c:pt>
                <c:pt idx="56">
                  <c:v>14.102499999999999</c:v>
                </c:pt>
                <c:pt idx="57">
                  <c:v>14.3528</c:v>
                </c:pt>
                <c:pt idx="58">
                  <c:v>14.6031</c:v>
                </c:pt>
                <c:pt idx="59">
                  <c:v>14.853300000000001</c:v>
                </c:pt>
                <c:pt idx="60">
                  <c:v>15.1036</c:v>
                </c:pt>
                <c:pt idx="61">
                  <c:v>15.353899999999999</c:v>
                </c:pt>
                <c:pt idx="62">
                  <c:v>15.604200000000001</c:v>
                </c:pt>
                <c:pt idx="63">
                  <c:v>15.8544</c:v>
                </c:pt>
                <c:pt idx="64">
                  <c:v>16.104700000000001</c:v>
                </c:pt>
                <c:pt idx="65">
                  <c:v>16.355</c:v>
                </c:pt>
                <c:pt idx="66">
                  <c:v>16.6053</c:v>
                </c:pt>
                <c:pt idx="67">
                  <c:v>16.855599999999999</c:v>
                </c:pt>
                <c:pt idx="68">
                  <c:v>17.105799999999999</c:v>
                </c:pt>
                <c:pt idx="69">
                  <c:v>17.356100000000001</c:v>
                </c:pt>
                <c:pt idx="70">
                  <c:v>17.606400000000001</c:v>
                </c:pt>
                <c:pt idx="71">
                  <c:v>17.8567</c:v>
                </c:pt>
                <c:pt idx="72">
                  <c:v>18.1069</c:v>
                </c:pt>
                <c:pt idx="73">
                  <c:v>18.357199999999999</c:v>
                </c:pt>
                <c:pt idx="74">
                  <c:v>18.607500000000002</c:v>
                </c:pt>
                <c:pt idx="75">
                  <c:v>18.857800000000001</c:v>
                </c:pt>
                <c:pt idx="76">
                  <c:v>19.1081</c:v>
                </c:pt>
                <c:pt idx="77">
                  <c:v>19.3583</c:v>
                </c:pt>
                <c:pt idx="78">
                  <c:v>19.608599999999999</c:v>
                </c:pt>
                <c:pt idx="79">
                  <c:v>19.858899999999998</c:v>
                </c:pt>
                <c:pt idx="80">
                  <c:v>20.109200000000001</c:v>
                </c:pt>
                <c:pt idx="81">
                  <c:v>20.359400000000001</c:v>
                </c:pt>
                <c:pt idx="82">
                  <c:v>20.6097</c:v>
                </c:pt>
                <c:pt idx="83">
                  <c:v>20.86</c:v>
                </c:pt>
                <c:pt idx="84">
                  <c:v>21.110299999999999</c:v>
                </c:pt>
                <c:pt idx="85">
                  <c:v>21.360600000000002</c:v>
                </c:pt>
                <c:pt idx="86">
                  <c:v>21.610800000000001</c:v>
                </c:pt>
                <c:pt idx="87">
                  <c:v>21.8611</c:v>
                </c:pt>
                <c:pt idx="88">
                  <c:v>22.1114</c:v>
                </c:pt>
                <c:pt idx="89">
                  <c:v>22.361699999999999</c:v>
                </c:pt>
                <c:pt idx="90">
                  <c:v>22.611899999999999</c:v>
                </c:pt>
                <c:pt idx="91">
                  <c:v>22.862200000000001</c:v>
                </c:pt>
                <c:pt idx="92">
                  <c:v>23.112500000000001</c:v>
                </c:pt>
                <c:pt idx="93">
                  <c:v>23.3628</c:v>
                </c:pt>
                <c:pt idx="94">
                  <c:v>23.613099999999999</c:v>
                </c:pt>
                <c:pt idx="95">
                  <c:v>23.863299999999999</c:v>
                </c:pt>
                <c:pt idx="96">
                  <c:v>24.113600000000002</c:v>
                </c:pt>
                <c:pt idx="97">
                  <c:v>24.363900000000001</c:v>
                </c:pt>
                <c:pt idx="98">
                  <c:v>24.6142</c:v>
                </c:pt>
                <c:pt idx="99">
                  <c:v>24.8644</c:v>
                </c:pt>
                <c:pt idx="100">
                  <c:v>25.114699999999999</c:v>
                </c:pt>
                <c:pt idx="101">
                  <c:v>25.364999999999998</c:v>
                </c:pt>
                <c:pt idx="102">
                  <c:v>25.615300000000001</c:v>
                </c:pt>
                <c:pt idx="103">
                  <c:v>25.865600000000001</c:v>
                </c:pt>
                <c:pt idx="104">
                  <c:v>26.1158</c:v>
                </c:pt>
                <c:pt idx="105">
                  <c:v>26.366099999999999</c:v>
                </c:pt>
                <c:pt idx="106">
                  <c:v>26.616399999999999</c:v>
                </c:pt>
                <c:pt idx="107">
                  <c:v>26.866700000000002</c:v>
                </c:pt>
                <c:pt idx="108">
                  <c:v>27.116900000000001</c:v>
                </c:pt>
                <c:pt idx="109">
                  <c:v>27.3672</c:v>
                </c:pt>
                <c:pt idx="110">
                  <c:v>27.6175</c:v>
                </c:pt>
                <c:pt idx="111">
                  <c:v>27.867799999999999</c:v>
                </c:pt>
                <c:pt idx="112">
                  <c:v>28.118099999999998</c:v>
                </c:pt>
                <c:pt idx="113">
                  <c:v>28.368300000000001</c:v>
                </c:pt>
              </c:numCache>
            </c:numRef>
          </c:xVal>
          <c:yVal>
            <c:numRef>
              <c:f>Sheet3!$B$2:$B$115</c:f>
              <c:numCache>
                <c:formatCode>General</c:formatCode>
                <c:ptCount val="114"/>
                <c:pt idx="0">
                  <c:v>0.99480000000000002</c:v>
                </c:pt>
                <c:pt idx="1">
                  <c:v>0.9929</c:v>
                </c:pt>
                <c:pt idx="2">
                  <c:v>0.99170000000000003</c:v>
                </c:pt>
                <c:pt idx="3">
                  <c:v>0.99450000000000005</c:v>
                </c:pt>
                <c:pt idx="4">
                  <c:v>0.99750000000000005</c:v>
                </c:pt>
                <c:pt idx="5">
                  <c:v>0.99960000000000004</c:v>
                </c:pt>
                <c:pt idx="6">
                  <c:v>1.0022</c:v>
                </c:pt>
                <c:pt idx="7">
                  <c:v>1.0027999999999999</c:v>
                </c:pt>
                <c:pt idx="8">
                  <c:v>1.0053000000000001</c:v>
                </c:pt>
                <c:pt idx="9">
                  <c:v>1.008</c:v>
                </c:pt>
                <c:pt idx="10">
                  <c:v>1.0105</c:v>
                </c:pt>
                <c:pt idx="11">
                  <c:v>1.0138</c:v>
                </c:pt>
                <c:pt idx="12">
                  <c:v>1.0181</c:v>
                </c:pt>
                <c:pt idx="13">
                  <c:v>1.0206999999999999</c:v>
                </c:pt>
                <c:pt idx="14">
                  <c:v>1.0237000000000001</c:v>
                </c:pt>
                <c:pt idx="15">
                  <c:v>1.0261</c:v>
                </c:pt>
                <c:pt idx="16">
                  <c:v>1.0284</c:v>
                </c:pt>
                <c:pt idx="17">
                  <c:v>1.0315000000000001</c:v>
                </c:pt>
                <c:pt idx="18">
                  <c:v>1.0327</c:v>
                </c:pt>
                <c:pt idx="19">
                  <c:v>1.036</c:v>
                </c:pt>
                <c:pt idx="20">
                  <c:v>1.0383</c:v>
                </c:pt>
                <c:pt idx="21">
                  <c:v>1.0415000000000001</c:v>
                </c:pt>
                <c:pt idx="22">
                  <c:v>1.0447</c:v>
                </c:pt>
                <c:pt idx="23">
                  <c:v>1.0471999999999999</c:v>
                </c:pt>
                <c:pt idx="24">
                  <c:v>1.05</c:v>
                </c:pt>
                <c:pt idx="25">
                  <c:v>1.054</c:v>
                </c:pt>
                <c:pt idx="26">
                  <c:v>1.056</c:v>
                </c:pt>
                <c:pt idx="27">
                  <c:v>1.0587</c:v>
                </c:pt>
                <c:pt idx="28">
                  <c:v>1.0602</c:v>
                </c:pt>
                <c:pt idx="29">
                  <c:v>1.0622</c:v>
                </c:pt>
                <c:pt idx="30">
                  <c:v>1.0638000000000001</c:v>
                </c:pt>
                <c:pt idx="31">
                  <c:v>1.0672999999999999</c:v>
                </c:pt>
                <c:pt idx="32">
                  <c:v>1.0689</c:v>
                </c:pt>
                <c:pt idx="33">
                  <c:v>1.0697000000000001</c:v>
                </c:pt>
                <c:pt idx="34">
                  <c:v>1.0716000000000001</c:v>
                </c:pt>
                <c:pt idx="35">
                  <c:v>1.0729</c:v>
                </c:pt>
                <c:pt idx="36">
                  <c:v>1.0740000000000001</c:v>
                </c:pt>
                <c:pt idx="37">
                  <c:v>1.0754999999999999</c:v>
                </c:pt>
                <c:pt idx="38">
                  <c:v>1.0768</c:v>
                </c:pt>
                <c:pt idx="39">
                  <c:v>1.0790999999999999</c:v>
                </c:pt>
                <c:pt idx="40">
                  <c:v>1.0803</c:v>
                </c:pt>
                <c:pt idx="41">
                  <c:v>1.0822000000000001</c:v>
                </c:pt>
                <c:pt idx="42">
                  <c:v>1.083</c:v>
                </c:pt>
                <c:pt idx="43">
                  <c:v>1.0857000000000001</c:v>
                </c:pt>
                <c:pt idx="44">
                  <c:v>1.0866</c:v>
                </c:pt>
                <c:pt idx="45">
                  <c:v>1.0882000000000001</c:v>
                </c:pt>
                <c:pt idx="46">
                  <c:v>1.0899000000000001</c:v>
                </c:pt>
                <c:pt idx="47">
                  <c:v>1.0931</c:v>
                </c:pt>
                <c:pt idx="48">
                  <c:v>1.0947</c:v>
                </c:pt>
                <c:pt idx="49">
                  <c:v>1.0964</c:v>
                </c:pt>
                <c:pt idx="50">
                  <c:v>1.0986</c:v>
                </c:pt>
                <c:pt idx="51">
                  <c:v>1.1002000000000001</c:v>
                </c:pt>
                <c:pt idx="52">
                  <c:v>1.1031</c:v>
                </c:pt>
                <c:pt idx="53">
                  <c:v>1.1054999999999999</c:v>
                </c:pt>
                <c:pt idx="54">
                  <c:v>1.1080000000000001</c:v>
                </c:pt>
                <c:pt idx="55">
                  <c:v>1.1111</c:v>
                </c:pt>
                <c:pt idx="56">
                  <c:v>1.1134999999999999</c:v>
                </c:pt>
                <c:pt idx="57">
                  <c:v>1.1166</c:v>
                </c:pt>
                <c:pt idx="58">
                  <c:v>1.1186</c:v>
                </c:pt>
                <c:pt idx="59">
                  <c:v>1.1217999999999999</c:v>
                </c:pt>
                <c:pt idx="60">
                  <c:v>1.1255999999999999</c:v>
                </c:pt>
                <c:pt idx="61">
                  <c:v>1.1294</c:v>
                </c:pt>
                <c:pt idx="62">
                  <c:v>1.1317999999999999</c:v>
                </c:pt>
                <c:pt idx="63">
                  <c:v>1.1348</c:v>
                </c:pt>
                <c:pt idx="64">
                  <c:v>1.1393</c:v>
                </c:pt>
                <c:pt idx="65">
                  <c:v>1.143</c:v>
                </c:pt>
                <c:pt idx="66">
                  <c:v>1.1468</c:v>
                </c:pt>
                <c:pt idx="67">
                  <c:v>1.1513</c:v>
                </c:pt>
                <c:pt idx="68">
                  <c:v>1.1566000000000001</c:v>
                </c:pt>
                <c:pt idx="69">
                  <c:v>1.1597</c:v>
                </c:pt>
                <c:pt idx="70">
                  <c:v>1.1645000000000001</c:v>
                </c:pt>
                <c:pt idx="71">
                  <c:v>1.1680999999999999</c:v>
                </c:pt>
                <c:pt idx="72">
                  <c:v>1.1727000000000001</c:v>
                </c:pt>
                <c:pt idx="73">
                  <c:v>1.1785000000000001</c:v>
                </c:pt>
                <c:pt idx="74">
                  <c:v>1.1834</c:v>
                </c:pt>
                <c:pt idx="75">
                  <c:v>1.1875</c:v>
                </c:pt>
                <c:pt idx="76">
                  <c:v>1.1927000000000001</c:v>
                </c:pt>
                <c:pt idx="77">
                  <c:v>1.1983999999999999</c:v>
                </c:pt>
                <c:pt idx="78">
                  <c:v>1.2019</c:v>
                </c:pt>
                <c:pt idx="79">
                  <c:v>1.2074</c:v>
                </c:pt>
                <c:pt idx="80">
                  <c:v>1.2139</c:v>
                </c:pt>
                <c:pt idx="81">
                  <c:v>1.2178</c:v>
                </c:pt>
                <c:pt idx="82">
                  <c:v>1.2229000000000001</c:v>
                </c:pt>
                <c:pt idx="83">
                  <c:v>1.2281</c:v>
                </c:pt>
                <c:pt idx="84">
                  <c:v>1.2332000000000001</c:v>
                </c:pt>
                <c:pt idx="85">
                  <c:v>1.2385999999999999</c:v>
                </c:pt>
                <c:pt idx="86">
                  <c:v>1.2437</c:v>
                </c:pt>
                <c:pt idx="87">
                  <c:v>1.2499</c:v>
                </c:pt>
                <c:pt idx="88">
                  <c:v>1.2562</c:v>
                </c:pt>
                <c:pt idx="89">
                  <c:v>1.2607999999999999</c:v>
                </c:pt>
                <c:pt idx="90">
                  <c:v>1.2667999999999999</c:v>
                </c:pt>
                <c:pt idx="91">
                  <c:v>1.2725</c:v>
                </c:pt>
                <c:pt idx="92">
                  <c:v>1.2786</c:v>
                </c:pt>
                <c:pt idx="93">
                  <c:v>1.2847999999999999</c:v>
                </c:pt>
                <c:pt idx="94">
                  <c:v>1.2892999999999999</c:v>
                </c:pt>
                <c:pt idx="95">
                  <c:v>1.2955000000000001</c:v>
                </c:pt>
                <c:pt idx="96">
                  <c:v>1.3028</c:v>
                </c:pt>
                <c:pt idx="97">
                  <c:v>1.3118000000000001</c:v>
                </c:pt>
                <c:pt idx="98">
                  <c:v>1.3179000000000001</c:v>
                </c:pt>
                <c:pt idx="99">
                  <c:v>1.3252999999999999</c:v>
                </c:pt>
                <c:pt idx="100">
                  <c:v>1.3322000000000001</c:v>
                </c:pt>
                <c:pt idx="101">
                  <c:v>1.3412999999999999</c:v>
                </c:pt>
                <c:pt idx="102">
                  <c:v>1.3476999999999999</c:v>
                </c:pt>
                <c:pt idx="103">
                  <c:v>1.3552999999999999</c:v>
                </c:pt>
                <c:pt idx="104">
                  <c:v>1.3624000000000001</c:v>
                </c:pt>
                <c:pt idx="105">
                  <c:v>1.3694</c:v>
                </c:pt>
                <c:pt idx="106">
                  <c:v>1.3764000000000001</c:v>
                </c:pt>
                <c:pt idx="107">
                  <c:v>1.3847</c:v>
                </c:pt>
                <c:pt idx="108">
                  <c:v>1.3895999999999999</c:v>
                </c:pt>
                <c:pt idx="109">
                  <c:v>1.3987000000000001</c:v>
                </c:pt>
                <c:pt idx="110">
                  <c:v>1.4076</c:v>
                </c:pt>
                <c:pt idx="111">
                  <c:v>1.4164000000000001</c:v>
                </c:pt>
                <c:pt idx="112">
                  <c:v>1.4238999999999999</c:v>
                </c:pt>
                <c:pt idx="113">
                  <c:v>1.4312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3!$C$1</c:f>
              <c:strCache>
                <c:ptCount val="1"/>
                <c:pt idx="0">
                  <c:v>WT14 Dox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1"/>
            <c:plus>
              <c:numRef>
                <c:f>Sheet3!$E$2:$E$115</c:f>
                <c:numCache>
                  <c:formatCode>General</c:formatCode>
                  <c:ptCount val="114"/>
                  <c:pt idx="0">
                    <c:v>8.9999999999999998E-4</c:v>
                  </c:pt>
                  <c:pt idx="1">
                    <c:v>1.75E-3</c:v>
                  </c:pt>
                  <c:pt idx="2">
                    <c:v>8.0000000000000004E-4</c:v>
                  </c:pt>
                  <c:pt idx="3">
                    <c:v>1.0499999999999999E-3</c:v>
                  </c:pt>
                  <c:pt idx="4">
                    <c:v>1.15E-3</c:v>
                  </c:pt>
                  <c:pt idx="5">
                    <c:v>1.9499999999999999E-3</c:v>
                  </c:pt>
                  <c:pt idx="6">
                    <c:v>2.7000000000000001E-3</c:v>
                  </c:pt>
                  <c:pt idx="7">
                    <c:v>3.4499999999999999E-3</c:v>
                  </c:pt>
                  <c:pt idx="8">
                    <c:v>5.0000000000000001E-3</c:v>
                  </c:pt>
                  <c:pt idx="9">
                    <c:v>6.1500000000000001E-3</c:v>
                  </c:pt>
                  <c:pt idx="10">
                    <c:v>7.2500000000000004E-3</c:v>
                  </c:pt>
                  <c:pt idx="11">
                    <c:v>8.8999999999999999E-3</c:v>
                  </c:pt>
                  <c:pt idx="12">
                    <c:v>1.11E-2</c:v>
                  </c:pt>
                  <c:pt idx="13">
                    <c:v>1.1849999999999999E-2</c:v>
                  </c:pt>
                  <c:pt idx="14">
                    <c:v>1.38E-2</c:v>
                  </c:pt>
                  <c:pt idx="15">
                    <c:v>1.4149999999999999E-2</c:v>
                  </c:pt>
                  <c:pt idx="16">
                    <c:v>1.61E-2</c:v>
                  </c:pt>
                  <c:pt idx="17">
                    <c:v>1.7399999999999999E-2</c:v>
                  </c:pt>
                  <c:pt idx="18">
                    <c:v>1.8100000000000002E-2</c:v>
                  </c:pt>
                  <c:pt idx="19">
                    <c:v>1.83E-2</c:v>
                  </c:pt>
                  <c:pt idx="20">
                    <c:v>1.8849999999999999E-2</c:v>
                  </c:pt>
                  <c:pt idx="21">
                    <c:v>1.975E-2</c:v>
                  </c:pt>
                  <c:pt idx="22">
                    <c:v>2.0150000000000001E-2</c:v>
                  </c:pt>
                  <c:pt idx="23">
                    <c:v>1.985E-2</c:v>
                  </c:pt>
                  <c:pt idx="24">
                    <c:v>2.0199999999999999E-2</c:v>
                  </c:pt>
                  <c:pt idx="25">
                    <c:v>2.085E-2</c:v>
                  </c:pt>
                  <c:pt idx="26">
                    <c:v>2.1350000000000001E-2</c:v>
                  </c:pt>
                  <c:pt idx="27">
                    <c:v>2.1850000000000001E-2</c:v>
                  </c:pt>
                  <c:pt idx="28">
                    <c:v>2.215E-2</c:v>
                  </c:pt>
                  <c:pt idx="29">
                    <c:v>2.2349999999999998E-2</c:v>
                  </c:pt>
                  <c:pt idx="30">
                    <c:v>2.215E-2</c:v>
                  </c:pt>
                  <c:pt idx="31">
                    <c:v>2.2450000000000001E-2</c:v>
                  </c:pt>
                  <c:pt idx="32">
                    <c:v>2.2450000000000001E-2</c:v>
                  </c:pt>
                  <c:pt idx="33">
                    <c:v>2.205E-2</c:v>
                  </c:pt>
                  <c:pt idx="34">
                    <c:v>2.18E-2</c:v>
                  </c:pt>
                  <c:pt idx="35">
                    <c:v>2.2450000000000001E-2</c:v>
                  </c:pt>
                  <c:pt idx="36">
                    <c:v>2.1649999999999999E-2</c:v>
                  </c:pt>
                  <c:pt idx="37">
                    <c:v>2.1850000000000001E-2</c:v>
                  </c:pt>
                  <c:pt idx="38">
                    <c:v>2.1999999999999999E-2</c:v>
                  </c:pt>
                  <c:pt idx="39">
                    <c:v>2.1649999999999999E-2</c:v>
                  </c:pt>
                  <c:pt idx="40">
                    <c:v>2.205E-2</c:v>
                  </c:pt>
                  <c:pt idx="41">
                    <c:v>2.1899999999999999E-2</c:v>
                  </c:pt>
                  <c:pt idx="42">
                    <c:v>2.3099999999999999E-2</c:v>
                  </c:pt>
                  <c:pt idx="43">
                    <c:v>2.2800000000000001E-2</c:v>
                  </c:pt>
                  <c:pt idx="44">
                    <c:v>2.23E-2</c:v>
                  </c:pt>
                  <c:pt idx="45">
                    <c:v>2.3800000000000002E-2</c:v>
                  </c:pt>
                  <c:pt idx="46">
                    <c:v>2.4299999999999999E-2</c:v>
                  </c:pt>
                  <c:pt idx="47">
                    <c:v>2.4199999999999999E-2</c:v>
                  </c:pt>
                  <c:pt idx="48">
                    <c:v>2.4E-2</c:v>
                  </c:pt>
                  <c:pt idx="49">
                    <c:v>2.4400000000000002E-2</c:v>
                  </c:pt>
                  <c:pt idx="50">
                    <c:v>2.4299999999999999E-2</c:v>
                  </c:pt>
                  <c:pt idx="51">
                    <c:v>2.4799999999999999E-2</c:v>
                  </c:pt>
                  <c:pt idx="52">
                    <c:v>2.4400000000000002E-2</c:v>
                  </c:pt>
                  <c:pt idx="53">
                    <c:v>2.495E-2</c:v>
                  </c:pt>
                  <c:pt idx="54">
                    <c:v>2.5950000000000001E-2</c:v>
                  </c:pt>
                  <c:pt idx="55">
                    <c:v>2.8250000000000001E-2</c:v>
                  </c:pt>
                  <c:pt idx="56">
                    <c:v>2.8250000000000001E-2</c:v>
                  </c:pt>
                  <c:pt idx="57">
                    <c:v>2.7099999999999999E-2</c:v>
                  </c:pt>
                  <c:pt idx="58">
                    <c:v>2.7699999999999999E-2</c:v>
                  </c:pt>
                  <c:pt idx="59">
                    <c:v>2.7349999999999999E-2</c:v>
                  </c:pt>
                  <c:pt idx="60">
                    <c:v>2.8850000000000001E-2</c:v>
                  </c:pt>
                  <c:pt idx="61">
                    <c:v>2.835E-2</c:v>
                  </c:pt>
                  <c:pt idx="62">
                    <c:v>2.81E-2</c:v>
                  </c:pt>
                  <c:pt idx="63">
                    <c:v>2.6950000000000002E-2</c:v>
                  </c:pt>
                  <c:pt idx="64">
                    <c:v>2.6200000000000001E-2</c:v>
                  </c:pt>
                  <c:pt idx="65">
                    <c:v>2.7099999999999999E-2</c:v>
                  </c:pt>
                  <c:pt idx="66">
                    <c:v>2.69E-2</c:v>
                  </c:pt>
                  <c:pt idx="67">
                    <c:v>2.7199999999999998E-2</c:v>
                  </c:pt>
                  <c:pt idx="68">
                    <c:v>2.7400000000000001E-2</c:v>
                  </c:pt>
                  <c:pt idx="69">
                    <c:v>2.7449999999999999E-2</c:v>
                  </c:pt>
                  <c:pt idx="70">
                    <c:v>2.81E-2</c:v>
                  </c:pt>
                  <c:pt idx="71">
                    <c:v>2.76E-2</c:v>
                  </c:pt>
                  <c:pt idx="72">
                    <c:v>2.8000000000000001E-2</c:v>
                  </c:pt>
                  <c:pt idx="73">
                    <c:v>2.7349999999999999E-2</c:v>
                  </c:pt>
                  <c:pt idx="74">
                    <c:v>2.7900000000000001E-2</c:v>
                  </c:pt>
                  <c:pt idx="75">
                    <c:v>2.9000000000000001E-2</c:v>
                  </c:pt>
                  <c:pt idx="76">
                    <c:v>2.8799999999999999E-2</c:v>
                  </c:pt>
                  <c:pt idx="77">
                    <c:v>2.8299999999999999E-2</c:v>
                  </c:pt>
                  <c:pt idx="78">
                    <c:v>2.9399999999999999E-2</c:v>
                  </c:pt>
                  <c:pt idx="79">
                    <c:v>3.0849999999999999E-2</c:v>
                  </c:pt>
                  <c:pt idx="80">
                    <c:v>3.0700000000000002E-2</c:v>
                  </c:pt>
                  <c:pt idx="81">
                    <c:v>3.1600000000000003E-2</c:v>
                  </c:pt>
                  <c:pt idx="82">
                    <c:v>3.1199999999999999E-2</c:v>
                  </c:pt>
                  <c:pt idx="83">
                    <c:v>3.0499999999999999E-2</c:v>
                  </c:pt>
                  <c:pt idx="84">
                    <c:v>3.1300000000000001E-2</c:v>
                  </c:pt>
                  <c:pt idx="85">
                    <c:v>3.1449999999999999E-2</c:v>
                  </c:pt>
                  <c:pt idx="86">
                    <c:v>3.175E-2</c:v>
                  </c:pt>
                  <c:pt idx="87">
                    <c:v>3.1949999999999999E-2</c:v>
                  </c:pt>
                  <c:pt idx="88">
                    <c:v>3.1850000000000003E-2</c:v>
                  </c:pt>
                  <c:pt idx="89">
                    <c:v>3.2849999999999997E-2</c:v>
                  </c:pt>
                  <c:pt idx="90">
                    <c:v>3.3550000000000003E-2</c:v>
                  </c:pt>
                  <c:pt idx="91">
                    <c:v>3.3250000000000002E-2</c:v>
                  </c:pt>
                  <c:pt idx="92">
                    <c:v>3.4700000000000002E-2</c:v>
                  </c:pt>
                  <c:pt idx="93">
                    <c:v>3.5000000000000003E-2</c:v>
                  </c:pt>
                  <c:pt idx="94">
                    <c:v>3.5049999999999998E-2</c:v>
                  </c:pt>
                  <c:pt idx="95">
                    <c:v>3.4799999999999998E-2</c:v>
                  </c:pt>
                  <c:pt idx="96">
                    <c:v>3.5650000000000001E-2</c:v>
                  </c:pt>
                  <c:pt idx="97">
                    <c:v>3.5900000000000001E-2</c:v>
                  </c:pt>
                  <c:pt idx="98">
                    <c:v>3.6450000000000003E-2</c:v>
                  </c:pt>
                  <c:pt idx="99">
                    <c:v>3.7449999999999997E-2</c:v>
                  </c:pt>
                  <c:pt idx="100">
                    <c:v>3.755E-2</c:v>
                  </c:pt>
                  <c:pt idx="101">
                    <c:v>3.8249999999999999E-2</c:v>
                  </c:pt>
                  <c:pt idx="102">
                    <c:v>3.8300000000000001E-2</c:v>
                  </c:pt>
                  <c:pt idx="103">
                    <c:v>3.8850000000000003E-2</c:v>
                  </c:pt>
                  <c:pt idx="104">
                    <c:v>3.9100000000000003E-2</c:v>
                  </c:pt>
                  <c:pt idx="105">
                    <c:v>3.925E-2</c:v>
                  </c:pt>
                  <c:pt idx="106">
                    <c:v>3.9899999999999998E-2</c:v>
                  </c:pt>
                  <c:pt idx="107">
                    <c:v>3.9849999999999997E-2</c:v>
                  </c:pt>
                  <c:pt idx="108">
                    <c:v>4.0250000000000001E-2</c:v>
                  </c:pt>
                  <c:pt idx="109">
                    <c:v>4.0550000000000003E-2</c:v>
                  </c:pt>
                  <c:pt idx="110">
                    <c:v>4.0300000000000002E-2</c:v>
                  </c:pt>
                  <c:pt idx="111">
                    <c:v>4.1050000000000003E-2</c:v>
                  </c:pt>
                  <c:pt idx="112">
                    <c:v>4.1450000000000001E-2</c:v>
                  </c:pt>
                  <c:pt idx="113">
                    <c:v>4.2299999999999997E-2</c:v>
                  </c:pt>
                </c:numCache>
              </c:numRef>
            </c:plus>
            <c:minus>
              <c:numRef>
                <c:f>Sheet3!$E$2:$E$115</c:f>
                <c:numCache>
                  <c:formatCode>General</c:formatCode>
                  <c:ptCount val="114"/>
                  <c:pt idx="0">
                    <c:v>8.9999999999999998E-4</c:v>
                  </c:pt>
                  <c:pt idx="1">
                    <c:v>1.75E-3</c:v>
                  </c:pt>
                  <c:pt idx="2">
                    <c:v>8.0000000000000004E-4</c:v>
                  </c:pt>
                  <c:pt idx="3">
                    <c:v>1.0499999999999999E-3</c:v>
                  </c:pt>
                  <c:pt idx="4">
                    <c:v>1.15E-3</c:v>
                  </c:pt>
                  <c:pt idx="5">
                    <c:v>1.9499999999999999E-3</c:v>
                  </c:pt>
                  <c:pt idx="6">
                    <c:v>2.7000000000000001E-3</c:v>
                  </c:pt>
                  <c:pt idx="7">
                    <c:v>3.4499999999999999E-3</c:v>
                  </c:pt>
                  <c:pt idx="8">
                    <c:v>5.0000000000000001E-3</c:v>
                  </c:pt>
                  <c:pt idx="9">
                    <c:v>6.1500000000000001E-3</c:v>
                  </c:pt>
                  <c:pt idx="10">
                    <c:v>7.2500000000000004E-3</c:v>
                  </c:pt>
                  <c:pt idx="11">
                    <c:v>8.8999999999999999E-3</c:v>
                  </c:pt>
                  <c:pt idx="12">
                    <c:v>1.11E-2</c:v>
                  </c:pt>
                  <c:pt idx="13">
                    <c:v>1.1849999999999999E-2</c:v>
                  </c:pt>
                  <c:pt idx="14">
                    <c:v>1.38E-2</c:v>
                  </c:pt>
                  <c:pt idx="15">
                    <c:v>1.4149999999999999E-2</c:v>
                  </c:pt>
                  <c:pt idx="16">
                    <c:v>1.61E-2</c:v>
                  </c:pt>
                  <c:pt idx="17">
                    <c:v>1.7399999999999999E-2</c:v>
                  </c:pt>
                  <c:pt idx="18">
                    <c:v>1.8100000000000002E-2</c:v>
                  </c:pt>
                  <c:pt idx="19">
                    <c:v>1.83E-2</c:v>
                  </c:pt>
                  <c:pt idx="20">
                    <c:v>1.8849999999999999E-2</c:v>
                  </c:pt>
                  <c:pt idx="21">
                    <c:v>1.975E-2</c:v>
                  </c:pt>
                  <c:pt idx="22">
                    <c:v>2.0150000000000001E-2</c:v>
                  </c:pt>
                  <c:pt idx="23">
                    <c:v>1.985E-2</c:v>
                  </c:pt>
                  <c:pt idx="24">
                    <c:v>2.0199999999999999E-2</c:v>
                  </c:pt>
                  <c:pt idx="25">
                    <c:v>2.085E-2</c:v>
                  </c:pt>
                  <c:pt idx="26">
                    <c:v>2.1350000000000001E-2</c:v>
                  </c:pt>
                  <c:pt idx="27">
                    <c:v>2.1850000000000001E-2</c:v>
                  </c:pt>
                  <c:pt idx="28">
                    <c:v>2.215E-2</c:v>
                  </c:pt>
                  <c:pt idx="29">
                    <c:v>2.2349999999999998E-2</c:v>
                  </c:pt>
                  <c:pt idx="30">
                    <c:v>2.215E-2</c:v>
                  </c:pt>
                  <c:pt idx="31">
                    <c:v>2.2450000000000001E-2</c:v>
                  </c:pt>
                  <c:pt idx="32">
                    <c:v>2.2450000000000001E-2</c:v>
                  </c:pt>
                  <c:pt idx="33">
                    <c:v>2.205E-2</c:v>
                  </c:pt>
                  <c:pt idx="34">
                    <c:v>2.18E-2</c:v>
                  </c:pt>
                  <c:pt idx="35">
                    <c:v>2.2450000000000001E-2</c:v>
                  </c:pt>
                  <c:pt idx="36">
                    <c:v>2.1649999999999999E-2</c:v>
                  </c:pt>
                  <c:pt idx="37">
                    <c:v>2.1850000000000001E-2</c:v>
                  </c:pt>
                  <c:pt idx="38">
                    <c:v>2.1999999999999999E-2</c:v>
                  </c:pt>
                  <c:pt idx="39">
                    <c:v>2.1649999999999999E-2</c:v>
                  </c:pt>
                  <c:pt idx="40">
                    <c:v>2.205E-2</c:v>
                  </c:pt>
                  <c:pt idx="41">
                    <c:v>2.1899999999999999E-2</c:v>
                  </c:pt>
                  <c:pt idx="42">
                    <c:v>2.3099999999999999E-2</c:v>
                  </c:pt>
                  <c:pt idx="43">
                    <c:v>2.2800000000000001E-2</c:v>
                  </c:pt>
                  <c:pt idx="44">
                    <c:v>2.23E-2</c:v>
                  </c:pt>
                  <c:pt idx="45">
                    <c:v>2.3800000000000002E-2</c:v>
                  </c:pt>
                  <c:pt idx="46">
                    <c:v>2.4299999999999999E-2</c:v>
                  </c:pt>
                  <c:pt idx="47">
                    <c:v>2.4199999999999999E-2</c:v>
                  </c:pt>
                  <c:pt idx="48">
                    <c:v>2.4E-2</c:v>
                  </c:pt>
                  <c:pt idx="49">
                    <c:v>2.4400000000000002E-2</c:v>
                  </c:pt>
                  <c:pt idx="50">
                    <c:v>2.4299999999999999E-2</c:v>
                  </c:pt>
                  <c:pt idx="51">
                    <c:v>2.4799999999999999E-2</c:v>
                  </c:pt>
                  <c:pt idx="52">
                    <c:v>2.4400000000000002E-2</c:v>
                  </c:pt>
                  <c:pt idx="53">
                    <c:v>2.495E-2</c:v>
                  </c:pt>
                  <c:pt idx="54">
                    <c:v>2.5950000000000001E-2</c:v>
                  </c:pt>
                  <c:pt idx="55">
                    <c:v>2.8250000000000001E-2</c:v>
                  </c:pt>
                  <c:pt idx="56">
                    <c:v>2.8250000000000001E-2</c:v>
                  </c:pt>
                  <c:pt idx="57">
                    <c:v>2.7099999999999999E-2</c:v>
                  </c:pt>
                  <c:pt idx="58">
                    <c:v>2.7699999999999999E-2</c:v>
                  </c:pt>
                  <c:pt idx="59">
                    <c:v>2.7349999999999999E-2</c:v>
                  </c:pt>
                  <c:pt idx="60">
                    <c:v>2.8850000000000001E-2</c:v>
                  </c:pt>
                  <c:pt idx="61">
                    <c:v>2.835E-2</c:v>
                  </c:pt>
                  <c:pt idx="62">
                    <c:v>2.81E-2</c:v>
                  </c:pt>
                  <c:pt idx="63">
                    <c:v>2.6950000000000002E-2</c:v>
                  </c:pt>
                  <c:pt idx="64">
                    <c:v>2.6200000000000001E-2</c:v>
                  </c:pt>
                  <c:pt idx="65">
                    <c:v>2.7099999999999999E-2</c:v>
                  </c:pt>
                  <c:pt idx="66">
                    <c:v>2.69E-2</c:v>
                  </c:pt>
                  <c:pt idx="67">
                    <c:v>2.7199999999999998E-2</c:v>
                  </c:pt>
                  <c:pt idx="68">
                    <c:v>2.7400000000000001E-2</c:v>
                  </c:pt>
                  <c:pt idx="69">
                    <c:v>2.7449999999999999E-2</c:v>
                  </c:pt>
                  <c:pt idx="70">
                    <c:v>2.81E-2</c:v>
                  </c:pt>
                  <c:pt idx="71">
                    <c:v>2.76E-2</c:v>
                  </c:pt>
                  <c:pt idx="72">
                    <c:v>2.8000000000000001E-2</c:v>
                  </c:pt>
                  <c:pt idx="73">
                    <c:v>2.7349999999999999E-2</c:v>
                  </c:pt>
                  <c:pt idx="74">
                    <c:v>2.7900000000000001E-2</c:v>
                  </c:pt>
                  <c:pt idx="75">
                    <c:v>2.9000000000000001E-2</c:v>
                  </c:pt>
                  <c:pt idx="76">
                    <c:v>2.8799999999999999E-2</c:v>
                  </c:pt>
                  <c:pt idx="77">
                    <c:v>2.8299999999999999E-2</c:v>
                  </c:pt>
                  <c:pt idx="78">
                    <c:v>2.9399999999999999E-2</c:v>
                  </c:pt>
                  <c:pt idx="79">
                    <c:v>3.0849999999999999E-2</c:v>
                  </c:pt>
                  <c:pt idx="80">
                    <c:v>3.0700000000000002E-2</c:v>
                  </c:pt>
                  <c:pt idx="81">
                    <c:v>3.1600000000000003E-2</c:v>
                  </c:pt>
                  <c:pt idx="82">
                    <c:v>3.1199999999999999E-2</c:v>
                  </c:pt>
                  <c:pt idx="83">
                    <c:v>3.0499999999999999E-2</c:v>
                  </c:pt>
                  <c:pt idx="84">
                    <c:v>3.1300000000000001E-2</c:v>
                  </c:pt>
                  <c:pt idx="85">
                    <c:v>3.1449999999999999E-2</c:v>
                  </c:pt>
                  <c:pt idx="86">
                    <c:v>3.175E-2</c:v>
                  </c:pt>
                  <c:pt idx="87">
                    <c:v>3.1949999999999999E-2</c:v>
                  </c:pt>
                  <c:pt idx="88">
                    <c:v>3.1850000000000003E-2</c:v>
                  </c:pt>
                  <c:pt idx="89">
                    <c:v>3.2849999999999997E-2</c:v>
                  </c:pt>
                  <c:pt idx="90">
                    <c:v>3.3550000000000003E-2</c:v>
                  </c:pt>
                  <c:pt idx="91">
                    <c:v>3.3250000000000002E-2</c:v>
                  </c:pt>
                  <c:pt idx="92">
                    <c:v>3.4700000000000002E-2</c:v>
                  </c:pt>
                  <c:pt idx="93">
                    <c:v>3.5000000000000003E-2</c:v>
                  </c:pt>
                  <c:pt idx="94">
                    <c:v>3.5049999999999998E-2</c:v>
                  </c:pt>
                  <c:pt idx="95">
                    <c:v>3.4799999999999998E-2</c:v>
                  </c:pt>
                  <c:pt idx="96">
                    <c:v>3.5650000000000001E-2</c:v>
                  </c:pt>
                  <c:pt idx="97">
                    <c:v>3.5900000000000001E-2</c:v>
                  </c:pt>
                  <c:pt idx="98">
                    <c:v>3.6450000000000003E-2</c:v>
                  </c:pt>
                  <c:pt idx="99">
                    <c:v>3.7449999999999997E-2</c:v>
                  </c:pt>
                  <c:pt idx="100">
                    <c:v>3.755E-2</c:v>
                  </c:pt>
                  <c:pt idx="101">
                    <c:v>3.8249999999999999E-2</c:v>
                  </c:pt>
                  <c:pt idx="102">
                    <c:v>3.8300000000000001E-2</c:v>
                  </c:pt>
                  <c:pt idx="103">
                    <c:v>3.8850000000000003E-2</c:v>
                  </c:pt>
                  <c:pt idx="104">
                    <c:v>3.9100000000000003E-2</c:v>
                  </c:pt>
                  <c:pt idx="105">
                    <c:v>3.925E-2</c:v>
                  </c:pt>
                  <c:pt idx="106">
                    <c:v>3.9899999999999998E-2</c:v>
                  </c:pt>
                  <c:pt idx="107">
                    <c:v>3.9849999999999997E-2</c:v>
                  </c:pt>
                  <c:pt idx="108">
                    <c:v>4.0250000000000001E-2</c:v>
                  </c:pt>
                  <c:pt idx="109">
                    <c:v>4.0550000000000003E-2</c:v>
                  </c:pt>
                  <c:pt idx="110">
                    <c:v>4.0300000000000002E-2</c:v>
                  </c:pt>
                  <c:pt idx="111">
                    <c:v>4.1050000000000003E-2</c:v>
                  </c:pt>
                  <c:pt idx="112">
                    <c:v>4.1450000000000001E-2</c:v>
                  </c:pt>
                  <c:pt idx="113">
                    <c:v>4.2299999999999997E-2</c:v>
                  </c:pt>
                </c:numCache>
              </c:numRef>
            </c:minus>
            <c:spPr>
              <a:ln>
                <a:solidFill>
                  <a:srgbClr val="C00000">
                    <a:alpha val="50000"/>
                  </a:srgbClr>
                </a:solidFill>
              </a:ln>
            </c:spPr>
          </c:errBars>
          <c:xVal>
            <c:numRef>
              <c:f>Sheet3!$A$2:$A$115</c:f>
              <c:numCache>
                <c:formatCode>General</c:formatCode>
                <c:ptCount val="114"/>
                <c:pt idx="0">
                  <c:v>0</c:v>
                </c:pt>
                <c:pt idx="1">
                  <c:v>3.0999999999999999E-3</c:v>
                </c:pt>
                <c:pt idx="2">
                  <c:v>0.58860000000000001</c:v>
                </c:pt>
                <c:pt idx="3">
                  <c:v>0.83860000000000001</c:v>
                </c:pt>
                <c:pt idx="4">
                  <c:v>1.0886</c:v>
                </c:pt>
                <c:pt idx="5">
                  <c:v>1.3389</c:v>
                </c:pt>
                <c:pt idx="6">
                  <c:v>1.5889</c:v>
                </c:pt>
                <c:pt idx="7">
                  <c:v>1.8389</c:v>
                </c:pt>
                <c:pt idx="8">
                  <c:v>2.0891999999999999</c:v>
                </c:pt>
                <c:pt idx="9">
                  <c:v>2.3393999999999999</c:v>
                </c:pt>
                <c:pt idx="10">
                  <c:v>2.5897000000000001</c:v>
                </c:pt>
                <c:pt idx="11">
                  <c:v>2.84</c:v>
                </c:pt>
                <c:pt idx="12">
                  <c:v>3.0903</c:v>
                </c:pt>
                <c:pt idx="13">
                  <c:v>3.3405999999999998</c:v>
                </c:pt>
                <c:pt idx="14">
                  <c:v>3.5908000000000002</c:v>
                </c:pt>
                <c:pt idx="15">
                  <c:v>3.8411</c:v>
                </c:pt>
                <c:pt idx="16">
                  <c:v>4.0914000000000001</c:v>
                </c:pt>
                <c:pt idx="17">
                  <c:v>4.3417000000000003</c:v>
                </c:pt>
                <c:pt idx="18">
                  <c:v>4.5918999999999999</c:v>
                </c:pt>
                <c:pt idx="19">
                  <c:v>4.8422000000000001</c:v>
                </c:pt>
                <c:pt idx="20">
                  <c:v>5.0925000000000002</c:v>
                </c:pt>
                <c:pt idx="21">
                  <c:v>5.3428000000000004</c:v>
                </c:pt>
                <c:pt idx="22">
                  <c:v>5.5930999999999997</c:v>
                </c:pt>
                <c:pt idx="23">
                  <c:v>5.8433000000000002</c:v>
                </c:pt>
                <c:pt idx="24">
                  <c:v>6.0936000000000003</c:v>
                </c:pt>
                <c:pt idx="25">
                  <c:v>6.3438999999999997</c:v>
                </c:pt>
                <c:pt idx="26">
                  <c:v>6.5941999999999998</c:v>
                </c:pt>
                <c:pt idx="27">
                  <c:v>6.8444000000000003</c:v>
                </c:pt>
                <c:pt idx="28">
                  <c:v>7.0946999999999996</c:v>
                </c:pt>
                <c:pt idx="29">
                  <c:v>7.3449999999999998</c:v>
                </c:pt>
                <c:pt idx="30">
                  <c:v>7.5952999999999999</c:v>
                </c:pt>
                <c:pt idx="31">
                  <c:v>7.8456000000000001</c:v>
                </c:pt>
                <c:pt idx="32">
                  <c:v>8.0958000000000006</c:v>
                </c:pt>
                <c:pt idx="33">
                  <c:v>8.3460999999999999</c:v>
                </c:pt>
                <c:pt idx="34">
                  <c:v>8.5963999999999992</c:v>
                </c:pt>
                <c:pt idx="35">
                  <c:v>8.8467000000000002</c:v>
                </c:pt>
                <c:pt idx="36">
                  <c:v>9.0968999999999998</c:v>
                </c:pt>
                <c:pt idx="37">
                  <c:v>9.3472000000000008</c:v>
                </c:pt>
                <c:pt idx="38">
                  <c:v>9.5975000000000001</c:v>
                </c:pt>
                <c:pt idx="39">
                  <c:v>9.8477999999999994</c:v>
                </c:pt>
                <c:pt idx="40">
                  <c:v>10.098100000000001</c:v>
                </c:pt>
                <c:pt idx="41">
                  <c:v>10.3483</c:v>
                </c:pt>
                <c:pt idx="42">
                  <c:v>10.598599999999999</c:v>
                </c:pt>
                <c:pt idx="43">
                  <c:v>10.8489</c:v>
                </c:pt>
                <c:pt idx="44">
                  <c:v>11.0992</c:v>
                </c:pt>
                <c:pt idx="45">
                  <c:v>11.349399999999999</c:v>
                </c:pt>
                <c:pt idx="46">
                  <c:v>11.5997</c:v>
                </c:pt>
                <c:pt idx="47">
                  <c:v>11.85</c:v>
                </c:pt>
                <c:pt idx="48">
                  <c:v>12.100300000000001</c:v>
                </c:pt>
                <c:pt idx="49">
                  <c:v>12.3506</c:v>
                </c:pt>
                <c:pt idx="50">
                  <c:v>12.6008</c:v>
                </c:pt>
                <c:pt idx="51">
                  <c:v>12.851100000000001</c:v>
                </c:pt>
                <c:pt idx="52">
                  <c:v>13.1014</c:v>
                </c:pt>
                <c:pt idx="53">
                  <c:v>13.351699999999999</c:v>
                </c:pt>
                <c:pt idx="54">
                  <c:v>13.601900000000001</c:v>
                </c:pt>
                <c:pt idx="55">
                  <c:v>13.8522</c:v>
                </c:pt>
                <c:pt idx="56">
                  <c:v>14.102499999999999</c:v>
                </c:pt>
                <c:pt idx="57">
                  <c:v>14.3528</c:v>
                </c:pt>
                <c:pt idx="58">
                  <c:v>14.6031</c:v>
                </c:pt>
                <c:pt idx="59">
                  <c:v>14.853300000000001</c:v>
                </c:pt>
                <c:pt idx="60">
                  <c:v>15.1036</c:v>
                </c:pt>
                <c:pt idx="61">
                  <c:v>15.353899999999999</c:v>
                </c:pt>
                <c:pt idx="62">
                  <c:v>15.604200000000001</c:v>
                </c:pt>
                <c:pt idx="63">
                  <c:v>15.8544</c:v>
                </c:pt>
                <c:pt idx="64">
                  <c:v>16.104700000000001</c:v>
                </c:pt>
                <c:pt idx="65">
                  <c:v>16.355</c:v>
                </c:pt>
                <c:pt idx="66">
                  <c:v>16.6053</c:v>
                </c:pt>
                <c:pt idx="67">
                  <c:v>16.855599999999999</c:v>
                </c:pt>
                <c:pt idx="68">
                  <c:v>17.105799999999999</c:v>
                </c:pt>
                <c:pt idx="69">
                  <c:v>17.356100000000001</c:v>
                </c:pt>
                <c:pt idx="70">
                  <c:v>17.606400000000001</c:v>
                </c:pt>
                <c:pt idx="71">
                  <c:v>17.8567</c:v>
                </c:pt>
                <c:pt idx="72">
                  <c:v>18.1069</c:v>
                </c:pt>
                <c:pt idx="73">
                  <c:v>18.357199999999999</c:v>
                </c:pt>
                <c:pt idx="74">
                  <c:v>18.607500000000002</c:v>
                </c:pt>
                <c:pt idx="75">
                  <c:v>18.857800000000001</c:v>
                </c:pt>
                <c:pt idx="76">
                  <c:v>19.1081</c:v>
                </c:pt>
                <c:pt idx="77">
                  <c:v>19.3583</c:v>
                </c:pt>
                <c:pt idx="78">
                  <c:v>19.608599999999999</c:v>
                </c:pt>
                <c:pt idx="79">
                  <c:v>19.858899999999998</c:v>
                </c:pt>
                <c:pt idx="80">
                  <c:v>20.109200000000001</c:v>
                </c:pt>
                <c:pt idx="81">
                  <c:v>20.359400000000001</c:v>
                </c:pt>
                <c:pt idx="82">
                  <c:v>20.6097</c:v>
                </c:pt>
                <c:pt idx="83">
                  <c:v>20.86</c:v>
                </c:pt>
                <c:pt idx="84">
                  <c:v>21.110299999999999</c:v>
                </c:pt>
                <c:pt idx="85">
                  <c:v>21.360600000000002</c:v>
                </c:pt>
                <c:pt idx="86">
                  <c:v>21.610800000000001</c:v>
                </c:pt>
                <c:pt idx="87">
                  <c:v>21.8611</c:v>
                </c:pt>
                <c:pt idx="88">
                  <c:v>22.1114</c:v>
                </c:pt>
                <c:pt idx="89">
                  <c:v>22.361699999999999</c:v>
                </c:pt>
                <c:pt idx="90">
                  <c:v>22.611899999999999</c:v>
                </c:pt>
                <c:pt idx="91">
                  <c:v>22.862200000000001</c:v>
                </c:pt>
                <c:pt idx="92">
                  <c:v>23.112500000000001</c:v>
                </c:pt>
                <c:pt idx="93">
                  <c:v>23.3628</c:v>
                </c:pt>
                <c:pt idx="94">
                  <c:v>23.613099999999999</c:v>
                </c:pt>
                <c:pt idx="95">
                  <c:v>23.863299999999999</c:v>
                </c:pt>
                <c:pt idx="96">
                  <c:v>24.113600000000002</c:v>
                </c:pt>
                <c:pt idx="97">
                  <c:v>24.363900000000001</c:v>
                </c:pt>
                <c:pt idx="98">
                  <c:v>24.6142</c:v>
                </c:pt>
                <c:pt idx="99">
                  <c:v>24.8644</c:v>
                </c:pt>
                <c:pt idx="100">
                  <c:v>25.114699999999999</c:v>
                </c:pt>
                <c:pt idx="101">
                  <c:v>25.364999999999998</c:v>
                </c:pt>
                <c:pt idx="102">
                  <c:v>25.615300000000001</c:v>
                </c:pt>
                <c:pt idx="103">
                  <c:v>25.865600000000001</c:v>
                </c:pt>
                <c:pt idx="104">
                  <c:v>26.1158</c:v>
                </c:pt>
                <c:pt idx="105">
                  <c:v>26.366099999999999</c:v>
                </c:pt>
                <c:pt idx="106">
                  <c:v>26.616399999999999</c:v>
                </c:pt>
                <c:pt idx="107">
                  <c:v>26.866700000000002</c:v>
                </c:pt>
                <c:pt idx="108">
                  <c:v>27.116900000000001</c:v>
                </c:pt>
                <c:pt idx="109">
                  <c:v>27.3672</c:v>
                </c:pt>
                <c:pt idx="110">
                  <c:v>27.6175</c:v>
                </c:pt>
                <c:pt idx="111">
                  <c:v>27.867799999999999</c:v>
                </c:pt>
                <c:pt idx="112">
                  <c:v>28.118099999999998</c:v>
                </c:pt>
                <c:pt idx="113">
                  <c:v>28.368300000000001</c:v>
                </c:pt>
              </c:numCache>
            </c:numRef>
          </c:xVal>
          <c:yVal>
            <c:numRef>
              <c:f>Sheet3!$C$2:$C$115</c:f>
              <c:numCache>
                <c:formatCode>General</c:formatCode>
                <c:ptCount val="114"/>
                <c:pt idx="0">
                  <c:v>0.99860000000000004</c:v>
                </c:pt>
                <c:pt idx="1">
                  <c:v>1</c:v>
                </c:pt>
                <c:pt idx="2">
                  <c:v>1.002</c:v>
                </c:pt>
                <c:pt idx="3">
                  <c:v>1.0037</c:v>
                </c:pt>
                <c:pt idx="4">
                  <c:v>1.0068999999999999</c:v>
                </c:pt>
                <c:pt idx="5">
                  <c:v>1.0095000000000001</c:v>
                </c:pt>
                <c:pt idx="6">
                  <c:v>1.0136000000000001</c:v>
                </c:pt>
                <c:pt idx="7">
                  <c:v>1.0165</c:v>
                </c:pt>
                <c:pt idx="8">
                  <c:v>1.0201</c:v>
                </c:pt>
                <c:pt idx="9">
                  <c:v>1.0253000000000001</c:v>
                </c:pt>
                <c:pt idx="10">
                  <c:v>1.0289999999999999</c:v>
                </c:pt>
                <c:pt idx="11">
                  <c:v>1.0330999999999999</c:v>
                </c:pt>
                <c:pt idx="12">
                  <c:v>1.0374000000000001</c:v>
                </c:pt>
                <c:pt idx="13">
                  <c:v>1.0421</c:v>
                </c:pt>
                <c:pt idx="14">
                  <c:v>1.0457000000000001</c:v>
                </c:pt>
                <c:pt idx="15">
                  <c:v>1.0501</c:v>
                </c:pt>
                <c:pt idx="16">
                  <c:v>1.0531999999999999</c:v>
                </c:pt>
                <c:pt idx="17">
                  <c:v>1.0561</c:v>
                </c:pt>
                <c:pt idx="18">
                  <c:v>1.0578000000000001</c:v>
                </c:pt>
                <c:pt idx="19">
                  <c:v>1.0601</c:v>
                </c:pt>
                <c:pt idx="20">
                  <c:v>1.0623</c:v>
                </c:pt>
                <c:pt idx="21">
                  <c:v>1.0645</c:v>
                </c:pt>
                <c:pt idx="22">
                  <c:v>1.0667</c:v>
                </c:pt>
                <c:pt idx="23">
                  <c:v>1.0688</c:v>
                </c:pt>
                <c:pt idx="24">
                  <c:v>1.0711999999999999</c:v>
                </c:pt>
                <c:pt idx="25">
                  <c:v>1.0730999999999999</c:v>
                </c:pt>
                <c:pt idx="26">
                  <c:v>1.0738000000000001</c:v>
                </c:pt>
                <c:pt idx="27">
                  <c:v>1.075</c:v>
                </c:pt>
                <c:pt idx="28">
                  <c:v>1.0752999999999999</c:v>
                </c:pt>
                <c:pt idx="29">
                  <c:v>1.0768</c:v>
                </c:pt>
                <c:pt idx="30">
                  <c:v>1.0769</c:v>
                </c:pt>
                <c:pt idx="31">
                  <c:v>1.0786</c:v>
                </c:pt>
                <c:pt idx="32">
                  <c:v>1.0794999999999999</c:v>
                </c:pt>
                <c:pt idx="33">
                  <c:v>1.0804</c:v>
                </c:pt>
                <c:pt idx="34">
                  <c:v>1.0818000000000001</c:v>
                </c:pt>
                <c:pt idx="35">
                  <c:v>1.0828</c:v>
                </c:pt>
                <c:pt idx="36">
                  <c:v>1.0837000000000001</c:v>
                </c:pt>
                <c:pt idx="37">
                  <c:v>1.0853999999999999</c:v>
                </c:pt>
                <c:pt idx="38">
                  <c:v>1.0860000000000001</c:v>
                </c:pt>
                <c:pt idx="39">
                  <c:v>1.0883</c:v>
                </c:pt>
                <c:pt idx="40">
                  <c:v>1.089</c:v>
                </c:pt>
                <c:pt idx="41">
                  <c:v>1.0904</c:v>
                </c:pt>
                <c:pt idx="42">
                  <c:v>1.0923</c:v>
                </c:pt>
                <c:pt idx="43">
                  <c:v>1.0938000000000001</c:v>
                </c:pt>
                <c:pt idx="44">
                  <c:v>1.0940000000000001</c:v>
                </c:pt>
                <c:pt idx="45">
                  <c:v>1.0973999999999999</c:v>
                </c:pt>
                <c:pt idx="46">
                  <c:v>1.1001000000000001</c:v>
                </c:pt>
                <c:pt idx="47">
                  <c:v>1.1026</c:v>
                </c:pt>
                <c:pt idx="48">
                  <c:v>1.1036999999999999</c:v>
                </c:pt>
                <c:pt idx="49">
                  <c:v>1.1053999999999999</c:v>
                </c:pt>
                <c:pt idx="50">
                  <c:v>1.1086</c:v>
                </c:pt>
                <c:pt idx="51">
                  <c:v>1.1108</c:v>
                </c:pt>
                <c:pt idx="52">
                  <c:v>1.1134999999999999</c:v>
                </c:pt>
                <c:pt idx="53">
                  <c:v>1.1158999999999999</c:v>
                </c:pt>
                <c:pt idx="54">
                  <c:v>1.1202000000000001</c:v>
                </c:pt>
                <c:pt idx="55">
                  <c:v>1.1263000000000001</c:v>
                </c:pt>
                <c:pt idx="56">
                  <c:v>1.1286</c:v>
                </c:pt>
                <c:pt idx="57">
                  <c:v>1.1299999999999999</c:v>
                </c:pt>
                <c:pt idx="58">
                  <c:v>1.1327</c:v>
                </c:pt>
                <c:pt idx="59">
                  <c:v>1.1355999999999999</c:v>
                </c:pt>
                <c:pt idx="60">
                  <c:v>1.1400999999999999</c:v>
                </c:pt>
                <c:pt idx="61">
                  <c:v>1.1427</c:v>
                </c:pt>
                <c:pt idx="62">
                  <c:v>1.1444000000000001</c:v>
                </c:pt>
                <c:pt idx="63">
                  <c:v>1.1456999999999999</c:v>
                </c:pt>
                <c:pt idx="64">
                  <c:v>1.1504000000000001</c:v>
                </c:pt>
                <c:pt idx="65">
                  <c:v>1.1534</c:v>
                </c:pt>
                <c:pt idx="66">
                  <c:v>1.1589</c:v>
                </c:pt>
                <c:pt idx="67">
                  <c:v>1.1684000000000001</c:v>
                </c:pt>
                <c:pt idx="68">
                  <c:v>1.1745000000000001</c:v>
                </c:pt>
                <c:pt idx="69">
                  <c:v>1.1768000000000001</c:v>
                </c:pt>
                <c:pt idx="70">
                  <c:v>1.1755</c:v>
                </c:pt>
                <c:pt idx="71">
                  <c:v>1.1788000000000001</c:v>
                </c:pt>
                <c:pt idx="72">
                  <c:v>1.1813</c:v>
                </c:pt>
                <c:pt idx="73">
                  <c:v>1.1847000000000001</c:v>
                </c:pt>
                <c:pt idx="74">
                  <c:v>1.1880999999999999</c:v>
                </c:pt>
                <c:pt idx="75">
                  <c:v>1.1930000000000001</c:v>
                </c:pt>
                <c:pt idx="76">
                  <c:v>1.196</c:v>
                </c:pt>
                <c:pt idx="77">
                  <c:v>1.2005999999999999</c:v>
                </c:pt>
                <c:pt idx="78">
                  <c:v>1.2067000000000001</c:v>
                </c:pt>
                <c:pt idx="79">
                  <c:v>1.2123999999999999</c:v>
                </c:pt>
                <c:pt idx="80">
                  <c:v>1.2164999999999999</c:v>
                </c:pt>
                <c:pt idx="81">
                  <c:v>1.2206999999999999</c:v>
                </c:pt>
                <c:pt idx="82">
                  <c:v>1.2256</c:v>
                </c:pt>
                <c:pt idx="83">
                  <c:v>1.2302999999999999</c:v>
                </c:pt>
                <c:pt idx="84">
                  <c:v>1.2365999999999999</c:v>
                </c:pt>
                <c:pt idx="85">
                  <c:v>1.2407999999999999</c:v>
                </c:pt>
                <c:pt idx="86">
                  <c:v>1.2457</c:v>
                </c:pt>
                <c:pt idx="87">
                  <c:v>1.2504999999999999</c:v>
                </c:pt>
                <c:pt idx="88">
                  <c:v>1.2565999999999999</c:v>
                </c:pt>
                <c:pt idx="89">
                  <c:v>1.2615000000000001</c:v>
                </c:pt>
                <c:pt idx="90">
                  <c:v>1.2675000000000001</c:v>
                </c:pt>
                <c:pt idx="91">
                  <c:v>1.2730999999999999</c:v>
                </c:pt>
                <c:pt idx="92">
                  <c:v>1.2799</c:v>
                </c:pt>
                <c:pt idx="93">
                  <c:v>1.286</c:v>
                </c:pt>
                <c:pt idx="94">
                  <c:v>1.2932999999999999</c:v>
                </c:pt>
                <c:pt idx="95">
                  <c:v>1.2990999999999999</c:v>
                </c:pt>
                <c:pt idx="96">
                  <c:v>1.3048</c:v>
                </c:pt>
                <c:pt idx="97">
                  <c:v>1.3120000000000001</c:v>
                </c:pt>
                <c:pt idx="98">
                  <c:v>1.3190999999999999</c:v>
                </c:pt>
                <c:pt idx="99">
                  <c:v>1.3259000000000001</c:v>
                </c:pt>
                <c:pt idx="100">
                  <c:v>1.3339000000000001</c:v>
                </c:pt>
                <c:pt idx="101">
                  <c:v>1.3403</c:v>
                </c:pt>
                <c:pt idx="102">
                  <c:v>1.347</c:v>
                </c:pt>
                <c:pt idx="103">
                  <c:v>1.3564000000000001</c:v>
                </c:pt>
                <c:pt idx="104">
                  <c:v>1.3634999999999999</c:v>
                </c:pt>
                <c:pt idx="105">
                  <c:v>1.3702000000000001</c:v>
                </c:pt>
                <c:pt idx="106">
                  <c:v>1.3773</c:v>
                </c:pt>
                <c:pt idx="107">
                  <c:v>1.3843000000000001</c:v>
                </c:pt>
                <c:pt idx="108">
                  <c:v>1.3915999999999999</c:v>
                </c:pt>
                <c:pt idx="109">
                  <c:v>1.3984000000000001</c:v>
                </c:pt>
                <c:pt idx="110">
                  <c:v>1.4084000000000001</c:v>
                </c:pt>
                <c:pt idx="111">
                  <c:v>1.4176</c:v>
                </c:pt>
                <c:pt idx="112">
                  <c:v>1.4263999999999999</c:v>
                </c:pt>
                <c:pt idx="113">
                  <c:v>1.434900000000000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803840"/>
        <c:axId val="32838784"/>
      </c:scatterChart>
      <c:valAx>
        <c:axId val="32803840"/>
        <c:scaling>
          <c:orientation val="minMax"/>
          <c:max val="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ou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32838784"/>
        <c:crosses val="autoZero"/>
        <c:crossBetween val="midCat"/>
      </c:valAx>
      <c:valAx>
        <c:axId val="32838784"/>
        <c:scaling>
          <c:orientation val="minMax"/>
          <c:min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I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32803840"/>
        <c:crosses val="autoZero"/>
        <c:crossBetween val="midCat"/>
        <c:majorUnit val="0.2"/>
      </c:valAx>
    </c:plotArea>
    <c:legend>
      <c:legendPos val="r"/>
      <c:layout>
        <c:manualLayout>
          <c:xMode val="edge"/>
          <c:yMode val="edge"/>
          <c:x val="0.21928611189483074"/>
          <c:y val="3.8852208278827856E-2"/>
          <c:w val="0.45728528835375665"/>
          <c:h val="0.21341369126905024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664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60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785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408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677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981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924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51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18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683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95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EF06E-9EFB-4A51-AD8F-EEED89E34E34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DA4776-F6A0-4A1B-88E6-E02A8FC682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94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050190"/>
              </p:ext>
            </p:extLst>
          </p:nvPr>
        </p:nvGraphicFramePr>
        <p:xfrm>
          <a:off x="304800" y="962799"/>
          <a:ext cx="2590799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224151"/>
              </p:ext>
            </p:extLst>
          </p:nvPr>
        </p:nvGraphicFramePr>
        <p:xfrm>
          <a:off x="3276600" y="962799"/>
          <a:ext cx="2819400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67109" y="594151"/>
            <a:ext cx="102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57600" y="594151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466470"/>
              </p:ext>
            </p:extLst>
          </p:nvPr>
        </p:nvGraphicFramePr>
        <p:xfrm>
          <a:off x="381000" y="3559517"/>
          <a:ext cx="2743200" cy="19685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6705448"/>
              </p:ext>
            </p:extLst>
          </p:nvPr>
        </p:nvGraphicFramePr>
        <p:xfrm>
          <a:off x="3276600" y="3648989"/>
          <a:ext cx="2819400" cy="1919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667109" y="3282517"/>
            <a:ext cx="1024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657600" y="3282517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Collagen I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53249" y="954155"/>
            <a:ext cx="360996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88759" y="3670192"/>
            <a:ext cx="360996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85747" y="3481347"/>
            <a:ext cx="360996" cy="13542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/>
            <a:endParaRPr lang="en-US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6866" y="906724"/>
            <a:ext cx="361061" cy="1615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/>
            <a:endParaRPr lang="en-US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/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/>
            <a:endParaRPr lang="en-US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/>
            <a:endParaRPr lang="en-US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/>
            <a:endParaRPr lang="en-US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81729" y="5590995"/>
            <a:ext cx="63745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gure 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PP4B expression does not suppress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he rate of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totactic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igration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uter sides of membranes in the CIM plates were coated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A, C)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or collagen I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, D), blocked with BSA, and rinsed in PBS. PC-3 #14 and #4 cells were treated with either vehicle or 0.5 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/ml doxycycline for 48 hours. Cells were washed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ypsinize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and plated into CIM plates at 50,000 per well in serum free medium. Full growth medium was used in the lower chamber. Cellular impedance as a measure 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totact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gration was monitored for 20-30 hour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68"/>
          <p:cNvSpPr txBox="1">
            <a:spLocks noChangeArrowheads="1"/>
          </p:cNvSpPr>
          <p:nvPr/>
        </p:nvSpPr>
        <p:spPr bwMode="auto">
          <a:xfrm>
            <a:off x="333374" y="378652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A</a:t>
            </a:r>
          </a:p>
        </p:txBody>
      </p:sp>
      <p:sp>
        <p:nvSpPr>
          <p:cNvPr id="22" name="TextBox 82"/>
          <p:cNvSpPr txBox="1">
            <a:spLocks noChangeArrowheads="1"/>
          </p:cNvSpPr>
          <p:nvPr/>
        </p:nvSpPr>
        <p:spPr bwMode="auto">
          <a:xfrm>
            <a:off x="3420989" y="456425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B</a:t>
            </a:r>
          </a:p>
        </p:txBody>
      </p:sp>
      <p:sp>
        <p:nvSpPr>
          <p:cNvPr id="23" name="TextBox 83"/>
          <p:cNvSpPr txBox="1">
            <a:spLocks noChangeArrowheads="1"/>
          </p:cNvSpPr>
          <p:nvPr/>
        </p:nvSpPr>
        <p:spPr bwMode="auto">
          <a:xfrm>
            <a:off x="371834" y="2895600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C</a:t>
            </a:r>
          </a:p>
        </p:txBody>
      </p:sp>
      <p:sp>
        <p:nvSpPr>
          <p:cNvPr id="24" name="TextBox 85"/>
          <p:cNvSpPr txBox="1">
            <a:spLocks noChangeArrowheads="1"/>
          </p:cNvSpPr>
          <p:nvPr/>
        </p:nvSpPr>
        <p:spPr bwMode="auto">
          <a:xfrm>
            <a:off x="3407061" y="3144404"/>
            <a:ext cx="2952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cs typeface="Arial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809749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162</Words>
  <Application>Microsoft Office PowerPoint</Application>
  <PresentationFormat>Letter Paper (8.5x11 in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ina Agoulnik</dc:creator>
  <cp:lastModifiedBy>Irina Agoulnik</cp:lastModifiedBy>
  <cp:revision>11</cp:revision>
  <dcterms:created xsi:type="dcterms:W3CDTF">2014-07-01T21:54:59Z</dcterms:created>
  <dcterms:modified xsi:type="dcterms:W3CDTF">2014-07-31T22:02:59Z</dcterms:modified>
</cp:coreProperties>
</file>